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597" autoAdjust="0"/>
    <p:restoredTop sz="94660"/>
  </p:normalViewPr>
  <p:slideViewPr>
    <p:cSldViewPr>
      <p:cViewPr>
        <p:scale>
          <a:sx n="80" d="100"/>
          <a:sy n="80" d="100"/>
        </p:scale>
        <p:origin x="-792" y="-57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7148-D462-457C-9604-82E70CF7F98C}" type="datetimeFigureOut">
              <a:rPr lang="ko-KR" altLang="en-US" smtClean="0"/>
              <a:t>2013-03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A2875E-B078-49A6-9BA7-5BFFE221222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230563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7148-D462-457C-9604-82E70CF7F98C}" type="datetimeFigureOut">
              <a:rPr lang="ko-KR" altLang="en-US" smtClean="0"/>
              <a:t>2013-03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A2875E-B078-49A6-9BA7-5BFFE221222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758248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7148-D462-457C-9604-82E70CF7F98C}" type="datetimeFigureOut">
              <a:rPr lang="ko-KR" altLang="en-US" smtClean="0"/>
              <a:t>2013-03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A2875E-B078-49A6-9BA7-5BFFE221222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112775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7148-D462-457C-9604-82E70CF7F98C}" type="datetimeFigureOut">
              <a:rPr lang="ko-KR" altLang="en-US" smtClean="0"/>
              <a:t>2013-03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A2875E-B078-49A6-9BA7-5BFFE221222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847655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7148-D462-457C-9604-82E70CF7F98C}" type="datetimeFigureOut">
              <a:rPr lang="ko-KR" altLang="en-US" smtClean="0"/>
              <a:t>2013-03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A2875E-B078-49A6-9BA7-5BFFE221222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150969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7148-D462-457C-9604-82E70CF7F98C}" type="datetimeFigureOut">
              <a:rPr lang="ko-KR" altLang="en-US" smtClean="0"/>
              <a:t>2013-03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A2875E-B078-49A6-9BA7-5BFFE221222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592428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7148-D462-457C-9604-82E70CF7F98C}" type="datetimeFigureOut">
              <a:rPr lang="ko-KR" altLang="en-US" smtClean="0"/>
              <a:t>2013-03-04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A2875E-B078-49A6-9BA7-5BFFE221222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855619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7148-D462-457C-9604-82E70CF7F98C}" type="datetimeFigureOut">
              <a:rPr lang="ko-KR" altLang="en-US" smtClean="0"/>
              <a:t>2013-03-0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A2875E-B078-49A6-9BA7-5BFFE221222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988467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7148-D462-457C-9604-82E70CF7F98C}" type="datetimeFigureOut">
              <a:rPr lang="ko-KR" altLang="en-US" smtClean="0"/>
              <a:t>2013-03-04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A2875E-B078-49A6-9BA7-5BFFE221222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30313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7148-D462-457C-9604-82E70CF7F98C}" type="datetimeFigureOut">
              <a:rPr lang="ko-KR" altLang="en-US" smtClean="0"/>
              <a:t>2013-03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A2875E-B078-49A6-9BA7-5BFFE221222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324148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7148-D462-457C-9604-82E70CF7F98C}" type="datetimeFigureOut">
              <a:rPr lang="ko-KR" altLang="en-US" smtClean="0"/>
              <a:t>2013-03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A2875E-B078-49A6-9BA7-5BFFE221222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728952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407148-D462-457C-9604-82E70CF7F98C}" type="datetimeFigureOut">
              <a:rPr lang="ko-KR" altLang="en-US" smtClean="0"/>
              <a:t>2013-03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A2875E-B078-49A6-9BA7-5BFFE221222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371868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7" name="그룹 236"/>
          <p:cNvGrpSpPr/>
          <p:nvPr/>
        </p:nvGrpSpPr>
        <p:grpSpPr>
          <a:xfrm>
            <a:off x="1508977" y="908720"/>
            <a:ext cx="6447399" cy="3743166"/>
            <a:chOff x="1369451" y="908720"/>
            <a:chExt cx="6665117" cy="3743166"/>
          </a:xfrm>
        </p:grpSpPr>
        <p:sp>
          <p:nvSpPr>
            <p:cNvPr id="121" name="AutoShape 120"/>
            <p:cNvSpPr>
              <a:spLocks noChangeAspect="1" noChangeArrowheads="1" noTextEdit="1"/>
            </p:cNvSpPr>
            <p:nvPr/>
          </p:nvSpPr>
          <p:spPr bwMode="auto">
            <a:xfrm>
              <a:off x="1763713" y="908720"/>
              <a:ext cx="6048375" cy="36703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22" name="Rectangle 122"/>
            <p:cNvSpPr>
              <a:spLocks noChangeArrowheads="1"/>
            </p:cNvSpPr>
            <p:nvPr/>
          </p:nvSpPr>
          <p:spPr bwMode="auto">
            <a:xfrm>
              <a:off x="1763713" y="908720"/>
              <a:ext cx="6053137" cy="3678237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23" name="Rectangle 123"/>
            <p:cNvSpPr>
              <a:spLocks noChangeArrowheads="1"/>
            </p:cNvSpPr>
            <p:nvPr/>
          </p:nvSpPr>
          <p:spPr bwMode="auto">
            <a:xfrm>
              <a:off x="2122488" y="962695"/>
              <a:ext cx="5629275" cy="3151187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24" name="Rectangle 124"/>
            <p:cNvSpPr>
              <a:spLocks noChangeArrowheads="1"/>
            </p:cNvSpPr>
            <p:nvPr/>
          </p:nvSpPr>
          <p:spPr bwMode="auto">
            <a:xfrm>
              <a:off x="2122488" y="962695"/>
              <a:ext cx="5629275" cy="3151187"/>
            </a:xfrm>
            <a:prstGeom prst="rect">
              <a:avLst/>
            </a:prstGeom>
            <a:noFill/>
            <a:ln w="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25" name="Freeform 125"/>
            <p:cNvSpPr>
              <a:spLocks/>
            </p:cNvSpPr>
            <p:nvPr/>
          </p:nvSpPr>
          <p:spPr bwMode="auto">
            <a:xfrm>
              <a:off x="2122488" y="1107157"/>
              <a:ext cx="5629275" cy="2862262"/>
            </a:xfrm>
            <a:custGeom>
              <a:avLst/>
              <a:gdLst>
                <a:gd name="T0" fmla="*/ 57 w 3546"/>
                <a:gd name="T1" fmla="*/ 1803 h 1803"/>
                <a:gd name="T2" fmla="*/ 110 w 3546"/>
                <a:gd name="T3" fmla="*/ 1803 h 1803"/>
                <a:gd name="T4" fmla="*/ 167 w 3546"/>
                <a:gd name="T5" fmla="*/ 1798 h 1803"/>
                <a:gd name="T6" fmla="*/ 224 w 3546"/>
                <a:gd name="T7" fmla="*/ 1751 h 1803"/>
                <a:gd name="T8" fmla="*/ 280 w 3546"/>
                <a:gd name="T9" fmla="*/ 1645 h 1803"/>
                <a:gd name="T10" fmla="*/ 337 w 3546"/>
                <a:gd name="T11" fmla="*/ 1621 h 1803"/>
                <a:gd name="T12" fmla="*/ 390 w 3546"/>
                <a:gd name="T13" fmla="*/ 1707 h 1803"/>
                <a:gd name="T14" fmla="*/ 447 w 3546"/>
                <a:gd name="T15" fmla="*/ 1712 h 1803"/>
                <a:gd name="T16" fmla="*/ 503 w 3546"/>
                <a:gd name="T17" fmla="*/ 1741 h 1803"/>
                <a:gd name="T18" fmla="*/ 560 w 3546"/>
                <a:gd name="T19" fmla="*/ 1770 h 1803"/>
                <a:gd name="T20" fmla="*/ 613 w 3546"/>
                <a:gd name="T21" fmla="*/ 1746 h 1803"/>
                <a:gd name="T22" fmla="*/ 670 w 3546"/>
                <a:gd name="T23" fmla="*/ 1765 h 1803"/>
                <a:gd name="T24" fmla="*/ 727 w 3546"/>
                <a:gd name="T25" fmla="*/ 1760 h 1803"/>
                <a:gd name="T26" fmla="*/ 783 w 3546"/>
                <a:gd name="T27" fmla="*/ 1727 h 1803"/>
                <a:gd name="T28" fmla="*/ 837 w 3546"/>
                <a:gd name="T29" fmla="*/ 1770 h 1803"/>
                <a:gd name="T30" fmla="*/ 893 w 3546"/>
                <a:gd name="T31" fmla="*/ 1760 h 1803"/>
                <a:gd name="T32" fmla="*/ 950 w 3546"/>
                <a:gd name="T33" fmla="*/ 1770 h 1803"/>
                <a:gd name="T34" fmla="*/ 1006 w 3546"/>
                <a:gd name="T35" fmla="*/ 1770 h 1803"/>
                <a:gd name="T36" fmla="*/ 1060 w 3546"/>
                <a:gd name="T37" fmla="*/ 1774 h 1803"/>
                <a:gd name="T38" fmla="*/ 1116 w 3546"/>
                <a:gd name="T39" fmla="*/ 1770 h 1803"/>
                <a:gd name="T40" fmla="*/ 1173 w 3546"/>
                <a:gd name="T41" fmla="*/ 1770 h 1803"/>
                <a:gd name="T42" fmla="*/ 1229 w 3546"/>
                <a:gd name="T43" fmla="*/ 1765 h 1803"/>
                <a:gd name="T44" fmla="*/ 1283 w 3546"/>
                <a:gd name="T45" fmla="*/ 1741 h 1803"/>
                <a:gd name="T46" fmla="*/ 1339 w 3546"/>
                <a:gd name="T47" fmla="*/ 1717 h 1803"/>
                <a:gd name="T48" fmla="*/ 1396 w 3546"/>
                <a:gd name="T49" fmla="*/ 1722 h 1803"/>
                <a:gd name="T50" fmla="*/ 1453 w 3546"/>
                <a:gd name="T51" fmla="*/ 1751 h 1803"/>
                <a:gd name="T52" fmla="*/ 1506 w 3546"/>
                <a:gd name="T53" fmla="*/ 1717 h 1803"/>
                <a:gd name="T54" fmla="*/ 1563 w 3546"/>
                <a:gd name="T55" fmla="*/ 1679 h 1803"/>
                <a:gd name="T56" fmla="*/ 1619 w 3546"/>
                <a:gd name="T57" fmla="*/ 1760 h 1803"/>
                <a:gd name="T58" fmla="*/ 1676 w 3546"/>
                <a:gd name="T59" fmla="*/ 1746 h 1803"/>
                <a:gd name="T60" fmla="*/ 1729 w 3546"/>
                <a:gd name="T61" fmla="*/ 1755 h 1803"/>
                <a:gd name="T62" fmla="*/ 1786 w 3546"/>
                <a:gd name="T63" fmla="*/ 1774 h 1803"/>
                <a:gd name="T64" fmla="*/ 1842 w 3546"/>
                <a:gd name="T65" fmla="*/ 1779 h 1803"/>
                <a:gd name="T66" fmla="*/ 1899 w 3546"/>
                <a:gd name="T67" fmla="*/ 1779 h 1803"/>
                <a:gd name="T68" fmla="*/ 1952 w 3546"/>
                <a:gd name="T69" fmla="*/ 1774 h 1803"/>
                <a:gd name="T70" fmla="*/ 2009 w 3546"/>
                <a:gd name="T71" fmla="*/ 1789 h 1803"/>
                <a:gd name="T72" fmla="*/ 2066 w 3546"/>
                <a:gd name="T73" fmla="*/ 1784 h 1803"/>
                <a:gd name="T74" fmla="*/ 2122 w 3546"/>
                <a:gd name="T75" fmla="*/ 1789 h 1803"/>
                <a:gd name="T76" fmla="*/ 2176 w 3546"/>
                <a:gd name="T77" fmla="*/ 1789 h 1803"/>
                <a:gd name="T78" fmla="*/ 2232 w 3546"/>
                <a:gd name="T79" fmla="*/ 1789 h 1803"/>
                <a:gd name="T80" fmla="*/ 2289 w 3546"/>
                <a:gd name="T81" fmla="*/ 1789 h 1803"/>
                <a:gd name="T82" fmla="*/ 2345 w 3546"/>
                <a:gd name="T83" fmla="*/ 1789 h 1803"/>
                <a:gd name="T84" fmla="*/ 2399 w 3546"/>
                <a:gd name="T85" fmla="*/ 1789 h 1803"/>
                <a:gd name="T86" fmla="*/ 2455 w 3546"/>
                <a:gd name="T87" fmla="*/ 1789 h 1803"/>
                <a:gd name="T88" fmla="*/ 2512 w 3546"/>
                <a:gd name="T89" fmla="*/ 1789 h 1803"/>
                <a:gd name="T90" fmla="*/ 2569 w 3546"/>
                <a:gd name="T91" fmla="*/ 1784 h 1803"/>
                <a:gd name="T92" fmla="*/ 2625 w 3546"/>
                <a:gd name="T93" fmla="*/ 1784 h 1803"/>
                <a:gd name="T94" fmla="*/ 2679 w 3546"/>
                <a:gd name="T95" fmla="*/ 1784 h 1803"/>
                <a:gd name="T96" fmla="*/ 2735 w 3546"/>
                <a:gd name="T97" fmla="*/ 1784 h 1803"/>
                <a:gd name="T98" fmla="*/ 2792 w 3546"/>
                <a:gd name="T99" fmla="*/ 1784 h 1803"/>
                <a:gd name="T100" fmla="*/ 2848 w 3546"/>
                <a:gd name="T101" fmla="*/ 1779 h 1803"/>
                <a:gd name="T102" fmla="*/ 2905 w 3546"/>
                <a:gd name="T103" fmla="*/ 1751 h 1803"/>
                <a:gd name="T104" fmla="*/ 2958 w 3546"/>
                <a:gd name="T105" fmla="*/ 1741 h 1803"/>
                <a:gd name="T106" fmla="*/ 3015 w 3546"/>
                <a:gd name="T107" fmla="*/ 1741 h 1803"/>
                <a:gd name="T108" fmla="*/ 3072 w 3546"/>
                <a:gd name="T109" fmla="*/ 1741 h 1803"/>
                <a:gd name="T110" fmla="*/ 3128 w 3546"/>
                <a:gd name="T111" fmla="*/ 1746 h 1803"/>
                <a:gd name="T112" fmla="*/ 3182 w 3546"/>
                <a:gd name="T113" fmla="*/ 1746 h 1803"/>
                <a:gd name="T114" fmla="*/ 3238 w 3546"/>
                <a:gd name="T115" fmla="*/ 1746 h 1803"/>
                <a:gd name="T116" fmla="*/ 3295 w 3546"/>
                <a:gd name="T117" fmla="*/ 1746 h 1803"/>
                <a:gd name="T118" fmla="*/ 3351 w 3546"/>
                <a:gd name="T119" fmla="*/ 1779 h 1803"/>
                <a:gd name="T120" fmla="*/ 3405 w 3546"/>
                <a:gd name="T121" fmla="*/ 1789 h 1803"/>
                <a:gd name="T122" fmla="*/ 3461 w 3546"/>
                <a:gd name="T123" fmla="*/ 1794 h 1803"/>
                <a:gd name="T124" fmla="*/ 3518 w 3546"/>
                <a:gd name="T125" fmla="*/ 1798 h 18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3546" h="1803">
                  <a:moveTo>
                    <a:pt x="0" y="1803"/>
                  </a:moveTo>
                  <a:lnTo>
                    <a:pt x="3" y="1803"/>
                  </a:lnTo>
                  <a:lnTo>
                    <a:pt x="3" y="1803"/>
                  </a:lnTo>
                  <a:lnTo>
                    <a:pt x="3" y="1803"/>
                  </a:lnTo>
                  <a:lnTo>
                    <a:pt x="3" y="1803"/>
                  </a:lnTo>
                  <a:lnTo>
                    <a:pt x="7" y="1803"/>
                  </a:lnTo>
                  <a:lnTo>
                    <a:pt x="7" y="1803"/>
                  </a:lnTo>
                  <a:lnTo>
                    <a:pt x="7" y="1803"/>
                  </a:lnTo>
                  <a:lnTo>
                    <a:pt x="7" y="1803"/>
                  </a:lnTo>
                  <a:lnTo>
                    <a:pt x="10" y="1803"/>
                  </a:lnTo>
                  <a:lnTo>
                    <a:pt x="10" y="1803"/>
                  </a:lnTo>
                  <a:lnTo>
                    <a:pt x="10" y="1803"/>
                  </a:lnTo>
                  <a:lnTo>
                    <a:pt x="10" y="1803"/>
                  </a:lnTo>
                  <a:lnTo>
                    <a:pt x="13" y="1803"/>
                  </a:lnTo>
                  <a:lnTo>
                    <a:pt x="13" y="1803"/>
                  </a:lnTo>
                  <a:lnTo>
                    <a:pt x="16" y="1803"/>
                  </a:lnTo>
                  <a:lnTo>
                    <a:pt x="16" y="1803"/>
                  </a:lnTo>
                  <a:lnTo>
                    <a:pt x="16" y="1803"/>
                  </a:lnTo>
                  <a:lnTo>
                    <a:pt x="16" y="1803"/>
                  </a:lnTo>
                  <a:lnTo>
                    <a:pt x="19" y="1803"/>
                  </a:lnTo>
                  <a:lnTo>
                    <a:pt x="19" y="1803"/>
                  </a:lnTo>
                  <a:lnTo>
                    <a:pt x="19" y="1803"/>
                  </a:lnTo>
                  <a:lnTo>
                    <a:pt x="19" y="1803"/>
                  </a:lnTo>
                  <a:lnTo>
                    <a:pt x="22" y="1803"/>
                  </a:lnTo>
                  <a:lnTo>
                    <a:pt x="22" y="1803"/>
                  </a:lnTo>
                  <a:lnTo>
                    <a:pt x="22" y="1803"/>
                  </a:lnTo>
                  <a:lnTo>
                    <a:pt x="22" y="1803"/>
                  </a:lnTo>
                  <a:lnTo>
                    <a:pt x="25" y="1803"/>
                  </a:lnTo>
                  <a:lnTo>
                    <a:pt x="25" y="1803"/>
                  </a:lnTo>
                  <a:lnTo>
                    <a:pt x="25" y="1803"/>
                  </a:lnTo>
                  <a:lnTo>
                    <a:pt x="25" y="1803"/>
                  </a:lnTo>
                  <a:lnTo>
                    <a:pt x="29" y="1803"/>
                  </a:lnTo>
                  <a:lnTo>
                    <a:pt x="29" y="1803"/>
                  </a:lnTo>
                  <a:lnTo>
                    <a:pt x="29" y="1803"/>
                  </a:lnTo>
                  <a:lnTo>
                    <a:pt x="32" y="1803"/>
                  </a:lnTo>
                  <a:lnTo>
                    <a:pt x="32" y="1803"/>
                  </a:lnTo>
                  <a:lnTo>
                    <a:pt x="32" y="1803"/>
                  </a:lnTo>
                  <a:lnTo>
                    <a:pt x="35" y="1803"/>
                  </a:lnTo>
                  <a:lnTo>
                    <a:pt x="35" y="1803"/>
                  </a:lnTo>
                  <a:lnTo>
                    <a:pt x="35" y="1803"/>
                  </a:lnTo>
                  <a:lnTo>
                    <a:pt x="35" y="1803"/>
                  </a:lnTo>
                  <a:lnTo>
                    <a:pt x="38" y="1803"/>
                  </a:lnTo>
                  <a:lnTo>
                    <a:pt x="38" y="1803"/>
                  </a:lnTo>
                  <a:lnTo>
                    <a:pt x="38" y="1803"/>
                  </a:lnTo>
                  <a:lnTo>
                    <a:pt x="38" y="1803"/>
                  </a:lnTo>
                  <a:lnTo>
                    <a:pt x="41" y="1803"/>
                  </a:lnTo>
                  <a:lnTo>
                    <a:pt x="41" y="1803"/>
                  </a:lnTo>
                  <a:lnTo>
                    <a:pt x="44" y="1803"/>
                  </a:lnTo>
                  <a:lnTo>
                    <a:pt x="44" y="1803"/>
                  </a:lnTo>
                  <a:lnTo>
                    <a:pt x="44" y="1803"/>
                  </a:lnTo>
                  <a:lnTo>
                    <a:pt x="44" y="1803"/>
                  </a:lnTo>
                  <a:lnTo>
                    <a:pt x="47" y="1803"/>
                  </a:lnTo>
                  <a:lnTo>
                    <a:pt x="47" y="1803"/>
                  </a:lnTo>
                  <a:lnTo>
                    <a:pt x="47" y="1803"/>
                  </a:lnTo>
                  <a:lnTo>
                    <a:pt x="47" y="1803"/>
                  </a:lnTo>
                  <a:lnTo>
                    <a:pt x="47" y="1803"/>
                  </a:lnTo>
                  <a:lnTo>
                    <a:pt x="51" y="1803"/>
                  </a:lnTo>
                  <a:lnTo>
                    <a:pt x="51" y="1803"/>
                  </a:lnTo>
                  <a:lnTo>
                    <a:pt x="51" y="1803"/>
                  </a:lnTo>
                  <a:lnTo>
                    <a:pt x="54" y="1803"/>
                  </a:lnTo>
                  <a:lnTo>
                    <a:pt x="54" y="1803"/>
                  </a:lnTo>
                  <a:lnTo>
                    <a:pt x="54" y="1803"/>
                  </a:lnTo>
                  <a:lnTo>
                    <a:pt x="57" y="1803"/>
                  </a:lnTo>
                  <a:lnTo>
                    <a:pt x="57" y="1803"/>
                  </a:lnTo>
                  <a:lnTo>
                    <a:pt x="57" y="1803"/>
                  </a:lnTo>
                  <a:lnTo>
                    <a:pt x="57" y="1803"/>
                  </a:lnTo>
                  <a:lnTo>
                    <a:pt x="60" y="1803"/>
                  </a:lnTo>
                  <a:lnTo>
                    <a:pt x="60" y="1803"/>
                  </a:lnTo>
                  <a:lnTo>
                    <a:pt x="60" y="1803"/>
                  </a:lnTo>
                  <a:lnTo>
                    <a:pt x="63" y="1803"/>
                  </a:lnTo>
                  <a:lnTo>
                    <a:pt x="63" y="1803"/>
                  </a:lnTo>
                  <a:lnTo>
                    <a:pt x="63" y="1803"/>
                  </a:lnTo>
                  <a:lnTo>
                    <a:pt x="63" y="1803"/>
                  </a:lnTo>
                  <a:lnTo>
                    <a:pt x="66" y="1803"/>
                  </a:lnTo>
                  <a:lnTo>
                    <a:pt x="66" y="1803"/>
                  </a:lnTo>
                  <a:lnTo>
                    <a:pt x="66" y="1803"/>
                  </a:lnTo>
                  <a:lnTo>
                    <a:pt x="66" y="1803"/>
                  </a:lnTo>
                  <a:lnTo>
                    <a:pt x="69" y="1803"/>
                  </a:lnTo>
                  <a:lnTo>
                    <a:pt x="69" y="1803"/>
                  </a:lnTo>
                  <a:lnTo>
                    <a:pt x="69" y="1803"/>
                  </a:lnTo>
                  <a:lnTo>
                    <a:pt x="73" y="1803"/>
                  </a:lnTo>
                  <a:lnTo>
                    <a:pt x="73" y="1803"/>
                  </a:lnTo>
                  <a:lnTo>
                    <a:pt x="73" y="1803"/>
                  </a:lnTo>
                  <a:lnTo>
                    <a:pt x="76" y="1803"/>
                  </a:lnTo>
                  <a:lnTo>
                    <a:pt x="76" y="1803"/>
                  </a:lnTo>
                  <a:lnTo>
                    <a:pt x="76" y="1803"/>
                  </a:lnTo>
                  <a:lnTo>
                    <a:pt x="76" y="1803"/>
                  </a:lnTo>
                  <a:lnTo>
                    <a:pt x="79" y="1803"/>
                  </a:lnTo>
                  <a:lnTo>
                    <a:pt x="79" y="1803"/>
                  </a:lnTo>
                  <a:lnTo>
                    <a:pt x="79" y="1803"/>
                  </a:lnTo>
                  <a:lnTo>
                    <a:pt x="79" y="1803"/>
                  </a:lnTo>
                  <a:lnTo>
                    <a:pt x="82" y="1803"/>
                  </a:lnTo>
                  <a:lnTo>
                    <a:pt x="82" y="1803"/>
                  </a:lnTo>
                  <a:lnTo>
                    <a:pt x="85" y="1803"/>
                  </a:lnTo>
                  <a:lnTo>
                    <a:pt x="85" y="1803"/>
                  </a:lnTo>
                  <a:lnTo>
                    <a:pt x="85" y="1803"/>
                  </a:lnTo>
                  <a:lnTo>
                    <a:pt x="85" y="1803"/>
                  </a:lnTo>
                  <a:lnTo>
                    <a:pt x="88" y="1803"/>
                  </a:lnTo>
                  <a:lnTo>
                    <a:pt x="88" y="1803"/>
                  </a:lnTo>
                  <a:lnTo>
                    <a:pt x="88" y="1803"/>
                  </a:lnTo>
                  <a:lnTo>
                    <a:pt x="88" y="1803"/>
                  </a:lnTo>
                  <a:lnTo>
                    <a:pt x="92" y="1803"/>
                  </a:lnTo>
                  <a:lnTo>
                    <a:pt x="92" y="1803"/>
                  </a:lnTo>
                  <a:lnTo>
                    <a:pt x="92" y="1803"/>
                  </a:lnTo>
                  <a:lnTo>
                    <a:pt x="92" y="1803"/>
                  </a:lnTo>
                  <a:lnTo>
                    <a:pt x="95" y="1803"/>
                  </a:lnTo>
                  <a:lnTo>
                    <a:pt x="95" y="1803"/>
                  </a:lnTo>
                  <a:lnTo>
                    <a:pt x="95" y="1803"/>
                  </a:lnTo>
                  <a:lnTo>
                    <a:pt x="98" y="1803"/>
                  </a:lnTo>
                  <a:lnTo>
                    <a:pt x="98" y="1803"/>
                  </a:lnTo>
                  <a:lnTo>
                    <a:pt x="98" y="1803"/>
                  </a:lnTo>
                  <a:lnTo>
                    <a:pt x="101" y="1803"/>
                  </a:lnTo>
                  <a:lnTo>
                    <a:pt x="101" y="1803"/>
                  </a:lnTo>
                  <a:lnTo>
                    <a:pt x="101" y="1803"/>
                  </a:lnTo>
                  <a:lnTo>
                    <a:pt x="101" y="1803"/>
                  </a:lnTo>
                  <a:lnTo>
                    <a:pt x="104" y="1803"/>
                  </a:lnTo>
                  <a:lnTo>
                    <a:pt x="104" y="1803"/>
                  </a:lnTo>
                  <a:lnTo>
                    <a:pt x="104" y="1803"/>
                  </a:lnTo>
                  <a:lnTo>
                    <a:pt x="104" y="1803"/>
                  </a:lnTo>
                  <a:lnTo>
                    <a:pt x="107" y="1803"/>
                  </a:lnTo>
                  <a:lnTo>
                    <a:pt x="107" y="1803"/>
                  </a:lnTo>
                  <a:lnTo>
                    <a:pt x="107" y="1803"/>
                  </a:lnTo>
                  <a:lnTo>
                    <a:pt x="107" y="1803"/>
                  </a:lnTo>
                  <a:lnTo>
                    <a:pt x="110" y="1803"/>
                  </a:lnTo>
                  <a:lnTo>
                    <a:pt x="110" y="1803"/>
                  </a:lnTo>
                  <a:lnTo>
                    <a:pt x="110" y="1803"/>
                  </a:lnTo>
                  <a:lnTo>
                    <a:pt x="114" y="1803"/>
                  </a:lnTo>
                  <a:lnTo>
                    <a:pt x="114" y="1803"/>
                  </a:lnTo>
                  <a:lnTo>
                    <a:pt x="114" y="1803"/>
                  </a:lnTo>
                  <a:lnTo>
                    <a:pt x="117" y="1803"/>
                  </a:lnTo>
                  <a:lnTo>
                    <a:pt x="117" y="1803"/>
                  </a:lnTo>
                  <a:lnTo>
                    <a:pt x="117" y="1803"/>
                  </a:lnTo>
                  <a:lnTo>
                    <a:pt x="117" y="1803"/>
                  </a:lnTo>
                  <a:lnTo>
                    <a:pt x="120" y="1803"/>
                  </a:lnTo>
                  <a:lnTo>
                    <a:pt x="120" y="1803"/>
                  </a:lnTo>
                  <a:lnTo>
                    <a:pt x="120" y="1803"/>
                  </a:lnTo>
                  <a:lnTo>
                    <a:pt x="120" y="1803"/>
                  </a:lnTo>
                  <a:lnTo>
                    <a:pt x="123" y="1803"/>
                  </a:lnTo>
                  <a:lnTo>
                    <a:pt x="123" y="1803"/>
                  </a:lnTo>
                  <a:lnTo>
                    <a:pt x="123" y="1803"/>
                  </a:lnTo>
                  <a:lnTo>
                    <a:pt x="123" y="1803"/>
                  </a:lnTo>
                  <a:lnTo>
                    <a:pt x="126" y="1803"/>
                  </a:lnTo>
                  <a:lnTo>
                    <a:pt x="126" y="1803"/>
                  </a:lnTo>
                  <a:lnTo>
                    <a:pt x="126" y="1803"/>
                  </a:lnTo>
                  <a:lnTo>
                    <a:pt x="129" y="1803"/>
                  </a:lnTo>
                  <a:lnTo>
                    <a:pt x="129" y="1803"/>
                  </a:lnTo>
                  <a:lnTo>
                    <a:pt x="129" y="1803"/>
                  </a:lnTo>
                  <a:lnTo>
                    <a:pt x="129" y="1803"/>
                  </a:lnTo>
                  <a:lnTo>
                    <a:pt x="132" y="1803"/>
                  </a:lnTo>
                  <a:lnTo>
                    <a:pt x="132" y="1803"/>
                  </a:lnTo>
                  <a:lnTo>
                    <a:pt x="132" y="1803"/>
                  </a:lnTo>
                  <a:lnTo>
                    <a:pt x="136" y="1803"/>
                  </a:lnTo>
                  <a:lnTo>
                    <a:pt x="136" y="1803"/>
                  </a:lnTo>
                  <a:lnTo>
                    <a:pt x="136" y="1803"/>
                  </a:lnTo>
                  <a:lnTo>
                    <a:pt x="139" y="1803"/>
                  </a:lnTo>
                  <a:lnTo>
                    <a:pt x="139" y="1803"/>
                  </a:lnTo>
                  <a:lnTo>
                    <a:pt x="139" y="1803"/>
                  </a:lnTo>
                  <a:lnTo>
                    <a:pt x="142" y="1803"/>
                  </a:lnTo>
                  <a:lnTo>
                    <a:pt x="142" y="1803"/>
                  </a:lnTo>
                  <a:lnTo>
                    <a:pt x="142" y="1803"/>
                  </a:lnTo>
                  <a:lnTo>
                    <a:pt x="142" y="1803"/>
                  </a:lnTo>
                  <a:lnTo>
                    <a:pt x="145" y="1803"/>
                  </a:lnTo>
                  <a:lnTo>
                    <a:pt x="145" y="1803"/>
                  </a:lnTo>
                  <a:lnTo>
                    <a:pt x="145" y="1803"/>
                  </a:lnTo>
                  <a:lnTo>
                    <a:pt x="145" y="1803"/>
                  </a:lnTo>
                  <a:lnTo>
                    <a:pt x="148" y="1803"/>
                  </a:lnTo>
                  <a:lnTo>
                    <a:pt x="148" y="1803"/>
                  </a:lnTo>
                  <a:lnTo>
                    <a:pt x="148" y="1803"/>
                  </a:lnTo>
                  <a:lnTo>
                    <a:pt x="148" y="1803"/>
                  </a:lnTo>
                  <a:lnTo>
                    <a:pt x="151" y="1803"/>
                  </a:lnTo>
                  <a:lnTo>
                    <a:pt x="151" y="1803"/>
                  </a:lnTo>
                  <a:lnTo>
                    <a:pt x="154" y="1803"/>
                  </a:lnTo>
                  <a:lnTo>
                    <a:pt x="154" y="1803"/>
                  </a:lnTo>
                  <a:lnTo>
                    <a:pt x="154" y="1803"/>
                  </a:lnTo>
                  <a:lnTo>
                    <a:pt x="154" y="1803"/>
                  </a:lnTo>
                  <a:lnTo>
                    <a:pt x="158" y="1803"/>
                  </a:lnTo>
                  <a:lnTo>
                    <a:pt x="158" y="1803"/>
                  </a:lnTo>
                  <a:lnTo>
                    <a:pt x="158" y="1803"/>
                  </a:lnTo>
                  <a:lnTo>
                    <a:pt x="158" y="1803"/>
                  </a:lnTo>
                  <a:lnTo>
                    <a:pt x="161" y="1803"/>
                  </a:lnTo>
                  <a:lnTo>
                    <a:pt x="161" y="1803"/>
                  </a:lnTo>
                  <a:lnTo>
                    <a:pt x="161" y="1803"/>
                  </a:lnTo>
                  <a:lnTo>
                    <a:pt x="161" y="1803"/>
                  </a:lnTo>
                  <a:lnTo>
                    <a:pt x="164" y="1803"/>
                  </a:lnTo>
                  <a:lnTo>
                    <a:pt x="164" y="1803"/>
                  </a:lnTo>
                  <a:lnTo>
                    <a:pt x="164" y="1803"/>
                  </a:lnTo>
                  <a:lnTo>
                    <a:pt x="164" y="1803"/>
                  </a:lnTo>
                  <a:lnTo>
                    <a:pt x="167" y="1798"/>
                  </a:lnTo>
                  <a:lnTo>
                    <a:pt x="167" y="1798"/>
                  </a:lnTo>
                  <a:lnTo>
                    <a:pt x="170" y="1798"/>
                  </a:lnTo>
                  <a:lnTo>
                    <a:pt x="170" y="1798"/>
                  </a:lnTo>
                  <a:lnTo>
                    <a:pt x="170" y="1798"/>
                  </a:lnTo>
                  <a:lnTo>
                    <a:pt x="170" y="1798"/>
                  </a:lnTo>
                  <a:lnTo>
                    <a:pt x="173" y="1798"/>
                  </a:lnTo>
                  <a:lnTo>
                    <a:pt x="173" y="1794"/>
                  </a:lnTo>
                  <a:lnTo>
                    <a:pt x="173" y="1794"/>
                  </a:lnTo>
                  <a:lnTo>
                    <a:pt x="173" y="1794"/>
                  </a:lnTo>
                  <a:lnTo>
                    <a:pt x="176" y="1789"/>
                  </a:lnTo>
                  <a:lnTo>
                    <a:pt x="176" y="1784"/>
                  </a:lnTo>
                  <a:lnTo>
                    <a:pt x="176" y="1774"/>
                  </a:lnTo>
                  <a:lnTo>
                    <a:pt x="180" y="1770"/>
                  </a:lnTo>
                  <a:lnTo>
                    <a:pt x="180" y="1751"/>
                  </a:lnTo>
                  <a:lnTo>
                    <a:pt x="180" y="1746"/>
                  </a:lnTo>
                  <a:lnTo>
                    <a:pt x="183" y="1688"/>
                  </a:lnTo>
                  <a:lnTo>
                    <a:pt x="183" y="1674"/>
                  </a:lnTo>
                  <a:lnTo>
                    <a:pt x="183" y="1583"/>
                  </a:lnTo>
                  <a:lnTo>
                    <a:pt x="183" y="1563"/>
                  </a:lnTo>
                  <a:lnTo>
                    <a:pt x="186" y="1396"/>
                  </a:lnTo>
                  <a:lnTo>
                    <a:pt x="186" y="1357"/>
                  </a:lnTo>
                  <a:lnTo>
                    <a:pt x="186" y="1021"/>
                  </a:lnTo>
                  <a:lnTo>
                    <a:pt x="186" y="949"/>
                  </a:lnTo>
                  <a:lnTo>
                    <a:pt x="189" y="575"/>
                  </a:lnTo>
                  <a:lnTo>
                    <a:pt x="189" y="513"/>
                  </a:lnTo>
                  <a:lnTo>
                    <a:pt x="189" y="369"/>
                  </a:lnTo>
                  <a:lnTo>
                    <a:pt x="189" y="393"/>
                  </a:lnTo>
                  <a:lnTo>
                    <a:pt x="192" y="532"/>
                  </a:lnTo>
                  <a:lnTo>
                    <a:pt x="192" y="571"/>
                  </a:lnTo>
                  <a:lnTo>
                    <a:pt x="192" y="508"/>
                  </a:lnTo>
                  <a:lnTo>
                    <a:pt x="195" y="484"/>
                  </a:lnTo>
                  <a:lnTo>
                    <a:pt x="195" y="388"/>
                  </a:lnTo>
                  <a:lnTo>
                    <a:pt x="195" y="403"/>
                  </a:lnTo>
                  <a:lnTo>
                    <a:pt x="198" y="575"/>
                  </a:lnTo>
                  <a:lnTo>
                    <a:pt x="198" y="652"/>
                  </a:lnTo>
                  <a:lnTo>
                    <a:pt x="198" y="532"/>
                  </a:lnTo>
                  <a:lnTo>
                    <a:pt x="198" y="465"/>
                  </a:lnTo>
                  <a:lnTo>
                    <a:pt x="202" y="134"/>
                  </a:lnTo>
                  <a:lnTo>
                    <a:pt x="202" y="120"/>
                  </a:lnTo>
                  <a:lnTo>
                    <a:pt x="202" y="551"/>
                  </a:lnTo>
                  <a:lnTo>
                    <a:pt x="202" y="676"/>
                  </a:lnTo>
                  <a:lnTo>
                    <a:pt x="205" y="1252"/>
                  </a:lnTo>
                  <a:lnTo>
                    <a:pt x="205" y="1309"/>
                  </a:lnTo>
                  <a:lnTo>
                    <a:pt x="205" y="1472"/>
                  </a:lnTo>
                  <a:lnTo>
                    <a:pt x="205" y="1491"/>
                  </a:lnTo>
                  <a:lnTo>
                    <a:pt x="208" y="1568"/>
                  </a:lnTo>
                  <a:lnTo>
                    <a:pt x="208" y="1578"/>
                  </a:lnTo>
                  <a:lnTo>
                    <a:pt x="208" y="1616"/>
                  </a:lnTo>
                  <a:lnTo>
                    <a:pt x="211" y="1621"/>
                  </a:lnTo>
                  <a:lnTo>
                    <a:pt x="211" y="1655"/>
                  </a:lnTo>
                  <a:lnTo>
                    <a:pt x="211" y="1655"/>
                  </a:lnTo>
                  <a:lnTo>
                    <a:pt x="214" y="1679"/>
                  </a:lnTo>
                  <a:lnTo>
                    <a:pt x="214" y="1683"/>
                  </a:lnTo>
                  <a:lnTo>
                    <a:pt x="214" y="1698"/>
                  </a:lnTo>
                  <a:lnTo>
                    <a:pt x="214" y="1703"/>
                  </a:lnTo>
                  <a:lnTo>
                    <a:pt x="217" y="1717"/>
                  </a:lnTo>
                  <a:lnTo>
                    <a:pt x="217" y="1717"/>
                  </a:lnTo>
                  <a:lnTo>
                    <a:pt x="217" y="1727"/>
                  </a:lnTo>
                  <a:lnTo>
                    <a:pt x="217" y="1727"/>
                  </a:lnTo>
                  <a:lnTo>
                    <a:pt x="220" y="1736"/>
                  </a:lnTo>
                  <a:lnTo>
                    <a:pt x="220" y="1741"/>
                  </a:lnTo>
                  <a:lnTo>
                    <a:pt x="220" y="1746"/>
                  </a:lnTo>
                  <a:lnTo>
                    <a:pt x="224" y="1746"/>
                  </a:lnTo>
                  <a:lnTo>
                    <a:pt x="224" y="1751"/>
                  </a:lnTo>
                  <a:lnTo>
                    <a:pt x="224" y="1751"/>
                  </a:lnTo>
                  <a:lnTo>
                    <a:pt x="227" y="1746"/>
                  </a:lnTo>
                  <a:lnTo>
                    <a:pt x="227" y="1746"/>
                  </a:lnTo>
                  <a:lnTo>
                    <a:pt x="227" y="1731"/>
                  </a:lnTo>
                  <a:lnTo>
                    <a:pt x="227" y="1731"/>
                  </a:lnTo>
                  <a:lnTo>
                    <a:pt x="230" y="1693"/>
                  </a:lnTo>
                  <a:lnTo>
                    <a:pt x="230" y="1688"/>
                  </a:lnTo>
                  <a:lnTo>
                    <a:pt x="230" y="1650"/>
                  </a:lnTo>
                  <a:lnTo>
                    <a:pt x="230" y="1640"/>
                  </a:lnTo>
                  <a:lnTo>
                    <a:pt x="233" y="1559"/>
                  </a:lnTo>
                  <a:lnTo>
                    <a:pt x="233" y="1520"/>
                  </a:lnTo>
                  <a:lnTo>
                    <a:pt x="233" y="973"/>
                  </a:lnTo>
                  <a:lnTo>
                    <a:pt x="236" y="839"/>
                  </a:lnTo>
                  <a:lnTo>
                    <a:pt x="236" y="211"/>
                  </a:lnTo>
                  <a:lnTo>
                    <a:pt x="236" y="129"/>
                  </a:lnTo>
                  <a:lnTo>
                    <a:pt x="236" y="0"/>
                  </a:lnTo>
                  <a:lnTo>
                    <a:pt x="239" y="62"/>
                  </a:lnTo>
                  <a:lnTo>
                    <a:pt x="239" y="369"/>
                  </a:lnTo>
                  <a:lnTo>
                    <a:pt x="239" y="436"/>
                  </a:lnTo>
                  <a:lnTo>
                    <a:pt x="242" y="810"/>
                  </a:lnTo>
                  <a:lnTo>
                    <a:pt x="242" y="887"/>
                  </a:lnTo>
                  <a:lnTo>
                    <a:pt x="242" y="1237"/>
                  </a:lnTo>
                  <a:lnTo>
                    <a:pt x="242" y="1276"/>
                  </a:lnTo>
                  <a:lnTo>
                    <a:pt x="246" y="1400"/>
                  </a:lnTo>
                  <a:lnTo>
                    <a:pt x="246" y="1410"/>
                  </a:lnTo>
                  <a:lnTo>
                    <a:pt x="246" y="1453"/>
                  </a:lnTo>
                  <a:lnTo>
                    <a:pt x="246" y="1458"/>
                  </a:lnTo>
                  <a:lnTo>
                    <a:pt x="249" y="1482"/>
                  </a:lnTo>
                  <a:lnTo>
                    <a:pt x="249" y="1487"/>
                  </a:lnTo>
                  <a:lnTo>
                    <a:pt x="249" y="1511"/>
                  </a:lnTo>
                  <a:lnTo>
                    <a:pt x="249" y="1515"/>
                  </a:lnTo>
                  <a:lnTo>
                    <a:pt x="252" y="1535"/>
                  </a:lnTo>
                  <a:lnTo>
                    <a:pt x="252" y="1539"/>
                  </a:lnTo>
                  <a:lnTo>
                    <a:pt x="255" y="1554"/>
                  </a:lnTo>
                  <a:lnTo>
                    <a:pt x="255" y="1554"/>
                  </a:lnTo>
                  <a:lnTo>
                    <a:pt x="255" y="1568"/>
                  </a:lnTo>
                  <a:lnTo>
                    <a:pt x="255" y="1568"/>
                  </a:lnTo>
                  <a:lnTo>
                    <a:pt x="258" y="1573"/>
                  </a:lnTo>
                  <a:lnTo>
                    <a:pt x="258" y="1573"/>
                  </a:lnTo>
                  <a:lnTo>
                    <a:pt x="258" y="1573"/>
                  </a:lnTo>
                  <a:lnTo>
                    <a:pt x="258" y="1578"/>
                  </a:lnTo>
                  <a:lnTo>
                    <a:pt x="261" y="1583"/>
                  </a:lnTo>
                  <a:lnTo>
                    <a:pt x="261" y="1583"/>
                  </a:lnTo>
                  <a:lnTo>
                    <a:pt x="261" y="1578"/>
                  </a:lnTo>
                  <a:lnTo>
                    <a:pt x="261" y="1573"/>
                  </a:lnTo>
                  <a:lnTo>
                    <a:pt x="264" y="1530"/>
                  </a:lnTo>
                  <a:lnTo>
                    <a:pt x="264" y="1520"/>
                  </a:lnTo>
                  <a:lnTo>
                    <a:pt x="268" y="1472"/>
                  </a:lnTo>
                  <a:lnTo>
                    <a:pt x="268" y="1467"/>
                  </a:lnTo>
                  <a:lnTo>
                    <a:pt x="268" y="1453"/>
                  </a:lnTo>
                  <a:lnTo>
                    <a:pt x="268" y="1453"/>
                  </a:lnTo>
                  <a:lnTo>
                    <a:pt x="271" y="1477"/>
                  </a:lnTo>
                  <a:lnTo>
                    <a:pt x="271" y="1487"/>
                  </a:lnTo>
                  <a:lnTo>
                    <a:pt x="271" y="1530"/>
                  </a:lnTo>
                  <a:lnTo>
                    <a:pt x="271" y="1539"/>
                  </a:lnTo>
                  <a:lnTo>
                    <a:pt x="274" y="1573"/>
                  </a:lnTo>
                  <a:lnTo>
                    <a:pt x="274" y="1578"/>
                  </a:lnTo>
                  <a:lnTo>
                    <a:pt x="274" y="1607"/>
                  </a:lnTo>
                  <a:lnTo>
                    <a:pt x="277" y="1611"/>
                  </a:lnTo>
                  <a:lnTo>
                    <a:pt x="277" y="1626"/>
                  </a:lnTo>
                  <a:lnTo>
                    <a:pt x="277" y="1631"/>
                  </a:lnTo>
                  <a:lnTo>
                    <a:pt x="280" y="1645"/>
                  </a:lnTo>
                  <a:lnTo>
                    <a:pt x="280" y="1645"/>
                  </a:lnTo>
                  <a:lnTo>
                    <a:pt x="280" y="1655"/>
                  </a:lnTo>
                  <a:lnTo>
                    <a:pt x="280" y="1655"/>
                  </a:lnTo>
                  <a:lnTo>
                    <a:pt x="283" y="1650"/>
                  </a:lnTo>
                  <a:lnTo>
                    <a:pt x="283" y="1650"/>
                  </a:lnTo>
                  <a:lnTo>
                    <a:pt x="283" y="1640"/>
                  </a:lnTo>
                  <a:lnTo>
                    <a:pt x="283" y="1635"/>
                  </a:lnTo>
                  <a:lnTo>
                    <a:pt x="286" y="1621"/>
                  </a:lnTo>
                  <a:lnTo>
                    <a:pt x="286" y="1621"/>
                  </a:lnTo>
                  <a:lnTo>
                    <a:pt x="286" y="1611"/>
                  </a:lnTo>
                  <a:lnTo>
                    <a:pt x="286" y="1607"/>
                  </a:lnTo>
                  <a:lnTo>
                    <a:pt x="290" y="1607"/>
                  </a:lnTo>
                  <a:lnTo>
                    <a:pt x="290" y="1607"/>
                  </a:lnTo>
                  <a:lnTo>
                    <a:pt x="290" y="1607"/>
                  </a:lnTo>
                  <a:lnTo>
                    <a:pt x="290" y="1611"/>
                  </a:lnTo>
                  <a:lnTo>
                    <a:pt x="293" y="1611"/>
                  </a:lnTo>
                  <a:lnTo>
                    <a:pt x="293" y="1611"/>
                  </a:lnTo>
                  <a:lnTo>
                    <a:pt x="296" y="1616"/>
                  </a:lnTo>
                  <a:lnTo>
                    <a:pt x="296" y="1616"/>
                  </a:lnTo>
                  <a:lnTo>
                    <a:pt x="296" y="1621"/>
                  </a:lnTo>
                  <a:lnTo>
                    <a:pt x="296" y="1621"/>
                  </a:lnTo>
                  <a:lnTo>
                    <a:pt x="299" y="1631"/>
                  </a:lnTo>
                  <a:lnTo>
                    <a:pt x="299" y="1631"/>
                  </a:lnTo>
                  <a:lnTo>
                    <a:pt x="299" y="1640"/>
                  </a:lnTo>
                  <a:lnTo>
                    <a:pt x="299" y="1640"/>
                  </a:lnTo>
                  <a:lnTo>
                    <a:pt x="302" y="1645"/>
                  </a:lnTo>
                  <a:lnTo>
                    <a:pt x="302" y="1650"/>
                  </a:lnTo>
                  <a:lnTo>
                    <a:pt x="302" y="1650"/>
                  </a:lnTo>
                  <a:lnTo>
                    <a:pt x="302" y="1645"/>
                  </a:lnTo>
                  <a:lnTo>
                    <a:pt x="305" y="1635"/>
                  </a:lnTo>
                  <a:lnTo>
                    <a:pt x="305" y="1631"/>
                  </a:lnTo>
                  <a:lnTo>
                    <a:pt x="308" y="1611"/>
                  </a:lnTo>
                  <a:lnTo>
                    <a:pt x="308" y="1611"/>
                  </a:lnTo>
                  <a:lnTo>
                    <a:pt x="308" y="1597"/>
                  </a:lnTo>
                  <a:lnTo>
                    <a:pt x="308" y="1597"/>
                  </a:lnTo>
                  <a:lnTo>
                    <a:pt x="312" y="1578"/>
                  </a:lnTo>
                  <a:lnTo>
                    <a:pt x="312" y="1573"/>
                  </a:lnTo>
                  <a:lnTo>
                    <a:pt x="312" y="1539"/>
                  </a:lnTo>
                  <a:lnTo>
                    <a:pt x="312" y="1530"/>
                  </a:lnTo>
                  <a:lnTo>
                    <a:pt x="315" y="1482"/>
                  </a:lnTo>
                  <a:lnTo>
                    <a:pt x="315" y="1477"/>
                  </a:lnTo>
                  <a:lnTo>
                    <a:pt x="315" y="1472"/>
                  </a:lnTo>
                  <a:lnTo>
                    <a:pt x="315" y="1477"/>
                  </a:lnTo>
                  <a:lnTo>
                    <a:pt x="318" y="1496"/>
                  </a:lnTo>
                  <a:lnTo>
                    <a:pt x="318" y="1501"/>
                  </a:lnTo>
                  <a:lnTo>
                    <a:pt x="318" y="1535"/>
                  </a:lnTo>
                  <a:lnTo>
                    <a:pt x="321" y="1539"/>
                  </a:lnTo>
                  <a:lnTo>
                    <a:pt x="321" y="1563"/>
                  </a:lnTo>
                  <a:lnTo>
                    <a:pt x="321" y="1568"/>
                  </a:lnTo>
                  <a:lnTo>
                    <a:pt x="324" y="1583"/>
                  </a:lnTo>
                  <a:lnTo>
                    <a:pt x="324" y="1587"/>
                  </a:lnTo>
                  <a:lnTo>
                    <a:pt x="324" y="1592"/>
                  </a:lnTo>
                  <a:lnTo>
                    <a:pt x="324" y="1592"/>
                  </a:lnTo>
                  <a:lnTo>
                    <a:pt x="327" y="1583"/>
                  </a:lnTo>
                  <a:lnTo>
                    <a:pt x="327" y="1583"/>
                  </a:lnTo>
                  <a:lnTo>
                    <a:pt x="327" y="1563"/>
                  </a:lnTo>
                  <a:lnTo>
                    <a:pt x="327" y="1563"/>
                  </a:lnTo>
                  <a:lnTo>
                    <a:pt x="330" y="1559"/>
                  </a:lnTo>
                  <a:lnTo>
                    <a:pt x="330" y="1559"/>
                  </a:lnTo>
                  <a:lnTo>
                    <a:pt x="330" y="1578"/>
                  </a:lnTo>
                  <a:lnTo>
                    <a:pt x="334" y="1578"/>
                  </a:lnTo>
                  <a:lnTo>
                    <a:pt x="334" y="1602"/>
                  </a:lnTo>
                  <a:lnTo>
                    <a:pt x="334" y="1607"/>
                  </a:lnTo>
                  <a:lnTo>
                    <a:pt x="337" y="1621"/>
                  </a:lnTo>
                  <a:lnTo>
                    <a:pt x="337" y="1626"/>
                  </a:lnTo>
                  <a:lnTo>
                    <a:pt x="337" y="1635"/>
                  </a:lnTo>
                  <a:lnTo>
                    <a:pt x="337" y="1635"/>
                  </a:lnTo>
                  <a:lnTo>
                    <a:pt x="337" y="1635"/>
                  </a:lnTo>
                  <a:lnTo>
                    <a:pt x="340" y="1635"/>
                  </a:lnTo>
                  <a:lnTo>
                    <a:pt x="340" y="1635"/>
                  </a:lnTo>
                  <a:lnTo>
                    <a:pt x="340" y="1635"/>
                  </a:lnTo>
                  <a:lnTo>
                    <a:pt x="343" y="1640"/>
                  </a:lnTo>
                  <a:lnTo>
                    <a:pt x="343" y="1640"/>
                  </a:lnTo>
                  <a:lnTo>
                    <a:pt x="343" y="1640"/>
                  </a:lnTo>
                  <a:lnTo>
                    <a:pt x="343" y="1645"/>
                  </a:lnTo>
                  <a:lnTo>
                    <a:pt x="346" y="1640"/>
                  </a:lnTo>
                  <a:lnTo>
                    <a:pt x="346" y="1640"/>
                  </a:lnTo>
                  <a:lnTo>
                    <a:pt x="346" y="1631"/>
                  </a:lnTo>
                  <a:lnTo>
                    <a:pt x="349" y="1631"/>
                  </a:lnTo>
                  <a:lnTo>
                    <a:pt x="349" y="1616"/>
                  </a:lnTo>
                  <a:lnTo>
                    <a:pt x="349" y="1616"/>
                  </a:lnTo>
                  <a:lnTo>
                    <a:pt x="352" y="1611"/>
                  </a:lnTo>
                  <a:lnTo>
                    <a:pt x="352" y="1611"/>
                  </a:lnTo>
                  <a:lnTo>
                    <a:pt x="352" y="1611"/>
                  </a:lnTo>
                  <a:lnTo>
                    <a:pt x="352" y="1616"/>
                  </a:lnTo>
                  <a:lnTo>
                    <a:pt x="356" y="1626"/>
                  </a:lnTo>
                  <a:lnTo>
                    <a:pt x="356" y="1626"/>
                  </a:lnTo>
                  <a:lnTo>
                    <a:pt x="356" y="1631"/>
                  </a:lnTo>
                  <a:lnTo>
                    <a:pt x="359" y="1631"/>
                  </a:lnTo>
                  <a:lnTo>
                    <a:pt x="359" y="1631"/>
                  </a:lnTo>
                  <a:lnTo>
                    <a:pt x="359" y="1631"/>
                  </a:lnTo>
                  <a:lnTo>
                    <a:pt x="359" y="1631"/>
                  </a:lnTo>
                  <a:lnTo>
                    <a:pt x="362" y="1631"/>
                  </a:lnTo>
                  <a:lnTo>
                    <a:pt x="362" y="1635"/>
                  </a:lnTo>
                  <a:lnTo>
                    <a:pt x="362" y="1635"/>
                  </a:lnTo>
                  <a:lnTo>
                    <a:pt x="365" y="1650"/>
                  </a:lnTo>
                  <a:lnTo>
                    <a:pt x="365" y="1650"/>
                  </a:lnTo>
                  <a:lnTo>
                    <a:pt x="365" y="1659"/>
                  </a:lnTo>
                  <a:lnTo>
                    <a:pt x="365" y="1664"/>
                  </a:lnTo>
                  <a:lnTo>
                    <a:pt x="368" y="1674"/>
                  </a:lnTo>
                  <a:lnTo>
                    <a:pt x="368" y="1679"/>
                  </a:lnTo>
                  <a:lnTo>
                    <a:pt x="368" y="1683"/>
                  </a:lnTo>
                  <a:lnTo>
                    <a:pt x="368" y="1683"/>
                  </a:lnTo>
                  <a:lnTo>
                    <a:pt x="371" y="1683"/>
                  </a:lnTo>
                  <a:lnTo>
                    <a:pt x="371" y="1679"/>
                  </a:lnTo>
                  <a:lnTo>
                    <a:pt x="371" y="1674"/>
                  </a:lnTo>
                  <a:lnTo>
                    <a:pt x="374" y="1674"/>
                  </a:lnTo>
                  <a:lnTo>
                    <a:pt x="374" y="1669"/>
                  </a:lnTo>
                  <a:lnTo>
                    <a:pt x="374" y="1664"/>
                  </a:lnTo>
                  <a:lnTo>
                    <a:pt x="378" y="1664"/>
                  </a:lnTo>
                  <a:lnTo>
                    <a:pt x="378" y="1669"/>
                  </a:lnTo>
                  <a:lnTo>
                    <a:pt x="378" y="1674"/>
                  </a:lnTo>
                  <a:lnTo>
                    <a:pt x="378" y="1674"/>
                  </a:lnTo>
                  <a:lnTo>
                    <a:pt x="381" y="1683"/>
                  </a:lnTo>
                  <a:lnTo>
                    <a:pt x="381" y="1683"/>
                  </a:lnTo>
                  <a:lnTo>
                    <a:pt x="381" y="1698"/>
                  </a:lnTo>
                  <a:lnTo>
                    <a:pt x="381" y="1698"/>
                  </a:lnTo>
                  <a:lnTo>
                    <a:pt x="384" y="1703"/>
                  </a:lnTo>
                  <a:lnTo>
                    <a:pt x="384" y="1707"/>
                  </a:lnTo>
                  <a:lnTo>
                    <a:pt x="384" y="1712"/>
                  </a:lnTo>
                  <a:lnTo>
                    <a:pt x="384" y="1712"/>
                  </a:lnTo>
                  <a:lnTo>
                    <a:pt x="387" y="1712"/>
                  </a:lnTo>
                  <a:lnTo>
                    <a:pt x="387" y="1712"/>
                  </a:lnTo>
                  <a:lnTo>
                    <a:pt x="387" y="1712"/>
                  </a:lnTo>
                  <a:lnTo>
                    <a:pt x="387" y="1712"/>
                  </a:lnTo>
                  <a:lnTo>
                    <a:pt x="390" y="1707"/>
                  </a:lnTo>
                  <a:lnTo>
                    <a:pt x="390" y="1707"/>
                  </a:lnTo>
                  <a:lnTo>
                    <a:pt x="393" y="1703"/>
                  </a:lnTo>
                  <a:lnTo>
                    <a:pt x="393" y="1703"/>
                  </a:lnTo>
                  <a:lnTo>
                    <a:pt x="393" y="1703"/>
                  </a:lnTo>
                  <a:lnTo>
                    <a:pt x="393" y="1703"/>
                  </a:lnTo>
                  <a:lnTo>
                    <a:pt x="396" y="1707"/>
                  </a:lnTo>
                  <a:lnTo>
                    <a:pt x="396" y="1707"/>
                  </a:lnTo>
                  <a:lnTo>
                    <a:pt x="396" y="1712"/>
                  </a:lnTo>
                  <a:lnTo>
                    <a:pt x="396" y="1712"/>
                  </a:lnTo>
                  <a:lnTo>
                    <a:pt x="400" y="1717"/>
                  </a:lnTo>
                  <a:lnTo>
                    <a:pt x="400" y="1717"/>
                  </a:lnTo>
                  <a:lnTo>
                    <a:pt x="400" y="1722"/>
                  </a:lnTo>
                  <a:lnTo>
                    <a:pt x="403" y="1722"/>
                  </a:lnTo>
                  <a:lnTo>
                    <a:pt x="403" y="1727"/>
                  </a:lnTo>
                  <a:lnTo>
                    <a:pt x="403" y="1727"/>
                  </a:lnTo>
                  <a:lnTo>
                    <a:pt x="406" y="1731"/>
                  </a:lnTo>
                  <a:lnTo>
                    <a:pt x="406" y="1731"/>
                  </a:lnTo>
                  <a:lnTo>
                    <a:pt x="406" y="1731"/>
                  </a:lnTo>
                  <a:lnTo>
                    <a:pt x="406" y="1731"/>
                  </a:lnTo>
                  <a:lnTo>
                    <a:pt x="409" y="1731"/>
                  </a:lnTo>
                  <a:lnTo>
                    <a:pt x="409" y="1731"/>
                  </a:lnTo>
                  <a:lnTo>
                    <a:pt x="409" y="1727"/>
                  </a:lnTo>
                  <a:lnTo>
                    <a:pt x="409" y="1727"/>
                  </a:lnTo>
                  <a:lnTo>
                    <a:pt x="412" y="1722"/>
                  </a:lnTo>
                  <a:lnTo>
                    <a:pt x="412" y="1722"/>
                  </a:lnTo>
                  <a:lnTo>
                    <a:pt x="412" y="1712"/>
                  </a:lnTo>
                  <a:lnTo>
                    <a:pt x="412" y="1712"/>
                  </a:lnTo>
                  <a:lnTo>
                    <a:pt x="415" y="1707"/>
                  </a:lnTo>
                  <a:lnTo>
                    <a:pt x="415" y="1707"/>
                  </a:lnTo>
                  <a:lnTo>
                    <a:pt x="418" y="1698"/>
                  </a:lnTo>
                  <a:lnTo>
                    <a:pt x="418" y="1698"/>
                  </a:lnTo>
                  <a:lnTo>
                    <a:pt x="418" y="1693"/>
                  </a:lnTo>
                  <a:lnTo>
                    <a:pt x="418" y="1688"/>
                  </a:lnTo>
                  <a:lnTo>
                    <a:pt x="422" y="1688"/>
                  </a:lnTo>
                  <a:lnTo>
                    <a:pt x="422" y="1688"/>
                  </a:lnTo>
                  <a:lnTo>
                    <a:pt x="422" y="1683"/>
                  </a:lnTo>
                  <a:lnTo>
                    <a:pt x="422" y="1688"/>
                  </a:lnTo>
                  <a:lnTo>
                    <a:pt x="425" y="1688"/>
                  </a:lnTo>
                  <a:lnTo>
                    <a:pt x="425" y="1688"/>
                  </a:lnTo>
                  <a:lnTo>
                    <a:pt x="425" y="1698"/>
                  </a:lnTo>
                  <a:lnTo>
                    <a:pt x="425" y="1698"/>
                  </a:lnTo>
                  <a:lnTo>
                    <a:pt x="428" y="1707"/>
                  </a:lnTo>
                  <a:lnTo>
                    <a:pt x="428" y="1707"/>
                  </a:lnTo>
                  <a:lnTo>
                    <a:pt x="428" y="1717"/>
                  </a:lnTo>
                  <a:lnTo>
                    <a:pt x="428" y="1717"/>
                  </a:lnTo>
                  <a:lnTo>
                    <a:pt x="431" y="1717"/>
                  </a:lnTo>
                  <a:lnTo>
                    <a:pt x="431" y="1717"/>
                  </a:lnTo>
                  <a:lnTo>
                    <a:pt x="434" y="1712"/>
                  </a:lnTo>
                  <a:lnTo>
                    <a:pt x="434" y="1712"/>
                  </a:lnTo>
                  <a:lnTo>
                    <a:pt x="434" y="1703"/>
                  </a:lnTo>
                  <a:lnTo>
                    <a:pt x="434" y="1698"/>
                  </a:lnTo>
                  <a:lnTo>
                    <a:pt x="437" y="1683"/>
                  </a:lnTo>
                  <a:lnTo>
                    <a:pt x="437" y="1679"/>
                  </a:lnTo>
                  <a:lnTo>
                    <a:pt x="437" y="1669"/>
                  </a:lnTo>
                  <a:lnTo>
                    <a:pt x="437" y="1669"/>
                  </a:lnTo>
                  <a:lnTo>
                    <a:pt x="440" y="1659"/>
                  </a:lnTo>
                  <a:lnTo>
                    <a:pt x="440" y="1659"/>
                  </a:lnTo>
                  <a:lnTo>
                    <a:pt x="440" y="1659"/>
                  </a:lnTo>
                  <a:lnTo>
                    <a:pt x="440" y="1664"/>
                  </a:lnTo>
                  <a:lnTo>
                    <a:pt x="444" y="1674"/>
                  </a:lnTo>
                  <a:lnTo>
                    <a:pt x="444" y="1679"/>
                  </a:lnTo>
                  <a:lnTo>
                    <a:pt x="447" y="1693"/>
                  </a:lnTo>
                  <a:lnTo>
                    <a:pt x="447" y="1698"/>
                  </a:lnTo>
                  <a:lnTo>
                    <a:pt x="447" y="1712"/>
                  </a:lnTo>
                  <a:lnTo>
                    <a:pt x="447" y="1712"/>
                  </a:lnTo>
                  <a:lnTo>
                    <a:pt x="450" y="1727"/>
                  </a:lnTo>
                  <a:lnTo>
                    <a:pt x="450" y="1727"/>
                  </a:lnTo>
                  <a:lnTo>
                    <a:pt x="450" y="1736"/>
                  </a:lnTo>
                  <a:lnTo>
                    <a:pt x="450" y="1736"/>
                  </a:lnTo>
                  <a:lnTo>
                    <a:pt x="453" y="1736"/>
                  </a:lnTo>
                  <a:lnTo>
                    <a:pt x="453" y="1736"/>
                  </a:lnTo>
                  <a:lnTo>
                    <a:pt x="453" y="1736"/>
                  </a:lnTo>
                  <a:lnTo>
                    <a:pt x="453" y="1736"/>
                  </a:lnTo>
                  <a:lnTo>
                    <a:pt x="456" y="1736"/>
                  </a:lnTo>
                  <a:lnTo>
                    <a:pt x="456" y="1731"/>
                  </a:lnTo>
                  <a:lnTo>
                    <a:pt x="456" y="1731"/>
                  </a:lnTo>
                  <a:lnTo>
                    <a:pt x="459" y="1731"/>
                  </a:lnTo>
                  <a:lnTo>
                    <a:pt x="459" y="1731"/>
                  </a:lnTo>
                  <a:lnTo>
                    <a:pt x="459" y="1731"/>
                  </a:lnTo>
                  <a:lnTo>
                    <a:pt x="462" y="1731"/>
                  </a:lnTo>
                  <a:lnTo>
                    <a:pt x="462" y="1731"/>
                  </a:lnTo>
                  <a:lnTo>
                    <a:pt x="462" y="1736"/>
                  </a:lnTo>
                  <a:lnTo>
                    <a:pt x="462" y="1736"/>
                  </a:lnTo>
                  <a:lnTo>
                    <a:pt x="466" y="1741"/>
                  </a:lnTo>
                  <a:lnTo>
                    <a:pt x="466" y="1741"/>
                  </a:lnTo>
                  <a:lnTo>
                    <a:pt x="466" y="1746"/>
                  </a:lnTo>
                  <a:lnTo>
                    <a:pt x="466" y="1746"/>
                  </a:lnTo>
                  <a:lnTo>
                    <a:pt x="469" y="1746"/>
                  </a:lnTo>
                  <a:lnTo>
                    <a:pt x="469" y="1746"/>
                  </a:lnTo>
                  <a:lnTo>
                    <a:pt x="469" y="1746"/>
                  </a:lnTo>
                  <a:lnTo>
                    <a:pt x="469" y="1746"/>
                  </a:lnTo>
                  <a:lnTo>
                    <a:pt x="472" y="1741"/>
                  </a:lnTo>
                  <a:lnTo>
                    <a:pt x="472" y="1741"/>
                  </a:lnTo>
                  <a:lnTo>
                    <a:pt x="475" y="1736"/>
                  </a:lnTo>
                  <a:lnTo>
                    <a:pt x="475" y="1736"/>
                  </a:lnTo>
                  <a:lnTo>
                    <a:pt x="475" y="1736"/>
                  </a:lnTo>
                  <a:lnTo>
                    <a:pt x="475" y="1736"/>
                  </a:lnTo>
                  <a:lnTo>
                    <a:pt x="478" y="1736"/>
                  </a:lnTo>
                  <a:lnTo>
                    <a:pt x="478" y="1736"/>
                  </a:lnTo>
                  <a:lnTo>
                    <a:pt x="478" y="1736"/>
                  </a:lnTo>
                  <a:lnTo>
                    <a:pt x="478" y="1736"/>
                  </a:lnTo>
                  <a:lnTo>
                    <a:pt x="481" y="1741"/>
                  </a:lnTo>
                  <a:lnTo>
                    <a:pt x="481" y="1741"/>
                  </a:lnTo>
                  <a:lnTo>
                    <a:pt x="481" y="1741"/>
                  </a:lnTo>
                  <a:lnTo>
                    <a:pt x="481" y="1741"/>
                  </a:lnTo>
                  <a:lnTo>
                    <a:pt x="484" y="1741"/>
                  </a:lnTo>
                  <a:lnTo>
                    <a:pt x="484" y="1741"/>
                  </a:lnTo>
                  <a:lnTo>
                    <a:pt x="484" y="1741"/>
                  </a:lnTo>
                  <a:lnTo>
                    <a:pt x="488" y="1741"/>
                  </a:lnTo>
                  <a:lnTo>
                    <a:pt x="488" y="1736"/>
                  </a:lnTo>
                  <a:lnTo>
                    <a:pt x="488" y="1736"/>
                  </a:lnTo>
                  <a:lnTo>
                    <a:pt x="491" y="1731"/>
                  </a:lnTo>
                  <a:lnTo>
                    <a:pt x="491" y="1731"/>
                  </a:lnTo>
                  <a:lnTo>
                    <a:pt x="491" y="1731"/>
                  </a:lnTo>
                  <a:lnTo>
                    <a:pt x="491" y="1731"/>
                  </a:lnTo>
                  <a:lnTo>
                    <a:pt x="494" y="1727"/>
                  </a:lnTo>
                  <a:lnTo>
                    <a:pt x="494" y="1727"/>
                  </a:lnTo>
                  <a:lnTo>
                    <a:pt x="494" y="1727"/>
                  </a:lnTo>
                  <a:lnTo>
                    <a:pt x="494" y="1727"/>
                  </a:lnTo>
                  <a:lnTo>
                    <a:pt x="497" y="1727"/>
                  </a:lnTo>
                  <a:lnTo>
                    <a:pt x="497" y="1727"/>
                  </a:lnTo>
                  <a:lnTo>
                    <a:pt x="497" y="1731"/>
                  </a:lnTo>
                  <a:lnTo>
                    <a:pt x="500" y="1731"/>
                  </a:lnTo>
                  <a:lnTo>
                    <a:pt x="500" y="1736"/>
                  </a:lnTo>
                  <a:lnTo>
                    <a:pt x="500" y="1736"/>
                  </a:lnTo>
                  <a:lnTo>
                    <a:pt x="503" y="1741"/>
                  </a:lnTo>
                  <a:lnTo>
                    <a:pt x="503" y="1741"/>
                  </a:lnTo>
                  <a:lnTo>
                    <a:pt x="503" y="1746"/>
                  </a:lnTo>
                  <a:lnTo>
                    <a:pt x="503" y="1746"/>
                  </a:lnTo>
                  <a:lnTo>
                    <a:pt x="506" y="1751"/>
                  </a:lnTo>
                  <a:lnTo>
                    <a:pt x="506" y="1751"/>
                  </a:lnTo>
                  <a:lnTo>
                    <a:pt x="506" y="1751"/>
                  </a:lnTo>
                  <a:lnTo>
                    <a:pt x="506" y="1751"/>
                  </a:lnTo>
                  <a:lnTo>
                    <a:pt x="510" y="1751"/>
                  </a:lnTo>
                  <a:lnTo>
                    <a:pt x="510" y="1755"/>
                  </a:lnTo>
                  <a:lnTo>
                    <a:pt x="510" y="1755"/>
                  </a:lnTo>
                  <a:lnTo>
                    <a:pt x="513" y="1755"/>
                  </a:lnTo>
                  <a:lnTo>
                    <a:pt x="513" y="1755"/>
                  </a:lnTo>
                  <a:lnTo>
                    <a:pt x="513" y="1755"/>
                  </a:lnTo>
                  <a:lnTo>
                    <a:pt x="516" y="1755"/>
                  </a:lnTo>
                  <a:lnTo>
                    <a:pt x="516" y="1755"/>
                  </a:lnTo>
                  <a:lnTo>
                    <a:pt x="516" y="1755"/>
                  </a:lnTo>
                  <a:lnTo>
                    <a:pt x="516" y="1755"/>
                  </a:lnTo>
                  <a:lnTo>
                    <a:pt x="519" y="1755"/>
                  </a:lnTo>
                  <a:lnTo>
                    <a:pt x="519" y="1755"/>
                  </a:lnTo>
                  <a:lnTo>
                    <a:pt x="519" y="1755"/>
                  </a:lnTo>
                  <a:lnTo>
                    <a:pt x="519" y="1755"/>
                  </a:lnTo>
                  <a:lnTo>
                    <a:pt x="522" y="1755"/>
                  </a:lnTo>
                  <a:lnTo>
                    <a:pt x="522" y="1755"/>
                  </a:lnTo>
                  <a:lnTo>
                    <a:pt x="522" y="1755"/>
                  </a:lnTo>
                  <a:lnTo>
                    <a:pt x="522" y="1755"/>
                  </a:lnTo>
                  <a:lnTo>
                    <a:pt x="525" y="1755"/>
                  </a:lnTo>
                  <a:lnTo>
                    <a:pt x="525" y="1755"/>
                  </a:lnTo>
                  <a:lnTo>
                    <a:pt x="525" y="1755"/>
                  </a:lnTo>
                  <a:lnTo>
                    <a:pt x="525" y="1755"/>
                  </a:lnTo>
                  <a:lnTo>
                    <a:pt x="528" y="1760"/>
                  </a:lnTo>
                  <a:lnTo>
                    <a:pt x="528" y="1760"/>
                  </a:lnTo>
                  <a:lnTo>
                    <a:pt x="532" y="1760"/>
                  </a:lnTo>
                  <a:lnTo>
                    <a:pt x="532" y="1760"/>
                  </a:lnTo>
                  <a:lnTo>
                    <a:pt x="532" y="1760"/>
                  </a:lnTo>
                  <a:lnTo>
                    <a:pt x="532" y="1760"/>
                  </a:lnTo>
                  <a:lnTo>
                    <a:pt x="532" y="1760"/>
                  </a:lnTo>
                  <a:lnTo>
                    <a:pt x="535" y="1760"/>
                  </a:lnTo>
                  <a:lnTo>
                    <a:pt x="535" y="1760"/>
                  </a:lnTo>
                  <a:lnTo>
                    <a:pt x="538" y="1760"/>
                  </a:lnTo>
                  <a:lnTo>
                    <a:pt x="538" y="1760"/>
                  </a:lnTo>
                  <a:lnTo>
                    <a:pt x="538" y="1760"/>
                  </a:lnTo>
                  <a:lnTo>
                    <a:pt x="538" y="1760"/>
                  </a:lnTo>
                  <a:lnTo>
                    <a:pt x="541" y="1760"/>
                  </a:lnTo>
                  <a:lnTo>
                    <a:pt x="541" y="1760"/>
                  </a:lnTo>
                  <a:lnTo>
                    <a:pt x="541" y="1760"/>
                  </a:lnTo>
                  <a:lnTo>
                    <a:pt x="544" y="1765"/>
                  </a:lnTo>
                  <a:lnTo>
                    <a:pt x="544" y="1765"/>
                  </a:lnTo>
                  <a:lnTo>
                    <a:pt x="544" y="1765"/>
                  </a:lnTo>
                  <a:lnTo>
                    <a:pt x="544" y="1765"/>
                  </a:lnTo>
                  <a:lnTo>
                    <a:pt x="547" y="1770"/>
                  </a:lnTo>
                  <a:lnTo>
                    <a:pt x="547" y="1770"/>
                  </a:lnTo>
                  <a:lnTo>
                    <a:pt x="547" y="1770"/>
                  </a:lnTo>
                  <a:lnTo>
                    <a:pt x="547" y="1770"/>
                  </a:lnTo>
                  <a:lnTo>
                    <a:pt x="550" y="1770"/>
                  </a:lnTo>
                  <a:lnTo>
                    <a:pt x="550" y="1770"/>
                  </a:lnTo>
                  <a:lnTo>
                    <a:pt x="550" y="1774"/>
                  </a:lnTo>
                  <a:lnTo>
                    <a:pt x="550" y="1774"/>
                  </a:lnTo>
                  <a:lnTo>
                    <a:pt x="554" y="1774"/>
                  </a:lnTo>
                  <a:lnTo>
                    <a:pt x="554" y="1774"/>
                  </a:lnTo>
                  <a:lnTo>
                    <a:pt x="554" y="1770"/>
                  </a:lnTo>
                  <a:lnTo>
                    <a:pt x="557" y="1770"/>
                  </a:lnTo>
                  <a:lnTo>
                    <a:pt x="557" y="1770"/>
                  </a:lnTo>
                  <a:lnTo>
                    <a:pt x="557" y="1770"/>
                  </a:lnTo>
                  <a:lnTo>
                    <a:pt x="560" y="1770"/>
                  </a:lnTo>
                  <a:lnTo>
                    <a:pt x="560" y="1770"/>
                  </a:lnTo>
                  <a:lnTo>
                    <a:pt x="560" y="1770"/>
                  </a:lnTo>
                  <a:lnTo>
                    <a:pt x="560" y="1770"/>
                  </a:lnTo>
                  <a:lnTo>
                    <a:pt x="563" y="1770"/>
                  </a:lnTo>
                  <a:lnTo>
                    <a:pt x="563" y="1770"/>
                  </a:lnTo>
                  <a:lnTo>
                    <a:pt x="563" y="1770"/>
                  </a:lnTo>
                  <a:lnTo>
                    <a:pt x="563" y="1770"/>
                  </a:lnTo>
                  <a:lnTo>
                    <a:pt x="566" y="1770"/>
                  </a:lnTo>
                  <a:lnTo>
                    <a:pt x="566" y="1770"/>
                  </a:lnTo>
                  <a:lnTo>
                    <a:pt x="566" y="1770"/>
                  </a:lnTo>
                  <a:lnTo>
                    <a:pt x="566" y="1770"/>
                  </a:lnTo>
                  <a:lnTo>
                    <a:pt x="569" y="1770"/>
                  </a:lnTo>
                  <a:lnTo>
                    <a:pt x="569" y="1770"/>
                  </a:lnTo>
                  <a:lnTo>
                    <a:pt x="572" y="1770"/>
                  </a:lnTo>
                  <a:lnTo>
                    <a:pt x="572" y="1770"/>
                  </a:lnTo>
                  <a:lnTo>
                    <a:pt x="572" y="1770"/>
                  </a:lnTo>
                  <a:lnTo>
                    <a:pt x="572" y="1770"/>
                  </a:lnTo>
                  <a:lnTo>
                    <a:pt x="576" y="1770"/>
                  </a:lnTo>
                  <a:lnTo>
                    <a:pt x="576" y="1770"/>
                  </a:lnTo>
                  <a:lnTo>
                    <a:pt x="576" y="1774"/>
                  </a:lnTo>
                  <a:lnTo>
                    <a:pt x="576" y="1774"/>
                  </a:lnTo>
                  <a:lnTo>
                    <a:pt x="579" y="1774"/>
                  </a:lnTo>
                  <a:lnTo>
                    <a:pt x="579" y="1774"/>
                  </a:lnTo>
                  <a:lnTo>
                    <a:pt x="579" y="1774"/>
                  </a:lnTo>
                  <a:lnTo>
                    <a:pt x="579" y="1774"/>
                  </a:lnTo>
                  <a:lnTo>
                    <a:pt x="582" y="1774"/>
                  </a:lnTo>
                  <a:lnTo>
                    <a:pt x="582" y="1774"/>
                  </a:lnTo>
                  <a:lnTo>
                    <a:pt x="582" y="1774"/>
                  </a:lnTo>
                  <a:lnTo>
                    <a:pt x="585" y="1774"/>
                  </a:lnTo>
                  <a:lnTo>
                    <a:pt x="585" y="1774"/>
                  </a:lnTo>
                  <a:lnTo>
                    <a:pt x="585" y="1774"/>
                  </a:lnTo>
                  <a:lnTo>
                    <a:pt x="588" y="1774"/>
                  </a:lnTo>
                  <a:lnTo>
                    <a:pt x="588" y="1774"/>
                  </a:lnTo>
                  <a:lnTo>
                    <a:pt x="588" y="1774"/>
                  </a:lnTo>
                  <a:lnTo>
                    <a:pt x="588" y="1774"/>
                  </a:lnTo>
                  <a:lnTo>
                    <a:pt x="591" y="1774"/>
                  </a:lnTo>
                  <a:lnTo>
                    <a:pt x="591" y="1779"/>
                  </a:lnTo>
                  <a:lnTo>
                    <a:pt x="591" y="1779"/>
                  </a:lnTo>
                  <a:lnTo>
                    <a:pt x="591" y="1779"/>
                  </a:lnTo>
                  <a:lnTo>
                    <a:pt x="594" y="1774"/>
                  </a:lnTo>
                  <a:lnTo>
                    <a:pt x="594" y="1774"/>
                  </a:lnTo>
                  <a:lnTo>
                    <a:pt x="594" y="1774"/>
                  </a:lnTo>
                  <a:lnTo>
                    <a:pt x="598" y="1774"/>
                  </a:lnTo>
                  <a:lnTo>
                    <a:pt x="598" y="1774"/>
                  </a:lnTo>
                  <a:lnTo>
                    <a:pt x="598" y="1774"/>
                  </a:lnTo>
                  <a:lnTo>
                    <a:pt x="601" y="1774"/>
                  </a:lnTo>
                  <a:lnTo>
                    <a:pt x="601" y="1774"/>
                  </a:lnTo>
                  <a:lnTo>
                    <a:pt x="601" y="1774"/>
                  </a:lnTo>
                  <a:lnTo>
                    <a:pt x="601" y="1774"/>
                  </a:lnTo>
                  <a:lnTo>
                    <a:pt x="604" y="1770"/>
                  </a:lnTo>
                  <a:lnTo>
                    <a:pt x="604" y="1770"/>
                  </a:lnTo>
                  <a:lnTo>
                    <a:pt x="604" y="1770"/>
                  </a:lnTo>
                  <a:lnTo>
                    <a:pt x="604" y="1770"/>
                  </a:lnTo>
                  <a:lnTo>
                    <a:pt x="607" y="1770"/>
                  </a:lnTo>
                  <a:lnTo>
                    <a:pt x="607" y="1770"/>
                  </a:lnTo>
                  <a:lnTo>
                    <a:pt x="607" y="1770"/>
                  </a:lnTo>
                  <a:lnTo>
                    <a:pt x="607" y="1770"/>
                  </a:lnTo>
                  <a:lnTo>
                    <a:pt x="610" y="1770"/>
                  </a:lnTo>
                  <a:lnTo>
                    <a:pt x="610" y="1765"/>
                  </a:lnTo>
                  <a:lnTo>
                    <a:pt x="613" y="1760"/>
                  </a:lnTo>
                  <a:lnTo>
                    <a:pt x="613" y="1760"/>
                  </a:lnTo>
                  <a:lnTo>
                    <a:pt x="613" y="1751"/>
                  </a:lnTo>
                  <a:lnTo>
                    <a:pt x="613" y="1746"/>
                  </a:lnTo>
                  <a:lnTo>
                    <a:pt x="616" y="1731"/>
                  </a:lnTo>
                  <a:lnTo>
                    <a:pt x="616" y="1727"/>
                  </a:lnTo>
                  <a:lnTo>
                    <a:pt x="616" y="1712"/>
                  </a:lnTo>
                  <a:lnTo>
                    <a:pt x="616" y="1707"/>
                  </a:lnTo>
                  <a:lnTo>
                    <a:pt x="620" y="1688"/>
                  </a:lnTo>
                  <a:lnTo>
                    <a:pt x="620" y="1683"/>
                  </a:lnTo>
                  <a:lnTo>
                    <a:pt x="620" y="1674"/>
                  </a:lnTo>
                  <a:lnTo>
                    <a:pt x="620" y="1674"/>
                  </a:lnTo>
                  <a:lnTo>
                    <a:pt x="623" y="1669"/>
                  </a:lnTo>
                  <a:lnTo>
                    <a:pt x="623" y="1669"/>
                  </a:lnTo>
                  <a:lnTo>
                    <a:pt x="623" y="1679"/>
                  </a:lnTo>
                  <a:lnTo>
                    <a:pt x="626" y="1679"/>
                  </a:lnTo>
                  <a:lnTo>
                    <a:pt x="626" y="1688"/>
                  </a:lnTo>
                  <a:lnTo>
                    <a:pt x="626" y="1693"/>
                  </a:lnTo>
                  <a:lnTo>
                    <a:pt x="629" y="1707"/>
                  </a:lnTo>
                  <a:lnTo>
                    <a:pt x="629" y="1712"/>
                  </a:lnTo>
                  <a:lnTo>
                    <a:pt x="629" y="1722"/>
                  </a:lnTo>
                  <a:lnTo>
                    <a:pt x="629" y="1727"/>
                  </a:lnTo>
                  <a:lnTo>
                    <a:pt x="632" y="1741"/>
                  </a:lnTo>
                  <a:lnTo>
                    <a:pt x="632" y="1741"/>
                  </a:lnTo>
                  <a:lnTo>
                    <a:pt x="632" y="1751"/>
                  </a:lnTo>
                  <a:lnTo>
                    <a:pt x="632" y="1755"/>
                  </a:lnTo>
                  <a:lnTo>
                    <a:pt x="635" y="1760"/>
                  </a:lnTo>
                  <a:lnTo>
                    <a:pt x="635" y="1760"/>
                  </a:lnTo>
                  <a:lnTo>
                    <a:pt x="635" y="1765"/>
                  </a:lnTo>
                  <a:lnTo>
                    <a:pt x="638" y="1765"/>
                  </a:lnTo>
                  <a:lnTo>
                    <a:pt x="638" y="1770"/>
                  </a:lnTo>
                  <a:lnTo>
                    <a:pt x="638" y="1770"/>
                  </a:lnTo>
                  <a:lnTo>
                    <a:pt x="642" y="1770"/>
                  </a:lnTo>
                  <a:lnTo>
                    <a:pt x="642" y="1770"/>
                  </a:lnTo>
                  <a:lnTo>
                    <a:pt x="642" y="1770"/>
                  </a:lnTo>
                  <a:lnTo>
                    <a:pt x="642" y="1770"/>
                  </a:lnTo>
                  <a:lnTo>
                    <a:pt x="645" y="1770"/>
                  </a:lnTo>
                  <a:lnTo>
                    <a:pt x="645" y="1770"/>
                  </a:lnTo>
                  <a:lnTo>
                    <a:pt x="645" y="1770"/>
                  </a:lnTo>
                  <a:lnTo>
                    <a:pt x="645" y="1770"/>
                  </a:lnTo>
                  <a:lnTo>
                    <a:pt x="648" y="1770"/>
                  </a:lnTo>
                  <a:lnTo>
                    <a:pt x="648" y="1770"/>
                  </a:lnTo>
                  <a:lnTo>
                    <a:pt x="648" y="1770"/>
                  </a:lnTo>
                  <a:lnTo>
                    <a:pt x="648" y="1770"/>
                  </a:lnTo>
                  <a:lnTo>
                    <a:pt x="651" y="1770"/>
                  </a:lnTo>
                  <a:lnTo>
                    <a:pt x="651" y="1770"/>
                  </a:lnTo>
                  <a:lnTo>
                    <a:pt x="651" y="1774"/>
                  </a:lnTo>
                  <a:lnTo>
                    <a:pt x="654" y="1774"/>
                  </a:lnTo>
                  <a:lnTo>
                    <a:pt x="654" y="1774"/>
                  </a:lnTo>
                  <a:lnTo>
                    <a:pt x="654" y="1770"/>
                  </a:lnTo>
                  <a:lnTo>
                    <a:pt x="657" y="1770"/>
                  </a:lnTo>
                  <a:lnTo>
                    <a:pt x="657" y="1770"/>
                  </a:lnTo>
                  <a:lnTo>
                    <a:pt x="657" y="1770"/>
                  </a:lnTo>
                  <a:lnTo>
                    <a:pt x="657" y="1770"/>
                  </a:lnTo>
                  <a:lnTo>
                    <a:pt x="660" y="1770"/>
                  </a:lnTo>
                  <a:lnTo>
                    <a:pt x="660" y="1765"/>
                  </a:lnTo>
                  <a:lnTo>
                    <a:pt x="660" y="1765"/>
                  </a:lnTo>
                  <a:lnTo>
                    <a:pt x="660" y="1765"/>
                  </a:lnTo>
                  <a:lnTo>
                    <a:pt x="664" y="1765"/>
                  </a:lnTo>
                  <a:lnTo>
                    <a:pt x="664" y="1760"/>
                  </a:lnTo>
                  <a:lnTo>
                    <a:pt x="664" y="1760"/>
                  </a:lnTo>
                  <a:lnTo>
                    <a:pt x="667" y="1760"/>
                  </a:lnTo>
                  <a:lnTo>
                    <a:pt x="667" y="1760"/>
                  </a:lnTo>
                  <a:lnTo>
                    <a:pt x="667" y="1760"/>
                  </a:lnTo>
                  <a:lnTo>
                    <a:pt x="670" y="1765"/>
                  </a:lnTo>
                  <a:lnTo>
                    <a:pt x="670" y="1765"/>
                  </a:lnTo>
                  <a:lnTo>
                    <a:pt x="670" y="1765"/>
                  </a:lnTo>
                  <a:lnTo>
                    <a:pt x="670" y="1765"/>
                  </a:lnTo>
                  <a:lnTo>
                    <a:pt x="673" y="1765"/>
                  </a:lnTo>
                  <a:lnTo>
                    <a:pt x="673" y="1765"/>
                  </a:lnTo>
                  <a:lnTo>
                    <a:pt x="673" y="1770"/>
                  </a:lnTo>
                  <a:lnTo>
                    <a:pt x="676" y="1770"/>
                  </a:lnTo>
                  <a:lnTo>
                    <a:pt x="676" y="1770"/>
                  </a:lnTo>
                  <a:lnTo>
                    <a:pt x="676" y="1770"/>
                  </a:lnTo>
                  <a:lnTo>
                    <a:pt x="676" y="1765"/>
                  </a:lnTo>
                  <a:lnTo>
                    <a:pt x="676" y="1765"/>
                  </a:lnTo>
                  <a:lnTo>
                    <a:pt x="679" y="1765"/>
                  </a:lnTo>
                  <a:lnTo>
                    <a:pt x="679" y="1760"/>
                  </a:lnTo>
                  <a:lnTo>
                    <a:pt x="682" y="1755"/>
                  </a:lnTo>
                  <a:lnTo>
                    <a:pt x="682" y="1755"/>
                  </a:lnTo>
                  <a:lnTo>
                    <a:pt x="682" y="1755"/>
                  </a:lnTo>
                  <a:lnTo>
                    <a:pt x="682" y="1751"/>
                  </a:lnTo>
                  <a:lnTo>
                    <a:pt x="686" y="1751"/>
                  </a:lnTo>
                  <a:lnTo>
                    <a:pt x="686" y="1751"/>
                  </a:lnTo>
                  <a:lnTo>
                    <a:pt x="686" y="1751"/>
                  </a:lnTo>
                  <a:lnTo>
                    <a:pt x="686" y="1751"/>
                  </a:lnTo>
                  <a:lnTo>
                    <a:pt x="689" y="1755"/>
                  </a:lnTo>
                  <a:lnTo>
                    <a:pt x="689" y="1755"/>
                  </a:lnTo>
                  <a:lnTo>
                    <a:pt x="689" y="1760"/>
                  </a:lnTo>
                  <a:lnTo>
                    <a:pt x="689" y="1760"/>
                  </a:lnTo>
                  <a:lnTo>
                    <a:pt x="692" y="1760"/>
                  </a:lnTo>
                  <a:lnTo>
                    <a:pt x="692" y="1760"/>
                  </a:lnTo>
                  <a:lnTo>
                    <a:pt x="692" y="1765"/>
                  </a:lnTo>
                  <a:lnTo>
                    <a:pt x="695" y="1765"/>
                  </a:lnTo>
                  <a:lnTo>
                    <a:pt x="695" y="1765"/>
                  </a:lnTo>
                  <a:lnTo>
                    <a:pt x="695" y="1765"/>
                  </a:lnTo>
                  <a:lnTo>
                    <a:pt x="698" y="1765"/>
                  </a:lnTo>
                  <a:lnTo>
                    <a:pt x="698" y="1765"/>
                  </a:lnTo>
                  <a:lnTo>
                    <a:pt x="698" y="1765"/>
                  </a:lnTo>
                  <a:lnTo>
                    <a:pt x="698" y="1765"/>
                  </a:lnTo>
                  <a:lnTo>
                    <a:pt x="701" y="1765"/>
                  </a:lnTo>
                  <a:lnTo>
                    <a:pt x="701" y="1765"/>
                  </a:lnTo>
                  <a:lnTo>
                    <a:pt x="701" y="1765"/>
                  </a:lnTo>
                  <a:lnTo>
                    <a:pt x="701" y="1765"/>
                  </a:lnTo>
                  <a:lnTo>
                    <a:pt x="704" y="1765"/>
                  </a:lnTo>
                  <a:lnTo>
                    <a:pt x="704" y="1765"/>
                  </a:lnTo>
                  <a:lnTo>
                    <a:pt x="704" y="1765"/>
                  </a:lnTo>
                  <a:lnTo>
                    <a:pt x="704" y="1765"/>
                  </a:lnTo>
                  <a:lnTo>
                    <a:pt x="708" y="1765"/>
                  </a:lnTo>
                  <a:lnTo>
                    <a:pt x="708" y="1765"/>
                  </a:lnTo>
                  <a:lnTo>
                    <a:pt x="711" y="1765"/>
                  </a:lnTo>
                  <a:lnTo>
                    <a:pt x="711" y="1760"/>
                  </a:lnTo>
                  <a:lnTo>
                    <a:pt x="711" y="1760"/>
                  </a:lnTo>
                  <a:lnTo>
                    <a:pt x="711" y="1760"/>
                  </a:lnTo>
                  <a:lnTo>
                    <a:pt x="714" y="1755"/>
                  </a:lnTo>
                  <a:lnTo>
                    <a:pt x="714" y="1755"/>
                  </a:lnTo>
                  <a:lnTo>
                    <a:pt x="714" y="1755"/>
                  </a:lnTo>
                  <a:lnTo>
                    <a:pt x="714" y="1755"/>
                  </a:lnTo>
                  <a:lnTo>
                    <a:pt x="717" y="1751"/>
                  </a:lnTo>
                  <a:lnTo>
                    <a:pt x="717" y="1755"/>
                  </a:lnTo>
                  <a:lnTo>
                    <a:pt x="717" y="1755"/>
                  </a:lnTo>
                  <a:lnTo>
                    <a:pt x="717" y="1755"/>
                  </a:lnTo>
                  <a:lnTo>
                    <a:pt x="720" y="1755"/>
                  </a:lnTo>
                  <a:lnTo>
                    <a:pt x="720" y="1755"/>
                  </a:lnTo>
                  <a:lnTo>
                    <a:pt x="720" y="1760"/>
                  </a:lnTo>
                  <a:lnTo>
                    <a:pt x="723" y="1760"/>
                  </a:lnTo>
                  <a:lnTo>
                    <a:pt x="723" y="1760"/>
                  </a:lnTo>
                  <a:lnTo>
                    <a:pt x="723" y="1760"/>
                  </a:lnTo>
                  <a:lnTo>
                    <a:pt x="727" y="1760"/>
                  </a:lnTo>
                  <a:lnTo>
                    <a:pt x="727" y="1760"/>
                  </a:lnTo>
                  <a:lnTo>
                    <a:pt x="727" y="1760"/>
                  </a:lnTo>
                  <a:lnTo>
                    <a:pt x="727" y="1760"/>
                  </a:lnTo>
                  <a:lnTo>
                    <a:pt x="730" y="1760"/>
                  </a:lnTo>
                  <a:lnTo>
                    <a:pt x="730" y="1760"/>
                  </a:lnTo>
                  <a:lnTo>
                    <a:pt x="730" y="1755"/>
                  </a:lnTo>
                  <a:lnTo>
                    <a:pt x="730" y="1755"/>
                  </a:lnTo>
                  <a:lnTo>
                    <a:pt x="733" y="1755"/>
                  </a:lnTo>
                  <a:lnTo>
                    <a:pt x="733" y="1755"/>
                  </a:lnTo>
                  <a:lnTo>
                    <a:pt x="733" y="1751"/>
                  </a:lnTo>
                  <a:lnTo>
                    <a:pt x="736" y="1751"/>
                  </a:lnTo>
                  <a:lnTo>
                    <a:pt x="736" y="1751"/>
                  </a:lnTo>
                  <a:lnTo>
                    <a:pt x="736" y="1751"/>
                  </a:lnTo>
                  <a:lnTo>
                    <a:pt x="736" y="1751"/>
                  </a:lnTo>
                  <a:lnTo>
                    <a:pt x="739" y="1751"/>
                  </a:lnTo>
                  <a:lnTo>
                    <a:pt x="739" y="1751"/>
                  </a:lnTo>
                  <a:lnTo>
                    <a:pt x="739" y="1751"/>
                  </a:lnTo>
                  <a:lnTo>
                    <a:pt x="742" y="1755"/>
                  </a:lnTo>
                  <a:lnTo>
                    <a:pt x="742" y="1755"/>
                  </a:lnTo>
                  <a:lnTo>
                    <a:pt x="742" y="1760"/>
                  </a:lnTo>
                  <a:lnTo>
                    <a:pt x="742" y="1760"/>
                  </a:lnTo>
                  <a:lnTo>
                    <a:pt x="745" y="1760"/>
                  </a:lnTo>
                  <a:lnTo>
                    <a:pt x="745" y="1760"/>
                  </a:lnTo>
                  <a:lnTo>
                    <a:pt x="745" y="1765"/>
                  </a:lnTo>
                  <a:lnTo>
                    <a:pt x="745" y="1765"/>
                  </a:lnTo>
                  <a:lnTo>
                    <a:pt x="749" y="1765"/>
                  </a:lnTo>
                  <a:lnTo>
                    <a:pt x="749" y="1765"/>
                  </a:lnTo>
                  <a:lnTo>
                    <a:pt x="752" y="1765"/>
                  </a:lnTo>
                  <a:lnTo>
                    <a:pt x="752" y="1765"/>
                  </a:lnTo>
                  <a:lnTo>
                    <a:pt x="752" y="1765"/>
                  </a:lnTo>
                  <a:lnTo>
                    <a:pt x="752" y="1765"/>
                  </a:lnTo>
                  <a:lnTo>
                    <a:pt x="755" y="1765"/>
                  </a:lnTo>
                  <a:lnTo>
                    <a:pt x="755" y="1760"/>
                  </a:lnTo>
                  <a:lnTo>
                    <a:pt x="755" y="1760"/>
                  </a:lnTo>
                  <a:lnTo>
                    <a:pt x="755" y="1760"/>
                  </a:lnTo>
                  <a:lnTo>
                    <a:pt x="758" y="1760"/>
                  </a:lnTo>
                  <a:lnTo>
                    <a:pt x="758" y="1760"/>
                  </a:lnTo>
                  <a:lnTo>
                    <a:pt x="758" y="1760"/>
                  </a:lnTo>
                  <a:lnTo>
                    <a:pt x="758" y="1760"/>
                  </a:lnTo>
                  <a:lnTo>
                    <a:pt x="761" y="1760"/>
                  </a:lnTo>
                  <a:lnTo>
                    <a:pt x="761" y="1760"/>
                  </a:lnTo>
                  <a:lnTo>
                    <a:pt x="761" y="1760"/>
                  </a:lnTo>
                  <a:lnTo>
                    <a:pt x="764" y="1760"/>
                  </a:lnTo>
                  <a:lnTo>
                    <a:pt x="764" y="1755"/>
                  </a:lnTo>
                  <a:lnTo>
                    <a:pt x="764" y="1755"/>
                  </a:lnTo>
                  <a:lnTo>
                    <a:pt x="767" y="1755"/>
                  </a:lnTo>
                  <a:lnTo>
                    <a:pt x="767" y="1755"/>
                  </a:lnTo>
                  <a:lnTo>
                    <a:pt x="767" y="1755"/>
                  </a:lnTo>
                  <a:lnTo>
                    <a:pt x="767" y="1751"/>
                  </a:lnTo>
                  <a:lnTo>
                    <a:pt x="771" y="1751"/>
                  </a:lnTo>
                  <a:lnTo>
                    <a:pt x="771" y="1751"/>
                  </a:lnTo>
                  <a:lnTo>
                    <a:pt x="771" y="1746"/>
                  </a:lnTo>
                  <a:lnTo>
                    <a:pt x="771" y="1741"/>
                  </a:lnTo>
                  <a:lnTo>
                    <a:pt x="774" y="1736"/>
                  </a:lnTo>
                  <a:lnTo>
                    <a:pt x="774" y="1736"/>
                  </a:lnTo>
                  <a:lnTo>
                    <a:pt x="774" y="1731"/>
                  </a:lnTo>
                  <a:lnTo>
                    <a:pt x="777" y="1731"/>
                  </a:lnTo>
                  <a:lnTo>
                    <a:pt x="777" y="1722"/>
                  </a:lnTo>
                  <a:lnTo>
                    <a:pt x="777" y="1722"/>
                  </a:lnTo>
                  <a:lnTo>
                    <a:pt x="780" y="1717"/>
                  </a:lnTo>
                  <a:lnTo>
                    <a:pt x="780" y="1717"/>
                  </a:lnTo>
                  <a:lnTo>
                    <a:pt x="780" y="1717"/>
                  </a:lnTo>
                  <a:lnTo>
                    <a:pt x="780" y="1717"/>
                  </a:lnTo>
                  <a:lnTo>
                    <a:pt x="783" y="1727"/>
                  </a:lnTo>
                  <a:lnTo>
                    <a:pt x="783" y="1727"/>
                  </a:lnTo>
                  <a:lnTo>
                    <a:pt x="783" y="1736"/>
                  </a:lnTo>
                  <a:lnTo>
                    <a:pt x="783" y="1736"/>
                  </a:lnTo>
                  <a:lnTo>
                    <a:pt x="786" y="1746"/>
                  </a:lnTo>
                  <a:lnTo>
                    <a:pt x="786" y="1746"/>
                  </a:lnTo>
                  <a:lnTo>
                    <a:pt x="786" y="1755"/>
                  </a:lnTo>
                  <a:lnTo>
                    <a:pt x="786" y="1755"/>
                  </a:lnTo>
                  <a:lnTo>
                    <a:pt x="789" y="1760"/>
                  </a:lnTo>
                  <a:lnTo>
                    <a:pt x="789" y="1760"/>
                  </a:lnTo>
                  <a:lnTo>
                    <a:pt x="789" y="1765"/>
                  </a:lnTo>
                  <a:lnTo>
                    <a:pt x="793" y="1765"/>
                  </a:lnTo>
                  <a:lnTo>
                    <a:pt x="793" y="1765"/>
                  </a:lnTo>
                  <a:lnTo>
                    <a:pt x="793" y="1765"/>
                  </a:lnTo>
                  <a:lnTo>
                    <a:pt x="796" y="1765"/>
                  </a:lnTo>
                  <a:lnTo>
                    <a:pt x="796" y="1765"/>
                  </a:lnTo>
                  <a:lnTo>
                    <a:pt x="796" y="1765"/>
                  </a:lnTo>
                  <a:lnTo>
                    <a:pt x="796" y="1765"/>
                  </a:lnTo>
                  <a:lnTo>
                    <a:pt x="799" y="1765"/>
                  </a:lnTo>
                  <a:lnTo>
                    <a:pt x="799" y="1765"/>
                  </a:lnTo>
                  <a:lnTo>
                    <a:pt x="799" y="1765"/>
                  </a:lnTo>
                  <a:lnTo>
                    <a:pt x="802" y="1765"/>
                  </a:lnTo>
                  <a:lnTo>
                    <a:pt x="802" y="1765"/>
                  </a:lnTo>
                  <a:lnTo>
                    <a:pt x="802" y="1765"/>
                  </a:lnTo>
                  <a:lnTo>
                    <a:pt x="802" y="1765"/>
                  </a:lnTo>
                  <a:lnTo>
                    <a:pt x="802" y="1765"/>
                  </a:lnTo>
                  <a:lnTo>
                    <a:pt x="805" y="1765"/>
                  </a:lnTo>
                  <a:lnTo>
                    <a:pt x="805" y="1765"/>
                  </a:lnTo>
                  <a:lnTo>
                    <a:pt x="808" y="1765"/>
                  </a:lnTo>
                  <a:lnTo>
                    <a:pt x="808" y="1765"/>
                  </a:lnTo>
                  <a:lnTo>
                    <a:pt x="808" y="1765"/>
                  </a:lnTo>
                  <a:lnTo>
                    <a:pt x="808" y="1765"/>
                  </a:lnTo>
                  <a:lnTo>
                    <a:pt x="811" y="1765"/>
                  </a:lnTo>
                  <a:lnTo>
                    <a:pt x="811" y="1765"/>
                  </a:lnTo>
                  <a:lnTo>
                    <a:pt x="811" y="1760"/>
                  </a:lnTo>
                  <a:lnTo>
                    <a:pt x="811" y="1760"/>
                  </a:lnTo>
                  <a:lnTo>
                    <a:pt x="815" y="1755"/>
                  </a:lnTo>
                  <a:lnTo>
                    <a:pt x="815" y="1755"/>
                  </a:lnTo>
                  <a:lnTo>
                    <a:pt x="815" y="1751"/>
                  </a:lnTo>
                  <a:lnTo>
                    <a:pt x="815" y="1746"/>
                  </a:lnTo>
                  <a:lnTo>
                    <a:pt x="818" y="1746"/>
                  </a:lnTo>
                  <a:lnTo>
                    <a:pt x="818" y="1746"/>
                  </a:lnTo>
                  <a:lnTo>
                    <a:pt x="818" y="1746"/>
                  </a:lnTo>
                  <a:lnTo>
                    <a:pt x="821" y="1746"/>
                  </a:lnTo>
                  <a:lnTo>
                    <a:pt x="821" y="1746"/>
                  </a:lnTo>
                  <a:lnTo>
                    <a:pt x="821" y="1746"/>
                  </a:lnTo>
                  <a:lnTo>
                    <a:pt x="824" y="1751"/>
                  </a:lnTo>
                  <a:lnTo>
                    <a:pt x="824" y="1751"/>
                  </a:lnTo>
                  <a:lnTo>
                    <a:pt x="824" y="1755"/>
                  </a:lnTo>
                  <a:lnTo>
                    <a:pt x="824" y="1755"/>
                  </a:lnTo>
                  <a:lnTo>
                    <a:pt x="827" y="1755"/>
                  </a:lnTo>
                  <a:lnTo>
                    <a:pt x="827" y="1760"/>
                  </a:lnTo>
                  <a:lnTo>
                    <a:pt x="827" y="1760"/>
                  </a:lnTo>
                  <a:lnTo>
                    <a:pt x="827" y="1765"/>
                  </a:lnTo>
                  <a:lnTo>
                    <a:pt x="830" y="1765"/>
                  </a:lnTo>
                  <a:lnTo>
                    <a:pt x="830" y="1765"/>
                  </a:lnTo>
                  <a:lnTo>
                    <a:pt x="830" y="1770"/>
                  </a:lnTo>
                  <a:lnTo>
                    <a:pt x="833" y="1770"/>
                  </a:lnTo>
                  <a:lnTo>
                    <a:pt x="833" y="1770"/>
                  </a:lnTo>
                  <a:lnTo>
                    <a:pt x="833" y="1770"/>
                  </a:lnTo>
                  <a:lnTo>
                    <a:pt x="837" y="1770"/>
                  </a:lnTo>
                  <a:lnTo>
                    <a:pt x="837" y="1770"/>
                  </a:lnTo>
                  <a:lnTo>
                    <a:pt x="837" y="1770"/>
                  </a:lnTo>
                  <a:lnTo>
                    <a:pt x="837" y="1770"/>
                  </a:lnTo>
                  <a:lnTo>
                    <a:pt x="840" y="1770"/>
                  </a:lnTo>
                  <a:lnTo>
                    <a:pt x="840" y="1770"/>
                  </a:lnTo>
                  <a:lnTo>
                    <a:pt x="840" y="1770"/>
                  </a:lnTo>
                  <a:lnTo>
                    <a:pt x="840" y="1770"/>
                  </a:lnTo>
                  <a:lnTo>
                    <a:pt x="843" y="1770"/>
                  </a:lnTo>
                  <a:lnTo>
                    <a:pt x="843" y="1770"/>
                  </a:lnTo>
                  <a:lnTo>
                    <a:pt x="843" y="1770"/>
                  </a:lnTo>
                  <a:lnTo>
                    <a:pt x="843" y="1765"/>
                  </a:lnTo>
                  <a:lnTo>
                    <a:pt x="846" y="1760"/>
                  </a:lnTo>
                  <a:lnTo>
                    <a:pt x="846" y="1760"/>
                  </a:lnTo>
                  <a:lnTo>
                    <a:pt x="846" y="1746"/>
                  </a:lnTo>
                  <a:lnTo>
                    <a:pt x="849" y="1741"/>
                  </a:lnTo>
                  <a:lnTo>
                    <a:pt x="849" y="1727"/>
                  </a:lnTo>
                  <a:lnTo>
                    <a:pt x="849" y="1722"/>
                  </a:lnTo>
                  <a:lnTo>
                    <a:pt x="852" y="1707"/>
                  </a:lnTo>
                  <a:lnTo>
                    <a:pt x="852" y="1707"/>
                  </a:lnTo>
                  <a:lnTo>
                    <a:pt x="852" y="1703"/>
                  </a:lnTo>
                  <a:lnTo>
                    <a:pt x="852" y="1703"/>
                  </a:lnTo>
                  <a:lnTo>
                    <a:pt x="855" y="1707"/>
                  </a:lnTo>
                  <a:lnTo>
                    <a:pt x="855" y="1712"/>
                  </a:lnTo>
                  <a:lnTo>
                    <a:pt x="855" y="1727"/>
                  </a:lnTo>
                  <a:lnTo>
                    <a:pt x="855" y="1727"/>
                  </a:lnTo>
                  <a:lnTo>
                    <a:pt x="859" y="1741"/>
                  </a:lnTo>
                  <a:lnTo>
                    <a:pt x="859" y="1741"/>
                  </a:lnTo>
                  <a:lnTo>
                    <a:pt x="859" y="1751"/>
                  </a:lnTo>
                  <a:lnTo>
                    <a:pt x="862" y="1751"/>
                  </a:lnTo>
                  <a:lnTo>
                    <a:pt x="862" y="1755"/>
                  </a:lnTo>
                  <a:lnTo>
                    <a:pt x="862" y="1755"/>
                  </a:lnTo>
                  <a:lnTo>
                    <a:pt x="865" y="1755"/>
                  </a:lnTo>
                  <a:lnTo>
                    <a:pt x="865" y="1755"/>
                  </a:lnTo>
                  <a:lnTo>
                    <a:pt x="865" y="1760"/>
                  </a:lnTo>
                  <a:lnTo>
                    <a:pt x="865" y="1760"/>
                  </a:lnTo>
                  <a:lnTo>
                    <a:pt x="868" y="1760"/>
                  </a:lnTo>
                  <a:lnTo>
                    <a:pt x="868" y="1760"/>
                  </a:lnTo>
                  <a:lnTo>
                    <a:pt x="868" y="1765"/>
                  </a:lnTo>
                  <a:lnTo>
                    <a:pt x="868" y="1765"/>
                  </a:lnTo>
                  <a:lnTo>
                    <a:pt x="871" y="1765"/>
                  </a:lnTo>
                  <a:lnTo>
                    <a:pt x="871" y="1765"/>
                  </a:lnTo>
                  <a:lnTo>
                    <a:pt x="871" y="1765"/>
                  </a:lnTo>
                  <a:lnTo>
                    <a:pt x="874" y="1760"/>
                  </a:lnTo>
                  <a:lnTo>
                    <a:pt x="874" y="1760"/>
                  </a:lnTo>
                  <a:lnTo>
                    <a:pt x="874" y="1755"/>
                  </a:lnTo>
                  <a:lnTo>
                    <a:pt x="877" y="1751"/>
                  </a:lnTo>
                  <a:lnTo>
                    <a:pt x="877" y="1751"/>
                  </a:lnTo>
                  <a:lnTo>
                    <a:pt x="877" y="1751"/>
                  </a:lnTo>
                  <a:lnTo>
                    <a:pt x="877" y="1746"/>
                  </a:lnTo>
                  <a:lnTo>
                    <a:pt x="881" y="1751"/>
                  </a:lnTo>
                  <a:lnTo>
                    <a:pt x="881" y="1751"/>
                  </a:lnTo>
                  <a:lnTo>
                    <a:pt x="881" y="1751"/>
                  </a:lnTo>
                  <a:lnTo>
                    <a:pt x="881" y="1755"/>
                  </a:lnTo>
                  <a:lnTo>
                    <a:pt x="884" y="1755"/>
                  </a:lnTo>
                  <a:lnTo>
                    <a:pt x="884" y="1755"/>
                  </a:lnTo>
                  <a:lnTo>
                    <a:pt x="884" y="1760"/>
                  </a:lnTo>
                  <a:lnTo>
                    <a:pt x="884" y="1760"/>
                  </a:lnTo>
                  <a:lnTo>
                    <a:pt x="887" y="1755"/>
                  </a:lnTo>
                  <a:lnTo>
                    <a:pt x="887" y="1755"/>
                  </a:lnTo>
                  <a:lnTo>
                    <a:pt x="887" y="1751"/>
                  </a:lnTo>
                  <a:lnTo>
                    <a:pt x="887" y="1751"/>
                  </a:lnTo>
                  <a:lnTo>
                    <a:pt x="890" y="1751"/>
                  </a:lnTo>
                  <a:lnTo>
                    <a:pt x="890" y="1751"/>
                  </a:lnTo>
                  <a:lnTo>
                    <a:pt x="893" y="1755"/>
                  </a:lnTo>
                  <a:lnTo>
                    <a:pt x="893" y="1755"/>
                  </a:lnTo>
                  <a:lnTo>
                    <a:pt x="893" y="1760"/>
                  </a:lnTo>
                  <a:lnTo>
                    <a:pt x="893" y="1765"/>
                  </a:lnTo>
                  <a:lnTo>
                    <a:pt x="896" y="1770"/>
                  </a:lnTo>
                  <a:lnTo>
                    <a:pt x="896" y="1770"/>
                  </a:lnTo>
                  <a:lnTo>
                    <a:pt x="896" y="1770"/>
                  </a:lnTo>
                  <a:lnTo>
                    <a:pt x="896" y="1770"/>
                  </a:lnTo>
                  <a:lnTo>
                    <a:pt x="899" y="1770"/>
                  </a:lnTo>
                  <a:lnTo>
                    <a:pt x="899" y="1770"/>
                  </a:lnTo>
                  <a:lnTo>
                    <a:pt x="899" y="1770"/>
                  </a:lnTo>
                  <a:lnTo>
                    <a:pt x="903" y="1770"/>
                  </a:lnTo>
                  <a:lnTo>
                    <a:pt x="903" y="1765"/>
                  </a:lnTo>
                  <a:lnTo>
                    <a:pt x="903" y="1765"/>
                  </a:lnTo>
                  <a:lnTo>
                    <a:pt x="906" y="1760"/>
                  </a:lnTo>
                  <a:lnTo>
                    <a:pt x="906" y="1760"/>
                  </a:lnTo>
                  <a:lnTo>
                    <a:pt x="906" y="1760"/>
                  </a:lnTo>
                  <a:lnTo>
                    <a:pt x="906" y="1760"/>
                  </a:lnTo>
                  <a:lnTo>
                    <a:pt x="909" y="1760"/>
                  </a:lnTo>
                  <a:lnTo>
                    <a:pt x="909" y="1760"/>
                  </a:lnTo>
                  <a:lnTo>
                    <a:pt x="909" y="1760"/>
                  </a:lnTo>
                  <a:lnTo>
                    <a:pt x="909" y="1760"/>
                  </a:lnTo>
                  <a:lnTo>
                    <a:pt x="912" y="1760"/>
                  </a:lnTo>
                  <a:lnTo>
                    <a:pt x="912" y="1760"/>
                  </a:lnTo>
                  <a:lnTo>
                    <a:pt x="912" y="1765"/>
                  </a:lnTo>
                  <a:lnTo>
                    <a:pt x="912" y="1760"/>
                  </a:lnTo>
                  <a:lnTo>
                    <a:pt x="915" y="1760"/>
                  </a:lnTo>
                  <a:lnTo>
                    <a:pt x="915" y="1760"/>
                  </a:lnTo>
                  <a:lnTo>
                    <a:pt x="915" y="1760"/>
                  </a:lnTo>
                  <a:lnTo>
                    <a:pt x="918" y="1760"/>
                  </a:lnTo>
                  <a:lnTo>
                    <a:pt x="918" y="1755"/>
                  </a:lnTo>
                  <a:lnTo>
                    <a:pt x="918" y="1751"/>
                  </a:lnTo>
                  <a:lnTo>
                    <a:pt x="921" y="1751"/>
                  </a:lnTo>
                  <a:lnTo>
                    <a:pt x="921" y="1751"/>
                  </a:lnTo>
                  <a:lnTo>
                    <a:pt x="921" y="1746"/>
                  </a:lnTo>
                  <a:lnTo>
                    <a:pt x="921" y="1746"/>
                  </a:lnTo>
                  <a:lnTo>
                    <a:pt x="925" y="1751"/>
                  </a:lnTo>
                  <a:lnTo>
                    <a:pt x="925" y="1751"/>
                  </a:lnTo>
                  <a:lnTo>
                    <a:pt x="925" y="1755"/>
                  </a:lnTo>
                  <a:lnTo>
                    <a:pt x="925" y="1755"/>
                  </a:lnTo>
                  <a:lnTo>
                    <a:pt x="928" y="1760"/>
                  </a:lnTo>
                  <a:lnTo>
                    <a:pt x="928" y="1760"/>
                  </a:lnTo>
                  <a:lnTo>
                    <a:pt x="928" y="1765"/>
                  </a:lnTo>
                  <a:lnTo>
                    <a:pt x="928" y="1765"/>
                  </a:lnTo>
                  <a:lnTo>
                    <a:pt x="931" y="1765"/>
                  </a:lnTo>
                  <a:lnTo>
                    <a:pt x="931" y="1765"/>
                  </a:lnTo>
                  <a:lnTo>
                    <a:pt x="934" y="1765"/>
                  </a:lnTo>
                  <a:lnTo>
                    <a:pt x="934" y="1765"/>
                  </a:lnTo>
                  <a:lnTo>
                    <a:pt x="934" y="1760"/>
                  </a:lnTo>
                  <a:lnTo>
                    <a:pt x="934" y="1760"/>
                  </a:lnTo>
                  <a:lnTo>
                    <a:pt x="937" y="1755"/>
                  </a:lnTo>
                  <a:lnTo>
                    <a:pt x="937" y="1751"/>
                  </a:lnTo>
                  <a:lnTo>
                    <a:pt x="937" y="1746"/>
                  </a:lnTo>
                  <a:lnTo>
                    <a:pt x="937" y="1746"/>
                  </a:lnTo>
                  <a:lnTo>
                    <a:pt x="940" y="1746"/>
                  </a:lnTo>
                  <a:lnTo>
                    <a:pt x="940" y="1746"/>
                  </a:lnTo>
                  <a:lnTo>
                    <a:pt x="940" y="1746"/>
                  </a:lnTo>
                  <a:lnTo>
                    <a:pt x="940" y="1751"/>
                  </a:lnTo>
                  <a:lnTo>
                    <a:pt x="943" y="1751"/>
                  </a:lnTo>
                  <a:lnTo>
                    <a:pt x="943" y="1755"/>
                  </a:lnTo>
                  <a:lnTo>
                    <a:pt x="947" y="1760"/>
                  </a:lnTo>
                  <a:lnTo>
                    <a:pt x="947" y="1760"/>
                  </a:lnTo>
                  <a:lnTo>
                    <a:pt x="947" y="1765"/>
                  </a:lnTo>
                  <a:lnTo>
                    <a:pt x="947" y="1765"/>
                  </a:lnTo>
                  <a:lnTo>
                    <a:pt x="950" y="1765"/>
                  </a:lnTo>
                  <a:lnTo>
                    <a:pt x="950" y="1770"/>
                  </a:lnTo>
                  <a:lnTo>
                    <a:pt x="950" y="1770"/>
                  </a:lnTo>
                  <a:lnTo>
                    <a:pt x="950" y="1770"/>
                  </a:lnTo>
                  <a:lnTo>
                    <a:pt x="953" y="1770"/>
                  </a:lnTo>
                  <a:lnTo>
                    <a:pt x="953" y="1770"/>
                  </a:lnTo>
                  <a:lnTo>
                    <a:pt x="953" y="1774"/>
                  </a:lnTo>
                  <a:lnTo>
                    <a:pt x="953" y="1774"/>
                  </a:lnTo>
                  <a:lnTo>
                    <a:pt x="956" y="1774"/>
                  </a:lnTo>
                  <a:lnTo>
                    <a:pt x="956" y="1774"/>
                  </a:lnTo>
                  <a:lnTo>
                    <a:pt x="956" y="1774"/>
                  </a:lnTo>
                  <a:lnTo>
                    <a:pt x="959" y="1774"/>
                  </a:lnTo>
                  <a:lnTo>
                    <a:pt x="959" y="1774"/>
                  </a:lnTo>
                  <a:lnTo>
                    <a:pt x="959" y="1774"/>
                  </a:lnTo>
                  <a:lnTo>
                    <a:pt x="962" y="1774"/>
                  </a:lnTo>
                  <a:lnTo>
                    <a:pt x="962" y="1774"/>
                  </a:lnTo>
                  <a:lnTo>
                    <a:pt x="962" y="1774"/>
                  </a:lnTo>
                  <a:lnTo>
                    <a:pt x="962" y="1774"/>
                  </a:lnTo>
                  <a:lnTo>
                    <a:pt x="965" y="1774"/>
                  </a:lnTo>
                  <a:lnTo>
                    <a:pt x="965" y="1774"/>
                  </a:lnTo>
                  <a:lnTo>
                    <a:pt x="965" y="1774"/>
                  </a:lnTo>
                  <a:lnTo>
                    <a:pt x="965" y="1774"/>
                  </a:lnTo>
                  <a:lnTo>
                    <a:pt x="969" y="1774"/>
                  </a:lnTo>
                  <a:lnTo>
                    <a:pt x="969" y="1774"/>
                  </a:lnTo>
                  <a:lnTo>
                    <a:pt x="969" y="1774"/>
                  </a:lnTo>
                  <a:lnTo>
                    <a:pt x="972" y="1774"/>
                  </a:lnTo>
                  <a:lnTo>
                    <a:pt x="972" y="1774"/>
                  </a:lnTo>
                  <a:lnTo>
                    <a:pt x="972" y="1774"/>
                  </a:lnTo>
                  <a:lnTo>
                    <a:pt x="975" y="1774"/>
                  </a:lnTo>
                  <a:lnTo>
                    <a:pt x="975" y="1770"/>
                  </a:lnTo>
                  <a:lnTo>
                    <a:pt x="975" y="1770"/>
                  </a:lnTo>
                  <a:lnTo>
                    <a:pt x="975" y="1770"/>
                  </a:lnTo>
                  <a:lnTo>
                    <a:pt x="978" y="1770"/>
                  </a:lnTo>
                  <a:lnTo>
                    <a:pt x="978" y="1770"/>
                  </a:lnTo>
                  <a:lnTo>
                    <a:pt x="978" y="1765"/>
                  </a:lnTo>
                  <a:lnTo>
                    <a:pt x="981" y="1765"/>
                  </a:lnTo>
                  <a:lnTo>
                    <a:pt x="981" y="1765"/>
                  </a:lnTo>
                  <a:lnTo>
                    <a:pt x="981" y="1765"/>
                  </a:lnTo>
                  <a:lnTo>
                    <a:pt x="981" y="1765"/>
                  </a:lnTo>
                  <a:lnTo>
                    <a:pt x="981" y="1765"/>
                  </a:lnTo>
                  <a:lnTo>
                    <a:pt x="984" y="1765"/>
                  </a:lnTo>
                  <a:lnTo>
                    <a:pt x="984" y="1765"/>
                  </a:lnTo>
                  <a:lnTo>
                    <a:pt x="984" y="1765"/>
                  </a:lnTo>
                  <a:lnTo>
                    <a:pt x="987" y="1765"/>
                  </a:lnTo>
                  <a:lnTo>
                    <a:pt x="987" y="1760"/>
                  </a:lnTo>
                  <a:lnTo>
                    <a:pt x="987" y="1760"/>
                  </a:lnTo>
                  <a:lnTo>
                    <a:pt x="991" y="1755"/>
                  </a:lnTo>
                  <a:lnTo>
                    <a:pt x="991" y="1755"/>
                  </a:lnTo>
                  <a:lnTo>
                    <a:pt x="991" y="1755"/>
                  </a:lnTo>
                  <a:lnTo>
                    <a:pt x="991" y="1755"/>
                  </a:lnTo>
                  <a:lnTo>
                    <a:pt x="994" y="1755"/>
                  </a:lnTo>
                  <a:lnTo>
                    <a:pt x="994" y="1755"/>
                  </a:lnTo>
                  <a:lnTo>
                    <a:pt x="994" y="1755"/>
                  </a:lnTo>
                  <a:lnTo>
                    <a:pt x="997" y="1755"/>
                  </a:lnTo>
                  <a:lnTo>
                    <a:pt x="997" y="1755"/>
                  </a:lnTo>
                  <a:lnTo>
                    <a:pt x="997" y="1755"/>
                  </a:lnTo>
                  <a:lnTo>
                    <a:pt x="997" y="1760"/>
                  </a:lnTo>
                  <a:lnTo>
                    <a:pt x="1000" y="1760"/>
                  </a:lnTo>
                  <a:lnTo>
                    <a:pt x="1000" y="1765"/>
                  </a:lnTo>
                  <a:lnTo>
                    <a:pt x="1000" y="1765"/>
                  </a:lnTo>
                  <a:lnTo>
                    <a:pt x="1003" y="1770"/>
                  </a:lnTo>
                  <a:lnTo>
                    <a:pt x="1003" y="1770"/>
                  </a:lnTo>
                  <a:lnTo>
                    <a:pt x="1003" y="1770"/>
                  </a:lnTo>
                  <a:lnTo>
                    <a:pt x="1003" y="1770"/>
                  </a:lnTo>
                  <a:lnTo>
                    <a:pt x="1006" y="1770"/>
                  </a:lnTo>
                  <a:lnTo>
                    <a:pt x="1006" y="1770"/>
                  </a:lnTo>
                  <a:lnTo>
                    <a:pt x="1006" y="1770"/>
                  </a:lnTo>
                  <a:lnTo>
                    <a:pt x="1006" y="1770"/>
                  </a:lnTo>
                  <a:lnTo>
                    <a:pt x="1009" y="1770"/>
                  </a:lnTo>
                  <a:lnTo>
                    <a:pt x="1009" y="1770"/>
                  </a:lnTo>
                  <a:lnTo>
                    <a:pt x="1009" y="1770"/>
                  </a:lnTo>
                  <a:lnTo>
                    <a:pt x="1009" y="1770"/>
                  </a:lnTo>
                  <a:lnTo>
                    <a:pt x="1013" y="1770"/>
                  </a:lnTo>
                  <a:lnTo>
                    <a:pt x="1013" y="1770"/>
                  </a:lnTo>
                  <a:lnTo>
                    <a:pt x="1016" y="1774"/>
                  </a:lnTo>
                  <a:lnTo>
                    <a:pt x="1016" y="1774"/>
                  </a:lnTo>
                  <a:lnTo>
                    <a:pt x="1016" y="1774"/>
                  </a:lnTo>
                  <a:lnTo>
                    <a:pt x="1016" y="1774"/>
                  </a:lnTo>
                  <a:lnTo>
                    <a:pt x="1019" y="1774"/>
                  </a:lnTo>
                  <a:lnTo>
                    <a:pt x="1019" y="1774"/>
                  </a:lnTo>
                  <a:lnTo>
                    <a:pt x="1019" y="1770"/>
                  </a:lnTo>
                  <a:lnTo>
                    <a:pt x="1019" y="1770"/>
                  </a:lnTo>
                  <a:lnTo>
                    <a:pt x="1022" y="1770"/>
                  </a:lnTo>
                  <a:lnTo>
                    <a:pt x="1022" y="1770"/>
                  </a:lnTo>
                  <a:lnTo>
                    <a:pt x="1022" y="1770"/>
                  </a:lnTo>
                  <a:lnTo>
                    <a:pt x="1022" y="1770"/>
                  </a:lnTo>
                  <a:lnTo>
                    <a:pt x="1025" y="1765"/>
                  </a:lnTo>
                  <a:lnTo>
                    <a:pt x="1025" y="1770"/>
                  </a:lnTo>
                  <a:lnTo>
                    <a:pt x="1025" y="1770"/>
                  </a:lnTo>
                  <a:lnTo>
                    <a:pt x="1028" y="1770"/>
                  </a:lnTo>
                  <a:lnTo>
                    <a:pt x="1028" y="1770"/>
                  </a:lnTo>
                  <a:lnTo>
                    <a:pt x="1028" y="1770"/>
                  </a:lnTo>
                  <a:lnTo>
                    <a:pt x="1031" y="1774"/>
                  </a:lnTo>
                  <a:lnTo>
                    <a:pt x="1031" y="1774"/>
                  </a:lnTo>
                  <a:lnTo>
                    <a:pt x="1031" y="1774"/>
                  </a:lnTo>
                  <a:lnTo>
                    <a:pt x="1031" y="1774"/>
                  </a:lnTo>
                  <a:lnTo>
                    <a:pt x="1035" y="1770"/>
                  </a:lnTo>
                  <a:lnTo>
                    <a:pt x="1035" y="1770"/>
                  </a:lnTo>
                  <a:lnTo>
                    <a:pt x="1035" y="1770"/>
                  </a:lnTo>
                  <a:lnTo>
                    <a:pt x="1038" y="1770"/>
                  </a:lnTo>
                  <a:lnTo>
                    <a:pt x="1038" y="1770"/>
                  </a:lnTo>
                  <a:lnTo>
                    <a:pt x="1038" y="1770"/>
                  </a:lnTo>
                  <a:lnTo>
                    <a:pt x="1038" y="1770"/>
                  </a:lnTo>
                  <a:lnTo>
                    <a:pt x="1041" y="1770"/>
                  </a:lnTo>
                  <a:lnTo>
                    <a:pt x="1041" y="1774"/>
                  </a:lnTo>
                  <a:lnTo>
                    <a:pt x="1041" y="1774"/>
                  </a:lnTo>
                  <a:lnTo>
                    <a:pt x="1044" y="1774"/>
                  </a:lnTo>
                  <a:lnTo>
                    <a:pt x="1044" y="1774"/>
                  </a:lnTo>
                  <a:lnTo>
                    <a:pt x="1044" y="1774"/>
                  </a:lnTo>
                  <a:lnTo>
                    <a:pt x="1044" y="1774"/>
                  </a:lnTo>
                  <a:lnTo>
                    <a:pt x="1047" y="1774"/>
                  </a:lnTo>
                  <a:lnTo>
                    <a:pt x="1047" y="1774"/>
                  </a:lnTo>
                  <a:lnTo>
                    <a:pt x="1047" y="1770"/>
                  </a:lnTo>
                  <a:lnTo>
                    <a:pt x="1047" y="1770"/>
                  </a:lnTo>
                  <a:lnTo>
                    <a:pt x="1050" y="1770"/>
                  </a:lnTo>
                  <a:lnTo>
                    <a:pt x="1050" y="1770"/>
                  </a:lnTo>
                  <a:lnTo>
                    <a:pt x="1050" y="1770"/>
                  </a:lnTo>
                  <a:lnTo>
                    <a:pt x="1050" y="1770"/>
                  </a:lnTo>
                  <a:lnTo>
                    <a:pt x="1053" y="1770"/>
                  </a:lnTo>
                  <a:lnTo>
                    <a:pt x="1053" y="1774"/>
                  </a:lnTo>
                  <a:lnTo>
                    <a:pt x="1053" y="1774"/>
                  </a:lnTo>
                  <a:lnTo>
                    <a:pt x="1057" y="1774"/>
                  </a:lnTo>
                  <a:lnTo>
                    <a:pt x="1057" y="1774"/>
                  </a:lnTo>
                  <a:lnTo>
                    <a:pt x="1057" y="1774"/>
                  </a:lnTo>
                  <a:lnTo>
                    <a:pt x="1060" y="1774"/>
                  </a:lnTo>
                  <a:lnTo>
                    <a:pt x="1060" y="1774"/>
                  </a:lnTo>
                  <a:lnTo>
                    <a:pt x="1060" y="1774"/>
                  </a:lnTo>
                  <a:lnTo>
                    <a:pt x="1060" y="1774"/>
                  </a:lnTo>
                  <a:lnTo>
                    <a:pt x="1063" y="1774"/>
                  </a:lnTo>
                  <a:lnTo>
                    <a:pt x="1063" y="1774"/>
                  </a:lnTo>
                  <a:lnTo>
                    <a:pt x="1063" y="1774"/>
                  </a:lnTo>
                  <a:lnTo>
                    <a:pt x="1063" y="1774"/>
                  </a:lnTo>
                  <a:lnTo>
                    <a:pt x="1066" y="1774"/>
                  </a:lnTo>
                  <a:lnTo>
                    <a:pt x="1066" y="1774"/>
                  </a:lnTo>
                  <a:lnTo>
                    <a:pt x="1066" y="1774"/>
                  </a:lnTo>
                  <a:lnTo>
                    <a:pt x="1066" y="1774"/>
                  </a:lnTo>
                  <a:lnTo>
                    <a:pt x="1069" y="1774"/>
                  </a:lnTo>
                  <a:lnTo>
                    <a:pt x="1069" y="1774"/>
                  </a:lnTo>
                  <a:lnTo>
                    <a:pt x="1072" y="1770"/>
                  </a:lnTo>
                  <a:lnTo>
                    <a:pt x="1072" y="1770"/>
                  </a:lnTo>
                  <a:lnTo>
                    <a:pt x="1072" y="1765"/>
                  </a:lnTo>
                  <a:lnTo>
                    <a:pt x="1072" y="1765"/>
                  </a:lnTo>
                  <a:lnTo>
                    <a:pt x="1075" y="1765"/>
                  </a:lnTo>
                  <a:lnTo>
                    <a:pt x="1075" y="1765"/>
                  </a:lnTo>
                  <a:lnTo>
                    <a:pt x="1075" y="1760"/>
                  </a:lnTo>
                  <a:lnTo>
                    <a:pt x="1075" y="1760"/>
                  </a:lnTo>
                  <a:lnTo>
                    <a:pt x="1079" y="1760"/>
                  </a:lnTo>
                  <a:lnTo>
                    <a:pt x="1079" y="1760"/>
                  </a:lnTo>
                  <a:lnTo>
                    <a:pt x="1079" y="1755"/>
                  </a:lnTo>
                  <a:lnTo>
                    <a:pt x="1079" y="1755"/>
                  </a:lnTo>
                  <a:lnTo>
                    <a:pt x="1082" y="1751"/>
                  </a:lnTo>
                  <a:lnTo>
                    <a:pt x="1082" y="1746"/>
                  </a:lnTo>
                  <a:lnTo>
                    <a:pt x="1082" y="1722"/>
                  </a:lnTo>
                  <a:lnTo>
                    <a:pt x="1085" y="1717"/>
                  </a:lnTo>
                  <a:lnTo>
                    <a:pt x="1085" y="1674"/>
                  </a:lnTo>
                  <a:lnTo>
                    <a:pt x="1085" y="1659"/>
                  </a:lnTo>
                  <a:lnTo>
                    <a:pt x="1088" y="1587"/>
                  </a:lnTo>
                  <a:lnTo>
                    <a:pt x="1088" y="1578"/>
                  </a:lnTo>
                  <a:lnTo>
                    <a:pt x="1088" y="1520"/>
                  </a:lnTo>
                  <a:lnTo>
                    <a:pt x="1088" y="1515"/>
                  </a:lnTo>
                  <a:lnTo>
                    <a:pt x="1091" y="1501"/>
                  </a:lnTo>
                  <a:lnTo>
                    <a:pt x="1091" y="1501"/>
                  </a:lnTo>
                  <a:lnTo>
                    <a:pt x="1091" y="1539"/>
                  </a:lnTo>
                  <a:lnTo>
                    <a:pt x="1091" y="1544"/>
                  </a:lnTo>
                  <a:lnTo>
                    <a:pt x="1094" y="1597"/>
                  </a:lnTo>
                  <a:lnTo>
                    <a:pt x="1094" y="1607"/>
                  </a:lnTo>
                  <a:lnTo>
                    <a:pt x="1094" y="1669"/>
                  </a:lnTo>
                  <a:lnTo>
                    <a:pt x="1097" y="1679"/>
                  </a:lnTo>
                  <a:lnTo>
                    <a:pt x="1097" y="1717"/>
                  </a:lnTo>
                  <a:lnTo>
                    <a:pt x="1097" y="1722"/>
                  </a:lnTo>
                  <a:lnTo>
                    <a:pt x="1101" y="1741"/>
                  </a:lnTo>
                  <a:lnTo>
                    <a:pt x="1101" y="1746"/>
                  </a:lnTo>
                  <a:lnTo>
                    <a:pt x="1101" y="1755"/>
                  </a:lnTo>
                  <a:lnTo>
                    <a:pt x="1101" y="1760"/>
                  </a:lnTo>
                  <a:lnTo>
                    <a:pt x="1104" y="1765"/>
                  </a:lnTo>
                  <a:lnTo>
                    <a:pt x="1104" y="1765"/>
                  </a:lnTo>
                  <a:lnTo>
                    <a:pt x="1104" y="1770"/>
                  </a:lnTo>
                  <a:lnTo>
                    <a:pt x="1104" y="1770"/>
                  </a:lnTo>
                  <a:lnTo>
                    <a:pt x="1107" y="1770"/>
                  </a:lnTo>
                  <a:lnTo>
                    <a:pt x="1107" y="1774"/>
                  </a:lnTo>
                  <a:lnTo>
                    <a:pt x="1107" y="1774"/>
                  </a:lnTo>
                  <a:lnTo>
                    <a:pt x="1107" y="1774"/>
                  </a:lnTo>
                  <a:lnTo>
                    <a:pt x="1110" y="1774"/>
                  </a:lnTo>
                  <a:lnTo>
                    <a:pt x="1110" y="1774"/>
                  </a:lnTo>
                  <a:lnTo>
                    <a:pt x="1113" y="1774"/>
                  </a:lnTo>
                  <a:lnTo>
                    <a:pt x="1113" y="1774"/>
                  </a:lnTo>
                  <a:lnTo>
                    <a:pt x="1113" y="1770"/>
                  </a:lnTo>
                  <a:lnTo>
                    <a:pt x="1113" y="1770"/>
                  </a:lnTo>
                  <a:lnTo>
                    <a:pt x="1116" y="1770"/>
                  </a:lnTo>
                  <a:lnTo>
                    <a:pt x="1116" y="1770"/>
                  </a:lnTo>
                  <a:lnTo>
                    <a:pt x="1116" y="1770"/>
                  </a:lnTo>
                  <a:lnTo>
                    <a:pt x="1116" y="1770"/>
                  </a:lnTo>
                  <a:lnTo>
                    <a:pt x="1119" y="1770"/>
                  </a:lnTo>
                  <a:lnTo>
                    <a:pt x="1119" y="1770"/>
                  </a:lnTo>
                  <a:lnTo>
                    <a:pt x="1119" y="1774"/>
                  </a:lnTo>
                  <a:lnTo>
                    <a:pt x="1119" y="1774"/>
                  </a:lnTo>
                  <a:lnTo>
                    <a:pt x="1123" y="1774"/>
                  </a:lnTo>
                  <a:lnTo>
                    <a:pt x="1123" y="1774"/>
                  </a:lnTo>
                  <a:lnTo>
                    <a:pt x="1123" y="1774"/>
                  </a:lnTo>
                  <a:lnTo>
                    <a:pt x="1126" y="1774"/>
                  </a:lnTo>
                  <a:lnTo>
                    <a:pt x="1126" y="1774"/>
                  </a:lnTo>
                  <a:lnTo>
                    <a:pt x="1126" y="1774"/>
                  </a:lnTo>
                  <a:lnTo>
                    <a:pt x="1129" y="1774"/>
                  </a:lnTo>
                  <a:lnTo>
                    <a:pt x="1129" y="1774"/>
                  </a:lnTo>
                  <a:lnTo>
                    <a:pt x="1129" y="1774"/>
                  </a:lnTo>
                  <a:lnTo>
                    <a:pt x="1129" y="1774"/>
                  </a:lnTo>
                  <a:lnTo>
                    <a:pt x="1132" y="1774"/>
                  </a:lnTo>
                  <a:lnTo>
                    <a:pt x="1132" y="1774"/>
                  </a:lnTo>
                  <a:lnTo>
                    <a:pt x="1132" y="1774"/>
                  </a:lnTo>
                  <a:lnTo>
                    <a:pt x="1132" y="1774"/>
                  </a:lnTo>
                  <a:lnTo>
                    <a:pt x="1135" y="1774"/>
                  </a:lnTo>
                  <a:lnTo>
                    <a:pt x="1135" y="1774"/>
                  </a:lnTo>
                  <a:lnTo>
                    <a:pt x="1135" y="1774"/>
                  </a:lnTo>
                  <a:lnTo>
                    <a:pt x="1138" y="1774"/>
                  </a:lnTo>
                  <a:lnTo>
                    <a:pt x="1138" y="1774"/>
                  </a:lnTo>
                  <a:lnTo>
                    <a:pt x="1138" y="1774"/>
                  </a:lnTo>
                  <a:lnTo>
                    <a:pt x="1138" y="1774"/>
                  </a:lnTo>
                  <a:lnTo>
                    <a:pt x="1141" y="1774"/>
                  </a:lnTo>
                  <a:lnTo>
                    <a:pt x="1141" y="1774"/>
                  </a:lnTo>
                  <a:lnTo>
                    <a:pt x="1141" y="1774"/>
                  </a:lnTo>
                  <a:lnTo>
                    <a:pt x="1145" y="1774"/>
                  </a:lnTo>
                  <a:lnTo>
                    <a:pt x="1145" y="1774"/>
                  </a:lnTo>
                  <a:lnTo>
                    <a:pt x="1145" y="1774"/>
                  </a:lnTo>
                  <a:lnTo>
                    <a:pt x="1145" y="1774"/>
                  </a:lnTo>
                  <a:lnTo>
                    <a:pt x="1148" y="1774"/>
                  </a:lnTo>
                  <a:lnTo>
                    <a:pt x="1148" y="1774"/>
                  </a:lnTo>
                  <a:lnTo>
                    <a:pt x="1148" y="1774"/>
                  </a:lnTo>
                  <a:lnTo>
                    <a:pt x="1148" y="1774"/>
                  </a:lnTo>
                  <a:lnTo>
                    <a:pt x="1151" y="1774"/>
                  </a:lnTo>
                  <a:lnTo>
                    <a:pt x="1151" y="1774"/>
                  </a:lnTo>
                  <a:lnTo>
                    <a:pt x="1151" y="1774"/>
                  </a:lnTo>
                  <a:lnTo>
                    <a:pt x="1154" y="1774"/>
                  </a:lnTo>
                  <a:lnTo>
                    <a:pt x="1154" y="1770"/>
                  </a:lnTo>
                  <a:lnTo>
                    <a:pt x="1154" y="1770"/>
                  </a:lnTo>
                  <a:lnTo>
                    <a:pt x="1157" y="1770"/>
                  </a:lnTo>
                  <a:lnTo>
                    <a:pt x="1157" y="1770"/>
                  </a:lnTo>
                  <a:lnTo>
                    <a:pt x="1157" y="1765"/>
                  </a:lnTo>
                  <a:lnTo>
                    <a:pt x="1160" y="1765"/>
                  </a:lnTo>
                  <a:lnTo>
                    <a:pt x="1160" y="1765"/>
                  </a:lnTo>
                  <a:lnTo>
                    <a:pt x="1160" y="1765"/>
                  </a:lnTo>
                  <a:lnTo>
                    <a:pt x="1160" y="1770"/>
                  </a:lnTo>
                  <a:lnTo>
                    <a:pt x="1160" y="1770"/>
                  </a:lnTo>
                  <a:lnTo>
                    <a:pt x="1163" y="1770"/>
                  </a:lnTo>
                  <a:lnTo>
                    <a:pt x="1163" y="1770"/>
                  </a:lnTo>
                  <a:lnTo>
                    <a:pt x="1163" y="1774"/>
                  </a:lnTo>
                  <a:lnTo>
                    <a:pt x="1167" y="1774"/>
                  </a:lnTo>
                  <a:lnTo>
                    <a:pt x="1167" y="1774"/>
                  </a:lnTo>
                  <a:lnTo>
                    <a:pt x="1167" y="1774"/>
                  </a:lnTo>
                  <a:lnTo>
                    <a:pt x="1170" y="1770"/>
                  </a:lnTo>
                  <a:lnTo>
                    <a:pt x="1170" y="1770"/>
                  </a:lnTo>
                  <a:lnTo>
                    <a:pt x="1170" y="1770"/>
                  </a:lnTo>
                  <a:lnTo>
                    <a:pt x="1170" y="1770"/>
                  </a:lnTo>
                  <a:lnTo>
                    <a:pt x="1173" y="1770"/>
                  </a:lnTo>
                  <a:lnTo>
                    <a:pt x="1173" y="1770"/>
                  </a:lnTo>
                  <a:lnTo>
                    <a:pt x="1173" y="1774"/>
                  </a:lnTo>
                  <a:lnTo>
                    <a:pt x="1173" y="1774"/>
                  </a:lnTo>
                  <a:lnTo>
                    <a:pt x="1176" y="1774"/>
                  </a:lnTo>
                  <a:lnTo>
                    <a:pt x="1176" y="1774"/>
                  </a:lnTo>
                  <a:lnTo>
                    <a:pt x="1176" y="1774"/>
                  </a:lnTo>
                  <a:lnTo>
                    <a:pt x="1176" y="1774"/>
                  </a:lnTo>
                  <a:lnTo>
                    <a:pt x="1179" y="1774"/>
                  </a:lnTo>
                  <a:lnTo>
                    <a:pt x="1179" y="1779"/>
                  </a:lnTo>
                  <a:lnTo>
                    <a:pt x="1179" y="1774"/>
                  </a:lnTo>
                  <a:lnTo>
                    <a:pt x="1182" y="1774"/>
                  </a:lnTo>
                  <a:lnTo>
                    <a:pt x="1182" y="1774"/>
                  </a:lnTo>
                  <a:lnTo>
                    <a:pt x="1182" y="1774"/>
                  </a:lnTo>
                  <a:lnTo>
                    <a:pt x="1185" y="1774"/>
                  </a:lnTo>
                  <a:lnTo>
                    <a:pt x="1185" y="1774"/>
                  </a:lnTo>
                  <a:lnTo>
                    <a:pt x="1185" y="1774"/>
                  </a:lnTo>
                  <a:lnTo>
                    <a:pt x="1185" y="1770"/>
                  </a:lnTo>
                  <a:lnTo>
                    <a:pt x="1189" y="1770"/>
                  </a:lnTo>
                  <a:lnTo>
                    <a:pt x="1189" y="1770"/>
                  </a:lnTo>
                  <a:lnTo>
                    <a:pt x="1189" y="1760"/>
                  </a:lnTo>
                  <a:lnTo>
                    <a:pt x="1189" y="1760"/>
                  </a:lnTo>
                  <a:lnTo>
                    <a:pt x="1192" y="1755"/>
                  </a:lnTo>
                  <a:lnTo>
                    <a:pt x="1192" y="1755"/>
                  </a:lnTo>
                  <a:lnTo>
                    <a:pt x="1192" y="1751"/>
                  </a:lnTo>
                  <a:lnTo>
                    <a:pt x="1195" y="1751"/>
                  </a:lnTo>
                  <a:lnTo>
                    <a:pt x="1195" y="1751"/>
                  </a:lnTo>
                  <a:lnTo>
                    <a:pt x="1195" y="1755"/>
                  </a:lnTo>
                  <a:lnTo>
                    <a:pt x="1198" y="1755"/>
                  </a:lnTo>
                  <a:lnTo>
                    <a:pt x="1198" y="1755"/>
                  </a:lnTo>
                  <a:lnTo>
                    <a:pt x="1198" y="1760"/>
                  </a:lnTo>
                  <a:lnTo>
                    <a:pt x="1198" y="1760"/>
                  </a:lnTo>
                  <a:lnTo>
                    <a:pt x="1201" y="1765"/>
                  </a:lnTo>
                  <a:lnTo>
                    <a:pt x="1201" y="1765"/>
                  </a:lnTo>
                  <a:lnTo>
                    <a:pt x="1201" y="1765"/>
                  </a:lnTo>
                  <a:lnTo>
                    <a:pt x="1201" y="1765"/>
                  </a:lnTo>
                  <a:lnTo>
                    <a:pt x="1204" y="1770"/>
                  </a:lnTo>
                  <a:lnTo>
                    <a:pt x="1204" y="1770"/>
                  </a:lnTo>
                  <a:lnTo>
                    <a:pt x="1204" y="1770"/>
                  </a:lnTo>
                  <a:lnTo>
                    <a:pt x="1204" y="1770"/>
                  </a:lnTo>
                  <a:lnTo>
                    <a:pt x="1207" y="1770"/>
                  </a:lnTo>
                  <a:lnTo>
                    <a:pt x="1207" y="1770"/>
                  </a:lnTo>
                  <a:lnTo>
                    <a:pt x="1211" y="1760"/>
                  </a:lnTo>
                  <a:lnTo>
                    <a:pt x="1211" y="1760"/>
                  </a:lnTo>
                  <a:lnTo>
                    <a:pt x="1211" y="1751"/>
                  </a:lnTo>
                  <a:lnTo>
                    <a:pt x="1211" y="1751"/>
                  </a:lnTo>
                  <a:lnTo>
                    <a:pt x="1214" y="1741"/>
                  </a:lnTo>
                  <a:lnTo>
                    <a:pt x="1214" y="1741"/>
                  </a:lnTo>
                  <a:lnTo>
                    <a:pt x="1214" y="1736"/>
                  </a:lnTo>
                  <a:lnTo>
                    <a:pt x="1214" y="1736"/>
                  </a:lnTo>
                  <a:lnTo>
                    <a:pt x="1217" y="1746"/>
                  </a:lnTo>
                  <a:lnTo>
                    <a:pt x="1217" y="1746"/>
                  </a:lnTo>
                  <a:lnTo>
                    <a:pt x="1217" y="1751"/>
                  </a:lnTo>
                  <a:lnTo>
                    <a:pt x="1217" y="1751"/>
                  </a:lnTo>
                  <a:lnTo>
                    <a:pt x="1220" y="1751"/>
                  </a:lnTo>
                  <a:lnTo>
                    <a:pt x="1220" y="1751"/>
                  </a:lnTo>
                  <a:lnTo>
                    <a:pt x="1220" y="1751"/>
                  </a:lnTo>
                  <a:lnTo>
                    <a:pt x="1223" y="1751"/>
                  </a:lnTo>
                  <a:lnTo>
                    <a:pt x="1223" y="1755"/>
                  </a:lnTo>
                  <a:lnTo>
                    <a:pt x="1223" y="1755"/>
                  </a:lnTo>
                  <a:lnTo>
                    <a:pt x="1226" y="1765"/>
                  </a:lnTo>
                  <a:lnTo>
                    <a:pt x="1226" y="1765"/>
                  </a:lnTo>
                  <a:lnTo>
                    <a:pt x="1226" y="1770"/>
                  </a:lnTo>
                  <a:lnTo>
                    <a:pt x="1226" y="1770"/>
                  </a:lnTo>
                  <a:lnTo>
                    <a:pt x="1229" y="1765"/>
                  </a:lnTo>
                  <a:lnTo>
                    <a:pt x="1229" y="1760"/>
                  </a:lnTo>
                  <a:lnTo>
                    <a:pt x="1229" y="1741"/>
                  </a:lnTo>
                  <a:lnTo>
                    <a:pt x="1229" y="1736"/>
                  </a:lnTo>
                  <a:lnTo>
                    <a:pt x="1233" y="1712"/>
                  </a:lnTo>
                  <a:lnTo>
                    <a:pt x="1233" y="1703"/>
                  </a:lnTo>
                  <a:lnTo>
                    <a:pt x="1233" y="1679"/>
                  </a:lnTo>
                  <a:lnTo>
                    <a:pt x="1236" y="1679"/>
                  </a:lnTo>
                  <a:lnTo>
                    <a:pt x="1236" y="1683"/>
                  </a:lnTo>
                  <a:lnTo>
                    <a:pt x="1236" y="1688"/>
                  </a:lnTo>
                  <a:lnTo>
                    <a:pt x="1239" y="1712"/>
                  </a:lnTo>
                  <a:lnTo>
                    <a:pt x="1239" y="1712"/>
                  </a:lnTo>
                  <a:lnTo>
                    <a:pt x="1239" y="1736"/>
                  </a:lnTo>
                  <a:lnTo>
                    <a:pt x="1239" y="1741"/>
                  </a:lnTo>
                  <a:lnTo>
                    <a:pt x="1242" y="1751"/>
                  </a:lnTo>
                  <a:lnTo>
                    <a:pt x="1242" y="1751"/>
                  </a:lnTo>
                  <a:lnTo>
                    <a:pt x="1242" y="1751"/>
                  </a:lnTo>
                  <a:lnTo>
                    <a:pt x="1242" y="1751"/>
                  </a:lnTo>
                  <a:lnTo>
                    <a:pt x="1245" y="1755"/>
                  </a:lnTo>
                  <a:lnTo>
                    <a:pt x="1245" y="1755"/>
                  </a:lnTo>
                  <a:lnTo>
                    <a:pt x="1245" y="1760"/>
                  </a:lnTo>
                  <a:lnTo>
                    <a:pt x="1245" y="1760"/>
                  </a:lnTo>
                  <a:lnTo>
                    <a:pt x="1248" y="1765"/>
                  </a:lnTo>
                  <a:lnTo>
                    <a:pt x="1248" y="1770"/>
                  </a:lnTo>
                  <a:lnTo>
                    <a:pt x="1251" y="1770"/>
                  </a:lnTo>
                  <a:lnTo>
                    <a:pt x="1251" y="1774"/>
                  </a:lnTo>
                  <a:lnTo>
                    <a:pt x="1251" y="1774"/>
                  </a:lnTo>
                  <a:lnTo>
                    <a:pt x="1251" y="1774"/>
                  </a:lnTo>
                  <a:lnTo>
                    <a:pt x="1255" y="1770"/>
                  </a:lnTo>
                  <a:lnTo>
                    <a:pt x="1255" y="1770"/>
                  </a:lnTo>
                  <a:lnTo>
                    <a:pt x="1255" y="1760"/>
                  </a:lnTo>
                  <a:lnTo>
                    <a:pt x="1255" y="1755"/>
                  </a:lnTo>
                  <a:lnTo>
                    <a:pt x="1258" y="1731"/>
                  </a:lnTo>
                  <a:lnTo>
                    <a:pt x="1258" y="1727"/>
                  </a:lnTo>
                  <a:lnTo>
                    <a:pt x="1258" y="1698"/>
                  </a:lnTo>
                  <a:lnTo>
                    <a:pt x="1258" y="1693"/>
                  </a:lnTo>
                  <a:lnTo>
                    <a:pt x="1261" y="1679"/>
                  </a:lnTo>
                  <a:lnTo>
                    <a:pt x="1261" y="1679"/>
                  </a:lnTo>
                  <a:lnTo>
                    <a:pt x="1261" y="1679"/>
                  </a:lnTo>
                  <a:lnTo>
                    <a:pt x="1264" y="1683"/>
                  </a:lnTo>
                  <a:lnTo>
                    <a:pt x="1264" y="1703"/>
                  </a:lnTo>
                  <a:lnTo>
                    <a:pt x="1264" y="1707"/>
                  </a:lnTo>
                  <a:lnTo>
                    <a:pt x="1267" y="1731"/>
                  </a:lnTo>
                  <a:lnTo>
                    <a:pt x="1267" y="1736"/>
                  </a:lnTo>
                  <a:lnTo>
                    <a:pt x="1267" y="1755"/>
                  </a:lnTo>
                  <a:lnTo>
                    <a:pt x="1267" y="1760"/>
                  </a:lnTo>
                  <a:lnTo>
                    <a:pt x="1270" y="1765"/>
                  </a:lnTo>
                  <a:lnTo>
                    <a:pt x="1270" y="1765"/>
                  </a:lnTo>
                  <a:lnTo>
                    <a:pt x="1270" y="1770"/>
                  </a:lnTo>
                  <a:lnTo>
                    <a:pt x="1270" y="1770"/>
                  </a:lnTo>
                  <a:lnTo>
                    <a:pt x="1273" y="1770"/>
                  </a:lnTo>
                  <a:lnTo>
                    <a:pt x="1273" y="1770"/>
                  </a:lnTo>
                  <a:lnTo>
                    <a:pt x="1273" y="1774"/>
                  </a:lnTo>
                  <a:lnTo>
                    <a:pt x="1273" y="1774"/>
                  </a:lnTo>
                  <a:lnTo>
                    <a:pt x="1277" y="1774"/>
                  </a:lnTo>
                  <a:lnTo>
                    <a:pt x="1277" y="1774"/>
                  </a:lnTo>
                  <a:lnTo>
                    <a:pt x="1280" y="1774"/>
                  </a:lnTo>
                  <a:lnTo>
                    <a:pt x="1280" y="1770"/>
                  </a:lnTo>
                  <a:lnTo>
                    <a:pt x="1280" y="1765"/>
                  </a:lnTo>
                  <a:lnTo>
                    <a:pt x="1280" y="1765"/>
                  </a:lnTo>
                  <a:lnTo>
                    <a:pt x="1283" y="1755"/>
                  </a:lnTo>
                  <a:lnTo>
                    <a:pt x="1283" y="1751"/>
                  </a:lnTo>
                  <a:lnTo>
                    <a:pt x="1283" y="1741"/>
                  </a:lnTo>
                  <a:lnTo>
                    <a:pt x="1283" y="1741"/>
                  </a:lnTo>
                  <a:lnTo>
                    <a:pt x="1286" y="1736"/>
                  </a:lnTo>
                  <a:lnTo>
                    <a:pt x="1286" y="1736"/>
                  </a:lnTo>
                  <a:lnTo>
                    <a:pt x="1286" y="1736"/>
                  </a:lnTo>
                  <a:lnTo>
                    <a:pt x="1286" y="1736"/>
                  </a:lnTo>
                  <a:lnTo>
                    <a:pt x="1289" y="1736"/>
                  </a:lnTo>
                  <a:lnTo>
                    <a:pt x="1289" y="1736"/>
                  </a:lnTo>
                  <a:lnTo>
                    <a:pt x="1289" y="1731"/>
                  </a:lnTo>
                  <a:lnTo>
                    <a:pt x="1292" y="1731"/>
                  </a:lnTo>
                  <a:lnTo>
                    <a:pt x="1292" y="1717"/>
                  </a:lnTo>
                  <a:lnTo>
                    <a:pt x="1292" y="1717"/>
                  </a:lnTo>
                  <a:lnTo>
                    <a:pt x="1295" y="1703"/>
                  </a:lnTo>
                  <a:lnTo>
                    <a:pt x="1295" y="1698"/>
                  </a:lnTo>
                  <a:lnTo>
                    <a:pt x="1295" y="1693"/>
                  </a:lnTo>
                  <a:lnTo>
                    <a:pt x="1295" y="1693"/>
                  </a:lnTo>
                  <a:lnTo>
                    <a:pt x="1299" y="1703"/>
                  </a:lnTo>
                  <a:lnTo>
                    <a:pt x="1299" y="1707"/>
                  </a:lnTo>
                  <a:lnTo>
                    <a:pt x="1299" y="1722"/>
                  </a:lnTo>
                  <a:lnTo>
                    <a:pt x="1299" y="1722"/>
                  </a:lnTo>
                  <a:lnTo>
                    <a:pt x="1302" y="1741"/>
                  </a:lnTo>
                  <a:lnTo>
                    <a:pt x="1302" y="1746"/>
                  </a:lnTo>
                  <a:lnTo>
                    <a:pt x="1302" y="1755"/>
                  </a:lnTo>
                  <a:lnTo>
                    <a:pt x="1305" y="1755"/>
                  </a:lnTo>
                  <a:lnTo>
                    <a:pt x="1305" y="1760"/>
                  </a:lnTo>
                  <a:lnTo>
                    <a:pt x="1305" y="1760"/>
                  </a:lnTo>
                  <a:lnTo>
                    <a:pt x="1308" y="1755"/>
                  </a:lnTo>
                  <a:lnTo>
                    <a:pt x="1308" y="1755"/>
                  </a:lnTo>
                  <a:lnTo>
                    <a:pt x="1308" y="1746"/>
                  </a:lnTo>
                  <a:lnTo>
                    <a:pt x="1308" y="1746"/>
                  </a:lnTo>
                  <a:lnTo>
                    <a:pt x="1311" y="1741"/>
                  </a:lnTo>
                  <a:lnTo>
                    <a:pt x="1311" y="1741"/>
                  </a:lnTo>
                  <a:lnTo>
                    <a:pt x="1311" y="1741"/>
                  </a:lnTo>
                  <a:lnTo>
                    <a:pt x="1311" y="1746"/>
                  </a:lnTo>
                  <a:lnTo>
                    <a:pt x="1314" y="1755"/>
                  </a:lnTo>
                  <a:lnTo>
                    <a:pt x="1314" y="1755"/>
                  </a:lnTo>
                  <a:lnTo>
                    <a:pt x="1314" y="1765"/>
                  </a:lnTo>
                  <a:lnTo>
                    <a:pt x="1314" y="1765"/>
                  </a:lnTo>
                  <a:lnTo>
                    <a:pt x="1317" y="1770"/>
                  </a:lnTo>
                  <a:lnTo>
                    <a:pt x="1317" y="1770"/>
                  </a:lnTo>
                  <a:lnTo>
                    <a:pt x="1317" y="1774"/>
                  </a:lnTo>
                  <a:lnTo>
                    <a:pt x="1321" y="1774"/>
                  </a:lnTo>
                  <a:lnTo>
                    <a:pt x="1321" y="1774"/>
                  </a:lnTo>
                  <a:lnTo>
                    <a:pt x="1321" y="1774"/>
                  </a:lnTo>
                  <a:lnTo>
                    <a:pt x="1324" y="1774"/>
                  </a:lnTo>
                  <a:lnTo>
                    <a:pt x="1324" y="1770"/>
                  </a:lnTo>
                  <a:lnTo>
                    <a:pt x="1324" y="1760"/>
                  </a:lnTo>
                  <a:lnTo>
                    <a:pt x="1324" y="1760"/>
                  </a:lnTo>
                  <a:lnTo>
                    <a:pt x="1327" y="1736"/>
                  </a:lnTo>
                  <a:lnTo>
                    <a:pt x="1327" y="1731"/>
                  </a:lnTo>
                  <a:lnTo>
                    <a:pt x="1327" y="1683"/>
                  </a:lnTo>
                  <a:lnTo>
                    <a:pt x="1327" y="1674"/>
                  </a:lnTo>
                  <a:lnTo>
                    <a:pt x="1330" y="1616"/>
                  </a:lnTo>
                  <a:lnTo>
                    <a:pt x="1330" y="1607"/>
                  </a:lnTo>
                  <a:lnTo>
                    <a:pt x="1330" y="1573"/>
                  </a:lnTo>
                  <a:lnTo>
                    <a:pt x="1333" y="1568"/>
                  </a:lnTo>
                  <a:lnTo>
                    <a:pt x="1333" y="1563"/>
                  </a:lnTo>
                  <a:lnTo>
                    <a:pt x="1333" y="1568"/>
                  </a:lnTo>
                  <a:lnTo>
                    <a:pt x="1336" y="1597"/>
                  </a:lnTo>
                  <a:lnTo>
                    <a:pt x="1336" y="1607"/>
                  </a:lnTo>
                  <a:lnTo>
                    <a:pt x="1336" y="1655"/>
                  </a:lnTo>
                  <a:lnTo>
                    <a:pt x="1336" y="1659"/>
                  </a:lnTo>
                  <a:lnTo>
                    <a:pt x="1339" y="1698"/>
                  </a:lnTo>
                  <a:lnTo>
                    <a:pt x="1339" y="1703"/>
                  </a:lnTo>
                  <a:lnTo>
                    <a:pt x="1339" y="1717"/>
                  </a:lnTo>
                  <a:lnTo>
                    <a:pt x="1339" y="1722"/>
                  </a:lnTo>
                  <a:lnTo>
                    <a:pt x="1343" y="1722"/>
                  </a:lnTo>
                  <a:lnTo>
                    <a:pt x="1343" y="1722"/>
                  </a:lnTo>
                  <a:lnTo>
                    <a:pt x="1343" y="1717"/>
                  </a:lnTo>
                  <a:lnTo>
                    <a:pt x="1346" y="1717"/>
                  </a:lnTo>
                  <a:lnTo>
                    <a:pt x="1346" y="1717"/>
                  </a:lnTo>
                  <a:lnTo>
                    <a:pt x="1346" y="1717"/>
                  </a:lnTo>
                  <a:lnTo>
                    <a:pt x="1346" y="1727"/>
                  </a:lnTo>
                  <a:lnTo>
                    <a:pt x="1349" y="1727"/>
                  </a:lnTo>
                  <a:lnTo>
                    <a:pt x="1349" y="1736"/>
                  </a:lnTo>
                  <a:lnTo>
                    <a:pt x="1349" y="1736"/>
                  </a:lnTo>
                  <a:lnTo>
                    <a:pt x="1352" y="1736"/>
                  </a:lnTo>
                  <a:lnTo>
                    <a:pt x="1352" y="1731"/>
                  </a:lnTo>
                  <a:lnTo>
                    <a:pt x="1352" y="1707"/>
                  </a:lnTo>
                  <a:lnTo>
                    <a:pt x="1352" y="1703"/>
                  </a:lnTo>
                  <a:lnTo>
                    <a:pt x="1355" y="1674"/>
                  </a:lnTo>
                  <a:lnTo>
                    <a:pt x="1355" y="1669"/>
                  </a:lnTo>
                  <a:lnTo>
                    <a:pt x="1355" y="1655"/>
                  </a:lnTo>
                  <a:lnTo>
                    <a:pt x="1355" y="1655"/>
                  </a:lnTo>
                  <a:lnTo>
                    <a:pt x="1358" y="1674"/>
                  </a:lnTo>
                  <a:lnTo>
                    <a:pt x="1358" y="1679"/>
                  </a:lnTo>
                  <a:lnTo>
                    <a:pt x="1358" y="1717"/>
                  </a:lnTo>
                  <a:lnTo>
                    <a:pt x="1362" y="1722"/>
                  </a:lnTo>
                  <a:lnTo>
                    <a:pt x="1362" y="1746"/>
                  </a:lnTo>
                  <a:lnTo>
                    <a:pt x="1362" y="1751"/>
                  </a:lnTo>
                  <a:lnTo>
                    <a:pt x="1365" y="1760"/>
                  </a:lnTo>
                  <a:lnTo>
                    <a:pt x="1365" y="1760"/>
                  </a:lnTo>
                  <a:lnTo>
                    <a:pt x="1365" y="1755"/>
                  </a:lnTo>
                  <a:lnTo>
                    <a:pt x="1365" y="1751"/>
                  </a:lnTo>
                  <a:lnTo>
                    <a:pt x="1368" y="1722"/>
                  </a:lnTo>
                  <a:lnTo>
                    <a:pt x="1368" y="1717"/>
                  </a:lnTo>
                  <a:lnTo>
                    <a:pt x="1368" y="1635"/>
                  </a:lnTo>
                  <a:lnTo>
                    <a:pt x="1368" y="1616"/>
                  </a:lnTo>
                  <a:lnTo>
                    <a:pt x="1371" y="1472"/>
                  </a:lnTo>
                  <a:lnTo>
                    <a:pt x="1371" y="1448"/>
                  </a:lnTo>
                  <a:lnTo>
                    <a:pt x="1371" y="1300"/>
                  </a:lnTo>
                  <a:lnTo>
                    <a:pt x="1374" y="1276"/>
                  </a:lnTo>
                  <a:lnTo>
                    <a:pt x="1374" y="1161"/>
                  </a:lnTo>
                  <a:lnTo>
                    <a:pt x="1374" y="1156"/>
                  </a:lnTo>
                  <a:lnTo>
                    <a:pt x="1377" y="1189"/>
                  </a:lnTo>
                  <a:lnTo>
                    <a:pt x="1377" y="1208"/>
                  </a:lnTo>
                  <a:lnTo>
                    <a:pt x="1377" y="1381"/>
                  </a:lnTo>
                  <a:lnTo>
                    <a:pt x="1377" y="1420"/>
                  </a:lnTo>
                  <a:lnTo>
                    <a:pt x="1380" y="1592"/>
                  </a:lnTo>
                  <a:lnTo>
                    <a:pt x="1380" y="1611"/>
                  </a:lnTo>
                  <a:lnTo>
                    <a:pt x="1380" y="1683"/>
                  </a:lnTo>
                  <a:lnTo>
                    <a:pt x="1380" y="1688"/>
                  </a:lnTo>
                  <a:lnTo>
                    <a:pt x="1384" y="1703"/>
                  </a:lnTo>
                  <a:lnTo>
                    <a:pt x="1384" y="1703"/>
                  </a:lnTo>
                  <a:lnTo>
                    <a:pt x="1384" y="1698"/>
                  </a:lnTo>
                  <a:lnTo>
                    <a:pt x="1387" y="1698"/>
                  </a:lnTo>
                  <a:lnTo>
                    <a:pt x="1387" y="1703"/>
                  </a:lnTo>
                  <a:lnTo>
                    <a:pt x="1387" y="1703"/>
                  </a:lnTo>
                  <a:lnTo>
                    <a:pt x="1390" y="1717"/>
                  </a:lnTo>
                  <a:lnTo>
                    <a:pt x="1390" y="1722"/>
                  </a:lnTo>
                  <a:lnTo>
                    <a:pt x="1390" y="1731"/>
                  </a:lnTo>
                  <a:lnTo>
                    <a:pt x="1390" y="1736"/>
                  </a:lnTo>
                  <a:lnTo>
                    <a:pt x="1393" y="1736"/>
                  </a:lnTo>
                  <a:lnTo>
                    <a:pt x="1393" y="1736"/>
                  </a:lnTo>
                  <a:lnTo>
                    <a:pt x="1393" y="1731"/>
                  </a:lnTo>
                  <a:lnTo>
                    <a:pt x="1393" y="1731"/>
                  </a:lnTo>
                  <a:lnTo>
                    <a:pt x="1396" y="1722"/>
                  </a:lnTo>
                  <a:lnTo>
                    <a:pt x="1396" y="1722"/>
                  </a:lnTo>
                  <a:lnTo>
                    <a:pt x="1396" y="1707"/>
                  </a:lnTo>
                  <a:lnTo>
                    <a:pt x="1396" y="1707"/>
                  </a:lnTo>
                  <a:lnTo>
                    <a:pt x="1399" y="1688"/>
                  </a:lnTo>
                  <a:lnTo>
                    <a:pt x="1399" y="1683"/>
                  </a:lnTo>
                  <a:lnTo>
                    <a:pt x="1399" y="1664"/>
                  </a:lnTo>
                  <a:lnTo>
                    <a:pt x="1402" y="1659"/>
                  </a:lnTo>
                  <a:lnTo>
                    <a:pt x="1402" y="1655"/>
                  </a:lnTo>
                  <a:lnTo>
                    <a:pt x="1402" y="1659"/>
                  </a:lnTo>
                  <a:lnTo>
                    <a:pt x="1406" y="1679"/>
                  </a:lnTo>
                  <a:lnTo>
                    <a:pt x="1406" y="1683"/>
                  </a:lnTo>
                  <a:lnTo>
                    <a:pt x="1406" y="1707"/>
                  </a:lnTo>
                  <a:lnTo>
                    <a:pt x="1406" y="1712"/>
                  </a:lnTo>
                  <a:lnTo>
                    <a:pt x="1409" y="1727"/>
                  </a:lnTo>
                  <a:lnTo>
                    <a:pt x="1409" y="1731"/>
                  </a:lnTo>
                  <a:lnTo>
                    <a:pt x="1409" y="1731"/>
                  </a:lnTo>
                  <a:lnTo>
                    <a:pt x="1409" y="1731"/>
                  </a:lnTo>
                  <a:lnTo>
                    <a:pt x="1412" y="1722"/>
                  </a:lnTo>
                  <a:lnTo>
                    <a:pt x="1412" y="1722"/>
                  </a:lnTo>
                  <a:lnTo>
                    <a:pt x="1412" y="1707"/>
                  </a:lnTo>
                  <a:lnTo>
                    <a:pt x="1415" y="1707"/>
                  </a:lnTo>
                  <a:lnTo>
                    <a:pt x="1415" y="1712"/>
                  </a:lnTo>
                  <a:lnTo>
                    <a:pt x="1415" y="1712"/>
                  </a:lnTo>
                  <a:lnTo>
                    <a:pt x="1415" y="1727"/>
                  </a:lnTo>
                  <a:lnTo>
                    <a:pt x="1418" y="1731"/>
                  </a:lnTo>
                  <a:lnTo>
                    <a:pt x="1418" y="1746"/>
                  </a:lnTo>
                  <a:lnTo>
                    <a:pt x="1418" y="1751"/>
                  </a:lnTo>
                  <a:lnTo>
                    <a:pt x="1421" y="1760"/>
                  </a:lnTo>
                  <a:lnTo>
                    <a:pt x="1421" y="1760"/>
                  </a:lnTo>
                  <a:lnTo>
                    <a:pt x="1421" y="1765"/>
                  </a:lnTo>
                  <a:lnTo>
                    <a:pt x="1421" y="1765"/>
                  </a:lnTo>
                  <a:lnTo>
                    <a:pt x="1424" y="1765"/>
                  </a:lnTo>
                  <a:lnTo>
                    <a:pt x="1424" y="1765"/>
                  </a:lnTo>
                  <a:lnTo>
                    <a:pt x="1424" y="1760"/>
                  </a:lnTo>
                  <a:lnTo>
                    <a:pt x="1424" y="1760"/>
                  </a:lnTo>
                  <a:lnTo>
                    <a:pt x="1428" y="1755"/>
                  </a:lnTo>
                  <a:lnTo>
                    <a:pt x="1428" y="1751"/>
                  </a:lnTo>
                  <a:lnTo>
                    <a:pt x="1428" y="1746"/>
                  </a:lnTo>
                  <a:lnTo>
                    <a:pt x="1431" y="1746"/>
                  </a:lnTo>
                  <a:lnTo>
                    <a:pt x="1431" y="1741"/>
                  </a:lnTo>
                  <a:lnTo>
                    <a:pt x="1431" y="1741"/>
                  </a:lnTo>
                  <a:lnTo>
                    <a:pt x="1434" y="1746"/>
                  </a:lnTo>
                  <a:lnTo>
                    <a:pt x="1434" y="1746"/>
                  </a:lnTo>
                  <a:lnTo>
                    <a:pt x="1434" y="1751"/>
                  </a:lnTo>
                  <a:lnTo>
                    <a:pt x="1434" y="1755"/>
                  </a:lnTo>
                  <a:lnTo>
                    <a:pt x="1437" y="1760"/>
                  </a:lnTo>
                  <a:lnTo>
                    <a:pt x="1437" y="1760"/>
                  </a:lnTo>
                  <a:lnTo>
                    <a:pt x="1437" y="1765"/>
                  </a:lnTo>
                  <a:lnTo>
                    <a:pt x="1437" y="1765"/>
                  </a:lnTo>
                  <a:lnTo>
                    <a:pt x="1440" y="1765"/>
                  </a:lnTo>
                  <a:lnTo>
                    <a:pt x="1440" y="1770"/>
                  </a:lnTo>
                  <a:lnTo>
                    <a:pt x="1440" y="1770"/>
                  </a:lnTo>
                  <a:lnTo>
                    <a:pt x="1440" y="1770"/>
                  </a:lnTo>
                  <a:lnTo>
                    <a:pt x="1443" y="1770"/>
                  </a:lnTo>
                  <a:lnTo>
                    <a:pt x="1443" y="1770"/>
                  </a:lnTo>
                  <a:lnTo>
                    <a:pt x="1443" y="1770"/>
                  </a:lnTo>
                  <a:lnTo>
                    <a:pt x="1446" y="1770"/>
                  </a:lnTo>
                  <a:lnTo>
                    <a:pt x="1446" y="1770"/>
                  </a:lnTo>
                  <a:lnTo>
                    <a:pt x="1446" y="1770"/>
                  </a:lnTo>
                  <a:lnTo>
                    <a:pt x="1450" y="1765"/>
                  </a:lnTo>
                  <a:lnTo>
                    <a:pt x="1450" y="1765"/>
                  </a:lnTo>
                  <a:lnTo>
                    <a:pt x="1450" y="1760"/>
                  </a:lnTo>
                  <a:lnTo>
                    <a:pt x="1450" y="1760"/>
                  </a:lnTo>
                  <a:lnTo>
                    <a:pt x="1453" y="1751"/>
                  </a:lnTo>
                  <a:lnTo>
                    <a:pt x="1453" y="1751"/>
                  </a:lnTo>
                  <a:lnTo>
                    <a:pt x="1453" y="1746"/>
                  </a:lnTo>
                  <a:lnTo>
                    <a:pt x="1453" y="1746"/>
                  </a:lnTo>
                  <a:lnTo>
                    <a:pt x="1456" y="1746"/>
                  </a:lnTo>
                  <a:lnTo>
                    <a:pt x="1456" y="1746"/>
                  </a:lnTo>
                  <a:lnTo>
                    <a:pt x="1456" y="1746"/>
                  </a:lnTo>
                  <a:lnTo>
                    <a:pt x="1459" y="1751"/>
                  </a:lnTo>
                  <a:lnTo>
                    <a:pt x="1459" y="1755"/>
                  </a:lnTo>
                  <a:lnTo>
                    <a:pt x="1459" y="1760"/>
                  </a:lnTo>
                  <a:lnTo>
                    <a:pt x="1462" y="1765"/>
                  </a:lnTo>
                  <a:lnTo>
                    <a:pt x="1462" y="1765"/>
                  </a:lnTo>
                  <a:lnTo>
                    <a:pt x="1462" y="1770"/>
                  </a:lnTo>
                  <a:lnTo>
                    <a:pt x="1462" y="1770"/>
                  </a:lnTo>
                  <a:lnTo>
                    <a:pt x="1465" y="1770"/>
                  </a:lnTo>
                  <a:lnTo>
                    <a:pt x="1465" y="1770"/>
                  </a:lnTo>
                  <a:lnTo>
                    <a:pt x="1465" y="1770"/>
                  </a:lnTo>
                  <a:lnTo>
                    <a:pt x="1465" y="1770"/>
                  </a:lnTo>
                  <a:lnTo>
                    <a:pt x="1468" y="1770"/>
                  </a:lnTo>
                  <a:lnTo>
                    <a:pt x="1468" y="1770"/>
                  </a:lnTo>
                  <a:lnTo>
                    <a:pt x="1468" y="1770"/>
                  </a:lnTo>
                  <a:lnTo>
                    <a:pt x="1472" y="1770"/>
                  </a:lnTo>
                  <a:lnTo>
                    <a:pt x="1472" y="1765"/>
                  </a:lnTo>
                  <a:lnTo>
                    <a:pt x="1472" y="1765"/>
                  </a:lnTo>
                  <a:lnTo>
                    <a:pt x="1475" y="1765"/>
                  </a:lnTo>
                  <a:lnTo>
                    <a:pt x="1475" y="1765"/>
                  </a:lnTo>
                  <a:lnTo>
                    <a:pt x="1475" y="1765"/>
                  </a:lnTo>
                  <a:lnTo>
                    <a:pt x="1475" y="1765"/>
                  </a:lnTo>
                  <a:lnTo>
                    <a:pt x="1478" y="1765"/>
                  </a:lnTo>
                  <a:lnTo>
                    <a:pt x="1478" y="1765"/>
                  </a:lnTo>
                  <a:lnTo>
                    <a:pt x="1478" y="1765"/>
                  </a:lnTo>
                  <a:lnTo>
                    <a:pt x="1478" y="1765"/>
                  </a:lnTo>
                  <a:lnTo>
                    <a:pt x="1481" y="1765"/>
                  </a:lnTo>
                  <a:lnTo>
                    <a:pt x="1481" y="1765"/>
                  </a:lnTo>
                  <a:lnTo>
                    <a:pt x="1481" y="1760"/>
                  </a:lnTo>
                  <a:lnTo>
                    <a:pt x="1481" y="1760"/>
                  </a:lnTo>
                  <a:lnTo>
                    <a:pt x="1484" y="1751"/>
                  </a:lnTo>
                  <a:lnTo>
                    <a:pt x="1484" y="1751"/>
                  </a:lnTo>
                  <a:lnTo>
                    <a:pt x="1484" y="1741"/>
                  </a:lnTo>
                  <a:lnTo>
                    <a:pt x="1487" y="1741"/>
                  </a:lnTo>
                  <a:lnTo>
                    <a:pt x="1487" y="1736"/>
                  </a:lnTo>
                  <a:lnTo>
                    <a:pt x="1487" y="1736"/>
                  </a:lnTo>
                  <a:lnTo>
                    <a:pt x="1490" y="1731"/>
                  </a:lnTo>
                  <a:lnTo>
                    <a:pt x="1490" y="1727"/>
                  </a:lnTo>
                  <a:lnTo>
                    <a:pt x="1490" y="1722"/>
                  </a:lnTo>
                  <a:lnTo>
                    <a:pt x="1490" y="1722"/>
                  </a:lnTo>
                  <a:lnTo>
                    <a:pt x="1494" y="1712"/>
                  </a:lnTo>
                  <a:lnTo>
                    <a:pt x="1494" y="1712"/>
                  </a:lnTo>
                  <a:lnTo>
                    <a:pt x="1494" y="1707"/>
                  </a:lnTo>
                  <a:lnTo>
                    <a:pt x="1494" y="1707"/>
                  </a:lnTo>
                  <a:lnTo>
                    <a:pt x="1497" y="1703"/>
                  </a:lnTo>
                  <a:lnTo>
                    <a:pt x="1497" y="1703"/>
                  </a:lnTo>
                  <a:lnTo>
                    <a:pt x="1497" y="1688"/>
                  </a:lnTo>
                  <a:lnTo>
                    <a:pt x="1500" y="1683"/>
                  </a:lnTo>
                  <a:lnTo>
                    <a:pt x="1500" y="1669"/>
                  </a:lnTo>
                  <a:lnTo>
                    <a:pt x="1500" y="1664"/>
                  </a:lnTo>
                  <a:lnTo>
                    <a:pt x="1503" y="1659"/>
                  </a:lnTo>
                  <a:lnTo>
                    <a:pt x="1503" y="1659"/>
                  </a:lnTo>
                  <a:lnTo>
                    <a:pt x="1503" y="1674"/>
                  </a:lnTo>
                  <a:lnTo>
                    <a:pt x="1503" y="1679"/>
                  </a:lnTo>
                  <a:lnTo>
                    <a:pt x="1506" y="1698"/>
                  </a:lnTo>
                  <a:lnTo>
                    <a:pt x="1506" y="1703"/>
                  </a:lnTo>
                  <a:lnTo>
                    <a:pt x="1506" y="1717"/>
                  </a:lnTo>
                  <a:lnTo>
                    <a:pt x="1506" y="1717"/>
                  </a:lnTo>
                  <a:lnTo>
                    <a:pt x="1509" y="1717"/>
                  </a:lnTo>
                  <a:lnTo>
                    <a:pt x="1509" y="1717"/>
                  </a:lnTo>
                  <a:lnTo>
                    <a:pt x="1509" y="1717"/>
                  </a:lnTo>
                  <a:lnTo>
                    <a:pt x="1509" y="1717"/>
                  </a:lnTo>
                  <a:lnTo>
                    <a:pt x="1512" y="1717"/>
                  </a:lnTo>
                  <a:lnTo>
                    <a:pt x="1512" y="1717"/>
                  </a:lnTo>
                  <a:lnTo>
                    <a:pt x="1512" y="1717"/>
                  </a:lnTo>
                  <a:lnTo>
                    <a:pt x="1516" y="1717"/>
                  </a:lnTo>
                  <a:lnTo>
                    <a:pt x="1516" y="1712"/>
                  </a:lnTo>
                  <a:lnTo>
                    <a:pt x="1516" y="1712"/>
                  </a:lnTo>
                  <a:lnTo>
                    <a:pt x="1519" y="1712"/>
                  </a:lnTo>
                  <a:lnTo>
                    <a:pt x="1519" y="1717"/>
                  </a:lnTo>
                  <a:lnTo>
                    <a:pt x="1519" y="1717"/>
                  </a:lnTo>
                  <a:lnTo>
                    <a:pt x="1519" y="1722"/>
                  </a:lnTo>
                  <a:lnTo>
                    <a:pt x="1522" y="1722"/>
                  </a:lnTo>
                  <a:lnTo>
                    <a:pt x="1522" y="1722"/>
                  </a:lnTo>
                  <a:lnTo>
                    <a:pt x="1522" y="1707"/>
                  </a:lnTo>
                  <a:lnTo>
                    <a:pt x="1522" y="1703"/>
                  </a:lnTo>
                  <a:lnTo>
                    <a:pt x="1525" y="1669"/>
                  </a:lnTo>
                  <a:lnTo>
                    <a:pt x="1525" y="1659"/>
                  </a:lnTo>
                  <a:lnTo>
                    <a:pt x="1525" y="1616"/>
                  </a:lnTo>
                  <a:lnTo>
                    <a:pt x="1528" y="1611"/>
                  </a:lnTo>
                  <a:lnTo>
                    <a:pt x="1528" y="1583"/>
                  </a:lnTo>
                  <a:lnTo>
                    <a:pt x="1528" y="1583"/>
                  </a:lnTo>
                  <a:lnTo>
                    <a:pt x="1528" y="1578"/>
                  </a:lnTo>
                  <a:lnTo>
                    <a:pt x="1531" y="1583"/>
                  </a:lnTo>
                  <a:lnTo>
                    <a:pt x="1531" y="1597"/>
                  </a:lnTo>
                  <a:lnTo>
                    <a:pt x="1531" y="1597"/>
                  </a:lnTo>
                  <a:lnTo>
                    <a:pt x="1534" y="1616"/>
                  </a:lnTo>
                  <a:lnTo>
                    <a:pt x="1534" y="1621"/>
                  </a:lnTo>
                  <a:lnTo>
                    <a:pt x="1534" y="1635"/>
                  </a:lnTo>
                  <a:lnTo>
                    <a:pt x="1534" y="1635"/>
                  </a:lnTo>
                  <a:lnTo>
                    <a:pt x="1538" y="1635"/>
                  </a:lnTo>
                  <a:lnTo>
                    <a:pt x="1538" y="1635"/>
                  </a:lnTo>
                  <a:lnTo>
                    <a:pt x="1538" y="1607"/>
                  </a:lnTo>
                  <a:lnTo>
                    <a:pt x="1538" y="1597"/>
                  </a:lnTo>
                  <a:lnTo>
                    <a:pt x="1541" y="1530"/>
                  </a:lnTo>
                  <a:lnTo>
                    <a:pt x="1541" y="1511"/>
                  </a:lnTo>
                  <a:lnTo>
                    <a:pt x="1544" y="1372"/>
                  </a:lnTo>
                  <a:lnTo>
                    <a:pt x="1544" y="1348"/>
                  </a:lnTo>
                  <a:lnTo>
                    <a:pt x="1544" y="1189"/>
                  </a:lnTo>
                  <a:lnTo>
                    <a:pt x="1544" y="1170"/>
                  </a:lnTo>
                  <a:lnTo>
                    <a:pt x="1547" y="1098"/>
                  </a:lnTo>
                  <a:lnTo>
                    <a:pt x="1547" y="1093"/>
                  </a:lnTo>
                  <a:lnTo>
                    <a:pt x="1547" y="1146"/>
                  </a:lnTo>
                  <a:lnTo>
                    <a:pt x="1547" y="1170"/>
                  </a:lnTo>
                  <a:lnTo>
                    <a:pt x="1550" y="1314"/>
                  </a:lnTo>
                  <a:lnTo>
                    <a:pt x="1550" y="1348"/>
                  </a:lnTo>
                  <a:lnTo>
                    <a:pt x="1550" y="1530"/>
                  </a:lnTo>
                  <a:lnTo>
                    <a:pt x="1550" y="1554"/>
                  </a:lnTo>
                  <a:lnTo>
                    <a:pt x="1553" y="1669"/>
                  </a:lnTo>
                  <a:lnTo>
                    <a:pt x="1553" y="1679"/>
                  </a:lnTo>
                  <a:lnTo>
                    <a:pt x="1553" y="1717"/>
                  </a:lnTo>
                  <a:lnTo>
                    <a:pt x="1556" y="1722"/>
                  </a:lnTo>
                  <a:lnTo>
                    <a:pt x="1556" y="1736"/>
                  </a:lnTo>
                  <a:lnTo>
                    <a:pt x="1556" y="1731"/>
                  </a:lnTo>
                  <a:lnTo>
                    <a:pt x="1560" y="1722"/>
                  </a:lnTo>
                  <a:lnTo>
                    <a:pt x="1560" y="1722"/>
                  </a:lnTo>
                  <a:lnTo>
                    <a:pt x="1560" y="1707"/>
                  </a:lnTo>
                  <a:lnTo>
                    <a:pt x="1560" y="1707"/>
                  </a:lnTo>
                  <a:lnTo>
                    <a:pt x="1563" y="1688"/>
                  </a:lnTo>
                  <a:lnTo>
                    <a:pt x="1563" y="1688"/>
                  </a:lnTo>
                  <a:lnTo>
                    <a:pt x="1563" y="1679"/>
                  </a:lnTo>
                  <a:lnTo>
                    <a:pt x="1563" y="1679"/>
                  </a:lnTo>
                  <a:lnTo>
                    <a:pt x="1566" y="1683"/>
                  </a:lnTo>
                  <a:lnTo>
                    <a:pt x="1566" y="1688"/>
                  </a:lnTo>
                  <a:lnTo>
                    <a:pt x="1569" y="1703"/>
                  </a:lnTo>
                  <a:lnTo>
                    <a:pt x="1569" y="1707"/>
                  </a:lnTo>
                  <a:lnTo>
                    <a:pt x="1569" y="1717"/>
                  </a:lnTo>
                  <a:lnTo>
                    <a:pt x="1569" y="1722"/>
                  </a:lnTo>
                  <a:lnTo>
                    <a:pt x="1569" y="1722"/>
                  </a:lnTo>
                  <a:lnTo>
                    <a:pt x="1572" y="1722"/>
                  </a:lnTo>
                  <a:lnTo>
                    <a:pt x="1572" y="1717"/>
                  </a:lnTo>
                  <a:lnTo>
                    <a:pt x="1572" y="1717"/>
                  </a:lnTo>
                  <a:lnTo>
                    <a:pt x="1575" y="1717"/>
                  </a:lnTo>
                  <a:lnTo>
                    <a:pt x="1575" y="1717"/>
                  </a:lnTo>
                  <a:lnTo>
                    <a:pt x="1575" y="1736"/>
                  </a:lnTo>
                  <a:lnTo>
                    <a:pt x="1575" y="1736"/>
                  </a:lnTo>
                  <a:lnTo>
                    <a:pt x="1578" y="1751"/>
                  </a:lnTo>
                  <a:lnTo>
                    <a:pt x="1578" y="1755"/>
                  </a:lnTo>
                  <a:lnTo>
                    <a:pt x="1578" y="1765"/>
                  </a:lnTo>
                  <a:lnTo>
                    <a:pt x="1578" y="1770"/>
                  </a:lnTo>
                  <a:lnTo>
                    <a:pt x="1582" y="1774"/>
                  </a:lnTo>
                  <a:lnTo>
                    <a:pt x="1582" y="1774"/>
                  </a:lnTo>
                  <a:lnTo>
                    <a:pt x="1582" y="1774"/>
                  </a:lnTo>
                  <a:lnTo>
                    <a:pt x="1585" y="1774"/>
                  </a:lnTo>
                  <a:lnTo>
                    <a:pt x="1585" y="1779"/>
                  </a:lnTo>
                  <a:lnTo>
                    <a:pt x="1585" y="1779"/>
                  </a:lnTo>
                  <a:lnTo>
                    <a:pt x="1588" y="1779"/>
                  </a:lnTo>
                  <a:lnTo>
                    <a:pt x="1588" y="1779"/>
                  </a:lnTo>
                  <a:lnTo>
                    <a:pt x="1588" y="1779"/>
                  </a:lnTo>
                  <a:lnTo>
                    <a:pt x="1588" y="1779"/>
                  </a:lnTo>
                  <a:lnTo>
                    <a:pt x="1591" y="1774"/>
                  </a:lnTo>
                  <a:lnTo>
                    <a:pt x="1591" y="1774"/>
                  </a:lnTo>
                  <a:lnTo>
                    <a:pt x="1591" y="1774"/>
                  </a:lnTo>
                  <a:lnTo>
                    <a:pt x="1591" y="1774"/>
                  </a:lnTo>
                  <a:lnTo>
                    <a:pt x="1594" y="1774"/>
                  </a:lnTo>
                  <a:lnTo>
                    <a:pt x="1594" y="1774"/>
                  </a:lnTo>
                  <a:lnTo>
                    <a:pt x="1594" y="1770"/>
                  </a:lnTo>
                  <a:lnTo>
                    <a:pt x="1597" y="1770"/>
                  </a:lnTo>
                  <a:lnTo>
                    <a:pt x="1597" y="1770"/>
                  </a:lnTo>
                  <a:lnTo>
                    <a:pt x="1597" y="1765"/>
                  </a:lnTo>
                  <a:lnTo>
                    <a:pt x="1600" y="1765"/>
                  </a:lnTo>
                  <a:lnTo>
                    <a:pt x="1600" y="1765"/>
                  </a:lnTo>
                  <a:lnTo>
                    <a:pt x="1600" y="1755"/>
                  </a:lnTo>
                  <a:lnTo>
                    <a:pt x="1600" y="1755"/>
                  </a:lnTo>
                  <a:lnTo>
                    <a:pt x="1604" y="1751"/>
                  </a:lnTo>
                  <a:lnTo>
                    <a:pt x="1604" y="1751"/>
                  </a:lnTo>
                  <a:lnTo>
                    <a:pt x="1604" y="1746"/>
                  </a:lnTo>
                  <a:lnTo>
                    <a:pt x="1604" y="1746"/>
                  </a:lnTo>
                  <a:lnTo>
                    <a:pt x="1607" y="1746"/>
                  </a:lnTo>
                  <a:lnTo>
                    <a:pt x="1607" y="1751"/>
                  </a:lnTo>
                  <a:lnTo>
                    <a:pt x="1607" y="1751"/>
                  </a:lnTo>
                  <a:lnTo>
                    <a:pt x="1607" y="1751"/>
                  </a:lnTo>
                  <a:lnTo>
                    <a:pt x="1610" y="1755"/>
                  </a:lnTo>
                  <a:lnTo>
                    <a:pt x="1610" y="1755"/>
                  </a:lnTo>
                  <a:lnTo>
                    <a:pt x="1613" y="1755"/>
                  </a:lnTo>
                  <a:lnTo>
                    <a:pt x="1613" y="1755"/>
                  </a:lnTo>
                  <a:lnTo>
                    <a:pt x="1613" y="1751"/>
                  </a:lnTo>
                  <a:lnTo>
                    <a:pt x="1613" y="1751"/>
                  </a:lnTo>
                  <a:lnTo>
                    <a:pt x="1613" y="1751"/>
                  </a:lnTo>
                  <a:lnTo>
                    <a:pt x="1616" y="1751"/>
                  </a:lnTo>
                  <a:lnTo>
                    <a:pt x="1616" y="1755"/>
                  </a:lnTo>
                  <a:lnTo>
                    <a:pt x="1616" y="1755"/>
                  </a:lnTo>
                  <a:lnTo>
                    <a:pt x="1619" y="1755"/>
                  </a:lnTo>
                  <a:lnTo>
                    <a:pt x="1619" y="1760"/>
                  </a:lnTo>
                  <a:lnTo>
                    <a:pt x="1619" y="1760"/>
                  </a:lnTo>
                  <a:lnTo>
                    <a:pt x="1619" y="1760"/>
                  </a:lnTo>
                  <a:lnTo>
                    <a:pt x="1622" y="1765"/>
                  </a:lnTo>
                  <a:lnTo>
                    <a:pt x="1622" y="1765"/>
                  </a:lnTo>
                  <a:lnTo>
                    <a:pt x="1622" y="1765"/>
                  </a:lnTo>
                  <a:lnTo>
                    <a:pt x="1626" y="1765"/>
                  </a:lnTo>
                  <a:lnTo>
                    <a:pt x="1626" y="1765"/>
                  </a:lnTo>
                  <a:lnTo>
                    <a:pt x="1626" y="1765"/>
                  </a:lnTo>
                  <a:lnTo>
                    <a:pt x="1629" y="1770"/>
                  </a:lnTo>
                  <a:lnTo>
                    <a:pt x="1629" y="1770"/>
                  </a:lnTo>
                  <a:lnTo>
                    <a:pt x="1629" y="1770"/>
                  </a:lnTo>
                  <a:lnTo>
                    <a:pt x="1629" y="1770"/>
                  </a:lnTo>
                  <a:lnTo>
                    <a:pt x="1632" y="1770"/>
                  </a:lnTo>
                  <a:lnTo>
                    <a:pt x="1632" y="1770"/>
                  </a:lnTo>
                  <a:lnTo>
                    <a:pt x="1632" y="1760"/>
                  </a:lnTo>
                  <a:lnTo>
                    <a:pt x="1632" y="1760"/>
                  </a:lnTo>
                  <a:lnTo>
                    <a:pt x="1635" y="1746"/>
                  </a:lnTo>
                  <a:lnTo>
                    <a:pt x="1635" y="1746"/>
                  </a:lnTo>
                  <a:lnTo>
                    <a:pt x="1635" y="1722"/>
                  </a:lnTo>
                  <a:lnTo>
                    <a:pt x="1638" y="1722"/>
                  </a:lnTo>
                  <a:lnTo>
                    <a:pt x="1638" y="1703"/>
                  </a:lnTo>
                  <a:lnTo>
                    <a:pt x="1638" y="1703"/>
                  </a:lnTo>
                  <a:lnTo>
                    <a:pt x="1638" y="1698"/>
                  </a:lnTo>
                  <a:lnTo>
                    <a:pt x="1641" y="1698"/>
                  </a:lnTo>
                  <a:lnTo>
                    <a:pt x="1641" y="1707"/>
                  </a:lnTo>
                  <a:lnTo>
                    <a:pt x="1641" y="1712"/>
                  </a:lnTo>
                  <a:lnTo>
                    <a:pt x="1644" y="1727"/>
                  </a:lnTo>
                  <a:lnTo>
                    <a:pt x="1644" y="1731"/>
                  </a:lnTo>
                  <a:lnTo>
                    <a:pt x="1644" y="1746"/>
                  </a:lnTo>
                  <a:lnTo>
                    <a:pt x="1644" y="1746"/>
                  </a:lnTo>
                  <a:lnTo>
                    <a:pt x="1648" y="1751"/>
                  </a:lnTo>
                  <a:lnTo>
                    <a:pt x="1648" y="1751"/>
                  </a:lnTo>
                  <a:lnTo>
                    <a:pt x="1648" y="1751"/>
                  </a:lnTo>
                  <a:lnTo>
                    <a:pt x="1648" y="1751"/>
                  </a:lnTo>
                  <a:lnTo>
                    <a:pt x="1651" y="1755"/>
                  </a:lnTo>
                  <a:lnTo>
                    <a:pt x="1651" y="1755"/>
                  </a:lnTo>
                  <a:lnTo>
                    <a:pt x="1651" y="1755"/>
                  </a:lnTo>
                  <a:lnTo>
                    <a:pt x="1654" y="1760"/>
                  </a:lnTo>
                  <a:lnTo>
                    <a:pt x="1654" y="1765"/>
                  </a:lnTo>
                  <a:lnTo>
                    <a:pt x="1654" y="1765"/>
                  </a:lnTo>
                  <a:lnTo>
                    <a:pt x="1657" y="1770"/>
                  </a:lnTo>
                  <a:lnTo>
                    <a:pt x="1657" y="1770"/>
                  </a:lnTo>
                  <a:lnTo>
                    <a:pt x="1657" y="1770"/>
                  </a:lnTo>
                  <a:lnTo>
                    <a:pt x="1657" y="1770"/>
                  </a:lnTo>
                  <a:lnTo>
                    <a:pt x="1660" y="1765"/>
                  </a:lnTo>
                  <a:lnTo>
                    <a:pt x="1660" y="1765"/>
                  </a:lnTo>
                  <a:lnTo>
                    <a:pt x="1660" y="1760"/>
                  </a:lnTo>
                  <a:lnTo>
                    <a:pt x="1660" y="1760"/>
                  </a:lnTo>
                  <a:lnTo>
                    <a:pt x="1663" y="1746"/>
                  </a:lnTo>
                  <a:lnTo>
                    <a:pt x="1663" y="1741"/>
                  </a:lnTo>
                  <a:lnTo>
                    <a:pt x="1663" y="1731"/>
                  </a:lnTo>
                  <a:lnTo>
                    <a:pt x="1666" y="1727"/>
                  </a:lnTo>
                  <a:lnTo>
                    <a:pt x="1666" y="1722"/>
                  </a:lnTo>
                  <a:lnTo>
                    <a:pt x="1666" y="1722"/>
                  </a:lnTo>
                  <a:lnTo>
                    <a:pt x="1670" y="1727"/>
                  </a:lnTo>
                  <a:lnTo>
                    <a:pt x="1670" y="1727"/>
                  </a:lnTo>
                  <a:lnTo>
                    <a:pt x="1670" y="1736"/>
                  </a:lnTo>
                  <a:lnTo>
                    <a:pt x="1670" y="1736"/>
                  </a:lnTo>
                  <a:lnTo>
                    <a:pt x="1673" y="1741"/>
                  </a:lnTo>
                  <a:lnTo>
                    <a:pt x="1673" y="1741"/>
                  </a:lnTo>
                  <a:lnTo>
                    <a:pt x="1673" y="1746"/>
                  </a:lnTo>
                  <a:lnTo>
                    <a:pt x="1673" y="1746"/>
                  </a:lnTo>
                  <a:lnTo>
                    <a:pt x="1676" y="1746"/>
                  </a:lnTo>
                  <a:lnTo>
                    <a:pt x="1676" y="1746"/>
                  </a:lnTo>
                  <a:lnTo>
                    <a:pt x="1676" y="1746"/>
                  </a:lnTo>
                  <a:lnTo>
                    <a:pt x="1676" y="1751"/>
                  </a:lnTo>
                  <a:lnTo>
                    <a:pt x="1679" y="1751"/>
                  </a:lnTo>
                  <a:lnTo>
                    <a:pt x="1679" y="1751"/>
                  </a:lnTo>
                  <a:lnTo>
                    <a:pt x="1679" y="1751"/>
                  </a:lnTo>
                  <a:lnTo>
                    <a:pt x="1682" y="1746"/>
                  </a:lnTo>
                  <a:lnTo>
                    <a:pt x="1682" y="1731"/>
                  </a:lnTo>
                  <a:lnTo>
                    <a:pt x="1682" y="1727"/>
                  </a:lnTo>
                  <a:lnTo>
                    <a:pt x="1685" y="1703"/>
                  </a:lnTo>
                  <a:lnTo>
                    <a:pt x="1685" y="1698"/>
                  </a:lnTo>
                  <a:lnTo>
                    <a:pt x="1685" y="1674"/>
                  </a:lnTo>
                  <a:lnTo>
                    <a:pt x="1688" y="1669"/>
                  </a:lnTo>
                  <a:lnTo>
                    <a:pt x="1688" y="1674"/>
                  </a:lnTo>
                  <a:lnTo>
                    <a:pt x="1688" y="1674"/>
                  </a:lnTo>
                  <a:lnTo>
                    <a:pt x="1688" y="1698"/>
                  </a:lnTo>
                  <a:lnTo>
                    <a:pt x="1688" y="1703"/>
                  </a:lnTo>
                  <a:lnTo>
                    <a:pt x="1692" y="1727"/>
                  </a:lnTo>
                  <a:lnTo>
                    <a:pt x="1692" y="1731"/>
                  </a:lnTo>
                  <a:lnTo>
                    <a:pt x="1692" y="1746"/>
                  </a:lnTo>
                  <a:lnTo>
                    <a:pt x="1695" y="1746"/>
                  </a:lnTo>
                  <a:lnTo>
                    <a:pt x="1695" y="1755"/>
                  </a:lnTo>
                  <a:lnTo>
                    <a:pt x="1695" y="1755"/>
                  </a:lnTo>
                  <a:lnTo>
                    <a:pt x="1698" y="1760"/>
                  </a:lnTo>
                  <a:lnTo>
                    <a:pt x="1698" y="1760"/>
                  </a:lnTo>
                  <a:lnTo>
                    <a:pt x="1698" y="1765"/>
                  </a:lnTo>
                  <a:lnTo>
                    <a:pt x="1698" y="1765"/>
                  </a:lnTo>
                  <a:lnTo>
                    <a:pt x="1701" y="1760"/>
                  </a:lnTo>
                  <a:lnTo>
                    <a:pt x="1701" y="1760"/>
                  </a:lnTo>
                  <a:lnTo>
                    <a:pt x="1701" y="1746"/>
                  </a:lnTo>
                  <a:lnTo>
                    <a:pt x="1701" y="1746"/>
                  </a:lnTo>
                  <a:lnTo>
                    <a:pt x="1704" y="1727"/>
                  </a:lnTo>
                  <a:lnTo>
                    <a:pt x="1704" y="1722"/>
                  </a:lnTo>
                  <a:lnTo>
                    <a:pt x="1704" y="1707"/>
                  </a:lnTo>
                  <a:lnTo>
                    <a:pt x="1704" y="1703"/>
                  </a:lnTo>
                  <a:lnTo>
                    <a:pt x="1707" y="1703"/>
                  </a:lnTo>
                  <a:lnTo>
                    <a:pt x="1707" y="1703"/>
                  </a:lnTo>
                  <a:lnTo>
                    <a:pt x="1710" y="1703"/>
                  </a:lnTo>
                  <a:lnTo>
                    <a:pt x="1710" y="1698"/>
                  </a:lnTo>
                  <a:lnTo>
                    <a:pt x="1710" y="1683"/>
                  </a:lnTo>
                  <a:lnTo>
                    <a:pt x="1710" y="1679"/>
                  </a:lnTo>
                  <a:lnTo>
                    <a:pt x="1714" y="1645"/>
                  </a:lnTo>
                  <a:lnTo>
                    <a:pt x="1714" y="1640"/>
                  </a:lnTo>
                  <a:lnTo>
                    <a:pt x="1714" y="1611"/>
                  </a:lnTo>
                  <a:lnTo>
                    <a:pt x="1717" y="1607"/>
                  </a:lnTo>
                  <a:lnTo>
                    <a:pt x="1717" y="1611"/>
                  </a:lnTo>
                  <a:lnTo>
                    <a:pt x="1717" y="1616"/>
                  </a:lnTo>
                  <a:lnTo>
                    <a:pt x="1717" y="1655"/>
                  </a:lnTo>
                  <a:lnTo>
                    <a:pt x="1717" y="1659"/>
                  </a:lnTo>
                  <a:lnTo>
                    <a:pt x="1720" y="1698"/>
                  </a:lnTo>
                  <a:lnTo>
                    <a:pt x="1720" y="1707"/>
                  </a:lnTo>
                  <a:lnTo>
                    <a:pt x="1720" y="1736"/>
                  </a:lnTo>
                  <a:lnTo>
                    <a:pt x="1723" y="1741"/>
                  </a:lnTo>
                  <a:lnTo>
                    <a:pt x="1723" y="1751"/>
                  </a:lnTo>
                  <a:lnTo>
                    <a:pt x="1723" y="1751"/>
                  </a:lnTo>
                  <a:lnTo>
                    <a:pt x="1726" y="1755"/>
                  </a:lnTo>
                  <a:lnTo>
                    <a:pt x="1726" y="1755"/>
                  </a:lnTo>
                  <a:lnTo>
                    <a:pt x="1726" y="1760"/>
                  </a:lnTo>
                  <a:lnTo>
                    <a:pt x="1726" y="1760"/>
                  </a:lnTo>
                  <a:lnTo>
                    <a:pt x="1729" y="1760"/>
                  </a:lnTo>
                  <a:lnTo>
                    <a:pt x="1729" y="1760"/>
                  </a:lnTo>
                  <a:lnTo>
                    <a:pt x="1729" y="1760"/>
                  </a:lnTo>
                  <a:lnTo>
                    <a:pt x="1729" y="1755"/>
                  </a:lnTo>
                  <a:lnTo>
                    <a:pt x="1732" y="1751"/>
                  </a:lnTo>
                  <a:lnTo>
                    <a:pt x="1732" y="1751"/>
                  </a:lnTo>
                  <a:lnTo>
                    <a:pt x="1732" y="1741"/>
                  </a:lnTo>
                  <a:lnTo>
                    <a:pt x="1736" y="1741"/>
                  </a:lnTo>
                  <a:lnTo>
                    <a:pt x="1736" y="1731"/>
                  </a:lnTo>
                  <a:lnTo>
                    <a:pt x="1736" y="1731"/>
                  </a:lnTo>
                  <a:lnTo>
                    <a:pt x="1736" y="1727"/>
                  </a:lnTo>
                  <a:lnTo>
                    <a:pt x="1739" y="1727"/>
                  </a:lnTo>
                  <a:lnTo>
                    <a:pt x="1739" y="1736"/>
                  </a:lnTo>
                  <a:lnTo>
                    <a:pt x="1739" y="1736"/>
                  </a:lnTo>
                  <a:lnTo>
                    <a:pt x="1742" y="1746"/>
                  </a:lnTo>
                  <a:lnTo>
                    <a:pt x="1742" y="1751"/>
                  </a:lnTo>
                  <a:lnTo>
                    <a:pt x="1742" y="1755"/>
                  </a:lnTo>
                  <a:lnTo>
                    <a:pt x="1742" y="1760"/>
                  </a:lnTo>
                  <a:lnTo>
                    <a:pt x="1745" y="1765"/>
                  </a:lnTo>
                  <a:lnTo>
                    <a:pt x="1745" y="1765"/>
                  </a:lnTo>
                  <a:lnTo>
                    <a:pt x="1745" y="1770"/>
                  </a:lnTo>
                  <a:lnTo>
                    <a:pt x="1745" y="1770"/>
                  </a:lnTo>
                  <a:lnTo>
                    <a:pt x="1748" y="1770"/>
                  </a:lnTo>
                  <a:lnTo>
                    <a:pt x="1748" y="1770"/>
                  </a:lnTo>
                  <a:lnTo>
                    <a:pt x="1751" y="1770"/>
                  </a:lnTo>
                  <a:lnTo>
                    <a:pt x="1751" y="1770"/>
                  </a:lnTo>
                  <a:lnTo>
                    <a:pt x="1751" y="1774"/>
                  </a:lnTo>
                  <a:lnTo>
                    <a:pt x="1751" y="1774"/>
                  </a:lnTo>
                  <a:lnTo>
                    <a:pt x="1754" y="1774"/>
                  </a:lnTo>
                  <a:lnTo>
                    <a:pt x="1754" y="1774"/>
                  </a:lnTo>
                  <a:lnTo>
                    <a:pt x="1754" y="1774"/>
                  </a:lnTo>
                  <a:lnTo>
                    <a:pt x="1754" y="1774"/>
                  </a:lnTo>
                  <a:lnTo>
                    <a:pt x="1758" y="1774"/>
                  </a:lnTo>
                  <a:lnTo>
                    <a:pt x="1758" y="1774"/>
                  </a:lnTo>
                  <a:lnTo>
                    <a:pt x="1758" y="1774"/>
                  </a:lnTo>
                  <a:lnTo>
                    <a:pt x="1758" y="1774"/>
                  </a:lnTo>
                  <a:lnTo>
                    <a:pt x="1761" y="1770"/>
                  </a:lnTo>
                  <a:lnTo>
                    <a:pt x="1761" y="1770"/>
                  </a:lnTo>
                  <a:lnTo>
                    <a:pt x="1761" y="1770"/>
                  </a:lnTo>
                  <a:lnTo>
                    <a:pt x="1764" y="1765"/>
                  </a:lnTo>
                  <a:lnTo>
                    <a:pt x="1764" y="1765"/>
                  </a:lnTo>
                  <a:lnTo>
                    <a:pt x="1764" y="1765"/>
                  </a:lnTo>
                  <a:lnTo>
                    <a:pt x="1767" y="1765"/>
                  </a:lnTo>
                  <a:lnTo>
                    <a:pt x="1767" y="1760"/>
                  </a:lnTo>
                  <a:lnTo>
                    <a:pt x="1767" y="1765"/>
                  </a:lnTo>
                  <a:lnTo>
                    <a:pt x="1767" y="1765"/>
                  </a:lnTo>
                  <a:lnTo>
                    <a:pt x="1770" y="1765"/>
                  </a:lnTo>
                  <a:lnTo>
                    <a:pt x="1770" y="1765"/>
                  </a:lnTo>
                  <a:lnTo>
                    <a:pt x="1770" y="1765"/>
                  </a:lnTo>
                  <a:lnTo>
                    <a:pt x="1770" y="1765"/>
                  </a:lnTo>
                  <a:lnTo>
                    <a:pt x="1773" y="1770"/>
                  </a:lnTo>
                  <a:lnTo>
                    <a:pt x="1773" y="1770"/>
                  </a:lnTo>
                  <a:lnTo>
                    <a:pt x="1773" y="1765"/>
                  </a:lnTo>
                  <a:lnTo>
                    <a:pt x="1773" y="1765"/>
                  </a:lnTo>
                  <a:lnTo>
                    <a:pt x="1776" y="1765"/>
                  </a:lnTo>
                  <a:lnTo>
                    <a:pt x="1776" y="1765"/>
                  </a:lnTo>
                  <a:lnTo>
                    <a:pt x="1776" y="1765"/>
                  </a:lnTo>
                  <a:lnTo>
                    <a:pt x="1780" y="1765"/>
                  </a:lnTo>
                  <a:lnTo>
                    <a:pt x="1780" y="1770"/>
                  </a:lnTo>
                  <a:lnTo>
                    <a:pt x="1780" y="1770"/>
                  </a:lnTo>
                  <a:lnTo>
                    <a:pt x="1783" y="1774"/>
                  </a:lnTo>
                  <a:lnTo>
                    <a:pt x="1783" y="1774"/>
                  </a:lnTo>
                  <a:lnTo>
                    <a:pt x="1783" y="1774"/>
                  </a:lnTo>
                  <a:lnTo>
                    <a:pt x="1783" y="1774"/>
                  </a:lnTo>
                  <a:lnTo>
                    <a:pt x="1786" y="1774"/>
                  </a:lnTo>
                  <a:lnTo>
                    <a:pt x="1786" y="1774"/>
                  </a:lnTo>
                  <a:lnTo>
                    <a:pt x="1786" y="1774"/>
                  </a:lnTo>
                  <a:lnTo>
                    <a:pt x="1786" y="1774"/>
                  </a:lnTo>
                  <a:lnTo>
                    <a:pt x="1789" y="1774"/>
                  </a:lnTo>
                  <a:lnTo>
                    <a:pt x="1789" y="1774"/>
                  </a:lnTo>
                  <a:lnTo>
                    <a:pt x="1789" y="1774"/>
                  </a:lnTo>
                  <a:lnTo>
                    <a:pt x="1792" y="1774"/>
                  </a:lnTo>
                  <a:lnTo>
                    <a:pt x="1792" y="1774"/>
                  </a:lnTo>
                  <a:lnTo>
                    <a:pt x="1792" y="1774"/>
                  </a:lnTo>
                  <a:lnTo>
                    <a:pt x="1795" y="1774"/>
                  </a:lnTo>
                  <a:lnTo>
                    <a:pt x="1795" y="1774"/>
                  </a:lnTo>
                  <a:lnTo>
                    <a:pt x="1795" y="1774"/>
                  </a:lnTo>
                  <a:lnTo>
                    <a:pt x="1795" y="1774"/>
                  </a:lnTo>
                  <a:lnTo>
                    <a:pt x="1795" y="1774"/>
                  </a:lnTo>
                  <a:lnTo>
                    <a:pt x="1798" y="1774"/>
                  </a:lnTo>
                  <a:lnTo>
                    <a:pt x="1798" y="1774"/>
                  </a:lnTo>
                  <a:lnTo>
                    <a:pt x="1798" y="1774"/>
                  </a:lnTo>
                  <a:lnTo>
                    <a:pt x="1802" y="1774"/>
                  </a:lnTo>
                  <a:lnTo>
                    <a:pt x="1802" y="1779"/>
                  </a:lnTo>
                  <a:lnTo>
                    <a:pt x="1802" y="1779"/>
                  </a:lnTo>
                  <a:lnTo>
                    <a:pt x="1802" y="1779"/>
                  </a:lnTo>
                  <a:lnTo>
                    <a:pt x="1805" y="1779"/>
                  </a:lnTo>
                  <a:lnTo>
                    <a:pt x="1805" y="1779"/>
                  </a:lnTo>
                  <a:lnTo>
                    <a:pt x="1808" y="1779"/>
                  </a:lnTo>
                  <a:lnTo>
                    <a:pt x="1808" y="1779"/>
                  </a:lnTo>
                  <a:lnTo>
                    <a:pt x="1808" y="1779"/>
                  </a:lnTo>
                  <a:lnTo>
                    <a:pt x="1808" y="1779"/>
                  </a:lnTo>
                  <a:lnTo>
                    <a:pt x="1811" y="1779"/>
                  </a:lnTo>
                  <a:lnTo>
                    <a:pt x="1811" y="1779"/>
                  </a:lnTo>
                  <a:lnTo>
                    <a:pt x="1811" y="1784"/>
                  </a:lnTo>
                  <a:lnTo>
                    <a:pt x="1811" y="1784"/>
                  </a:lnTo>
                  <a:lnTo>
                    <a:pt x="1814" y="1784"/>
                  </a:lnTo>
                  <a:lnTo>
                    <a:pt x="1814" y="1784"/>
                  </a:lnTo>
                  <a:lnTo>
                    <a:pt x="1814" y="1784"/>
                  </a:lnTo>
                  <a:lnTo>
                    <a:pt x="1814" y="1784"/>
                  </a:lnTo>
                  <a:lnTo>
                    <a:pt x="1817" y="1784"/>
                  </a:lnTo>
                  <a:lnTo>
                    <a:pt x="1817" y="1784"/>
                  </a:lnTo>
                  <a:lnTo>
                    <a:pt x="1817" y="1784"/>
                  </a:lnTo>
                  <a:lnTo>
                    <a:pt x="1820" y="1784"/>
                  </a:lnTo>
                  <a:lnTo>
                    <a:pt x="1820" y="1784"/>
                  </a:lnTo>
                  <a:lnTo>
                    <a:pt x="1820" y="1784"/>
                  </a:lnTo>
                  <a:lnTo>
                    <a:pt x="1824" y="1784"/>
                  </a:lnTo>
                  <a:lnTo>
                    <a:pt x="1824" y="1784"/>
                  </a:lnTo>
                  <a:lnTo>
                    <a:pt x="1824" y="1784"/>
                  </a:lnTo>
                  <a:lnTo>
                    <a:pt x="1824" y="1784"/>
                  </a:lnTo>
                  <a:lnTo>
                    <a:pt x="1827" y="1784"/>
                  </a:lnTo>
                  <a:lnTo>
                    <a:pt x="1827" y="1784"/>
                  </a:lnTo>
                  <a:lnTo>
                    <a:pt x="1827" y="1784"/>
                  </a:lnTo>
                  <a:lnTo>
                    <a:pt x="1827" y="1784"/>
                  </a:lnTo>
                  <a:lnTo>
                    <a:pt x="1830" y="1779"/>
                  </a:lnTo>
                  <a:lnTo>
                    <a:pt x="1830" y="1779"/>
                  </a:lnTo>
                  <a:lnTo>
                    <a:pt x="1830" y="1779"/>
                  </a:lnTo>
                  <a:lnTo>
                    <a:pt x="1833" y="1779"/>
                  </a:lnTo>
                  <a:lnTo>
                    <a:pt x="1833" y="1779"/>
                  </a:lnTo>
                  <a:lnTo>
                    <a:pt x="1833" y="1779"/>
                  </a:lnTo>
                  <a:lnTo>
                    <a:pt x="1836" y="1779"/>
                  </a:lnTo>
                  <a:lnTo>
                    <a:pt x="1836" y="1779"/>
                  </a:lnTo>
                  <a:lnTo>
                    <a:pt x="1836" y="1779"/>
                  </a:lnTo>
                  <a:lnTo>
                    <a:pt x="1836" y="1784"/>
                  </a:lnTo>
                  <a:lnTo>
                    <a:pt x="1839" y="1784"/>
                  </a:lnTo>
                  <a:lnTo>
                    <a:pt x="1839" y="1784"/>
                  </a:lnTo>
                  <a:lnTo>
                    <a:pt x="1839" y="1784"/>
                  </a:lnTo>
                  <a:lnTo>
                    <a:pt x="1839" y="1784"/>
                  </a:lnTo>
                  <a:lnTo>
                    <a:pt x="1842" y="1779"/>
                  </a:lnTo>
                  <a:lnTo>
                    <a:pt x="1842" y="1779"/>
                  </a:lnTo>
                  <a:lnTo>
                    <a:pt x="1842" y="1774"/>
                  </a:lnTo>
                  <a:lnTo>
                    <a:pt x="1842" y="1774"/>
                  </a:lnTo>
                  <a:lnTo>
                    <a:pt x="1846" y="1770"/>
                  </a:lnTo>
                  <a:lnTo>
                    <a:pt x="1846" y="1770"/>
                  </a:lnTo>
                  <a:lnTo>
                    <a:pt x="1849" y="1770"/>
                  </a:lnTo>
                  <a:lnTo>
                    <a:pt x="1849" y="1770"/>
                  </a:lnTo>
                  <a:lnTo>
                    <a:pt x="1849" y="1770"/>
                  </a:lnTo>
                  <a:lnTo>
                    <a:pt x="1849" y="1770"/>
                  </a:lnTo>
                  <a:lnTo>
                    <a:pt x="1852" y="1770"/>
                  </a:lnTo>
                  <a:lnTo>
                    <a:pt x="1852" y="1774"/>
                  </a:lnTo>
                  <a:lnTo>
                    <a:pt x="1852" y="1774"/>
                  </a:lnTo>
                  <a:lnTo>
                    <a:pt x="1852" y="1774"/>
                  </a:lnTo>
                  <a:lnTo>
                    <a:pt x="1855" y="1779"/>
                  </a:lnTo>
                  <a:lnTo>
                    <a:pt x="1855" y="1779"/>
                  </a:lnTo>
                  <a:lnTo>
                    <a:pt x="1855" y="1779"/>
                  </a:lnTo>
                  <a:lnTo>
                    <a:pt x="1855" y="1779"/>
                  </a:lnTo>
                  <a:lnTo>
                    <a:pt x="1858" y="1779"/>
                  </a:lnTo>
                  <a:lnTo>
                    <a:pt x="1858" y="1779"/>
                  </a:lnTo>
                  <a:lnTo>
                    <a:pt x="1858" y="1774"/>
                  </a:lnTo>
                  <a:lnTo>
                    <a:pt x="1861" y="1774"/>
                  </a:lnTo>
                  <a:lnTo>
                    <a:pt x="1861" y="1774"/>
                  </a:lnTo>
                  <a:lnTo>
                    <a:pt x="1861" y="1774"/>
                  </a:lnTo>
                  <a:lnTo>
                    <a:pt x="1864" y="1770"/>
                  </a:lnTo>
                  <a:lnTo>
                    <a:pt x="1864" y="1770"/>
                  </a:lnTo>
                  <a:lnTo>
                    <a:pt x="1864" y="1770"/>
                  </a:lnTo>
                  <a:lnTo>
                    <a:pt x="1864" y="1770"/>
                  </a:lnTo>
                  <a:lnTo>
                    <a:pt x="1868" y="1765"/>
                  </a:lnTo>
                  <a:lnTo>
                    <a:pt x="1868" y="1765"/>
                  </a:lnTo>
                  <a:lnTo>
                    <a:pt x="1868" y="1765"/>
                  </a:lnTo>
                  <a:lnTo>
                    <a:pt x="1868" y="1765"/>
                  </a:lnTo>
                  <a:lnTo>
                    <a:pt x="1871" y="1765"/>
                  </a:lnTo>
                  <a:lnTo>
                    <a:pt x="1871" y="1765"/>
                  </a:lnTo>
                  <a:lnTo>
                    <a:pt x="1871" y="1770"/>
                  </a:lnTo>
                  <a:lnTo>
                    <a:pt x="1871" y="1770"/>
                  </a:lnTo>
                  <a:lnTo>
                    <a:pt x="1874" y="1774"/>
                  </a:lnTo>
                  <a:lnTo>
                    <a:pt x="1874" y="1774"/>
                  </a:lnTo>
                  <a:lnTo>
                    <a:pt x="1877" y="1779"/>
                  </a:lnTo>
                  <a:lnTo>
                    <a:pt x="1877" y="1779"/>
                  </a:lnTo>
                  <a:lnTo>
                    <a:pt x="1877" y="1784"/>
                  </a:lnTo>
                  <a:lnTo>
                    <a:pt x="1877" y="1784"/>
                  </a:lnTo>
                  <a:lnTo>
                    <a:pt x="1880" y="1784"/>
                  </a:lnTo>
                  <a:lnTo>
                    <a:pt x="1880" y="1784"/>
                  </a:lnTo>
                  <a:lnTo>
                    <a:pt x="1880" y="1784"/>
                  </a:lnTo>
                  <a:lnTo>
                    <a:pt x="1880" y="1784"/>
                  </a:lnTo>
                  <a:lnTo>
                    <a:pt x="1883" y="1779"/>
                  </a:lnTo>
                  <a:lnTo>
                    <a:pt x="1883" y="1779"/>
                  </a:lnTo>
                  <a:lnTo>
                    <a:pt x="1883" y="1779"/>
                  </a:lnTo>
                  <a:lnTo>
                    <a:pt x="1883" y="1779"/>
                  </a:lnTo>
                  <a:lnTo>
                    <a:pt x="1886" y="1779"/>
                  </a:lnTo>
                  <a:lnTo>
                    <a:pt x="1886" y="1779"/>
                  </a:lnTo>
                  <a:lnTo>
                    <a:pt x="1890" y="1779"/>
                  </a:lnTo>
                  <a:lnTo>
                    <a:pt x="1890" y="1779"/>
                  </a:lnTo>
                  <a:lnTo>
                    <a:pt x="1890" y="1779"/>
                  </a:lnTo>
                  <a:lnTo>
                    <a:pt x="1890" y="1779"/>
                  </a:lnTo>
                  <a:lnTo>
                    <a:pt x="1893" y="1779"/>
                  </a:lnTo>
                  <a:lnTo>
                    <a:pt x="1893" y="1779"/>
                  </a:lnTo>
                  <a:lnTo>
                    <a:pt x="1893" y="1779"/>
                  </a:lnTo>
                  <a:lnTo>
                    <a:pt x="1893" y="1779"/>
                  </a:lnTo>
                  <a:lnTo>
                    <a:pt x="1896" y="1779"/>
                  </a:lnTo>
                  <a:lnTo>
                    <a:pt x="1896" y="1779"/>
                  </a:lnTo>
                  <a:lnTo>
                    <a:pt x="1896" y="1779"/>
                  </a:lnTo>
                  <a:lnTo>
                    <a:pt x="1896" y="1779"/>
                  </a:lnTo>
                  <a:lnTo>
                    <a:pt x="1899" y="1779"/>
                  </a:lnTo>
                  <a:lnTo>
                    <a:pt x="1899" y="1779"/>
                  </a:lnTo>
                  <a:lnTo>
                    <a:pt x="1899" y="1779"/>
                  </a:lnTo>
                  <a:lnTo>
                    <a:pt x="1902" y="1779"/>
                  </a:lnTo>
                  <a:lnTo>
                    <a:pt x="1902" y="1779"/>
                  </a:lnTo>
                  <a:lnTo>
                    <a:pt x="1902" y="1779"/>
                  </a:lnTo>
                  <a:lnTo>
                    <a:pt x="1905" y="1779"/>
                  </a:lnTo>
                  <a:lnTo>
                    <a:pt x="1905" y="1779"/>
                  </a:lnTo>
                  <a:lnTo>
                    <a:pt x="1905" y="1779"/>
                  </a:lnTo>
                  <a:lnTo>
                    <a:pt x="1905" y="1779"/>
                  </a:lnTo>
                  <a:lnTo>
                    <a:pt x="1908" y="1779"/>
                  </a:lnTo>
                  <a:lnTo>
                    <a:pt x="1908" y="1779"/>
                  </a:lnTo>
                  <a:lnTo>
                    <a:pt x="1908" y="1779"/>
                  </a:lnTo>
                  <a:lnTo>
                    <a:pt x="1908" y="1779"/>
                  </a:lnTo>
                  <a:lnTo>
                    <a:pt x="1912" y="1779"/>
                  </a:lnTo>
                  <a:lnTo>
                    <a:pt x="1912" y="1779"/>
                  </a:lnTo>
                  <a:lnTo>
                    <a:pt x="1912" y="1779"/>
                  </a:lnTo>
                  <a:lnTo>
                    <a:pt x="1912" y="1779"/>
                  </a:lnTo>
                  <a:lnTo>
                    <a:pt x="1915" y="1779"/>
                  </a:lnTo>
                  <a:lnTo>
                    <a:pt x="1915" y="1779"/>
                  </a:lnTo>
                  <a:lnTo>
                    <a:pt x="1915" y="1784"/>
                  </a:lnTo>
                  <a:lnTo>
                    <a:pt x="1918" y="1784"/>
                  </a:lnTo>
                  <a:lnTo>
                    <a:pt x="1918" y="1784"/>
                  </a:lnTo>
                  <a:lnTo>
                    <a:pt x="1918" y="1784"/>
                  </a:lnTo>
                  <a:lnTo>
                    <a:pt x="1921" y="1784"/>
                  </a:lnTo>
                  <a:lnTo>
                    <a:pt x="1921" y="1784"/>
                  </a:lnTo>
                  <a:lnTo>
                    <a:pt x="1921" y="1784"/>
                  </a:lnTo>
                  <a:lnTo>
                    <a:pt x="1921" y="1784"/>
                  </a:lnTo>
                  <a:lnTo>
                    <a:pt x="1924" y="1784"/>
                  </a:lnTo>
                  <a:lnTo>
                    <a:pt x="1924" y="1784"/>
                  </a:lnTo>
                  <a:lnTo>
                    <a:pt x="1924" y="1784"/>
                  </a:lnTo>
                  <a:lnTo>
                    <a:pt x="1924" y="1784"/>
                  </a:lnTo>
                  <a:lnTo>
                    <a:pt x="1927" y="1784"/>
                  </a:lnTo>
                  <a:lnTo>
                    <a:pt x="1927" y="1784"/>
                  </a:lnTo>
                  <a:lnTo>
                    <a:pt x="1927" y="1784"/>
                  </a:lnTo>
                  <a:lnTo>
                    <a:pt x="1930" y="1784"/>
                  </a:lnTo>
                  <a:lnTo>
                    <a:pt x="1930" y="1784"/>
                  </a:lnTo>
                  <a:lnTo>
                    <a:pt x="1930" y="1784"/>
                  </a:lnTo>
                  <a:lnTo>
                    <a:pt x="1934" y="1784"/>
                  </a:lnTo>
                  <a:lnTo>
                    <a:pt x="1934" y="1784"/>
                  </a:lnTo>
                  <a:lnTo>
                    <a:pt x="1934" y="1779"/>
                  </a:lnTo>
                  <a:lnTo>
                    <a:pt x="1934" y="1779"/>
                  </a:lnTo>
                  <a:lnTo>
                    <a:pt x="1937" y="1779"/>
                  </a:lnTo>
                  <a:lnTo>
                    <a:pt x="1937" y="1779"/>
                  </a:lnTo>
                  <a:lnTo>
                    <a:pt x="1937" y="1779"/>
                  </a:lnTo>
                  <a:lnTo>
                    <a:pt x="1937" y="1784"/>
                  </a:lnTo>
                  <a:lnTo>
                    <a:pt x="1940" y="1784"/>
                  </a:lnTo>
                  <a:lnTo>
                    <a:pt x="1940" y="1784"/>
                  </a:lnTo>
                  <a:lnTo>
                    <a:pt x="1940" y="1784"/>
                  </a:lnTo>
                  <a:lnTo>
                    <a:pt x="1940" y="1784"/>
                  </a:lnTo>
                  <a:lnTo>
                    <a:pt x="1943" y="1784"/>
                  </a:lnTo>
                  <a:lnTo>
                    <a:pt x="1943" y="1784"/>
                  </a:lnTo>
                  <a:lnTo>
                    <a:pt x="1943" y="1784"/>
                  </a:lnTo>
                  <a:lnTo>
                    <a:pt x="1946" y="1784"/>
                  </a:lnTo>
                  <a:lnTo>
                    <a:pt x="1946" y="1784"/>
                  </a:lnTo>
                  <a:lnTo>
                    <a:pt x="1946" y="1779"/>
                  </a:lnTo>
                  <a:lnTo>
                    <a:pt x="1949" y="1779"/>
                  </a:lnTo>
                  <a:lnTo>
                    <a:pt x="1949" y="1779"/>
                  </a:lnTo>
                  <a:lnTo>
                    <a:pt x="1949" y="1774"/>
                  </a:lnTo>
                  <a:lnTo>
                    <a:pt x="1949" y="1774"/>
                  </a:lnTo>
                  <a:lnTo>
                    <a:pt x="1952" y="1774"/>
                  </a:lnTo>
                  <a:lnTo>
                    <a:pt x="1952" y="1770"/>
                  </a:lnTo>
                  <a:lnTo>
                    <a:pt x="1952" y="1770"/>
                  </a:lnTo>
                  <a:lnTo>
                    <a:pt x="1952" y="1774"/>
                  </a:lnTo>
                  <a:lnTo>
                    <a:pt x="1956" y="1774"/>
                  </a:lnTo>
                  <a:lnTo>
                    <a:pt x="1956" y="1774"/>
                  </a:lnTo>
                  <a:lnTo>
                    <a:pt x="1956" y="1779"/>
                  </a:lnTo>
                  <a:lnTo>
                    <a:pt x="1959" y="1779"/>
                  </a:lnTo>
                  <a:lnTo>
                    <a:pt x="1959" y="1784"/>
                  </a:lnTo>
                  <a:lnTo>
                    <a:pt x="1959" y="1784"/>
                  </a:lnTo>
                  <a:lnTo>
                    <a:pt x="1962" y="1784"/>
                  </a:lnTo>
                  <a:lnTo>
                    <a:pt x="1962" y="1784"/>
                  </a:lnTo>
                  <a:lnTo>
                    <a:pt x="1962" y="1784"/>
                  </a:lnTo>
                  <a:lnTo>
                    <a:pt x="1962" y="1784"/>
                  </a:lnTo>
                  <a:lnTo>
                    <a:pt x="1962" y="1784"/>
                  </a:lnTo>
                  <a:lnTo>
                    <a:pt x="1965" y="1784"/>
                  </a:lnTo>
                  <a:lnTo>
                    <a:pt x="1965" y="1784"/>
                  </a:lnTo>
                  <a:lnTo>
                    <a:pt x="1965" y="1784"/>
                  </a:lnTo>
                  <a:lnTo>
                    <a:pt x="1968" y="1784"/>
                  </a:lnTo>
                  <a:lnTo>
                    <a:pt x="1968" y="1784"/>
                  </a:lnTo>
                  <a:lnTo>
                    <a:pt x="1968" y="1784"/>
                  </a:lnTo>
                  <a:lnTo>
                    <a:pt x="1971" y="1784"/>
                  </a:lnTo>
                  <a:lnTo>
                    <a:pt x="1971" y="1784"/>
                  </a:lnTo>
                  <a:lnTo>
                    <a:pt x="1971" y="1784"/>
                  </a:lnTo>
                  <a:lnTo>
                    <a:pt x="1971" y="1784"/>
                  </a:lnTo>
                  <a:lnTo>
                    <a:pt x="1974" y="1784"/>
                  </a:lnTo>
                  <a:lnTo>
                    <a:pt x="1974" y="1784"/>
                  </a:lnTo>
                  <a:lnTo>
                    <a:pt x="1974" y="1784"/>
                  </a:lnTo>
                  <a:lnTo>
                    <a:pt x="1978" y="1784"/>
                  </a:lnTo>
                  <a:lnTo>
                    <a:pt x="1978" y="1784"/>
                  </a:lnTo>
                  <a:lnTo>
                    <a:pt x="1978" y="1784"/>
                  </a:lnTo>
                  <a:lnTo>
                    <a:pt x="1978" y="1784"/>
                  </a:lnTo>
                  <a:lnTo>
                    <a:pt x="1981" y="1779"/>
                  </a:lnTo>
                  <a:lnTo>
                    <a:pt x="1981" y="1779"/>
                  </a:lnTo>
                  <a:lnTo>
                    <a:pt x="1981" y="1779"/>
                  </a:lnTo>
                  <a:lnTo>
                    <a:pt x="1981" y="1779"/>
                  </a:lnTo>
                  <a:lnTo>
                    <a:pt x="1984" y="1779"/>
                  </a:lnTo>
                  <a:lnTo>
                    <a:pt x="1984" y="1779"/>
                  </a:lnTo>
                  <a:lnTo>
                    <a:pt x="1987" y="1779"/>
                  </a:lnTo>
                  <a:lnTo>
                    <a:pt x="1987" y="1779"/>
                  </a:lnTo>
                  <a:lnTo>
                    <a:pt x="1987" y="1779"/>
                  </a:lnTo>
                  <a:lnTo>
                    <a:pt x="1987" y="1779"/>
                  </a:lnTo>
                  <a:lnTo>
                    <a:pt x="1990" y="1784"/>
                  </a:lnTo>
                  <a:lnTo>
                    <a:pt x="1990" y="1784"/>
                  </a:lnTo>
                  <a:lnTo>
                    <a:pt x="1990" y="1784"/>
                  </a:lnTo>
                  <a:lnTo>
                    <a:pt x="1990" y="1784"/>
                  </a:lnTo>
                  <a:lnTo>
                    <a:pt x="1993" y="1784"/>
                  </a:lnTo>
                  <a:lnTo>
                    <a:pt x="1993" y="1784"/>
                  </a:lnTo>
                  <a:lnTo>
                    <a:pt x="1993" y="1789"/>
                  </a:lnTo>
                  <a:lnTo>
                    <a:pt x="1993" y="1789"/>
                  </a:lnTo>
                  <a:lnTo>
                    <a:pt x="1997" y="1789"/>
                  </a:lnTo>
                  <a:lnTo>
                    <a:pt x="1997" y="1789"/>
                  </a:lnTo>
                  <a:lnTo>
                    <a:pt x="1997" y="1789"/>
                  </a:lnTo>
                  <a:lnTo>
                    <a:pt x="2000" y="1789"/>
                  </a:lnTo>
                  <a:lnTo>
                    <a:pt x="2000" y="1789"/>
                  </a:lnTo>
                  <a:lnTo>
                    <a:pt x="2000" y="1789"/>
                  </a:lnTo>
                  <a:lnTo>
                    <a:pt x="2000" y="1789"/>
                  </a:lnTo>
                  <a:lnTo>
                    <a:pt x="2003" y="1789"/>
                  </a:lnTo>
                  <a:lnTo>
                    <a:pt x="2003" y="1789"/>
                  </a:lnTo>
                  <a:lnTo>
                    <a:pt x="2003" y="1789"/>
                  </a:lnTo>
                  <a:lnTo>
                    <a:pt x="2006" y="1789"/>
                  </a:lnTo>
                  <a:lnTo>
                    <a:pt x="2006" y="1789"/>
                  </a:lnTo>
                  <a:lnTo>
                    <a:pt x="2006" y="1789"/>
                  </a:lnTo>
                  <a:lnTo>
                    <a:pt x="2006" y="1789"/>
                  </a:lnTo>
                  <a:lnTo>
                    <a:pt x="2009" y="1789"/>
                  </a:lnTo>
                  <a:lnTo>
                    <a:pt x="2009" y="1789"/>
                  </a:lnTo>
                  <a:lnTo>
                    <a:pt x="2009" y="1789"/>
                  </a:lnTo>
                  <a:lnTo>
                    <a:pt x="2009" y="1789"/>
                  </a:lnTo>
                  <a:lnTo>
                    <a:pt x="2012" y="1789"/>
                  </a:lnTo>
                  <a:lnTo>
                    <a:pt x="2012" y="1789"/>
                  </a:lnTo>
                  <a:lnTo>
                    <a:pt x="2015" y="1789"/>
                  </a:lnTo>
                  <a:lnTo>
                    <a:pt x="2015" y="1789"/>
                  </a:lnTo>
                  <a:lnTo>
                    <a:pt x="2015" y="1789"/>
                  </a:lnTo>
                  <a:lnTo>
                    <a:pt x="2015" y="1789"/>
                  </a:lnTo>
                  <a:lnTo>
                    <a:pt x="2019" y="1789"/>
                  </a:lnTo>
                  <a:lnTo>
                    <a:pt x="2019" y="1789"/>
                  </a:lnTo>
                  <a:lnTo>
                    <a:pt x="2019" y="1789"/>
                  </a:lnTo>
                  <a:lnTo>
                    <a:pt x="2019" y="1789"/>
                  </a:lnTo>
                  <a:lnTo>
                    <a:pt x="2022" y="1789"/>
                  </a:lnTo>
                  <a:lnTo>
                    <a:pt x="2022" y="1789"/>
                  </a:lnTo>
                  <a:lnTo>
                    <a:pt x="2022" y="1789"/>
                  </a:lnTo>
                  <a:lnTo>
                    <a:pt x="2022" y="1789"/>
                  </a:lnTo>
                  <a:lnTo>
                    <a:pt x="2025" y="1789"/>
                  </a:lnTo>
                  <a:lnTo>
                    <a:pt x="2025" y="1789"/>
                  </a:lnTo>
                  <a:lnTo>
                    <a:pt x="2028" y="1789"/>
                  </a:lnTo>
                  <a:lnTo>
                    <a:pt x="2028" y="1789"/>
                  </a:lnTo>
                  <a:lnTo>
                    <a:pt x="2028" y="1784"/>
                  </a:lnTo>
                  <a:lnTo>
                    <a:pt x="2028" y="1784"/>
                  </a:lnTo>
                  <a:lnTo>
                    <a:pt x="2031" y="1784"/>
                  </a:lnTo>
                  <a:lnTo>
                    <a:pt x="2031" y="1784"/>
                  </a:lnTo>
                  <a:lnTo>
                    <a:pt x="2031" y="1784"/>
                  </a:lnTo>
                  <a:lnTo>
                    <a:pt x="2031" y="1784"/>
                  </a:lnTo>
                  <a:lnTo>
                    <a:pt x="2034" y="1784"/>
                  </a:lnTo>
                  <a:lnTo>
                    <a:pt x="2034" y="1784"/>
                  </a:lnTo>
                  <a:lnTo>
                    <a:pt x="2034" y="1784"/>
                  </a:lnTo>
                  <a:lnTo>
                    <a:pt x="2034" y="1784"/>
                  </a:lnTo>
                  <a:lnTo>
                    <a:pt x="2037" y="1784"/>
                  </a:lnTo>
                  <a:lnTo>
                    <a:pt x="2037" y="1784"/>
                  </a:lnTo>
                  <a:lnTo>
                    <a:pt x="2037" y="1784"/>
                  </a:lnTo>
                  <a:lnTo>
                    <a:pt x="2037" y="1784"/>
                  </a:lnTo>
                  <a:lnTo>
                    <a:pt x="2041" y="1784"/>
                  </a:lnTo>
                  <a:lnTo>
                    <a:pt x="2041" y="1784"/>
                  </a:lnTo>
                  <a:lnTo>
                    <a:pt x="2041" y="1789"/>
                  </a:lnTo>
                  <a:lnTo>
                    <a:pt x="2044" y="1789"/>
                  </a:lnTo>
                  <a:lnTo>
                    <a:pt x="2044" y="1789"/>
                  </a:lnTo>
                  <a:lnTo>
                    <a:pt x="2044" y="1789"/>
                  </a:lnTo>
                  <a:lnTo>
                    <a:pt x="2047" y="1789"/>
                  </a:lnTo>
                  <a:lnTo>
                    <a:pt x="2047" y="1789"/>
                  </a:lnTo>
                  <a:lnTo>
                    <a:pt x="2047" y="1789"/>
                  </a:lnTo>
                  <a:lnTo>
                    <a:pt x="2047" y="1789"/>
                  </a:lnTo>
                  <a:lnTo>
                    <a:pt x="2050" y="1789"/>
                  </a:lnTo>
                  <a:lnTo>
                    <a:pt x="2050" y="1789"/>
                  </a:lnTo>
                  <a:lnTo>
                    <a:pt x="2050" y="1789"/>
                  </a:lnTo>
                  <a:lnTo>
                    <a:pt x="2050" y="1789"/>
                  </a:lnTo>
                  <a:lnTo>
                    <a:pt x="2053" y="1789"/>
                  </a:lnTo>
                  <a:lnTo>
                    <a:pt x="2053" y="1789"/>
                  </a:lnTo>
                  <a:lnTo>
                    <a:pt x="2053" y="1789"/>
                  </a:lnTo>
                  <a:lnTo>
                    <a:pt x="2056" y="1789"/>
                  </a:lnTo>
                  <a:lnTo>
                    <a:pt x="2056" y="1789"/>
                  </a:lnTo>
                  <a:lnTo>
                    <a:pt x="2056" y="1789"/>
                  </a:lnTo>
                  <a:lnTo>
                    <a:pt x="2059" y="1789"/>
                  </a:lnTo>
                  <a:lnTo>
                    <a:pt x="2059" y="1789"/>
                  </a:lnTo>
                  <a:lnTo>
                    <a:pt x="2059" y="1789"/>
                  </a:lnTo>
                  <a:lnTo>
                    <a:pt x="2059" y="1789"/>
                  </a:lnTo>
                  <a:lnTo>
                    <a:pt x="2063" y="1789"/>
                  </a:lnTo>
                  <a:lnTo>
                    <a:pt x="2063" y="1789"/>
                  </a:lnTo>
                  <a:lnTo>
                    <a:pt x="2063" y="1789"/>
                  </a:lnTo>
                  <a:lnTo>
                    <a:pt x="2063" y="1789"/>
                  </a:lnTo>
                  <a:lnTo>
                    <a:pt x="2066" y="1784"/>
                  </a:lnTo>
                  <a:lnTo>
                    <a:pt x="2066" y="1784"/>
                  </a:lnTo>
                  <a:lnTo>
                    <a:pt x="2069" y="1784"/>
                  </a:lnTo>
                  <a:lnTo>
                    <a:pt x="2069" y="1784"/>
                  </a:lnTo>
                  <a:lnTo>
                    <a:pt x="2069" y="1784"/>
                  </a:lnTo>
                  <a:lnTo>
                    <a:pt x="2069" y="1784"/>
                  </a:lnTo>
                  <a:lnTo>
                    <a:pt x="2072" y="1779"/>
                  </a:lnTo>
                  <a:lnTo>
                    <a:pt x="2072" y="1779"/>
                  </a:lnTo>
                  <a:lnTo>
                    <a:pt x="2072" y="1779"/>
                  </a:lnTo>
                  <a:lnTo>
                    <a:pt x="2072" y="1779"/>
                  </a:lnTo>
                  <a:lnTo>
                    <a:pt x="2075" y="1779"/>
                  </a:lnTo>
                  <a:lnTo>
                    <a:pt x="2075" y="1779"/>
                  </a:lnTo>
                  <a:lnTo>
                    <a:pt x="2075" y="1779"/>
                  </a:lnTo>
                  <a:lnTo>
                    <a:pt x="2075" y="1779"/>
                  </a:lnTo>
                  <a:lnTo>
                    <a:pt x="2078" y="1784"/>
                  </a:lnTo>
                  <a:lnTo>
                    <a:pt x="2078" y="1784"/>
                  </a:lnTo>
                  <a:lnTo>
                    <a:pt x="2078" y="1784"/>
                  </a:lnTo>
                  <a:lnTo>
                    <a:pt x="2078" y="1784"/>
                  </a:lnTo>
                  <a:lnTo>
                    <a:pt x="2081" y="1784"/>
                  </a:lnTo>
                  <a:lnTo>
                    <a:pt x="2081" y="1784"/>
                  </a:lnTo>
                  <a:lnTo>
                    <a:pt x="2081" y="1784"/>
                  </a:lnTo>
                  <a:lnTo>
                    <a:pt x="2085" y="1784"/>
                  </a:lnTo>
                  <a:lnTo>
                    <a:pt x="2085" y="1784"/>
                  </a:lnTo>
                  <a:lnTo>
                    <a:pt x="2085" y="1784"/>
                  </a:lnTo>
                  <a:lnTo>
                    <a:pt x="2088" y="1789"/>
                  </a:lnTo>
                  <a:lnTo>
                    <a:pt x="2088" y="1789"/>
                  </a:lnTo>
                  <a:lnTo>
                    <a:pt x="2088" y="1789"/>
                  </a:lnTo>
                  <a:lnTo>
                    <a:pt x="2088" y="1789"/>
                  </a:lnTo>
                  <a:lnTo>
                    <a:pt x="2091" y="1789"/>
                  </a:lnTo>
                  <a:lnTo>
                    <a:pt x="2091" y="1789"/>
                  </a:lnTo>
                  <a:lnTo>
                    <a:pt x="2091" y="1789"/>
                  </a:lnTo>
                  <a:lnTo>
                    <a:pt x="2091" y="1789"/>
                  </a:lnTo>
                  <a:lnTo>
                    <a:pt x="2094" y="1789"/>
                  </a:lnTo>
                  <a:lnTo>
                    <a:pt x="2094" y="1789"/>
                  </a:lnTo>
                  <a:lnTo>
                    <a:pt x="2094" y="1789"/>
                  </a:lnTo>
                  <a:lnTo>
                    <a:pt x="2097" y="1789"/>
                  </a:lnTo>
                  <a:lnTo>
                    <a:pt x="2097" y="1789"/>
                  </a:lnTo>
                  <a:lnTo>
                    <a:pt x="2097" y="1789"/>
                  </a:lnTo>
                  <a:lnTo>
                    <a:pt x="2100" y="1789"/>
                  </a:lnTo>
                  <a:lnTo>
                    <a:pt x="2100" y="1789"/>
                  </a:lnTo>
                  <a:lnTo>
                    <a:pt x="2100" y="1789"/>
                  </a:lnTo>
                  <a:lnTo>
                    <a:pt x="2100" y="1789"/>
                  </a:lnTo>
                  <a:lnTo>
                    <a:pt x="2103" y="1789"/>
                  </a:lnTo>
                  <a:lnTo>
                    <a:pt x="2103" y="1789"/>
                  </a:lnTo>
                  <a:lnTo>
                    <a:pt x="2103" y="1789"/>
                  </a:lnTo>
                  <a:lnTo>
                    <a:pt x="2103" y="1789"/>
                  </a:lnTo>
                  <a:lnTo>
                    <a:pt x="2107" y="1784"/>
                  </a:lnTo>
                  <a:lnTo>
                    <a:pt x="2107" y="1784"/>
                  </a:lnTo>
                  <a:lnTo>
                    <a:pt x="2107" y="1784"/>
                  </a:lnTo>
                  <a:lnTo>
                    <a:pt x="2110" y="1784"/>
                  </a:lnTo>
                  <a:lnTo>
                    <a:pt x="2110" y="1784"/>
                  </a:lnTo>
                  <a:lnTo>
                    <a:pt x="2110" y="1784"/>
                  </a:lnTo>
                  <a:lnTo>
                    <a:pt x="2113" y="1784"/>
                  </a:lnTo>
                  <a:lnTo>
                    <a:pt x="2113" y="1784"/>
                  </a:lnTo>
                  <a:lnTo>
                    <a:pt x="2113" y="1784"/>
                  </a:lnTo>
                  <a:lnTo>
                    <a:pt x="2113" y="1784"/>
                  </a:lnTo>
                  <a:lnTo>
                    <a:pt x="2116" y="1784"/>
                  </a:lnTo>
                  <a:lnTo>
                    <a:pt x="2116" y="1784"/>
                  </a:lnTo>
                  <a:lnTo>
                    <a:pt x="2116" y="1789"/>
                  </a:lnTo>
                  <a:lnTo>
                    <a:pt x="2116" y="1789"/>
                  </a:lnTo>
                  <a:lnTo>
                    <a:pt x="2119" y="1789"/>
                  </a:lnTo>
                  <a:lnTo>
                    <a:pt x="2119" y="1789"/>
                  </a:lnTo>
                  <a:lnTo>
                    <a:pt x="2119" y="1789"/>
                  </a:lnTo>
                  <a:lnTo>
                    <a:pt x="2122" y="1789"/>
                  </a:lnTo>
                  <a:lnTo>
                    <a:pt x="2122" y="1789"/>
                  </a:lnTo>
                  <a:lnTo>
                    <a:pt x="2122" y="1789"/>
                  </a:lnTo>
                  <a:lnTo>
                    <a:pt x="2122" y="1789"/>
                  </a:lnTo>
                  <a:lnTo>
                    <a:pt x="2125" y="1789"/>
                  </a:lnTo>
                  <a:lnTo>
                    <a:pt x="2125" y="1784"/>
                  </a:lnTo>
                  <a:lnTo>
                    <a:pt x="2125" y="1784"/>
                  </a:lnTo>
                  <a:lnTo>
                    <a:pt x="2129" y="1784"/>
                  </a:lnTo>
                  <a:lnTo>
                    <a:pt x="2129" y="1784"/>
                  </a:lnTo>
                  <a:lnTo>
                    <a:pt x="2129" y="1784"/>
                  </a:lnTo>
                  <a:lnTo>
                    <a:pt x="2129" y="1784"/>
                  </a:lnTo>
                  <a:lnTo>
                    <a:pt x="2132" y="1784"/>
                  </a:lnTo>
                  <a:lnTo>
                    <a:pt x="2132" y="1784"/>
                  </a:lnTo>
                  <a:lnTo>
                    <a:pt x="2132" y="1784"/>
                  </a:lnTo>
                  <a:lnTo>
                    <a:pt x="2132" y="1784"/>
                  </a:lnTo>
                  <a:lnTo>
                    <a:pt x="2135" y="1784"/>
                  </a:lnTo>
                  <a:lnTo>
                    <a:pt x="2135" y="1784"/>
                  </a:lnTo>
                  <a:lnTo>
                    <a:pt x="2135" y="1784"/>
                  </a:lnTo>
                  <a:lnTo>
                    <a:pt x="2135" y="1784"/>
                  </a:lnTo>
                  <a:lnTo>
                    <a:pt x="2138" y="1784"/>
                  </a:lnTo>
                  <a:lnTo>
                    <a:pt x="2138" y="1784"/>
                  </a:lnTo>
                  <a:lnTo>
                    <a:pt x="2141" y="1784"/>
                  </a:lnTo>
                  <a:lnTo>
                    <a:pt x="2141" y="1784"/>
                  </a:lnTo>
                  <a:lnTo>
                    <a:pt x="2141" y="1784"/>
                  </a:lnTo>
                  <a:lnTo>
                    <a:pt x="2141" y="1784"/>
                  </a:lnTo>
                  <a:lnTo>
                    <a:pt x="2144" y="1784"/>
                  </a:lnTo>
                  <a:lnTo>
                    <a:pt x="2144" y="1784"/>
                  </a:lnTo>
                  <a:lnTo>
                    <a:pt x="2144" y="1784"/>
                  </a:lnTo>
                  <a:lnTo>
                    <a:pt x="2144" y="1784"/>
                  </a:lnTo>
                  <a:lnTo>
                    <a:pt x="2147" y="1784"/>
                  </a:lnTo>
                  <a:lnTo>
                    <a:pt x="2147" y="1784"/>
                  </a:lnTo>
                  <a:lnTo>
                    <a:pt x="2147" y="1789"/>
                  </a:lnTo>
                  <a:lnTo>
                    <a:pt x="2147" y="1789"/>
                  </a:lnTo>
                  <a:lnTo>
                    <a:pt x="2151" y="1789"/>
                  </a:lnTo>
                  <a:lnTo>
                    <a:pt x="2151" y="1789"/>
                  </a:lnTo>
                  <a:lnTo>
                    <a:pt x="2154" y="1789"/>
                  </a:lnTo>
                  <a:lnTo>
                    <a:pt x="2154" y="1789"/>
                  </a:lnTo>
                  <a:lnTo>
                    <a:pt x="2154" y="1789"/>
                  </a:lnTo>
                  <a:lnTo>
                    <a:pt x="2154" y="1789"/>
                  </a:lnTo>
                  <a:lnTo>
                    <a:pt x="2157" y="1789"/>
                  </a:lnTo>
                  <a:lnTo>
                    <a:pt x="2157" y="1789"/>
                  </a:lnTo>
                  <a:lnTo>
                    <a:pt x="2157" y="1789"/>
                  </a:lnTo>
                  <a:lnTo>
                    <a:pt x="2157" y="1789"/>
                  </a:lnTo>
                  <a:lnTo>
                    <a:pt x="2160" y="1789"/>
                  </a:lnTo>
                  <a:lnTo>
                    <a:pt x="2160" y="1789"/>
                  </a:lnTo>
                  <a:lnTo>
                    <a:pt x="2160" y="1789"/>
                  </a:lnTo>
                  <a:lnTo>
                    <a:pt x="2160" y="1789"/>
                  </a:lnTo>
                  <a:lnTo>
                    <a:pt x="2163" y="1789"/>
                  </a:lnTo>
                  <a:lnTo>
                    <a:pt x="2163" y="1789"/>
                  </a:lnTo>
                  <a:lnTo>
                    <a:pt x="2166" y="1789"/>
                  </a:lnTo>
                  <a:lnTo>
                    <a:pt x="2166" y="1789"/>
                  </a:lnTo>
                  <a:lnTo>
                    <a:pt x="2166" y="1789"/>
                  </a:lnTo>
                  <a:lnTo>
                    <a:pt x="2166" y="1789"/>
                  </a:lnTo>
                  <a:lnTo>
                    <a:pt x="2169" y="1789"/>
                  </a:lnTo>
                  <a:lnTo>
                    <a:pt x="2169" y="1789"/>
                  </a:lnTo>
                  <a:lnTo>
                    <a:pt x="2169" y="1789"/>
                  </a:lnTo>
                  <a:lnTo>
                    <a:pt x="2169" y="1789"/>
                  </a:lnTo>
                  <a:lnTo>
                    <a:pt x="2173" y="1789"/>
                  </a:lnTo>
                  <a:lnTo>
                    <a:pt x="2173" y="1789"/>
                  </a:lnTo>
                  <a:lnTo>
                    <a:pt x="2173" y="1789"/>
                  </a:lnTo>
                  <a:lnTo>
                    <a:pt x="2173" y="1789"/>
                  </a:lnTo>
                  <a:lnTo>
                    <a:pt x="2176" y="1789"/>
                  </a:lnTo>
                  <a:lnTo>
                    <a:pt x="2176" y="1789"/>
                  </a:lnTo>
                  <a:lnTo>
                    <a:pt x="2176" y="1789"/>
                  </a:lnTo>
                  <a:lnTo>
                    <a:pt x="2176" y="1789"/>
                  </a:lnTo>
                  <a:lnTo>
                    <a:pt x="2179" y="1789"/>
                  </a:lnTo>
                  <a:lnTo>
                    <a:pt x="2179" y="1789"/>
                  </a:lnTo>
                  <a:lnTo>
                    <a:pt x="2179" y="1789"/>
                  </a:lnTo>
                  <a:lnTo>
                    <a:pt x="2182" y="1789"/>
                  </a:lnTo>
                  <a:lnTo>
                    <a:pt x="2182" y="1789"/>
                  </a:lnTo>
                  <a:lnTo>
                    <a:pt x="2182" y="1789"/>
                  </a:lnTo>
                  <a:lnTo>
                    <a:pt x="2185" y="1789"/>
                  </a:lnTo>
                  <a:lnTo>
                    <a:pt x="2185" y="1789"/>
                  </a:lnTo>
                  <a:lnTo>
                    <a:pt x="2185" y="1789"/>
                  </a:lnTo>
                  <a:lnTo>
                    <a:pt x="2185" y="1789"/>
                  </a:lnTo>
                  <a:lnTo>
                    <a:pt x="2188" y="1789"/>
                  </a:lnTo>
                  <a:lnTo>
                    <a:pt x="2188" y="1789"/>
                  </a:lnTo>
                  <a:lnTo>
                    <a:pt x="2188" y="1789"/>
                  </a:lnTo>
                  <a:lnTo>
                    <a:pt x="2188" y="1789"/>
                  </a:lnTo>
                  <a:lnTo>
                    <a:pt x="2191" y="1789"/>
                  </a:lnTo>
                  <a:lnTo>
                    <a:pt x="2191" y="1789"/>
                  </a:lnTo>
                  <a:lnTo>
                    <a:pt x="2191" y="1789"/>
                  </a:lnTo>
                  <a:lnTo>
                    <a:pt x="2195" y="1789"/>
                  </a:lnTo>
                  <a:lnTo>
                    <a:pt x="2195" y="1789"/>
                  </a:lnTo>
                  <a:lnTo>
                    <a:pt x="2195" y="1789"/>
                  </a:lnTo>
                  <a:lnTo>
                    <a:pt x="2198" y="1789"/>
                  </a:lnTo>
                  <a:lnTo>
                    <a:pt x="2198" y="1789"/>
                  </a:lnTo>
                  <a:lnTo>
                    <a:pt x="2198" y="1789"/>
                  </a:lnTo>
                  <a:lnTo>
                    <a:pt x="2198" y="1789"/>
                  </a:lnTo>
                  <a:lnTo>
                    <a:pt x="2201" y="1789"/>
                  </a:lnTo>
                  <a:lnTo>
                    <a:pt x="2201" y="1789"/>
                  </a:lnTo>
                  <a:lnTo>
                    <a:pt x="2201" y="1789"/>
                  </a:lnTo>
                  <a:lnTo>
                    <a:pt x="2201" y="1789"/>
                  </a:lnTo>
                  <a:lnTo>
                    <a:pt x="2204" y="1789"/>
                  </a:lnTo>
                  <a:lnTo>
                    <a:pt x="2204" y="1789"/>
                  </a:lnTo>
                  <a:lnTo>
                    <a:pt x="2204" y="1789"/>
                  </a:lnTo>
                  <a:lnTo>
                    <a:pt x="2207" y="1789"/>
                  </a:lnTo>
                  <a:lnTo>
                    <a:pt x="2207" y="1789"/>
                  </a:lnTo>
                  <a:lnTo>
                    <a:pt x="2207" y="1789"/>
                  </a:lnTo>
                  <a:lnTo>
                    <a:pt x="2210" y="1789"/>
                  </a:lnTo>
                  <a:lnTo>
                    <a:pt x="2210" y="1789"/>
                  </a:lnTo>
                  <a:lnTo>
                    <a:pt x="2210" y="1789"/>
                  </a:lnTo>
                  <a:lnTo>
                    <a:pt x="2210" y="1789"/>
                  </a:lnTo>
                  <a:lnTo>
                    <a:pt x="2213" y="1789"/>
                  </a:lnTo>
                  <a:lnTo>
                    <a:pt x="2213" y="1789"/>
                  </a:lnTo>
                  <a:lnTo>
                    <a:pt x="2213" y="1789"/>
                  </a:lnTo>
                  <a:lnTo>
                    <a:pt x="2213" y="1789"/>
                  </a:lnTo>
                  <a:lnTo>
                    <a:pt x="2217" y="1789"/>
                  </a:lnTo>
                  <a:lnTo>
                    <a:pt x="2217" y="1789"/>
                  </a:lnTo>
                  <a:lnTo>
                    <a:pt x="2217" y="1789"/>
                  </a:lnTo>
                  <a:lnTo>
                    <a:pt x="2217" y="1789"/>
                  </a:lnTo>
                  <a:lnTo>
                    <a:pt x="2220" y="1789"/>
                  </a:lnTo>
                  <a:lnTo>
                    <a:pt x="2220" y="1789"/>
                  </a:lnTo>
                  <a:lnTo>
                    <a:pt x="2220" y="1789"/>
                  </a:lnTo>
                  <a:lnTo>
                    <a:pt x="2223" y="1789"/>
                  </a:lnTo>
                  <a:lnTo>
                    <a:pt x="2223" y="1789"/>
                  </a:lnTo>
                  <a:lnTo>
                    <a:pt x="2223" y="1789"/>
                  </a:lnTo>
                  <a:lnTo>
                    <a:pt x="2223" y="1789"/>
                  </a:lnTo>
                  <a:lnTo>
                    <a:pt x="2226" y="1789"/>
                  </a:lnTo>
                  <a:lnTo>
                    <a:pt x="2226" y="1789"/>
                  </a:lnTo>
                  <a:lnTo>
                    <a:pt x="2226" y="1789"/>
                  </a:lnTo>
                  <a:lnTo>
                    <a:pt x="2229" y="1789"/>
                  </a:lnTo>
                  <a:lnTo>
                    <a:pt x="2229" y="1789"/>
                  </a:lnTo>
                  <a:lnTo>
                    <a:pt x="2229" y="1789"/>
                  </a:lnTo>
                  <a:lnTo>
                    <a:pt x="2229" y="1789"/>
                  </a:lnTo>
                  <a:lnTo>
                    <a:pt x="2232" y="1789"/>
                  </a:lnTo>
                  <a:lnTo>
                    <a:pt x="2232" y="1789"/>
                  </a:lnTo>
                  <a:lnTo>
                    <a:pt x="2232" y="1789"/>
                  </a:lnTo>
                  <a:lnTo>
                    <a:pt x="2235" y="1789"/>
                  </a:lnTo>
                  <a:lnTo>
                    <a:pt x="2235" y="1789"/>
                  </a:lnTo>
                  <a:lnTo>
                    <a:pt x="2235" y="1789"/>
                  </a:lnTo>
                  <a:lnTo>
                    <a:pt x="2239" y="1789"/>
                  </a:lnTo>
                  <a:lnTo>
                    <a:pt x="2239" y="1789"/>
                  </a:lnTo>
                  <a:lnTo>
                    <a:pt x="2239" y="1789"/>
                  </a:lnTo>
                  <a:lnTo>
                    <a:pt x="2239" y="1789"/>
                  </a:lnTo>
                  <a:lnTo>
                    <a:pt x="2242" y="1789"/>
                  </a:lnTo>
                  <a:lnTo>
                    <a:pt x="2242" y="1789"/>
                  </a:lnTo>
                  <a:lnTo>
                    <a:pt x="2242" y="1789"/>
                  </a:lnTo>
                  <a:lnTo>
                    <a:pt x="2242" y="1789"/>
                  </a:lnTo>
                  <a:lnTo>
                    <a:pt x="2245" y="1789"/>
                  </a:lnTo>
                  <a:lnTo>
                    <a:pt x="2245" y="1789"/>
                  </a:lnTo>
                  <a:lnTo>
                    <a:pt x="2245" y="1789"/>
                  </a:lnTo>
                  <a:lnTo>
                    <a:pt x="2248" y="1789"/>
                  </a:lnTo>
                  <a:lnTo>
                    <a:pt x="2248" y="1789"/>
                  </a:lnTo>
                  <a:lnTo>
                    <a:pt x="2248" y="1789"/>
                  </a:lnTo>
                  <a:lnTo>
                    <a:pt x="2251" y="1789"/>
                  </a:lnTo>
                  <a:lnTo>
                    <a:pt x="2251" y="1789"/>
                  </a:lnTo>
                  <a:lnTo>
                    <a:pt x="2251" y="1789"/>
                  </a:lnTo>
                  <a:lnTo>
                    <a:pt x="2251" y="1789"/>
                  </a:lnTo>
                  <a:lnTo>
                    <a:pt x="2254" y="1789"/>
                  </a:lnTo>
                  <a:lnTo>
                    <a:pt x="2254" y="1789"/>
                  </a:lnTo>
                  <a:lnTo>
                    <a:pt x="2254" y="1789"/>
                  </a:lnTo>
                  <a:lnTo>
                    <a:pt x="2254" y="1789"/>
                  </a:lnTo>
                  <a:lnTo>
                    <a:pt x="2257" y="1789"/>
                  </a:lnTo>
                  <a:lnTo>
                    <a:pt x="2257" y="1789"/>
                  </a:lnTo>
                  <a:lnTo>
                    <a:pt x="2257" y="1789"/>
                  </a:lnTo>
                  <a:lnTo>
                    <a:pt x="2257" y="1789"/>
                  </a:lnTo>
                  <a:lnTo>
                    <a:pt x="2261" y="1789"/>
                  </a:lnTo>
                  <a:lnTo>
                    <a:pt x="2261" y="1789"/>
                  </a:lnTo>
                  <a:lnTo>
                    <a:pt x="2261" y="1789"/>
                  </a:lnTo>
                  <a:lnTo>
                    <a:pt x="2264" y="1789"/>
                  </a:lnTo>
                  <a:lnTo>
                    <a:pt x="2264" y="1789"/>
                  </a:lnTo>
                  <a:lnTo>
                    <a:pt x="2264" y="1789"/>
                  </a:lnTo>
                  <a:lnTo>
                    <a:pt x="2267" y="1789"/>
                  </a:lnTo>
                  <a:lnTo>
                    <a:pt x="2267" y="1789"/>
                  </a:lnTo>
                  <a:lnTo>
                    <a:pt x="2267" y="1789"/>
                  </a:lnTo>
                  <a:lnTo>
                    <a:pt x="2267" y="1789"/>
                  </a:lnTo>
                  <a:lnTo>
                    <a:pt x="2270" y="1789"/>
                  </a:lnTo>
                  <a:lnTo>
                    <a:pt x="2270" y="1789"/>
                  </a:lnTo>
                  <a:lnTo>
                    <a:pt x="2270" y="1789"/>
                  </a:lnTo>
                  <a:lnTo>
                    <a:pt x="2270" y="1789"/>
                  </a:lnTo>
                  <a:lnTo>
                    <a:pt x="2273" y="1789"/>
                  </a:lnTo>
                  <a:lnTo>
                    <a:pt x="2273" y="1789"/>
                  </a:lnTo>
                  <a:lnTo>
                    <a:pt x="2273" y="1789"/>
                  </a:lnTo>
                  <a:lnTo>
                    <a:pt x="2273" y="1789"/>
                  </a:lnTo>
                  <a:lnTo>
                    <a:pt x="2276" y="1789"/>
                  </a:lnTo>
                  <a:lnTo>
                    <a:pt x="2276" y="1789"/>
                  </a:lnTo>
                  <a:lnTo>
                    <a:pt x="2276" y="1789"/>
                  </a:lnTo>
                  <a:lnTo>
                    <a:pt x="2279" y="1789"/>
                  </a:lnTo>
                  <a:lnTo>
                    <a:pt x="2279" y="1789"/>
                  </a:lnTo>
                  <a:lnTo>
                    <a:pt x="2279" y="1789"/>
                  </a:lnTo>
                  <a:lnTo>
                    <a:pt x="2283" y="1789"/>
                  </a:lnTo>
                  <a:lnTo>
                    <a:pt x="2283" y="1789"/>
                  </a:lnTo>
                  <a:lnTo>
                    <a:pt x="2283" y="1789"/>
                  </a:lnTo>
                  <a:lnTo>
                    <a:pt x="2283" y="1789"/>
                  </a:lnTo>
                  <a:lnTo>
                    <a:pt x="2286" y="1789"/>
                  </a:lnTo>
                  <a:lnTo>
                    <a:pt x="2286" y="1789"/>
                  </a:lnTo>
                  <a:lnTo>
                    <a:pt x="2286" y="1789"/>
                  </a:lnTo>
                  <a:lnTo>
                    <a:pt x="2286" y="1789"/>
                  </a:lnTo>
                  <a:lnTo>
                    <a:pt x="2289" y="1789"/>
                  </a:lnTo>
                  <a:lnTo>
                    <a:pt x="2289" y="1789"/>
                  </a:lnTo>
                  <a:lnTo>
                    <a:pt x="2292" y="1789"/>
                  </a:lnTo>
                  <a:lnTo>
                    <a:pt x="2292" y="1789"/>
                  </a:lnTo>
                  <a:lnTo>
                    <a:pt x="2292" y="1789"/>
                  </a:lnTo>
                  <a:lnTo>
                    <a:pt x="2292" y="1789"/>
                  </a:lnTo>
                  <a:lnTo>
                    <a:pt x="2295" y="1789"/>
                  </a:lnTo>
                  <a:lnTo>
                    <a:pt x="2295" y="1789"/>
                  </a:lnTo>
                  <a:lnTo>
                    <a:pt x="2295" y="1789"/>
                  </a:lnTo>
                  <a:lnTo>
                    <a:pt x="2295" y="1789"/>
                  </a:lnTo>
                  <a:lnTo>
                    <a:pt x="2298" y="1789"/>
                  </a:lnTo>
                  <a:lnTo>
                    <a:pt x="2298" y="1789"/>
                  </a:lnTo>
                  <a:lnTo>
                    <a:pt x="2298" y="1789"/>
                  </a:lnTo>
                  <a:lnTo>
                    <a:pt x="2298" y="1789"/>
                  </a:lnTo>
                  <a:lnTo>
                    <a:pt x="2301" y="1789"/>
                  </a:lnTo>
                  <a:lnTo>
                    <a:pt x="2301" y="1789"/>
                  </a:lnTo>
                  <a:lnTo>
                    <a:pt x="2301" y="1789"/>
                  </a:lnTo>
                  <a:lnTo>
                    <a:pt x="2301" y="1789"/>
                  </a:lnTo>
                  <a:lnTo>
                    <a:pt x="2305" y="1789"/>
                  </a:lnTo>
                  <a:lnTo>
                    <a:pt x="2305" y="1789"/>
                  </a:lnTo>
                  <a:lnTo>
                    <a:pt x="2308" y="1789"/>
                  </a:lnTo>
                  <a:lnTo>
                    <a:pt x="2308" y="1789"/>
                  </a:lnTo>
                  <a:lnTo>
                    <a:pt x="2308" y="1789"/>
                  </a:lnTo>
                  <a:lnTo>
                    <a:pt x="2308" y="1789"/>
                  </a:lnTo>
                  <a:lnTo>
                    <a:pt x="2311" y="1789"/>
                  </a:lnTo>
                  <a:lnTo>
                    <a:pt x="2311" y="1789"/>
                  </a:lnTo>
                  <a:lnTo>
                    <a:pt x="2311" y="1789"/>
                  </a:lnTo>
                  <a:lnTo>
                    <a:pt x="2311" y="1789"/>
                  </a:lnTo>
                  <a:lnTo>
                    <a:pt x="2314" y="1789"/>
                  </a:lnTo>
                  <a:lnTo>
                    <a:pt x="2314" y="1789"/>
                  </a:lnTo>
                  <a:lnTo>
                    <a:pt x="2314" y="1789"/>
                  </a:lnTo>
                  <a:lnTo>
                    <a:pt x="2314" y="1789"/>
                  </a:lnTo>
                  <a:lnTo>
                    <a:pt x="2317" y="1789"/>
                  </a:lnTo>
                  <a:lnTo>
                    <a:pt x="2317" y="1789"/>
                  </a:lnTo>
                  <a:lnTo>
                    <a:pt x="2317" y="1789"/>
                  </a:lnTo>
                  <a:lnTo>
                    <a:pt x="2320" y="1789"/>
                  </a:lnTo>
                  <a:lnTo>
                    <a:pt x="2320" y="1789"/>
                  </a:lnTo>
                  <a:lnTo>
                    <a:pt x="2320" y="1789"/>
                  </a:lnTo>
                  <a:lnTo>
                    <a:pt x="2323" y="1789"/>
                  </a:lnTo>
                  <a:lnTo>
                    <a:pt x="2323" y="1789"/>
                  </a:lnTo>
                  <a:lnTo>
                    <a:pt x="2323" y="1789"/>
                  </a:lnTo>
                  <a:lnTo>
                    <a:pt x="2323" y="1789"/>
                  </a:lnTo>
                  <a:lnTo>
                    <a:pt x="2327" y="1789"/>
                  </a:lnTo>
                  <a:lnTo>
                    <a:pt x="2327" y="1789"/>
                  </a:lnTo>
                  <a:lnTo>
                    <a:pt x="2327" y="1789"/>
                  </a:lnTo>
                  <a:lnTo>
                    <a:pt x="2327" y="1789"/>
                  </a:lnTo>
                  <a:lnTo>
                    <a:pt x="2330" y="1789"/>
                  </a:lnTo>
                  <a:lnTo>
                    <a:pt x="2330" y="1789"/>
                  </a:lnTo>
                  <a:lnTo>
                    <a:pt x="2333" y="1789"/>
                  </a:lnTo>
                  <a:lnTo>
                    <a:pt x="2333" y="1789"/>
                  </a:lnTo>
                  <a:lnTo>
                    <a:pt x="2333" y="1789"/>
                  </a:lnTo>
                  <a:lnTo>
                    <a:pt x="2333" y="1789"/>
                  </a:lnTo>
                  <a:lnTo>
                    <a:pt x="2336" y="1789"/>
                  </a:lnTo>
                  <a:lnTo>
                    <a:pt x="2336" y="1789"/>
                  </a:lnTo>
                  <a:lnTo>
                    <a:pt x="2336" y="1789"/>
                  </a:lnTo>
                  <a:lnTo>
                    <a:pt x="2336" y="1789"/>
                  </a:lnTo>
                  <a:lnTo>
                    <a:pt x="2336" y="1789"/>
                  </a:lnTo>
                  <a:lnTo>
                    <a:pt x="2339" y="1789"/>
                  </a:lnTo>
                  <a:lnTo>
                    <a:pt x="2339" y="1789"/>
                  </a:lnTo>
                  <a:lnTo>
                    <a:pt x="2339" y="1789"/>
                  </a:lnTo>
                  <a:lnTo>
                    <a:pt x="2342" y="1789"/>
                  </a:lnTo>
                  <a:lnTo>
                    <a:pt x="2342" y="1789"/>
                  </a:lnTo>
                  <a:lnTo>
                    <a:pt x="2342" y="1789"/>
                  </a:lnTo>
                  <a:lnTo>
                    <a:pt x="2345" y="1789"/>
                  </a:lnTo>
                  <a:lnTo>
                    <a:pt x="2345" y="1789"/>
                  </a:lnTo>
                  <a:lnTo>
                    <a:pt x="2345" y="1789"/>
                  </a:lnTo>
                  <a:lnTo>
                    <a:pt x="2349" y="1789"/>
                  </a:lnTo>
                  <a:lnTo>
                    <a:pt x="2349" y="1789"/>
                  </a:lnTo>
                  <a:lnTo>
                    <a:pt x="2349" y="1789"/>
                  </a:lnTo>
                  <a:lnTo>
                    <a:pt x="2349" y="1789"/>
                  </a:lnTo>
                  <a:lnTo>
                    <a:pt x="2352" y="1789"/>
                  </a:lnTo>
                  <a:lnTo>
                    <a:pt x="2352" y="1789"/>
                  </a:lnTo>
                  <a:lnTo>
                    <a:pt x="2352" y="1789"/>
                  </a:lnTo>
                  <a:lnTo>
                    <a:pt x="2352" y="1789"/>
                  </a:lnTo>
                  <a:lnTo>
                    <a:pt x="2355" y="1789"/>
                  </a:lnTo>
                  <a:lnTo>
                    <a:pt x="2355" y="1789"/>
                  </a:lnTo>
                  <a:lnTo>
                    <a:pt x="2355" y="1789"/>
                  </a:lnTo>
                  <a:lnTo>
                    <a:pt x="2355" y="1789"/>
                  </a:lnTo>
                  <a:lnTo>
                    <a:pt x="2358" y="1789"/>
                  </a:lnTo>
                  <a:lnTo>
                    <a:pt x="2358" y="1789"/>
                  </a:lnTo>
                  <a:lnTo>
                    <a:pt x="2358" y="1789"/>
                  </a:lnTo>
                  <a:lnTo>
                    <a:pt x="2361" y="1789"/>
                  </a:lnTo>
                  <a:lnTo>
                    <a:pt x="2361" y="1789"/>
                  </a:lnTo>
                  <a:lnTo>
                    <a:pt x="2361" y="1789"/>
                  </a:lnTo>
                  <a:lnTo>
                    <a:pt x="2364" y="1789"/>
                  </a:lnTo>
                  <a:lnTo>
                    <a:pt x="2364" y="1789"/>
                  </a:lnTo>
                  <a:lnTo>
                    <a:pt x="2364" y="1789"/>
                  </a:lnTo>
                  <a:lnTo>
                    <a:pt x="2364" y="1789"/>
                  </a:lnTo>
                  <a:lnTo>
                    <a:pt x="2367" y="1789"/>
                  </a:lnTo>
                  <a:lnTo>
                    <a:pt x="2367" y="1789"/>
                  </a:lnTo>
                  <a:lnTo>
                    <a:pt x="2367" y="1789"/>
                  </a:lnTo>
                  <a:lnTo>
                    <a:pt x="2367" y="1789"/>
                  </a:lnTo>
                  <a:lnTo>
                    <a:pt x="2371" y="1789"/>
                  </a:lnTo>
                  <a:lnTo>
                    <a:pt x="2371" y="1789"/>
                  </a:lnTo>
                  <a:lnTo>
                    <a:pt x="2371" y="1789"/>
                  </a:lnTo>
                  <a:lnTo>
                    <a:pt x="2371" y="1789"/>
                  </a:lnTo>
                  <a:lnTo>
                    <a:pt x="2374" y="1789"/>
                  </a:lnTo>
                  <a:lnTo>
                    <a:pt x="2374" y="1789"/>
                  </a:lnTo>
                  <a:lnTo>
                    <a:pt x="2377" y="1789"/>
                  </a:lnTo>
                  <a:lnTo>
                    <a:pt x="2377" y="1789"/>
                  </a:lnTo>
                  <a:lnTo>
                    <a:pt x="2377" y="1789"/>
                  </a:lnTo>
                  <a:lnTo>
                    <a:pt x="2377" y="1789"/>
                  </a:lnTo>
                  <a:lnTo>
                    <a:pt x="2380" y="1789"/>
                  </a:lnTo>
                  <a:lnTo>
                    <a:pt x="2380" y="1789"/>
                  </a:lnTo>
                  <a:lnTo>
                    <a:pt x="2380" y="1789"/>
                  </a:lnTo>
                  <a:lnTo>
                    <a:pt x="2380" y="1789"/>
                  </a:lnTo>
                  <a:lnTo>
                    <a:pt x="2383" y="1789"/>
                  </a:lnTo>
                  <a:lnTo>
                    <a:pt x="2383" y="1789"/>
                  </a:lnTo>
                  <a:lnTo>
                    <a:pt x="2383" y="1789"/>
                  </a:lnTo>
                  <a:lnTo>
                    <a:pt x="2386" y="1789"/>
                  </a:lnTo>
                  <a:lnTo>
                    <a:pt x="2386" y="1789"/>
                  </a:lnTo>
                  <a:lnTo>
                    <a:pt x="2386" y="1789"/>
                  </a:lnTo>
                  <a:lnTo>
                    <a:pt x="2389" y="1789"/>
                  </a:lnTo>
                  <a:lnTo>
                    <a:pt x="2389" y="1789"/>
                  </a:lnTo>
                  <a:lnTo>
                    <a:pt x="2389" y="1789"/>
                  </a:lnTo>
                  <a:lnTo>
                    <a:pt x="2389" y="1789"/>
                  </a:lnTo>
                  <a:lnTo>
                    <a:pt x="2393" y="1789"/>
                  </a:lnTo>
                  <a:lnTo>
                    <a:pt x="2393" y="1789"/>
                  </a:lnTo>
                  <a:lnTo>
                    <a:pt x="2393" y="1789"/>
                  </a:lnTo>
                  <a:lnTo>
                    <a:pt x="2393" y="1789"/>
                  </a:lnTo>
                  <a:lnTo>
                    <a:pt x="2396" y="1789"/>
                  </a:lnTo>
                  <a:lnTo>
                    <a:pt x="2396" y="1789"/>
                  </a:lnTo>
                  <a:lnTo>
                    <a:pt x="2396" y="1789"/>
                  </a:lnTo>
                  <a:lnTo>
                    <a:pt x="2396" y="1789"/>
                  </a:lnTo>
                  <a:lnTo>
                    <a:pt x="2399" y="1789"/>
                  </a:lnTo>
                  <a:lnTo>
                    <a:pt x="2399" y="1789"/>
                  </a:lnTo>
                  <a:lnTo>
                    <a:pt x="2399" y="1789"/>
                  </a:lnTo>
                  <a:lnTo>
                    <a:pt x="2399" y="1789"/>
                  </a:lnTo>
                  <a:lnTo>
                    <a:pt x="2402" y="1789"/>
                  </a:lnTo>
                  <a:lnTo>
                    <a:pt x="2402" y="1789"/>
                  </a:lnTo>
                  <a:lnTo>
                    <a:pt x="2405" y="1789"/>
                  </a:lnTo>
                  <a:lnTo>
                    <a:pt x="2405" y="1789"/>
                  </a:lnTo>
                  <a:lnTo>
                    <a:pt x="2405" y="1789"/>
                  </a:lnTo>
                  <a:lnTo>
                    <a:pt x="2405" y="1789"/>
                  </a:lnTo>
                  <a:lnTo>
                    <a:pt x="2408" y="1789"/>
                  </a:lnTo>
                  <a:lnTo>
                    <a:pt x="2408" y="1789"/>
                  </a:lnTo>
                  <a:lnTo>
                    <a:pt x="2408" y="1789"/>
                  </a:lnTo>
                  <a:lnTo>
                    <a:pt x="2408" y="1789"/>
                  </a:lnTo>
                  <a:lnTo>
                    <a:pt x="2411" y="1789"/>
                  </a:lnTo>
                  <a:lnTo>
                    <a:pt x="2411" y="1789"/>
                  </a:lnTo>
                  <a:lnTo>
                    <a:pt x="2411" y="1789"/>
                  </a:lnTo>
                  <a:lnTo>
                    <a:pt x="2411" y="1789"/>
                  </a:lnTo>
                  <a:lnTo>
                    <a:pt x="2415" y="1789"/>
                  </a:lnTo>
                  <a:lnTo>
                    <a:pt x="2415" y="1789"/>
                  </a:lnTo>
                  <a:lnTo>
                    <a:pt x="2415" y="1789"/>
                  </a:lnTo>
                  <a:lnTo>
                    <a:pt x="2418" y="1789"/>
                  </a:lnTo>
                  <a:lnTo>
                    <a:pt x="2418" y="1789"/>
                  </a:lnTo>
                  <a:lnTo>
                    <a:pt x="2418" y="1789"/>
                  </a:lnTo>
                  <a:lnTo>
                    <a:pt x="2421" y="1789"/>
                  </a:lnTo>
                  <a:lnTo>
                    <a:pt x="2421" y="1789"/>
                  </a:lnTo>
                  <a:lnTo>
                    <a:pt x="2421" y="1789"/>
                  </a:lnTo>
                  <a:lnTo>
                    <a:pt x="2421" y="1789"/>
                  </a:lnTo>
                  <a:lnTo>
                    <a:pt x="2424" y="1789"/>
                  </a:lnTo>
                  <a:lnTo>
                    <a:pt x="2424" y="1789"/>
                  </a:lnTo>
                  <a:lnTo>
                    <a:pt x="2424" y="1789"/>
                  </a:lnTo>
                  <a:lnTo>
                    <a:pt x="2427" y="1789"/>
                  </a:lnTo>
                  <a:lnTo>
                    <a:pt x="2427" y="1784"/>
                  </a:lnTo>
                  <a:lnTo>
                    <a:pt x="2427" y="1784"/>
                  </a:lnTo>
                  <a:lnTo>
                    <a:pt x="2430" y="1784"/>
                  </a:lnTo>
                  <a:lnTo>
                    <a:pt x="2430" y="1784"/>
                  </a:lnTo>
                  <a:lnTo>
                    <a:pt x="2430" y="1784"/>
                  </a:lnTo>
                  <a:lnTo>
                    <a:pt x="2430" y="1784"/>
                  </a:lnTo>
                  <a:lnTo>
                    <a:pt x="2433" y="1784"/>
                  </a:lnTo>
                  <a:lnTo>
                    <a:pt x="2433" y="1784"/>
                  </a:lnTo>
                  <a:lnTo>
                    <a:pt x="2433" y="1789"/>
                  </a:lnTo>
                  <a:lnTo>
                    <a:pt x="2433" y="1789"/>
                  </a:lnTo>
                  <a:lnTo>
                    <a:pt x="2437" y="1789"/>
                  </a:lnTo>
                  <a:lnTo>
                    <a:pt x="2437" y="1789"/>
                  </a:lnTo>
                  <a:lnTo>
                    <a:pt x="2437" y="1789"/>
                  </a:lnTo>
                  <a:lnTo>
                    <a:pt x="2437" y="1789"/>
                  </a:lnTo>
                  <a:lnTo>
                    <a:pt x="2440" y="1789"/>
                  </a:lnTo>
                  <a:lnTo>
                    <a:pt x="2440" y="1789"/>
                  </a:lnTo>
                  <a:lnTo>
                    <a:pt x="2440" y="1784"/>
                  </a:lnTo>
                  <a:lnTo>
                    <a:pt x="2440" y="1784"/>
                  </a:lnTo>
                  <a:lnTo>
                    <a:pt x="2443" y="1784"/>
                  </a:lnTo>
                  <a:lnTo>
                    <a:pt x="2443" y="1784"/>
                  </a:lnTo>
                  <a:lnTo>
                    <a:pt x="2446" y="1784"/>
                  </a:lnTo>
                  <a:lnTo>
                    <a:pt x="2446" y="1784"/>
                  </a:lnTo>
                  <a:lnTo>
                    <a:pt x="2446" y="1784"/>
                  </a:lnTo>
                  <a:lnTo>
                    <a:pt x="2446" y="1784"/>
                  </a:lnTo>
                  <a:lnTo>
                    <a:pt x="2449" y="1784"/>
                  </a:lnTo>
                  <a:lnTo>
                    <a:pt x="2449" y="1784"/>
                  </a:lnTo>
                  <a:lnTo>
                    <a:pt x="2449" y="1784"/>
                  </a:lnTo>
                  <a:lnTo>
                    <a:pt x="2449" y="1784"/>
                  </a:lnTo>
                  <a:lnTo>
                    <a:pt x="2452" y="1784"/>
                  </a:lnTo>
                  <a:lnTo>
                    <a:pt x="2452" y="1784"/>
                  </a:lnTo>
                  <a:lnTo>
                    <a:pt x="2452" y="1789"/>
                  </a:lnTo>
                  <a:lnTo>
                    <a:pt x="2452" y="1789"/>
                  </a:lnTo>
                  <a:lnTo>
                    <a:pt x="2455" y="1789"/>
                  </a:lnTo>
                  <a:lnTo>
                    <a:pt x="2455" y="1789"/>
                  </a:lnTo>
                  <a:lnTo>
                    <a:pt x="2455" y="1789"/>
                  </a:lnTo>
                  <a:lnTo>
                    <a:pt x="2459" y="1789"/>
                  </a:lnTo>
                  <a:lnTo>
                    <a:pt x="2459" y="1789"/>
                  </a:lnTo>
                  <a:lnTo>
                    <a:pt x="2459" y="1789"/>
                  </a:lnTo>
                  <a:lnTo>
                    <a:pt x="2462" y="1784"/>
                  </a:lnTo>
                  <a:lnTo>
                    <a:pt x="2462" y="1784"/>
                  </a:lnTo>
                  <a:lnTo>
                    <a:pt x="2462" y="1784"/>
                  </a:lnTo>
                  <a:lnTo>
                    <a:pt x="2462" y="1784"/>
                  </a:lnTo>
                  <a:lnTo>
                    <a:pt x="2465" y="1784"/>
                  </a:lnTo>
                  <a:lnTo>
                    <a:pt x="2465" y="1784"/>
                  </a:lnTo>
                  <a:lnTo>
                    <a:pt x="2465" y="1784"/>
                  </a:lnTo>
                  <a:lnTo>
                    <a:pt x="2465" y="1784"/>
                  </a:lnTo>
                  <a:lnTo>
                    <a:pt x="2468" y="1784"/>
                  </a:lnTo>
                  <a:lnTo>
                    <a:pt x="2468" y="1784"/>
                  </a:lnTo>
                  <a:lnTo>
                    <a:pt x="2468" y="1784"/>
                  </a:lnTo>
                  <a:lnTo>
                    <a:pt x="2471" y="1784"/>
                  </a:lnTo>
                  <a:lnTo>
                    <a:pt x="2471" y="1784"/>
                  </a:lnTo>
                  <a:lnTo>
                    <a:pt x="2471" y="1784"/>
                  </a:lnTo>
                  <a:lnTo>
                    <a:pt x="2471" y="1784"/>
                  </a:lnTo>
                  <a:lnTo>
                    <a:pt x="2474" y="1784"/>
                  </a:lnTo>
                  <a:lnTo>
                    <a:pt x="2474" y="1784"/>
                  </a:lnTo>
                  <a:lnTo>
                    <a:pt x="2474" y="1784"/>
                  </a:lnTo>
                  <a:lnTo>
                    <a:pt x="2477" y="1784"/>
                  </a:lnTo>
                  <a:lnTo>
                    <a:pt x="2477" y="1784"/>
                  </a:lnTo>
                  <a:lnTo>
                    <a:pt x="2477" y="1784"/>
                  </a:lnTo>
                  <a:lnTo>
                    <a:pt x="2477" y="1784"/>
                  </a:lnTo>
                  <a:lnTo>
                    <a:pt x="2481" y="1789"/>
                  </a:lnTo>
                  <a:lnTo>
                    <a:pt x="2481" y="1789"/>
                  </a:lnTo>
                  <a:lnTo>
                    <a:pt x="2481" y="1789"/>
                  </a:lnTo>
                  <a:lnTo>
                    <a:pt x="2481" y="1789"/>
                  </a:lnTo>
                  <a:lnTo>
                    <a:pt x="2484" y="1789"/>
                  </a:lnTo>
                  <a:lnTo>
                    <a:pt x="2484" y="1789"/>
                  </a:lnTo>
                  <a:lnTo>
                    <a:pt x="2487" y="1789"/>
                  </a:lnTo>
                  <a:lnTo>
                    <a:pt x="2487" y="1789"/>
                  </a:lnTo>
                  <a:lnTo>
                    <a:pt x="2487" y="1789"/>
                  </a:lnTo>
                  <a:lnTo>
                    <a:pt x="2487" y="1789"/>
                  </a:lnTo>
                  <a:lnTo>
                    <a:pt x="2487" y="1789"/>
                  </a:lnTo>
                  <a:lnTo>
                    <a:pt x="2490" y="1789"/>
                  </a:lnTo>
                  <a:lnTo>
                    <a:pt x="2490" y="1789"/>
                  </a:lnTo>
                  <a:lnTo>
                    <a:pt x="2493" y="1789"/>
                  </a:lnTo>
                  <a:lnTo>
                    <a:pt x="2493" y="1789"/>
                  </a:lnTo>
                  <a:lnTo>
                    <a:pt x="2493" y="1789"/>
                  </a:lnTo>
                  <a:lnTo>
                    <a:pt x="2493" y="1789"/>
                  </a:lnTo>
                  <a:lnTo>
                    <a:pt x="2493" y="1789"/>
                  </a:lnTo>
                  <a:lnTo>
                    <a:pt x="2496" y="1789"/>
                  </a:lnTo>
                  <a:lnTo>
                    <a:pt x="2496" y="1789"/>
                  </a:lnTo>
                  <a:lnTo>
                    <a:pt x="2496" y="1789"/>
                  </a:lnTo>
                  <a:lnTo>
                    <a:pt x="2499" y="1789"/>
                  </a:lnTo>
                  <a:lnTo>
                    <a:pt x="2499" y="1789"/>
                  </a:lnTo>
                  <a:lnTo>
                    <a:pt x="2499" y="1789"/>
                  </a:lnTo>
                  <a:lnTo>
                    <a:pt x="2503" y="1789"/>
                  </a:lnTo>
                  <a:lnTo>
                    <a:pt x="2503" y="1789"/>
                  </a:lnTo>
                  <a:lnTo>
                    <a:pt x="2503" y="1789"/>
                  </a:lnTo>
                  <a:lnTo>
                    <a:pt x="2503" y="1789"/>
                  </a:lnTo>
                  <a:lnTo>
                    <a:pt x="2506" y="1789"/>
                  </a:lnTo>
                  <a:lnTo>
                    <a:pt x="2506" y="1789"/>
                  </a:lnTo>
                  <a:lnTo>
                    <a:pt x="2506" y="1789"/>
                  </a:lnTo>
                  <a:lnTo>
                    <a:pt x="2506" y="1789"/>
                  </a:lnTo>
                  <a:lnTo>
                    <a:pt x="2509" y="1789"/>
                  </a:lnTo>
                  <a:lnTo>
                    <a:pt x="2509" y="1789"/>
                  </a:lnTo>
                  <a:lnTo>
                    <a:pt x="2509" y="1789"/>
                  </a:lnTo>
                  <a:lnTo>
                    <a:pt x="2509" y="1789"/>
                  </a:lnTo>
                  <a:lnTo>
                    <a:pt x="2512" y="1789"/>
                  </a:lnTo>
                  <a:lnTo>
                    <a:pt x="2512" y="1789"/>
                  </a:lnTo>
                  <a:lnTo>
                    <a:pt x="2512" y="1789"/>
                  </a:lnTo>
                  <a:lnTo>
                    <a:pt x="2515" y="1789"/>
                  </a:lnTo>
                  <a:lnTo>
                    <a:pt x="2515" y="1789"/>
                  </a:lnTo>
                  <a:lnTo>
                    <a:pt x="2515" y="1789"/>
                  </a:lnTo>
                  <a:lnTo>
                    <a:pt x="2518" y="1789"/>
                  </a:lnTo>
                  <a:lnTo>
                    <a:pt x="2518" y="1789"/>
                  </a:lnTo>
                  <a:lnTo>
                    <a:pt x="2518" y="1789"/>
                  </a:lnTo>
                  <a:lnTo>
                    <a:pt x="2518" y="1789"/>
                  </a:lnTo>
                  <a:lnTo>
                    <a:pt x="2521" y="1789"/>
                  </a:lnTo>
                  <a:lnTo>
                    <a:pt x="2521" y="1789"/>
                  </a:lnTo>
                  <a:lnTo>
                    <a:pt x="2521" y="1789"/>
                  </a:lnTo>
                  <a:lnTo>
                    <a:pt x="2525" y="1789"/>
                  </a:lnTo>
                  <a:lnTo>
                    <a:pt x="2525" y="1789"/>
                  </a:lnTo>
                  <a:lnTo>
                    <a:pt x="2525" y="1789"/>
                  </a:lnTo>
                  <a:lnTo>
                    <a:pt x="2528" y="1789"/>
                  </a:lnTo>
                  <a:lnTo>
                    <a:pt x="2528" y="1789"/>
                  </a:lnTo>
                  <a:lnTo>
                    <a:pt x="2528" y="1789"/>
                  </a:lnTo>
                  <a:lnTo>
                    <a:pt x="2528" y="1789"/>
                  </a:lnTo>
                  <a:lnTo>
                    <a:pt x="2531" y="1789"/>
                  </a:lnTo>
                  <a:lnTo>
                    <a:pt x="2531" y="1789"/>
                  </a:lnTo>
                  <a:lnTo>
                    <a:pt x="2531" y="1789"/>
                  </a:lnTo>
                  <a:lnTo>
                    <a:pt x="2531" y="1789"/>
                  </a:lnTo>
                  <a:lnTo>
                    <a:pt x="2534" y="1784"/>
                  </a:lnTo>
                  <a:lnTo>
                    <a:pt x="2534" y="1784"/>
                  </a:lnTo>
                  <a:lnTo>
                    <a:pt x="2534" y="1784"/>
                  </a:lnTo>
                  <a:lnTo>
                    <a:pt x="2534" y="1784"/>
                  </a:lnTo>
                  <a:lnTo>
                    <a:pt x="2537" y="1784"/>
                  </a:lnTo>
                  <a:lnTo>
                    <a:pt x="2537" y="1784"/>
                  </a:lnTo>
                  <a:lnTo>
                    <a:pt x="2537" y="1784"/>
                  </a:lnTo>
                  <a:lnTo>
                    <a:pt x="2537" y="1784"/>
                  </a:lnTo>
                  <a:lnTo>
                    <a:pt x="2540" y="1784"/>
                  </a:lnTo>
                  <a:lnTo>
                    <a:pt x="2540" y="1784"/>
                  </a:lnTo>
                  <a:lnTo>
                    <a:pt x="2540" y="1784"/>
                  </a:lnTo>
                  <a:lnTo>
                    <a:pt x="2543" y="1789"/>
                  </a:lnTo>
                  <a:lnTo>
                    <a:pt x="2543" y="1789"/>
                  </a:lnTo>
                  <a:lnTo>
                    <a:pt x="2543" y="1789"/>
                  </a:lnTo>
                  <a:lnTo>
                    <a:pt x="2547" y="1789"/>
                  </a:lnTo>
                  <a:lnTo>
                    <a:pt x="2547" y="1789"/>
                  </a:lnTo>
                  <a:lnTo>
                    <a:pt x="2547" y="1789"/>
                  </a:lnTo>
                  <a:lnTo>
                    <a:pt x="2547" y="1789"/>
                  </a:lnTo>
                  <a:lnTo>
                    <a:pt x="2550" y="1789"/>
                  </a:lnTo>
                  <a:lnTo>
                    <a:pt x="2550" y="1789"/>
                  </a:lnTo>
                  <a:lnTo>
                    <a:pt x="2550" y="1789"/>
                  </a:lnTo>
                  <a:lnTo>
                    <a:pt x="2550" y="1789"/>
                  </a:lnTo>
                  <a:lnTo>
                    <a:pt x="2553" y="1789"/>
                  </a:lnTo>
                  <a:lnTo>
                    <a:pt x="2553" y="1789"/>
                  </a:lnTo>
                  <a:lnTo>
                    <a:pt x="2556" y="1789"/>
                  </a:lnTo>
                  <a:lnTo>
                    <a:pt x="2556" y="1789"/>
                  </a:lnTo>
                  <a:lnTo>
                    <a:pt x="2556" y="1789"/>
                  </a:lnTo>
                  <a:lnTo>
                    <a:pt x="2556" y="1789"/>
                  </a:lnTo>
                  <a:lnTo>
                    <a:pt x="2559" y="1789"/>
                  </a:lnTo>
                  <a:lnTo>
                    <a:pt x="2559" y="1789"/>
                  </a:lnTo>
                  <a:lnTo>
                    <a:pt x="2559" y="1789"/>
                  </a:lnTo>
                  <a:lnTo>
                    <a:pt x="2559" y="1789"/>
                  </a:lnTo>
                  <a:lnTo>
                    <a:pt x="2562" y="1784"/>
                  </a:lnTo>
                  <a:lnTo>
                    <a:pt x="2562" y="1784"/>
                  </a:lnTo>
                  <a:lnTo>
                    <a:pt x="2562" y="1784"/>
                  </a:lnTo>
                  <a:lnTo>
                    <a:pt x="2562" y="1784"/>
                  </a:lnTo>
                  <a:lnTo>
                    <a:pt x="2565" y="1784"/>
                  </a:lnTo>
                  <a:lnTo>
                    <a:pt x="2565" y="1784"/>
                  </a:lnTo>
                  <a:lnTo>
                    <a:pt x="2569" y="1784"/>
                  </a:lnTo>
                  <a:lnTo>
                    <a:pt x="2569" y="1784"/>
                  </a:lnTo>
                  <a:lnTo>
                    <a:pt x="2569" y="1784"/>
                  </a:lnTo>
                  <a:lnTo>
                    <a:pt x="2569" y="1784"/>
                  </a:lnTo>
                  <a:lnTo>
                    <a:pt x="2572" y="1784"/>
                  </a:lnTo>
                  <a:lnTo>
                    <a:pt x="2572" y="1784"/>
                  </a:lnTo>
                  <a:lnTo>
                    <a:pt x="2572" y="1789"/>
                  </a:lnTo>
                  <a:lnTo>
                    <a:pt x="2572" y="1789"/>
                  </a:lnTo>
                  <a:lnTo>
                    <a:pt x="2575" y="1789"/>
                  </a:lnTo>
                  <a:lnTo>
                    <a:pt x="2575" y="1789"/>
                  </a:lnTo>
                  <a:lnTo>
                    <a:pt x="2575" y="1789"/>
                  </a:lnTo>
                  <a:lnTo>
                    <a:pt x="2575" y="1789"/>
                  </a:lnTo>
                  <a:lnTo>
                    <a:pt x="2578" y="1789"/>
                  </a:lnTo>
                  <a:lnTo>
                    <a:pt x="2578" y="1789"/>
                  </a:lnTo>
                  <a:lnTo>
                    <a:pt x="2578" y="1789"/>
                  </a:lnTo>
                  <a:lnTo>
                    <a:pt x="2578" y="1789"/>
                  </a:lnTo>
                  <a:lnTo>
                    <a:pt x="2581" y="1789"/>
                  </a:lnTo>
                  <a:lnTo>
                    <a:pt x="2581" y="1789"/>
                  </a:lnTo>
                  <a:lnTo>
                    <a:pt x="2584" y="1789"/>
                  </a:lnTo>
                  <a:lnTo>
                    <a:pt x="2584" y="1789"/>
                  </a:lnTo>
                  <a:lnTo>
                    <a:pt x="2584" y="1784"/>
                  </a:lnTo>
                  <a:lnTo>
                    <a:pt x="2584" y="1784"/>
                  </a:lnTo>
                  <a:lnTo>
                    <a:pt x="2587" y="1784"/>
                  </a:lnTo>
                  <a:lnTo>
                    <a:pt x="2587" y="1784"/>
                  </a:lnTo>
                  <a:lnTo>
                    <a:pt x="2587" y="1784"/>
                  </a:lnTo>
                  <a:lnTo>
                    <a:pt x="2587" y="1784"/>
                  </a:lnTo>
                  <a:lnTo>
                    <a:pt x="2591" y="1784"/>
                  </a:lnTo>
                  <a:lnTo>
                    <a:pt x="2591" y="1784"/>
                  </a:lnTo>
                  <a:lnTo>
                    <a:pt x="2591" y="1784"/>
                  </a:lnTo>
                  <a:lnTo>
                    <a:pt x="2591" y="1784"/>
                  </a:lnTo>
                  <a:lnTo>
                    <a:pt x="2594" y="1789"/>
                  </a:lnTo>
                  <a:lnTo>
                    <a:pt x="2594" y="1789"/>
                  </a:lnTo>
                  <a:lnTo>
                    <a:pt x="2594" y="1789"/>
                  </a:lnTo>
                  <a:lnTo>
                    <a:pt x="2597" y="1789"/>
                  </a:lnTo>
                  <a:lnTo>
                    <a:pt x="2597" y="1789"/>
                  </a:lnTo>
                  <a:lnTo>
                    <a:pt x="2597" y="1789"/>
                  </a:lnTo>
                  <a:lnTo>
                    <a:pt x="2600" y="1789"/>
                  </a:lnTo>
                  <a:lnTo>
                    <a:pt x="2600" y="1789"/>
                  </a:lnTo>
                  <a:lnTo>
                    <a:pt x="2600" y="1789"/>
                  </a:lnTo>
                  <a:lnTo>
                    <a:pt x="2600" y="1789"/>
                  </a:lnTo>
                  <a:lnTo>
                    <a:pt x="2603" y="1789"/>
                  </a:lnTo>
                  <a:lnTo>
                    <a:pt x="2603" y="1789"/>
                  </a:lnTo>
                  <a:lnTo>
                    <a:pt x="2603" y="1789"/>
                  </a:lnTo>
                  <a:lnTo>
                    <a:pt x="2603" y="1789"/>
                  </a:lnTo>
                  <a:lnTo>
                    <a:pt x="2606" y="1789"/>
                  </a:lnTo>
                  <a:lnTo>
                    <a:pt x="2606" y="1789"/>
                  </a:lnTo>
                  <a:lnTo>
                    <a:pt x="2606" y="1789"/>
                  </a:lnTo>
                  <a:lnTo>
                    <a:pt x="2609" y="1789"/>
                  </a:lnTo>
                  <a:lnTo>
                    <a:pt x="2609" y="1789"/>
                  </a:lnTo>
                  <a:lnTo>
                    <a:pt x="2609" y="1789"/>
                  </a:lnTo>
                  <a:lnTo>
                    <a:pt x="2609" y="1789"/>
                  </a:lnTo>
                  <a:lnTo>
                    <a:pt x="2613" y="1789"/>
                  </a:lnTo>
                  <a:lnTo>
                    <a:pt x="2613" y="1789"/>
                  </a:lnTo>
                  <a:lnTo>
                    <a:pt x="2613" y="1789"/>
                  </a:lnTo>
                  <a:lnTo>
                    <a:pt x="2616" y="1789"/>
                  </a:lnTo>
                  <a:lnTo>
                    <a:pt x="2616" y="1789"/>
                  </a:lnTo>
                  <a:lnTo>
                    <a:pt x="2616" y="1789"/>
                  </a:lnTo>
                  <a:lnTo>
                    <a:pt x="2616" y="1789"/>
                  </a:lnTo>
                  <a:lnTo>
                    <a:pt x="2619" y="1784"/>
                  </a:lnTo>
                  <a:lnTo>
                    <a:pt x="2619" y="1784"/>
                  </a:lnTo>
                  <a:lnTo>
                    <a:pt x="2619" y="1784"/>
                  </a:lnTo>
                  <a:lnTo>
                    <a:pt x="2619" y="1784"/>
                  </a:lnTo>
                  <a:lnTo>
                    <a:pt x="2622" y="1784"/>
                  </a:lnTo>
                  <a:lnTo>
                    <a:pt x="2622" y="1784"/>
                  </a:lnTo>
                  <a:lnTo>
                    <a:pt x="2625" y="1784"/>
                  </a:lnTo>
                  <a:lnTo>
                    <a:pt x="2625" y="1784"/>
                  </a:lnTo>
                  <a:lnTo>
                    <a:pt x="2625" y="1784"/>
                  </a:lnTo>
                  <a:lnTo>
                    <a:pt x="2625" y="1784"/>
                  </a:lnTo>
                  <a:lnTo>
                    <a:pt x="2628" y="1784"/>
                  </a:lnTo>
                  <a:lnTo>
                    <a:pt x="2628" y="1784"/>
                  </a:lnTo>
                  <a:lnTo>
                    <a:pt x="2628" y="1784"/>
                  </a:lnTo>
                  <a:lnTo>
                    <a:pt x="2628" y="1784"/>
                  </a:lnTo>
                  <a:lnTo>
                    <a:pt x="2632" y="1784"/>
                  </a:lnTo>
                  <a:lnTo>
                    <a:pt x="2632" y="1784"/>
                  </a:lnTo>
                  <a:lnTo>
                    <a:pt x="2632" y="1784"/>
                  </a:lnTo>
                  <a:lnTo>
                    <a:pt x="2632" y="1784"/>
                  </a:lnTo>
                  <a:lnTo>
                    <a:pt x="2635" y="1784"/>
                  </a:lnTo>
                  <a:lnTo>
                    <a:pt x="2635" y="1784"/>
                  </a:lnTo>
                  <a:lnTo>
                    <a:pt x="2635" y="1789"/>
                  </a:lnTo>
                  <a:lnTo>
                    <a:pt x="2635" y="1789"/>
                  </a:lnTo>
                  <a:lnTo>
                    <a:pt x="2638" y="1789"/>
                  </a:lnTo>
                  <a:lnTo>
                    <a:pt x="2638" y="1789"/>
                  </a:lnTo>
                  <a:lnTo>
                    <a:pt x="2641" y="1789"/>
                  </a:lnTo>
                  <a:lnTo>
                    <a:pt x="2641" y="1789"/>
                  </a:lnTo>
                  <a:lnTo>
                    <a:pt x="2641" y="1789"/>
                  </a:lnTo>
                  <a:lnTo>
                    <a:pt x="2641" y="1789"/>
                  </a:lnTo>
                  <a:lnTo>
                    <a:pt x="2644" y="1789"/>
                  </a:lnTo>
                  <a:lnTo>
                    <a:pt x="2644" y="1784"/>
                  </a:lnTo>
                  <a:lnTo>
                    <a:pt x="2644" y="1784"/>
                  </a:lnTo>
                  <a:lnTo>
                    <a:pt x="2644" y="1784"/>
                  </a:lnTo>
                  <a:lnTo>
                    <a:pt x="2647" y="1784"/>
                  </a:lnTo>
                  <a:lnTo>
                    <a:pt x="2647" y="1784"/>
                  </a:lnTo>
                  <a:lnTo>
                    <a:pt x="2647" y="1784"/>
                  </a:lnTo>
                  <a:lnTo>
                    <a:pt x="2650" y="1784"/>
                  </a:lnTo>
                  <a:lnTo>
                    <a:pt x="2650" y="1784"/>
                  </a:lnTo>
                  <a:lnTo>
                    <a:pt x="2650" y="1784"/>
                  </a:lnTo>
                  <a:lnTo>
                    <a:pt x="2654" y="1784"/>
                  </a:lnTo>
                  <a:lnTo>
                    <a:pt x="2654" y="1784"/>
                  </a:lnTo>
                  <a:lnTo>
                    <a:pt x="2654" y="1784"/>
                  </a:lnTo>
                  <a:lnTo>
                    <a:pt x="2654" y="1784"/>
                  </a:lnTo>
                  <a:lnTo>
                    <a:pt x="2654" y="1784"/>
                  </a:lnTo>
                  <a:lnTo>
                    <a:pt x="2657" y="1784"/>
                  </a:lnTo>
                  <a:lnTo>
                    <a:pt x="2657" y="1784"/>
                  </a:lnTo>
                  <a:lnTo>
                    <a:pt x="2657" y="1784"/>
                  </a:lnTo>
                  <a:lnTo>
                    <a:pt x="2660" y="1784"/>
                  </a:lnTo>
                  <a:lnTo>
                    <a:pt x="2660" y="1784"/>
                  </a:lnTo>
                  <a:lnTo>
                    <a:pt x="2660" y="1784"/>
                  </a:lnTo>
                  <a:lnTo>
                    <a:pt x="2660" y="1784"/>
                  </a:lnTo>
                  <a:lnTo>
                    <a:pt x="2663" y="1784"/>
                  </a:lnTo>
                  <a:lnTo>
                    <a:pt x="2663" y="1784"/>
                  </a:lnTo>
                  <a:lnTo>
                    <a:pt x="2666" y="1784"/>
                  </a:lnTo>
                  <a:lnTo>
                    <a:pt x="2666" y="1784"/>
                  </a:lnTo>
                  <a:lnTo>
                    <a:pt x="2666" y="1784"/>
                  </a:lnTo>
                  <a:lnTo>
                    <a:pt x="2666" y="1784"/>
                  </a:lnTo>
                  <a:lnTo>
                    <a:pt x="2669" y="1784"/>
                  </a:lnTo>
                  <a:lnTo>
                    <a:pt x="2669" y="1784"/>
                  </a:lnTo>
                  <a:lnTo>
                    <a:pt x="2669" y="1784"/>
                  </a:lnTo>
                  <a:lnTo>
                    <a:pt x="2669" y="1784"/>
                  </a:lnTo>
                  <a:lnTo>
                    <a:pt x="2672" y="1784"/>
                  </a:lnTo>
                  <a:lnTo>
                    <a:pt x="2672" y="1784"/>
                  </a:lnTo>
                  <a:lnTo>
                    <a:pt x="2672" y="1784"/>
                  </a:lnTo>
                  <a:lnTo>
                    <a:pt x="2672" y="1784"/>
                  </a:lnTo>
                  <a:lnTo>
                    <a:pt x="2676" y="1784"/>
                  </a:lnTo>
                  <a:lnTo>
                    <a:pt x="2676" y="1784"/>
                  </a:lnTo>
                  <a:lnTo>
                    <a:pt x="2676" y="1784"/>
                  </a:lnTo>
                  <a:lnTo>
                    <a:pt x="2676" y="1784"/>
                  </a:lnTo>
                  <a:lnTo>
                    <a:pt x="2679" y="1784"/>
                  </a:lnTo>
                  <a:lnTo>
                    <a:pt x="2679" y="1784"/>
                  </a:lnTo>
                  <a:lnTo>
                    <a:pt x="2679" y="1784"/>
                  </a:lnTo>
                  <a:lnTo>
                    <a:pt x="2682" y="1784"/>
                  </a:lnTo>
                  <a:lnTo>
                    <a:pt x="2682" y="1784"/>
                  </a:lnTo>
                  <a:lnTo>
                    <a:pt x="2682" y="1784"/>
                  </a:lnTo>
                  <a:lnTo>
                    <a:pt x="2685" y="1784"/>
                  </a:lnTo>
                  <a:lnTo>
                    <a:pt x="2685" y="1784"/>
                  </a:lnTo>
                  <a:lnTo>
                    <a:pt x="2685" y="1789"/>
                  </a:lnTo>
                  <a:lnTo>
                    <a:pt x="2685" y="1789"/>
                  </a:lnTo>
                  <a:lnTo>
                    <a:pt x="2688" y="1789"/>
                  </a:lnTo>
                  <a:lnTo>
                    <a:pt x="2688" y="1789"/>
                  </a:lnTo>
                  <a:lnTo>
                    <a:pt x="2688" y="1789"/>
                  </a:lnTo>
                  <a:lnTo>
                    <a:pt x="2691" y="1789"/>
                  </a:lnTo>
                  <a:lnTo>
                    <a:pt x="2691" y="1789"/>
                  </a:lnTo>
                  <a:lnTo>
                    <a:pt x="2691" y="1789"/>
                  </a:lnTo>
                  <a:lnTo>
                    <a:pt x="2694" y="1789"/>
                  </a:lnTo>
                  <a:lnTo>
                    <a:pt x="2694" y="1789"/>
                  </a:lnTo>
                  <a:lnTo>
                    <a:pt x="2694" y="1789"/>
                  </a:lnTo>
                  <a:lnTo>
                    <a:pt x="2694" y="1789"/>
                  </a:lnTo>
                  <a:lnTo>
                    <a:pt x="2698" y="1784"/>
                  </a:lnTo>
                  <a:lnTo>
                    <a:pt x="2698" y="1784"/>
                  </a:lnTo>
                  <a:lnTo>
                    <a:pt x="2698" y="1784"/>
                  </a:lnTo>
                  <a:lnTo>
                    <a:pt x="2698" y="1784"/>
                  </a:lnTo>
                  <a:lnTo>
                    <a:pt x="2701" y="1784"/>
                  </a:lnTo>
                  <a:lnTo>
                    <a:pt x="2701" y="1784"/>
                  </a:lnTo>
                  <a:lnTo>
                    <a:pt x="2701" y="1784"/>
                  </a:lnTo>
                  <a:lnTo>
                    <a:pt x="2701" y="1784"/>
                  </a:lnTo>
                  <a:lnTo>
                    <a:pt x="2704" y="1784"/>
                  </a:lnTo>
                  <a:lnTo>
                    <a:pt x="2704" y="1784"/>
                  </a:lnTo>
                  <a:lnTo>
                    <a:pt x="2704" y="1784"/>
                  </a:lnTo>
                  <a:lnTo>
                    <a:pt x="2707" y="1784"/>
                  </a:lnTo>
                  <a:lnTo>
                    <a:pt x="2707" y="1784"/>
                  </a:lnTo>
                  <a:lnTo>
                    <a:pt x="2707" y="1784"/>
                  </a:lnTo>
                  <a:lnTo>
                    <a:pt x="2710" y="1784"/>
                  </a:lnTo>
                  <a:lnTo>
                    <a:pt x="2710" y="1784"/>
                  </a:lnTo>
                  <a:lnTo>
                    <a:pt x="2710" y="1784"/>
                  </a:lnTo>
                  <a:lnTo>
                    <a:pt x="2710" y="1784"/>
                  </a:lnTo>
                  <a:lnTo>
                    <a:pt x="2713" y="1784"/>
                  </a:lnTo>
                  <a:lnTo>
                    <a:pt x="2713" y="1784"/>
                  </a:lnTo>
                  <a:lnTo>
                    <a:pt x="2713" y="1784"/>
                  </a:lnTo>
                  <a:lnTo>
                    <a:pt x="2713" y="1784"/>
                  </a:lnTo>
                  <a:lnTo>
                    <a:pt x="2716" y="1784"/>
                  </a:lnTo>
                  <a:lnTo>
                    <a:pt x="2716" y="1784"/>
                  </a:lnTo>
                  <a:lnTo>
                    <a:pt x="2716" y="1784"/>
                  </a:lnTo>
                  <a:lnTo>
                    <a:pt x="2716" y="1784"/>
                  </a:lnTo>
                  <a:lnTo>
                    <a:pt x="2720" y="1784"/>
                  </a:lnTo>
                  <a:lnTo>
                    <a:pt x="2720" y="1784"/>
                  </a:lnTo>
                  <a:lnTo>
                    <a:pt x="2720" y="1784"/>
                  </a:lnTo>
                  <a:lnTo>
                    <a:pt x="2723" y="1784"/>
                  </a:lnTo>
                  <a:lnTo>
                    <a:pt x="2723" y="1784"/>
                  </a:lnTo>
                  <a:lnTo>
                    <a:pt x="2723" y="1784"/>
                  </a:lnTo>
                  <a:lnTo>
                    <a:pt x="2726" y="1784"/>
                  </a:lnTo>
                  <a:lnTo>
                    <a:pt x="2726" y="1784"/>
                  </a:lnTo>
                  <a:lnTo>
                    <a:pt x="2726" y="1784"/>
                  </a:lnTo>
                  <a:lnTo>
                    <a:pt x="2726" y="1784"/>
                  </a:lnTo>
                  <a:lnTo>
                    <a:pt x="2729" y="1784"/>
                  </a:lnTo>
                  <a:lnTo>
                    <a:pt x="2729" y="1784"/>
                  </a:lnTo>
                  <a:lnTo>
                    <a:pt x="2729" y="1784"/>
                  </a:lnTo>
                  <a:lnTo>
                    <a:pt x="2732" y="1784"/>
                  </a:lnTo>
                  <a:lnTo>
                    <a:pt x="2732" y="1784"/>
                  </a:lnTo>
                  <a:lnTo>
                    <a:pt x="2732" y="1784"/>
                  </a:lnTo>
                  <a:lnTo>
                    <a:pt x="2732" y="1784"/>
                  </a:lnTo>
                  <a:lnTo>
                    <a:pt x="2732" y="1784"/>
                  </a:lnTo>
                  <a:lnTo>
                    <a:pt x="2735" y="1784"/>
                  </a:lnTo>
                  <a:lnTo>
                    <a:pt x="2735" y="1784"/>
                  </a:lnTo>
                  <a:lnTo>
                    <a:pt x="2738" y="1784"/>
                  </a:lnTo>
                  <a:lnTo>
                    <a:pt x="2738" y="1784"/>
                  </a:lnTo>
                  <a:lnTo>
                    <a:pt x="2738" y="1784"/>
                  </a:lnTo>
                  <a:lnTo>
                    <a:pt x="2738" y="1784"/>
                  </a:lnTo>
                  <a:lnTo>
                    <a:pt x="2742" y="1784"/>
                  </a:lnTo>
                  <a:lnTo>
                    <a:pt x="2742" y="1784"/>
                  </a:lnTo>
                  <a:lnTo>
                    <a:pt x="2742" y="1784"/>
                  </a:lnTo>
                  <a:lnTo>
                    <a:pt x="2742" y="1784"/>
                  </a:lnTo>
                  <a:lnTo>
                    <a:pt x="2745" y="1784"/>
                  </a:lnTo>
                  <a:lnTo>
                    <a:pt x="2745" y="1784"/>
                  </a:lnTo>
                  <a:lnTo>
                    <a:pt x="2745" y="1784"/>
                  </a:lnTo>
                  <a:lnTo>
                    <a:pt x="2748" y="1784"/>
                  </a:lnTo>
                  <a:lnTo>
                    <a:pt x="2748" y="1784"/>
                  </a:lnTo>
                  <a:lnTo>
                    <a:pt x="2748" y="1784"/>
                  </a:lnTo>
                  <a:lnTo>
                    <a:pt x="2751" y="1784"/>
                  </a:lnTo>
                  <a:lnTo>
                    <a:pt x="2751" y="1784"/>
                  </a:lnTo>
                  <a:lnTo>
                    <a:pt x="2751" y="1784"/>
                  </a:lnTo>
                  <a:lnTo>
                    <a:pt x="2751" y="1784"/>
                  </a:lnTo>
                  <a:lnTo>
                    <a:pt x="2754" y="1784"/>
                  </a:lnTo>
                  <a:lnTo>
                    <a:pt x="2754" y="1784"/>
                  </a:lnTo>
                  <a:lnTo>
                    <a:pt x="2754" y="1784"/>
                  </a:lnTo>
                  <a:lnTo>
                    <a:pt x="2754" y="1784"/>
                  </a:lnTo>
                  <a:lnTo>
                    <a:pt x="2757" y="1784"/>
                  </a:lnTo>
                  <a:lnTo>
                    <a:pt x="2757" y="1784"/>
                  </a:lnTo>
                  <a:lnTo>
                    <a:pt x="2757" y="1784"/>
                  </a:lnTo>
                  <a:lnTo>
                    <a:pt x="2757" y="1784"/>
                  </a:lnTo>
                  <a:lnTo>
                    <a:pt x="2760" y="1784"/>
                  </a:lnTo>
                  <a:lnTo>
                    <a:pt x="2760" y="1784"/>
                  </a:lnTo>
                  <a:lnTo>
                    <a:pt x="2764" y="1784"/>
                  </a:lnTo>
                  <a:lnTo>
                    <a:pt x="2764" y="1784"/>
                  </a:lnTo>
                  <a:lnTo>
                    <a:pt x="2764" y="1784"/>
                  </a:lnTo>
                  <a:lnTo>
                    <a:pt x="2764" y="1784"/>
                  </a:lnTo>
                  <a:lnTo>
                    <a:pt x="2767" y="1784"/>
                  </a:lnTo>
                  <a:lnTo>
                    <a:pt x="2767" y="1784"/>
                  </a:lnTo>
                  <a:lnTo>
                    <a:pt x="2767" y="1784"/>
                  </a:lnTo>
                  <a:lnTo>
                    <a:pt x="2767" y="1784"/>
                  </a:lnTo>
                  <a:lnTo>
                    <a:pt x="2770" y="1784"/>
                  </a:lnTo>
                  <a:lnTo>
                    <a:pt x="2770" y="1784"/>
                  </a:lnTo>
                  <a:lnTo>
                    <a:pt x="2770" y="1784"/>
                  </a:lnTo>
                  <a:lnTo>
                    <a:pt x="2770" y="1784"/>
                  </a:lnTo>
                  <a:lnTo>
                    <a:pt x="2773" y="1784"/>
                  </a:lnTo>
                  <a:lnTo>
                    <a:pt x="2773" y="1784"/>
                  </a:lnTo>
                  <a:lnTo>
                    <a:pt x="2773" y="1784"/>
                  </a:lnTo>
                  <a:lnTo>
                    <a:pt x="2773" y="1784"/>
                  </a:lnTo>
                  <a:lnTo>
                    <a:pt x="2776" y="1784"/>
                  </a:lnTo>
                  <a:lnTo>
                    <a:pt x="2776" y="1784"/>
                  </a:lnTo>
                  <a:lnTo>
                    <a:pt x="2779" y="1784"/>
                  </a:lnTo>
                  <a:lnTo>
                    <a:pt x="2779" y="1784"/>
                  </a:lnTo>
                  <a:lnTo>
                    <a:pt x="2779" y="1784"/>
                  </a:lnTo>
                  <a:lnTo>
                    <a:pt x="2779" y="1784"/>
                  </a:lnTo>
                  <a:lnTo>
                    <a:pt x="2782" y="1784"/>
                  </a:lnTo>
                  <a:lnTo>
                    <a:pt x="2782" y="1784"/>
                  </a:lnTo>
                  <a:lnTo>
                    <a:pt x="2782" y="1784"/>
                  </a:lnTo>
                  <a:lnTo>
                    <a:pt x="2782" y="1784"/>
                  </a:lnTo>
                  <a:lnTo>
                    <a:pt x="2786" y="1784"/>
                  </a:lnTo>
                  <a:lnTo>
                    <a:pt x="2786" y="1784"/>
                  </a:lnTo>
                  <a:lnTo>
                    <a:pt x="2786" y="1784"/>
                  </a:lnTo>
                  <a:lnTo>
                    <a:pt x="2789" y="1784"/>
                  </a:lnTo>
                  <a:lnTo>
                    <a:pt x="2789" y="1784"/>
                  </a:lnTo>
                  <a:lnTo>
                    <a:pt x="2789" y="1784"/>
                  </a:lnTo>
                  <a:lnTo>
                    <a:pt x="2792" y="1784"/>
                  </a:lnTo>
                  <a:lnTo>
                    <a:pt x="2792" y="1784"/>
                  </a:lnTo>
                  <a:lnTo>
                    <a:pt x="2792" y="1784"/>
                  </a:lnTo>
                  <a:lnTo>
                    <a:pt x="2792" y="1784"/>
                  </a:lnTo>
                  <a:lnTo>
                    <a:pt x="2795" y="1784"/>
                  </a:lnTo>
                  <a:lnTo>
                    <a:pt x="2795" y="1784"/>
                  </a:lnTo>
                  <a:lnTo>
                    <a:pt x="2795" y="1784"/>
                  </a:lnTo>
                  <a:lnTo>
                    <a:pt x="2795" y="1784"/>
                  </a:lnTo>
                  <a:lnTo>
                    <a:pt x="2798" y="1784"/>
                  </a:lnTo>
                  <a:lnTo>
                    <a:pt x="2798" y="1784"/>
                  </a:lnTo>
                  <a:lnTo>
                    <a:pt x="2798" y="1784"/>
                  </a:lnTo>
                  <a:lnTo>
                    <a:pt x="2798" y="1784"/>
                  </a:lnTo>
                  <a:lnTo>
                    <a:pt x="2801" y="1784"/>
                  </a:lnTo>
                  <a:lnTo>
                    <a:pt x="2801" y="1784"/>
                  </a:lnTo>
                  <a:lnTo>
                    <a:pt x="2801" y="1784"/>
                  </a:lnTo>
                  <a:lnTo>
                    <a:pt x="2804" y="1784"/>
                  </a:lnTo>
                  <a:lnTo>
                    <a:pt x="2804" y="1784"/>
                  </a:lnTo>
                  <a:lnTo>
                    <a:pt x="2804" y="1784"/>
                  </a:lnTo>
                  <a:lnTo>
                    <a:pt x="2808" y="1784"/>
                  </a:lnTo>
                  <a:lnTo>
                    <a:pt x="2808" y="1784"/>
                  </a:lnTo>
                  <a:lnTo>
                    <a:pt x="2808" y="1784"/>
                  </a:lnTo>
                  <a:lnTo>
                    <a:pt x="2808" y="1784"/>
                  </a:lnTo>
                  <a:lnTo>
                    <a:pt x="2811" y="1784"/>
                  </a:lnTo>
                  <a:lnTo>
                    <a:pt x="2811" y="1784"/>
                  </a:lnTo>
                  <a:lnTo>
                    <a:pt x="2811" y="1784"/>
                  </a:lnTo>
                  <a:lnTo>
                    <a:pt x="2811" y="1784"/>
                  </a:lnTo>
                  <a:lnTo>
                    <a:pt x="2814" y="1784"/>
                  </a:lnTo>
                  <a:lnTo>
                    <a:pt x="2814" y="1784"/>
                  </a:lnTo>
                  <a:lnTo>
                    <a:pt x="2814" y="1784"/>
                  </a:lnTo>
                  <a:lnTo>
                    <a:pt x="2814" y="1784"/>
                  </a:lnTo>
                  <a:lnTo>
                    <a:pt x="2817" y="1784"/>
                  </a:lnTo>
                  <a:lnTo>
                    <a:pt x="2817" y="1784"/>
                  </a:lnTo>
                  <a:lnTo>
                    <a:pt x="2817" y="1784"/>
                  </a:lnTo>
                  <a:lnTo>
                    <a:pt x="2820" y="1784"/>
                  </a:lnTo>
                  <a:lnTo>
                    <a:pt x="2820" y="1784"/>
                  </a:lnTo>
                  <a:lnTo>
                    <a:pt x="2820" y="1784"/>
                  </a:lnTo>
                  <a:lnTo>
                    <a:pt x="2823" y="1784"/>
                  </a:lnTo>
                  <a:lnTo>
                    <a:pt x="2823" y="1784"/>
                  </a:lnTo>
                  <a:lnTo>
                    <a:pt x="2823" y="1784"/>
                  </a:lnTo>
                  <a:lnTo>
                    <a:pt x="2823" y="1784"/>
                  </a:lnTo>
                  <a:lnTo>
                    <a:pt x="2826" y="1784"/>
                  </a:lnTo>
                  <a:lnTo>
                    <a:pt x="2826" y="1784"/>
                  </a:lnTo>
                  <a:lnTo>
                    <a:pt x="2826" y="1784"/>
                  </a:lnTo>
                  <a:lnTo>
                    <a:pt x="2826" y="1784"/>
                  </a:lnTo>
                  <a:lnTo>
                    <a:pt x="2830" y="1784"/>
                  </a:lnTo>
                  <a:lnTo>
                    <a:pt x="2830" y="1784"/>
                  </a:lnTo>
                  <a:lnTo>
                    <a:pt x="2833" y="1784"/>
                  </a:lnTo>
                  <a:lnTo>
                    <a:pt x="2833" y="1784"/>
                  </a:lnTo>
                  <a:lnTo>
                    <a:pt x="2833" y="1784"/>
                  </a:lnTo>
                  <a:lnTo>
                    <a:pt x="2833" y="1784"/>
                  </a:lnTo>
                  <a:lnTo>
                    <a:pt x="2836" y="1784"/>
                  </a:lnTo>
                  <a:lnTo>
                    <a:pt x="2836" y="1784"/>
                  </a:lnTo>
                  <a:lnTo>
                    <a:pt x="2836" y="1784"/>
                  </a:lnTo>
                  <a:lnTo>
                    <a:pt x="2836" y="1784"/>
                  </a:lnTo>
                  <a:lnTo>
                    <a:pt x="2839" y="1784"/>
                  </a:lnTo>
                  <a:lnTo>
                    <a:pt x="2839" y="1784"/>
                  </a:lnTo>
                  <a:lnTo>
                    <a:pt x="2839" y="1779"/>
                  </a:lnTo>
                  <a:lnTo>
                    <a:pt x="2839" y="1779"/>
                  </a:lnTo>
                  <a:lnTo>
                    <a:pt x="2842" y="1779"/>
                  </a:lnTo>
                  <a:lnTo>
                    <a:pt x="2842" y="1779"/>
                  </a:lnTo>
                  <a:lnTo>
                    <a:pt x="2842" y="1779"/>
                  </a:lnTo>
                  <a:lnTo>
                    <a:pt x="2845" y="1779"/>
                  </a:lnTo>
                  <a:lnTo>
                    <a:pt x="2845" y="1779"/>
                  </a:lnTo>
                  <a:lnTo>
                    <a:pt x="2845" y="1779"/>
                  </a:lnTo>
                  <a:lnTo>
                    <a:pt x="2848" y="1779"/>
                  </a:lnTo>
                  <a:lnTo>
                    <a:pt x="2848" y="1779"/>
                  </a:lnTo>
                  <a:lnTo>
                    <a:pt x="2848" y="1774"/>
                  </a:lnTo>
                  <a:lnTo>
                    <a:pt x="2848" y="1774"/>
                  </a:lnTo>
                  <a:lnTo>
                    <a:pt x="2852" y="1774"/>
                  </a:lnTo>
                  <a:lnTo>
                    <a:pt x="2852" y="1774"/>
                  </a:lnTo>
                  <a:lnTo>
                    <a:pt x="2852" y="1774"/>
                  </a:lnTo>
                  <a:lnTo>
                    <a:pt x="2852" y="1774"/>
                  </a:lnTo>
                  <a:lnTo>
                    <a:pt x="2855" y="1774"/>
                  </a:lnTo>
                  <a:lnTo>
                    <a:pt x="2855" y="1774"/>
                  </a:lnTo>
                  <a:lnTo>
                    <a:pt x="2855" y="1774"/>
                  </a:lnTo>
                  <a:lnTo>
                    <a:pt x="2855" y="1774"/>
                  </a:lnTo>
                  <a:lnTo>
                    <a:pt x="2858" y="1774"/>
                  </a:lnTo>
                  <a:lnTo>
                    <a:pt x="2858" y="1774"/>
                  </a:lnTo>
                  <a:lnTo>
                    <a:pt x="2858" y="1774"/>
                  </a:lnTo>
                  <a:lnTo>
                    <a:pt x="2861" y="1774"/>
                  </a:lnTo>
                  <a:lnTo>
                    <a:pt x="2861" y="1774"/>
                  </a:lnTo>
                  <a:lnTo>
                    <a:pt x="2861" y="1770"/>
                  </a:lnTo>
                  <a:lnTo>
                    <a:pt x="2864" y="1770"/>
                  </a:lnTo>
                  <a:lnTo>
                    <a:pt x="2864" y="1770"/>
                  </a:lnTo>
                  <a:lnTo>
                    <a:pt x="2864" y="1770"/>
                  </a:lnTo>
                  <a:lnTo>
                    <a:pt x="2864" y="1770"/>
                  </a:lnTo>
                  <a:lnTo>
                    <a:pt x="2867" y="1765"/>
                  </a:lnTo>
                  <a:lnTo>
                    <a:pt x="2867" y="1765"/>
                  </a:lnTo>
                  <a:lnTo>
                    <a:pt x="2867" y="1765"/>
                  </a:lnTo>
                  <a:lnTo>
                    <a:pt x="2867" y="1765"/>
                  </a:lnTo>
                  <a:lnTo>
                    <a:pt x="2870" y="1765"/>
                  </a:lnTo>
                  <a:lnTo>
                    <a:pt x="2870" y="1765"/>
                  </a:lnTo>
                  <a:lnTo>
                    <a:pt x="2870" y="1760"/>
                  </a:lnTo>
                  <a:lnTo>
                    <a:pt x="2874" y="1760"/>
                  </a:lnTo>
                  <a:lnTo>
                    <a:pt x="2874" y="1751"/>
                  </a:lnTo>
                  <a:lnTo>
                    <a:pt x="2874" y="1746"/>
                  </a:lnTo>
                  <a:lnTo>
                    <a:pt x="2877" y="1731"/>
                  </a:lnTo>
                  <a:lnTo>
                    <a:pt x="2877" y="1731"/>
                  </a:lnTo>
                  <a:lnTo>
                    <a:pt x="2877" y="1722"/>
                  </a:lnTo>
                  <a:lnTo>
                    <a:pt x="2877" y="1722"/>
                  </a:lnTo>
                  <a:lnTo>
                    <a:pt x="2880" y="1727"/>
                  </a:lnTo>
                  <a:lnTo>
                    <a:pt x="2880" y="1731"/>
                  </a:lnTo>
                  <a:lnTo>
                    <a:pt x="2880" y="1741"/>
                  </a:lnTo>
                  <a:lnTo>
                    <a:pt x="2880" y="1741"/>
                  </a:lnTo>
                  <a:lnTo>
                    <a:pt x="2883" y="1746"/>
                  </a:lnTo>
                  <a:lnTo>
                    <a:pt x="2883" y="1751"/>
                  </a:lnTo>
                  <a:lnTo>
                    <a:pt x="2883" y="1751"/>
                  </a:lnTo>
                  <a:lnTo>
                    <a:pt x="2886" y="1751"/>
                  </a:lnTo>
                  <a:lnTo>
                    <a:pt x="2886" y="1755"/>
                  </a:lnTo>
                  <a:lnTo>
                    <a:pt x="2886" y="1755"/>
                  </a:lnTo>
                  <a:lnTo>
                    <a:pt x="2889" y="1755"/>
                  </a:lnTo>
                  <a:lnTo>
                    <a:pt x="2889" y="1755"/>
                  </a:lnTo>
                  <a:lnTo>
                    <a:pt x="2889" y="1755"/>
                  </a:lnTo>
                  <a:lnTo>
                    <a:pt x="2889" y="1755"/>
                  </a:lnTo>
                  <a:lnTo>
                    <a:pt x="2892" y="1755"/>
                  </a:lnTo>
                  <a:lnTo>
                    <a:pt x="2892" y="1755"/>
                  </a:lnTo>
                  <a:lnTo>
                    <a:pt x="2892" y="1755"/>
                  </a:lnTo>
                  <a:lnTo>
                    <a:pt x="2892" y="1755"/>
                  </a:lnTo>
                  <a:lnTo>
                    <a:pt x="2896" y="1755"/>
                  </a:lnTo>
                  <a:lnTo>
                    <a:pt x="2896" y="1755"/>
                  </a:lnTo>
                  <a:lnTo>
                    <a:pt x="2896" y="1755"/>
                  </a:lnTo>
                  <a:lnTo>
                    <a:pt x="2896" y="1755"/>
                  </a:lnTo>
                  <a:lnTo>
                    <a:pt x="2899" y="1751"/>
                  </a:lnTo>
                  <a:lnTo>
                    <a:pt x="2899" y="1751"/>
                  </a:lnTo>
                  <a:lnTo>
                    <a:pt x="2899" y="1751"/>
                  </a:lnTo>
                  <a:lnTo>
                    <a:pt x="2899" y="1751"/>
                  </a:lnTo>
                  <a:lnTo>
                    <a:pt x="2902" y="1751"/>
                  </a:lnTo>
                  <a:lnTo>
                    <a:pt x="2902" y="1751"/>
                  </a:lnTo>
                  <a:lnTo>
                    <a:pt x="2905" y="1751"/>
                  </a:lnTo>
                  <a:lnTo>
                    <a:pt x="2905" y="1751"/>
                  </a:lnTo>
                  <a:lnTo>
                    <a:pt x="2905" y="1751"/>
                  </a:lnTo>
                  <a:lnTo>
                    <a:pt x="2905" y="1751"/>
                  </a:lnTo>
                  <a:lnTo>
                    <a:pt x="2908" y="1751"/>
                  </a:lnTo>
                  <a:lnTo>
                    <a:pt x="2908" y="1751"/>
                  </a:lnTo>
                  <a:lnTo>
                    <a:pt x="2908" y="1751"/>
                  </a:lnTo>
                  <a:lnTo>
                    <a:pt x="2908" y="1751"/>
                  </a:lnTo>
                  <a:lnTo>
                    <a:pt x="2911" y="1751"/>
                  </a:lnTo>
                  <a:lnTo>
                    <a:pt x="2911" y="1751"/>
                  </a:lnTo>
                  <a:lnTo>
                    <a:pt x="2911" y="1751"/>
                  </a:lnTo>
                  <a:lnTo>
                    <a:pt x="2911" y="1751"/>
                  </a:lnTo>
                  <a:lnTo>
                    <a:pt x="2914" y="1751"/>
                  </a:lnTo>
                  <a:lnTo>
                    <a:pt x="2914" y="1751"/>
                  </a:lnTo>
                  <a:lnTo>
                    <a:pt x="2918" y="1751"/>
                  </a:lnTo>
                  <a:lnTo>
                    <a:pt x="2918" y="1751"/>
                  </a:lnTo>
                  <a:lnTo>
                    <a:pt x="2918" y="1751"/>
                  </a:lnTo>
                  <a:lnTo>
                    <a:pt x="2918" y="1751"/>
                  </a:lnTo>
                  <a:lnTo>
                    <a:pt x="2921" y="1751"/>
                  </a:lnTo>
                  <a:lnTo>
                    <a:pt x="2921" y="1751"/>
                  </a:lnTo>
                  <a:lnTo>
                    <a:pt x="2921" y="1751"/>
                  </a:lnTo>
                  <a:lnTo>
                    <a:pt x="2921" y="1751"/>
                  </a:lnTo>
                  <a:lnTo>
                    <a:pt x="2924" y="1751"/>
                  </a:lnTo>
                  <a:lnTo>
                    <a:pt x="2924" y="1751"/>
                  </a:lnTo>
                  <a:lnTo>
                    <a:pt x="2924" y="1751"/>
                  </a:lnTo>
                  <a:lnTo>
                    <a:pt x="2927" y="1751"/>
                  </a:lnTo>
                  <a:lnTo>
                    <a:pt x="2927" y="1751"/>
                  </a:lnTo>
                  <a:lnTo>
                    <a:pt x="2927" y="1751"/>
                  </a:lnTo>
                  <a:lnTo>
                    <a:pt x="2930" y="1751"/>
                  </a:lnTo>
                  <a:lnTo>
                    <a:pt x="2930" y="1751"/>
                  </a:lnTo>
                  <a:lnTo>
                    <a:pt x="2930" y="1751"/>
                  </a:lnTo>
                  <a:lnTo>
                    <a:pt x="2930" y="1751"/>
                  </a:lnTo>
                  <a:lnTo>
                    <a:pt x="2933" y="1751"/>
                  </a:lnTo>
                  <a:lnTo>
                    <a:pt x="2933" y="1751"/>
                  </a:lnTo>
                  <a:lnTo>
                    <a:pt x="2933" y="1751"/>
                  </a:lnTo>
                  <a:lnTo>
                    <a:pt x="2933" y="1751"/>
                  </a:lnTo>
                  <a:lnTo>
                    <a:pt x="2936" y="1746"/>
                  </a:lnTo>
                  <a:lnTo>
                    <a:pt x="2936" y="1746"/>
                  </a:lnTo>
                  <a:lnTo>
                    <a:pt x="2936" y="1746"/>
                  </a:lnTo>
                  <a:lnTo>
                    <a:pt x="2936" y="1746"/>
                  </a:lnTo>
                  <a:lnTo>
                    <a:pt x="2940" y="1746"/>
                  </a:lnTo>
                  <a:lnTo>
                    <a:pt x="2940" y="1746"/>
                  </a:lnTo>
                  <a:lnTo>
                    <a:pt x="2940" y="1746"/>
                  </a:lnTo>
                  <a:lnTo>
                    <a:pt x="2940" y="1746"/>
                  </a:lnTo>
                  <a:lnTo>
                    <a:pt x="2943" y="1746"/>
                  </a:lnTo>
                  <a:lnTo>
                    <a:pt x="2943" y="1746"/>
                  </a:lnTo>
                  <a:lnTo>
                    <a:pt x="2943" y="1746"/>
                  </a:lnTo>
                  <a:lnTo>
                    <a:pt x="2946" y="1746"/>
                  </a:lnTo>
                  <a:lnTo>
                    <a:pt x="2946" y="1746"/>
                  </a:lnTo>
                  <a:lnTo>
                    <a:pt x="2946" y="1746"/>
                  </a:lnTo>
                  <a:lnTo>
                    <a:pt x="2949" y="1746"/>
                  </a:lnTo>
                  <a:lnTo>
                    <a:pt x="2949" y="1746"/>
                  </a:lnTo>
                  <a:lnTo>
                    <a:pt x="2949" y="1746"/>
                  </a:lnTo>
                  <a:lnTo>
                    <a:pt x="2949" y="1746"/>
                  </a:lnTo>
                  <a:lnTo>
                    <a:pt x="2952" y="1746"/>
                  </a:lnTo>
                  <a:lnTo>
                    <a:pt x="2952" y="1746"/>
                  </a:lnTo>
                  <a:lnTo>
                    <a:pt x="2952" y="1746"/>
                  </a:lnTo>
                  <a:lnTo>
                    <a:pt x="2952" y="1746"/>
                  </a:lnTo>
                  <a:lnTo>
                    <a:pt x="2955" y="1746"/>
                  </a:lnTo>
                  <a:lnTo>
                    <a:pt x="2955" y="1746"/>
                  </a:lnTo>
                  <a:lnTo>
                    <a:pt x="2958" y="1746"/>
                  </a:lnTo>
                  <a:lnTo>
                    <a:pt x="2958" y="1741"/>
                  </a:lnTo>
                  <a:lnTo>
                    <a:pt x="2958" y="1741"/>
                  </a:lnTo>
                  <a:lnTo>
                    <a:pt x="2958" y="1741"/>
                  </a:lnTo>
                  <a:lnTo>
                    <a:pt x="2962" y="1736"/>
                  </a:lnTo>
                  <a:lnTo>
                    <a:pt x="2962" y="1731"/>
                  </a:lnTo>
                  <a:lnTo>
                    <a:pt x="2962" y="1727"/>
                  </a:lnTo>
                  <a:lnTo>
                    <a:pt x="2962" y="1727"/>
                  </a:lnTo>
                  <a:lnTo>
                    <a:pt x="2965" y="1727"/>
                  </a:lnTo>
                  <a:lnTo>
                    <a:pt x="2965" y="1727"/>
                  </a:lnTo>
                  <a:lnTo>
                    <a:pt x="2965" y="1731"/>
                  </a:lnTo>
                  <a:lnTo>
                    <a:pt x="2965" y="1736"/>
                  </a:lnTo>
                  <a:lnTo>
                    <a:pt x="2968" y="1741"/>
                  </a:lnTo>
                  <a:lnTo>
                    <a:pt x="2968" y="1741"/>
                  </a:lnTo>
                  <a:lnTo>
                    <a:pt x="2968" y="1741"/>
                  </a:lnTo>
                  <a:lnTo>
                    <a:pt x="2971" y="1741"/>
                  </a:lnTo>
                  <a:lnTo>
                    <a:pt x="2971" y="1746"/>
                  </a:lnTo>
                  <a:lnTo>
                    <a:pt x="2971" y="1746"/>
                  </a:lnTo>
                  <a:lnTo>
                    <a:pt x="2974" y="1741"/>
                  </a:lnTo>
                  <a:lnTo>
                    <a:pt x="2974" y="1741"/>
                  </a:lnTo>
                  <a:lnTo>
                    <a:pt x="2974" y="1741"/>
                  </a:lnTo>
                  <a:lnTo>
                    <a:pt x="2974" y="1741"/>
                  </a:lnTo>
                  <a:lnTo>
                    <a:pt x="2977" y="1741"/>
                  </a:lnTo>
                  <a:lnTo>
                    <a:pt x="2977" y="1741"/>
                  </a:lnTo>
                  <a:lnTo>
                    <a:pt x="2977" y="1741"/>
                  </a:lnTo>
                  <a:lnTo>
                    <a:pt x="2977" y="1736"/>
                  </a:lnTo>
                  <a:lnTo>
                    <a:pt x="2980" y="1736"/>
                  </a:lnTo>
                  <a:lnTo>
                    <a:pt x="2980" y="1736"/>
                  </a:lnTo>
                  <a:lnTo>
                    <a:pt x="2980" y="1736"/>
                  </a:lnTo>
                  <a:lnTo>
                    <a:pt x="2984" y="1736"/>
                  </a:lnTo>
                  <a:lnTo>
                    <a:pt x="2984" y="1736"/>
                  </a:lnTo>
                  <a:lnTo>
                    <a:pt x="2984" y="1736"/>
                  </a:lnTo>
                  <a:lnTo>
                    <a:pt x="2987" y="1736"/>
                  </a:lnTo>
                  <a:lnTo>
                    <a:pt x="2987" y="1736"/>
                  </a:lnTo>
                  <a:lnTo>
                    <a:pt x="2987" y="1736"/>
                  </a:lnTo>
                  <a:lnTo>
                    <a:pt x="2987" y="1736"/>
                  </a:lnTo>
                  <a:lnTo>
                    <a:pt x="2990" y="1736"/>
                  </a:lnTo>
                  <a:lnTo>
                    <a:pt x="2990" y="1736"/>
                  </a:lnTo>
                  <a:lnTo>
                    <a:pt x="2990" y="1741"/>
                  </a:lnTo>
                  <a:lnTo>
                    <a:pt x="2990" y="1741"/>
                  </a:lnTo>
                  <a:lnTo>
                    <a:pt x="2993" y="1736"/>
                  </a:lnTo>
                  <a:lnTo>
                    <a:pt x="2993" y="1736"/>
                  </a:lnTo>
                  <a:lnTo>
                    <a:pt x="2993" y="1736"/>
                  </a:lnTo>
                  <a:lnTo>
                    <a:pt x="2996" y="1736"/>
                  </a:lnTo>
                  <a:lnTo>
                    <a:pt x="2996" y="1736"/>
                  </a:lnTo>
                  <a:lnTo>
                    <a:pt x="2996" y="1736"/>
                  </a:lnTo>
                  <a:lnTo>
                    <a:pt x="2996" y="1741"/>
                  </a:lnTo>
                  <a:lnTo>
                    <a:pt x="2996" y="1741"/>
                  </a:lnTo>
                  <a:lnTo>
                    <a:pt x="2999" y="1741"/>
                  </a:lnTo>
                  <a:lnTo>
                    <a:pt x="2999" y="1741"/>
                  </a:lnTo>
                  <a:lnTo>
                    <a:pt x="3002" y="1741"/>
                  </a:lnTo>
                  <a:lnTo>
                    <a:pt x="3002" y="1741"/>
                  </a:lnTo>
                  <a:lnTo>
                    <a:pt x="3002" y="1741"/>
                  </a:lnTo>
                  <a:lnTo>
                    <a:pt x="3002" y="1741"/>
                  </a:lnTo>
                  <a:lnTo>
                    <a:pt x="3006" y="1741"/>
                  </a:lnTo>
                  <a:lnTo>
                    <a:pt x="3006" y="1741"/>
                  </a:lnTo>
                  <a:lnTo>
                    <a:pt x="3006" y="1741"/>
                  </a:lnTo>
                  <a:lnTo>
                    <a:pt x="3006" y="1741"/>
                  </a:lnTo>
                  <a:lnTo>
                    <a:pt x="3009" y="1741"/>
                  </a:lnTo>
                  <a:lnTo>
                    <a:pt x="3009" y="1741"/>
                  </a:lnTo>
                  <a:lnTo>
                    <a:pt x="3009" y="1741"/>
                  </a:lnTo>
                  <a:lnTo>
                    <a:pt x="3012" y="1741"/>
                  </a:lnTo>
                  <a:lnTo>
                    <a:pt x="3012" y="1741"/>
                  </a:lnTo>
                  <a:lnTo>
                    <a:pt x="3012" y="1741"/>
                  </a:lnTo>
                  <a:lnTo>
                    <a:pt x="3015" y="1741"/>
                  </a:lnTo>
                  <a:lnTo>
                    <a:pt x="3015" y="1741"/>
                  </a:lnTo>
                  <a:lnTo>
                    <a:pt x="3015" y="1741"/>
                  </a:lnTo>
                  <a:lnTo>
                    <a:pt x="3015" y="1741"/>
                  </a:lnTo>
                  <a:lnTo>
                    <a:pt x="3018" y="1741"/>
                  </a:lnTo>
                  <a:lnTo>
                    <a:pt x="3018" y="1741"/>
                  </a:lnTo>
                  <a:lnTo>
                    <a:pt x="3018" y="1741"/>
                  </a:lnTo>
                  <a:lnTo>
                    <a:pt x="3018" y="1741"/>
                  </a:lnTo>
                  <a:lnTo>
                    <a:pt x="3021" y="1741"/>
                  </a:lnTo>
                  <a:lnTo>
                    <a:pt x="3021" y="1741"/>
                  </a:lnTo>
                  <a:lnTo>
                    <a:pt x="3021" y="1741"/>
                  </a:lnTo>
                  <a:lnTo>
                    <a:pt x="3024" y="1741"/>
                  </a:lnTo>
                  <a:lnTo>
                    <a:pt x="3024" y="1741"/>
                  </a:lnTo>
                  <a:lnTo>
                    <a:pt x="3024" y="1741"/>
                  </a:lnTo>
                  <a:lnTo>
                    <a:pt x="3028" y="1741"/>
                  </a:lnTo>
                  <a:lnTo>
                    <a:pt x="3028" y="1741"/>
                  </a:lnTo>
                  <a:lnTo>
                    <a:pt x="3028" y="1741"/>
                  </a:lnTo>
                  <a:lnTo>
                    <a:pt x="3028" y="1741"/>
                  </a:lnTo>
                  <a:lnTo>
                    <a:pt x="3031" y="1741"/>
                  </a:lnTo>
                  <a:lnTo>
                    <a:pt x="3031" y="1741"/>
                  </a:lnTo>
                  <a:lnTo>
                    <a:pt x="3031" y="1746"/>
                  </a:lnTo>
                  <a:lnTo>
                    <a:pt x="3031" y="1746"/>
                  </a:lnTo>
                  <a:lnTo>
                    <a:pt x="3034" y="1746"/>
                  </a:lnTo>
                  <a:lnTo>
                    <a:pt x="3034" y="1746"/>
                  </a:lnTo>
                  <a:lnTo>
                    <a:pt x="3034" y="1746"/>
                  </a:lnTo>
                  <a:lnTo>
                    <a:pt x="3034" y="1746"/>
                  </a:lnTo>
                  <a:lnTo>
                    <a:pt x="3037" y="1746"/>
                  </a:lnTo>
                  <a:lnTo>
                    <a:pt x="3037" y="1746"/>
                  </a:lnTo>
                  <a:lnTo>
                    <a:pt x="3037" y="1741"/>
                  </a:lnTo>
                  <a:lnTo>
                    <a:pt x="3037" y="1741"/>
                  </a:lnTo>
                  <a:lnTo>
                    <a:pt x="3040" y="1741"/>
                  </a:lnTo>
                  <a:lnTo>
                    <a:pt x="3040" y="1741"/>
                  </a:lnTo>
                  <a:lnTo>
                    <a:pt x="3043" y="1741"/>
                  </a:lnTo>
                  <a:lnTo>
                    <a:pt x="3043" y="1741"/>
                  </a:lnTo>
                  <a:lnTo>
                    <a:pt x="3043" y="1741"/>
                  </a:lnTo>
                  <a:lnTo>
                    <a:pt x="3043" y="1741"/>
                  </a:lnTo>
                  <a:lnTo>
                    <a:pt x="3046" y="1741"/>
                  </a:lnTo>
                  <a:lnTo>
                    <a:pt x="3046" y="1741"/>
                  </a:lnTo>
                  <a:lnTo>
                    <a:pt x="3046" y="1746"/>
                  </a:lnTo>
                  <a:lnTo>
                    <a:pt x="3046" y="1746"/>
                  </a:lnTo>
                  <a:lnTo>
                    <a:pt x="3050" y="1746"/>
                  </a:lnTo>
                  <a:lnTo>
                    <a:pt x="3050" y="1746"/>
                  </a:lnTo>
                  <a:lnTo>
                    <a:pt x="3050" y="1746"/>
                  </a:lnTo>
                  <a:lnTo>
                    <a:pt x="3050" y="1746"/>
                  </a:lnTo>
                  <a:lnTo>
                    <a:pt x="3053" y="1746"/>
                  </a:lnTo>
                  <a:lnTo>
                    <a:pt x="3053" y="1746"/>
                  </a:lnTo>
                  <a:lnTo>
                    <a:pt x="3056" y="1746"/>
                  </a:lnTo>
                  <a:lnTo>
                    <a:pt x="3056" y="1746"/>
                  </a:lnTo>
                  <a:lnTo>
                    <a:pt x="3056" y="1746"/>
                  </a:lnTo>
                  <a:lnTo>
                    <a:pt x="3056" y="1746"/>
                  </a:lnTo>
                  <a:lnTo>
                    <a:pt x="3059" y="1746"/>
                  </a:lnTo>
                  <a:lnTo>
                    <a:pt x="3059" y="1746"/>
                  </a:lnTo>
                  <a:lnTo>
                    <a:pt x="3059" y="1746"/>
                  </a:lnTo>
                  <a:lnTo>
                    <a:pt x="3059" y="1746"/>
                  </a:lnTo>
                  <a:lnTo>
                    <a:pt x="3062" y="1746"/>
                  </a:lnTo>
                  <a:lnTo>
                    <a:pt x="3062" y="1746"/>
                  </a:lnTo>
                  <a:lnTo>
                    <a:pt x="3062" y="1746"/>
                  </a:lnTo>
                  <a:lnTo>
                    <a:pt x="3062" y="1746"/>
                  </a:lnTo>
                  <a:lnTo>
                    <a:pt x="3065" y="1746"/>
                  </a:lnTo>
                  <a:lnTo>
                    <a:pt x="3065" y="1746"/>
                  </a:lnTo>
                  <a:lnTo>
                    <a:pt x="3065" y="1746"/>
                  </a:lnTo>
                  <a:lnTo>
                    <a:pt x="3068" y="1746"/>
                  </a:lnTo>
                  <a:lnTo>
                    <a:pt x="3068" y="1746"/>
                  </a:lnTo>
                  <a:lnTo>
                    <a:pt x="3068" y="1741"/>
                  </a:lnTo>
                  <a:lnTo>
                    <a:pt x="3072" y="1741"/>
                  </a:lnTo>
                  <a:lnTo>
                    <a:pt x="3072" y="1741"/>
                  </a:lnTo>
                  <a:lnTo>
                    <a:pt x="3072" y="1741"/>
                  </a:lnTo>
                  <a:lnTo>
                    <a:pt x="3072" y="1741"/>
                  </a:lnTo>
                  <a:lnTo>
                    <a:pt x="3075" y="1741"/>
                  </a:lnTo>
                  <a:lnTo>
                    <a:pt x="3075" y="1741"/>
                  </a:lnTo>
                  <a:lnTo>
                    <a:pt x="3075" y="1741"/>
                  </a:lnTo>
                  <a:lnTo>
                    <a:pt x="3075" y="1741"/>
                  </a:lnTo>
                  <a:lnTo>
                    <a:pt x="3078" y="1741"/>
                  </a:lnTo>
                  <a:lnTo>
                    <a:pt x="3078" y="1741"/>
                  </a:lnTo>
                  <a:lnTo>
                    <a:pt x="3078" y="1741"/>
                  </a:lnTo>
                  <a:lnTo>
                    <a:pt x="3078" y="1741"/>
                  </a:lnTo>
                  <a:lnTo>
                    <a:pt x="3081" y="1741"/>
                  </a:lnTo>
                  <a:lnTo>
                    <a:pt x="3081" y="1741"/>
                  </a:lnTo>
                  <a:lnTo>
                    <a:pt x="3084" y="1741"/>
                  </a:lnTo>
                  <a:lnTo>
                    <a:pt x="3084" y="1741"/>
                  </a:lnTo>
                  <a:lnTo>
                    <a:pt x="3084" y="1741"/>
                  </a:lnTo>
                  <a:lnTo>
                    <a:pt x="3084" y="1741"/>
                  </a:lnTo>
                  <a:lnTo>
                    <a:pt x="3087" y="1741"/>
                  </a:lnTo>
                  <a:lnTo>
                    <a:pt x="3087" y="1741"/>
                  </a:lnTo>
                  <a:lnTo>
                    <a:pt x="3087" y="1741"/>
                  </a:lnTo>
                  <a:lnTo>
                    <a:pt x="3087" y="1741"/>
                  </a:lnTo>
                  <a:lnTo>
                    <a:pt x="3090" y="1741"/>
                  </a:lnTo>
                  <a:lnTo>
                    <a:pt x="3090" y="1741"/>
                  </a:lnTo>
                  <a:lnTo>
                    <a:pt x="3090" y="1741"/>
                  </a:lnTo>
                  <a:lnTo>
                    <a:pt x="3090" y="1741"/>
                  </a:lnTo>
                  <a:lnTo>
                    <a:pt x="3094" y="1741"/>
                  </a:lnTo>
                  <a:lnTo>
                    <a:pt x="3094" y="1741"/>
                  </a:lnTo>
                  <a:lnTo>
                    <a:pt x="3097" y="1741"/>
                  </a:lnTo>
                  <a:lnTo>
                    <a:pt x="3097" y="1741"/>
                  </a:lnTo>
                  <a:lnTo>
                    <a:pt x="3097" y="1741"/>
                  </a:lnTo>
                  <a:lnTo>
                    <a:pt x="3097" y="1741"/>
                  </a:lnTo>
                  <a:lnTo>
                    <a:pt x="3100" y="1746"/>
                  </a:lnTo>
                  <a:lnTo>
                    <a:pt x="3100" y="1746"/>
                  </a:lnTo>
                  <a:lnTo>
                    <a:pt x="3100" y="1746"/>
                  </a:lnTo>
                  <a:lnTo>
                    <a:pt x="3100" y="1746"/>
                  </a:lnTo>
                  <a:lnTo>
                    <a:pt x="3103" y="1746"/>
                  </a:lnTo>
                  <a:lnTo>
                    <a:pt x="3103" y="1746"/>
                  </a:lnTo>
                  <a:lnTo>
                    <a:pt x="3103" y="1746"/>
                  </a:lnTo>
                  <a:lnTo>
                    <a:pt x="3103" y="1746"/>
                  </a:lnTo>
                  <a:lnTo>
                    <a:pt x="3106" y="1746"/>
                  </a:lnTo>
                  <a:lnTo>
                    <a:pt x="3106" y="1746"/>
                  </a:lnTo>
                  <a:lnTo>
                    <a:pt x="3106" y="1746"/>
                  </a:lnTo>
                  <a:lnTo>
                    <a:pt x="3109" y="1746"/>
                  </a:lnTo>
                  <a:lnTo>
                    <a:pt x="3109" y="1746"/>
                  </a:lnTo>
                  <a:lnTo>
                    <a:pt x="3109" y="1746"/>
                  </a:lnTo>
                  <a:lnTo>
                    <a:pt x="3112" y="1746"/>
                  </a:lnTo>
                  <a:lnTo>
                    <a:pt x="3112" y="1746"/>
                  </a:lnTo>
                  <a:lnTo>
                    <a:pt x="3112" y="1741"/>
                  </a:lnTo>
                  <a:lnTo>
                    <a:pt x="3112" y="1741"/>
                  </a:lnTo>
                  <a:lnTo>
                    <a:pt x="3116" y="1741"/>
                  </a:lnTo>
                  <a:lnTo>
                    <a:pt x="3116" y="1736"/>
                  </a:lnTo>
                  <a:lnTo>
                    <a:pt x="3116" y="1736"/>
                  </a:lnTo>
                  <a:lnTo>
                    <a:pt x="3116" y="1731"/>
                  </a:lnTo>
                  <a:lnTo>
                    <a:pt x="3119" y="1731"/>
                  </a:lnTo>
                  <a:lnTo>
                    <a:pt x="3119" y="1731"/>
                  </a:lnTo>
                  <a:lnTo>
                    <a:pt x="3119" y="1731"/>
                  </a:lnTo>
                  <a:lnTo>
                    <a:pt x="3119" y="1731"/>
                  </a:lnTo>
                  <a:lnTo>
                    <a:pt x="3122" y="1736"/>
                  </a:lnTo>
                  <a:lnTo>
                    <a:pt x="3122" y="1736"/>
                  </a:lnTo>
                  <a:lnTo>
                    <a:pt x="3125" y="1736"/>
                  </a:lnTo>
                  <a:lnTo>
                    <a:pt x="3125" y="1741"/>
                  </a:lnTo>
                  <a:lnTo>
                    <a:pt x="3125" y="1741"/>
                  </a:lnTo>
                  <a:lnTo>
                    <a:pt x="3125" y="1741"/>
                  </a:lnTo>
                  <a:lnTo>
                    <a:pt x="3128" y="1746"/>
                  </a:lnTo>
                  <a:lnTo>
                    <a:pt x="3128" y="1746"/>
                  </a:lnTo>
                  <a:lnTo>
                    <a:pt x="3128" y="1746"/>
                  </a:lnTo>
                  <a:lnTo>
                    <a:pt x="3128" y="1746"/>
                  </a:lnTo>
                  <a:lnTo>
                    <a:pt x="3131" y="1746"/>
                  </a:lnTo>
                  <a:lnTo>
                    <a:pt x="3131" y="1746"/>
                  </a:lnTo>
                  <a:lnTo>
                    <a:pt x="3131" y="1746"/>
                  </a:lnTo>
                  <a:lnTo>
                    <a:pt x="3131" y="1746"/>
                  </a:lnTo>
                  <a:lnTo>
                    <a:pt x="3134" y="1746"/>
                  </a:lnTo>
                  <a:lnTo>
                    <a:pt x="3134" y="1746"/>
                  </a:lnTo>
                  <a:lnTo>
                    <a:pt x="3134" y="1746"/>
                  </a:lnTo>
                  <a:lnTo>
                    <a:pt x="3134" y="1746"/>
                  </a:lnTo>
                  <a:lnTo>
                    <a:pt x="3138" y="1746"/>
                  </a:lnTo>
                  <a:lnTo>
                    <a:pt x="3138" y="1746"/>
                  </a:lnTo>
                  <a:lnTo>
                    <a:pt x="3141" y="1746"/>
                  </a:lnTo>
                  <a:lnTo>
                    <a:pt x="3141" y="1746"/>
                  </a:lnTo>
                  <a:lnTo>
                    <a:pt x="3141" y="1746"/>
                  </a:lnTo>
                  <a:lnTo>
                    <a:pt x="3141" y="1741"/>
                  </a:lnTo>
                  <a:lnTo>
                    <a:pt x="3144" y="1741"/>
                  </a:lnTo>
                  <a:lnTo>
                    <a:pt x="3144" y="1741"/>
                  </a:lnTo>
                  <a:lnTo>
                    <a:pt x="3144" y="1741"/>
                  </a:lnTo>
                  <a:lnTo>
                    <a:pt x="3144" y="1741"/>
                  </a:lnTo>
                  <a:lnTo>
                    <a:pt x="3147" y="1741"/>
                  </a:lnTo>
                  <a:lnTo>
                    <a:pt x="3147" y="1741"/>
                  </a:lnTo>
                  <a:lnTo>
                    <a:pt x="3147" y="1741"/>
                  </a:lnTo>
                  <a:lnTo>
                    <a:pt x="3150" y="1741"/>
                  </a:lnTo>
                  <a:lnTo>
                    <a:pt x="3150" y="1741"/>
                  </a:lnTo>
                  <a:lnTo>
                    <a:pt x="3150" y="1741"/>
                  </a:lnTo>
                  <a:lnTo>
                    <a:pt x="3153" y="1746"/>
                  </a:lnTo>
                  <a:lnTo>
                    <a:pt x="3153" y="1746"/>
                  </a:lnTo>
                  <a:lnTo>
                    <a:pt x="3153" y="1746"/>
                  </a:lnTo>
                  <a:lnTo>
                    <a:pt x="3153" y="1746"/>
                  </a:lnTo>
                  <a:lnTo>
                    <a:pt x="3156" y="1741"/>
                  </a:lnTo>
                  <a:lnTo>
                    <a:pt x="3156" y="1741"/>
                  </a:lnTo>
                  <a:lnTo>
                    <a:pt x="3156" y="1741"/>
                  </a:lnTo>
                  <a:lnTo>
                    <a:pt x="3156" y="1741"/>
                  </a:lnTo>
                  <a:lnTo>
                    <a:pt x="3160" y="1741"/>
                  </a:lnTo>
                  <a:lnTo>
                    <a:pt x="3160" y="1741"/>
                  </a:lnTo>
                  <a:lnTo>
                    <a:pt x="3160" y="1741"/>
                  </a:lnTo>
                  <a:lnTo>
                    <a:pt x="3160" y="1741"/>
                  </a:lnTo>
                  <a:lnTo>
                    <a:pt x="3163" y="1741"/>
                  </a:lnTo>
                  <a:lnTo>
                    <a:pt x="3163" y="1741"/>
                  </a:lnTo>
                  <a:lnTo>
                    <a:pt x="3166" y="1741"/>
                  </a:lnTo>
                  <a:lnTo>
                    <a:pt x="3166" y="1741"/>
                  </a:lnTo>
                  <a:lnTo>
                    <a:pt x="3166" y="1741"/>
                  </a:lnTo>
                  <a:lnTo>
                    <a:pt x="3166" y="1741"/>
                  </a:lnTo>
                  <a:lnTo>
                    <a:pt x="3169" y="1741"/>
                  </a:lnTo>
                  <a:lnTo>
                    <a:pt x="3169" y="1741"/>
                  </a:lnTo>
                  <a:lnTo>
                    <a:pt x="3169" y="1741"/>
                  </a:lnTo>
                  <a:lnTo>
                    <a:pt x="3169" y="1741"/>
                  </a:lnTo>
                  <a:lnTo>
                    <a:pt x="3172" y="1741"/>
                  </a:lnTo>
                  <a:lnTo>
                    <a:pt x="3172" y="1741"/>
                  </a:lnTo>
                  <a:lnTo>
                    <a:pt x="3172" y="1741"/>
                  </a:lnTo>
                  <a:lnTo>
                    <a:pt x="3172" y="1741"/>
                  </a:lnTo>
                  <a:lnTo>
                    <a:pt x="3175" y="1746"/>
                  </a:lnTo>
                  <a:lnTo>
                    <a:pt x="3175" y="1746"/>
                  </a:lnTo>
                  <a:lnTo>
                    <a:pt x="3175" y="1746"/>
                  </a:lnTo>
                  <a:lnTo>
                    <a:pt x="3175" y="1746"/>
                  </a:lnTo>
                  <a:lnTo>
                    <a:pt x="3178" y="1746"/>
                  </a:lnTo>
                  <a:lnTo>
                    <a:pt x="3178" y="1746"/>
                  </a:lnTo>
                  <a:lnTo>
                    <a:pt x="3182" y="1746"/>
                  </a:lnTo>
                  <a:lnTo>
                    <a:pt x="3182" y="1746"/>
                  </a:lnTo>
                  <a:lnTo>
                    <a:pt x="3182" y="1746"/>
                  </a:lnTo>
                  <a:lnTo>
                    <a:pt x="3182" y="1746"/>
                  </a:lnTo>
                  <a:lnTo>
                    <a:pt x="3185" y="1746"/>
                  </a:lnTo>
                  <a:lnTo>
                    <a:pt x="3185" y="1746"/>
                  </a:lnTo>
                  <a:lnTo>
                    <a:pt x="3185" y="1746"/>
                  </a:lnTo>
                  <a:lnTo>
                    <a:pt x="3185" y="1746"/>
                  </a:lnTo>
                  <a:lnTo>
                    <a:pt x="3188" y="1746"/>
                  </a:lnTo>
                  <a:lnTo>
                    <a:pt x="3188" y="1746"/>
                  </a:lnTo>
                  <a:lnTo>
                    <a:pt x="3188" y="1746"/>
                  </a:lnTo>
                  <a:lnTo>
                    <a:pt x="3191" y="1746"/>
                  </a:lnTo>
                  <a:lnTo>
                    <a:pt x="3191" y="1746"/>
                  </a:lnTo>
                  <a:lnTo>
                    <a:pt x="3191" y="1746"/>
                  </a:lnTo>
                  <a:lnTo>
                    <a:pt x="3191" y="1746"/>
                  </a:lnTo>
                  <a:lnTo>
                    <a:pt x="3194" y="1746"/>
                  </a:lnTo>
                  <a:lnTo>
                    <a:pt x="3194" y="1746"/>
                  </a:lnTo>
                  <a:lnTo>
                    <a:pt x="3194" y="1746"/>
                  </a:lnTo>
                  <a:lnTo>
                    <a:pt x="3197" y="1746"/>
                  </a:lnTo>
                  <a:lnTo>
                    <a:pt x="3197" y="1746"/>
                  </a:lnTo>
                  <a:lnTo>
                    <a:pt x="3197" y="1746"/>
                  </a:lnTo>
                  <a:lnTo>
                    <a:pt x="3197" y="1746"/>
                  </a:lnTo>
                  <a:lnTo>
                    <a:pt x="3200" y="1746"/>
                  </a:lnTo>
                  <a:lnTo>
                    <a:pt x="3200" y="1746"/>
                  </a:lnTo>
                  <a:lnTo>
                    <a:pt x="3200" y="1746"/>
                  </a:lnTo>
                  <a:lnTo>
                    <a:pt x="3200" y="1746"/>
                  </a:lnTo>
                  <a:lnTo>
                    <a:pt x="3204" y="1746"/>
                  </a:lnTo>
                  <a:lnTo>
                    <a:pt x="3204" y="1746"/>
                  </a:lnTo>
                  <a:lnTo>
                    <a:pt x="3204" y="1746"/>
                  </a:lnTo>
                  <a:lnTo>
                    <a:pt x="3207" y="1746"/>
                  </a:lnTo>
                  <a:lnTo>
                    <a:pt x="3207" y="1746"/>
                  </a:lnTo>
                  <a:lnTo>
                    <a:pt x="3207" y="1746"/>
                  </a:lnTo>
                  <a:lnTo>
                    <a:pt x="3210" y="1746"/>
                  </a:lnTo>
                  <a:lnTo>
                    <a:pt x="3210" y="1746"/>
                  </a:lnTo>
                  <a:lnTo>
                    <a:pt x="3210" y="1746"/>
                  </a:lnTo>
                  <a:lnTo>
                    <a:pt x="3210" y="1746"/>
                  </a:lnTo>
                  <a:lnTo>
                    <a:pt x="3213" y="1746"/>
                  </a:lnTo>
                  <a:lnTo>
                    <a:pt x="3213" y="1746"/>
                  </a:lnTo>
                  <a:lnTo>
                    <a:pt x="3213" y="1746"/>
                  </a:lnTo>
                  <a:lnTo>
                    <a:pt x="3213" y="1746"/>
                  </a:lnTo>
                  <a:lnTo>
                    <a:pt x="3216" y="1746"/>
                  </a:lnTo>
                  <a:lnTo>
                    <a:pt x="3216" y="1746"/>
                  </a:lnTo>
                  <a:lnTo>
                    <a:pt x="3216" y="1746"/>
                  </a:lnTo>
                  <a:lnTo>
                    <a:pt x="3216" y="1746"/>
                  </a:lnTo>
                  <a:lnTo>
                    <a:pt x="3219" y="1746"/>
                  </a:lnTo>
                  <a:lnTo>
                    <a:pt x="3219" y="1746"/>
                  </a:lnTo>
                  <a:lnTo>
                    <a:pt x="3222" y="1746"/>
                  </a:lnTo>
                  <a:lnTo>
                    <a:pt x="3222" y="1746"/>
                  </a:lnTo>
                  <a:lnTo>
                    <a:pt x="3222" y="1746"/>
                  </a:lnTo>
                  <a:lnTo>
                    <a:pt x="3222" y="1746"/>
                  </a:lnTo>
                  <a:lnTo>
                    <a:pt x="3226" y="1746"/>
                  </a:lnTo>
                  <a:lnTo>
                    <a:pt x="3226" y="1746"/>
                  </a:lnTo>
                  <a:lnTo>
                    <a:pt x="3226" y="1746"/>
                  </a:lnTo>
                  <a:lnTo>
                    <a:pt x="3226" y="1746"/>
                  </a:lnTo>
                  <a:lnTo>
                    <a:pt x="3229" y="1746"/>
                  </a:lnTo>
                  <a:lnTo>
                    <a:pt x="3229" y="1746"/>
                  </a:lnTo>
                  <a:lnTo>
                    <a:pt x="3229" y="1746"/>
                  </a:lnTo>
                  <a:lnTo>
                    <a:pt x="3229" y="1746"/>
                  </a:lnTo>
                  <a:lnTo>
                    <a:pt x="3232" y="1746"/>
                  </a:lnTo>
                  <a:lnTo>
                    <a:pt x="3232" y="1746"/>
                  </a:lnTo>
                  <a:lnTo>
                    <a:pt x="3232" y="1746"/>
                  </a:lnTo>
                  <a:lnTo>
                    <a:pt x="3235" y="1746"/>
                  </a:lnTo>
                  <a:lnTo>
                    <a:pt x="3235" y="1746"/>
                  </a:lnTo>
                  <a:lnTo>
                    <a:pt x="3235" y="1746"/>
                  </a:lnTo>
                  <a:lnTo>
                    <a:pt x="3238" y="1746"/>
                  </a:lnTo>
                  <a:lnTo>
                    <a:pt x="3238" y="1746"/>
                  </a:lnTo>
                  <a:lnTo>
                    <a:pt x="3238" y="1746"/>
                  </a:lnTo>
                  <a:lnTo>
                    <a:pt x="3238" y="1746"/>
                  </a:lnTo>
                  <a:lnTo>
                    <a:pt x="3241" y="1746"/>
                  </a:lnTo>
                  <a:lnTo>
                    <a:pt x="3241" y="1746"/>
                  </a:lnTo>
                  <a:lnTo>
                    <a:pt x="3241" y="1746"/>
                  </a:lnTo>
                  <a:lnTo>
                    <a:pt x="3241" y="1746"/>
                  </a:lnTo>
                  <a:lnTo>
                    <a:pt x="3244" y="1746"/>
                  </a:lnTo>
                  <a:lnTo>
                    <a:pt x="3244" y="1746"/>
                  </a:lnTo>
                  <a:lnTo>
                    <a:pt x="3244" y="1746"/>
                  </a:lnTo>
                  <a:lnTo>
                    <a:pt x="3248" y="1746"/>
                  </a:lnTo>
                  <a:lnTo>
                    <a:pt x="3248" y="1746"/>
                  </a:lnTo>
                  <a:lnTo>
                    <a:pt x="3248" y="1746"/>
                  </a:lnTo>
                  <a:lnTo>
                    <a:pt x="3251" y="1746"/>
                  </a:lnTo>
                  <a:lnTo>
                    <a:pt x="3251" y="1746"/>
                  </a:lnTo>
                  <a:lnTo>
                    <a:pt x="3251" y="1746"/>
                  </a:lnTo>
                  <a:lnTo>
                    <a:pt x="3251" y="1746"/>
                  </a:lnTo>
                  <a:lnTo>
                    <a:pt x="3254" y="1741"/>
                  </a:lnTo>
                  <a:lnTo>
                    <a:pt x="3254" y="1741"/>
                  </a:lnTo>
                  <a:lnTo>
                    <a:pt x="3254" y="1741"/>
                  </a:lnTo>
                  <a:lnTo>
                    <a:pt x="3254" y="1741"/>
                  </a:lnTo>
                  <a:lnTo>
                    <a:pt x="3257" y="1741"/>
                  </a:lnTo>
                  <a:lnTo>
                    <a:pt x="3257" y="1741"/>
                  </a:lnTo>
                  <a:lnTo>
                    <a:pt x="3257" y="1741"/>
                  </a:lnTo>
                  <a:lnTo>
                    <a:pt x="3257" y="1741"/>
                  </a:lnTo>
                  <a:lnTo>
                    <a:pt x="3260" y="1741"/>
                  </a:lnTo>
                  <a:lnTo>
                    <a:pt x="3260" y="1741"/>
                  </a:lnTo>
                  <a:lnTo>
                    <a:pt x="3263" y="1741"/>
                  </a:lnTo>
                  <a:lnTo>
                    <a:pt x="3263" y="1741"/>
                  </a:lnTo>
                  <a:lnTo>
                    <a:pt x="3263" y="1741"/>
                  </a:lnTo>
                  <a:lnTo>
                    <a:pt x="3263" y="1741"/>
                  </a:lnTo>
                  <a:lnTo>
                    <a:pt x="3267" y="1741"/>
                  </a:lnTo>
                  <a:lnTo>
                    <a:pt x="3267" y="1741"/>
                  </a:lnTo>
                  <a:lnTo>
                    <a:pt x="3267" y="1741"/>
                  </a:lnTo>
                  <a:lnTo>
                    <a:pt x="3267" y="1741"/>
                  </a:lnTo>
                  <a:lnTo>
                    <a:pt x="3270" y="1741"/>
                  </a:lnTo>
                  <a:lnTo>
                    <a:pt x="3270" y="1741"/>
                  </a:lnTo>
                  <a:lnTo>
                    <a:pt x="3270" y="1741"/>
                  </a:lnTo>
                  <a:lnTo>
                    <a:pt x="3270" y="1741"/>
                  </a:lnTo>
                  <a:lnTo>
                    <a:pt x="3273" y="1741"/>
                  </a:lnTo>
                  <a:lnTo>
                    <a:pt x="3273" y="1741"/>
                  </a:lnTo>
                  <a:lnTo>
                    <a:pt x="3273" y="1746"/>
                  </a:lnTo>
                  <a:lnTo>
                    <a:pt x="3273" y="1746"/>
                  </a:lnTo>
                  <a:lnTo>
                    <a:pt x="3276" y="1746"/>
                  </a:lnTo>
                  <a:lnTo>
                    <a:pt x="3276" y="1746"/>
                  </a:lnTo>
                  <a:lnTo>
                    <a:pt x="3279" y="1746"/>
                  </a:lnTo>
                  <a:lnTo>
                    <a:pt x="3279" y="1746"/>
                  </a:lnTo>
                  <a:lnTo>
                    <a:pt x="3279" y="1746"/>
                  </a:lnTo>
                  <a:lnTo>
                    <a:pt x="3279" y="1746"/>
                  </a:lnTo>
                  <a:lnTo>
                    <a:pt x="3282" y="1746"/>
                  </a:lnTo>
                  <a:lnTo>
                    <a:pt x="3282" y="1746"/>
                  </a:lnTo>
                  <a:lnTo>
                    <a:pt x="3282" y="1746"/>
                  </a:lnTo>
                  <a:lnTo>
                    <a:pt x="3282" y="1746"/>
                  </a:lnTo>
                  <a:lnTo>
                    <a:pt x="3285" y="1746"/>
                  </a:lnTo>
                  <a:lnTo>
                    <a:pt x="3285" y="1746"/>
                  </a:lnTo>
                  <a:lnTo>
                    <a:pt x="3285" y="1746"/>
                  </a:lnTo>
                  <a:lnTo>
                    <a:pt x="3289" y="1746"/>
                  </a:lnTo>
                  <a:lnTo>
                    <a:pt x="3289" y="1746"/>
                  </a:lnTo>
                  <a:lnTo>
                    <a:pt x="3289" y="1746"/>
                  </a:lnTo>
                  <a:lnTo>
                    <a:pt x="3292" y="1746"/>
                  </a:lnTo>
                  <a:lnTo>
                    <a:pt x="3292" y="1746"/>
                  </a:lnTo>
                  <a:lnTo>
                    <a:pt x="3292" y="1746"/>
                  </a:lnTo>
                  <a:lnTo>
                    <a:pt x="3292" y="1746"/>
                  </a:lnTo>
                  <a:lnTo>
                    <a:pt x="3295" y="1746"/>
                  </a:lnTo>
                  <a:lnTo>
                    <a:pt x="3295" y="1746"/>
                  </a:lnTo>
                  <a:lnTo>
                    <a:pt x="3295" y="1746"/>
                  </a:lnTo>
                  <a:lnTo>
                    <a:pt x="3295" y="1746"/>
                  </a:lnTo>
                  <a:lnTo>
                    <a:pt x="3298" y="1746"/>
                  </a:lnTo>
                  <a:lnTo>
                    <a:pt x="3298" y="1746"/>
                  </a:lnTo>
                  <a:lnTo>
                    <a:pt x="3298" y="1746"/>
                  </a:lnTo>
                  <a:lnTo>
                    <a:pt x="3298" y="1746"/>
                  </a:lnTo>
                  <a:lnTo>
                    <a:pt x="3301" y="1746"/>
                  </a:lnTo>
                  <a:lnTo>
                    <a:pt x="3301" y="1746"/>
                  </a:lnTo>
                  <a:lnTo>
                    <a:pt x="3301" y="1746"/>
                  </a:lnTo>
                  <a:lnTo>
                    <a:pt x="3304" y="1746"/>
                  </a:lnTo>
                  <a:lnTo>
                    <a:pt x="3304" y="1741"/>
                  </a:lnTo>
                  <a:lnTo>
                    <a:pt x="3304" y="1741"/>
                  </a:lnTo>
                  <a:lnTo>
                    <a:pt x="3307" y="1741"/>
                  </a:lnTo>
                  <a:lnTo>
                    <a:pt x="3307" y="1741"/>
                  </a:lnTo>
                  <a:lnTo>
                    <a:pt x="3307" y="1741"/>
                  </a:lnTo>
                  <a:lnTo>
                    <a:pt x="3307" y="1741"/>
                  </a:lnTo>
                  <a:lnTo>
                    <a:pt x="3311" y="1741"/>
                  </a:lnTo>
                  <a:lnTo>
                    <a:pt x="3311" y="1741"/>
                  </a:lnTo>
                  <a:lnTo>
                    <a:pt x="3311" y="1741"/>
                  </a:lnTo>
                  <a:lnTo>
                    <a:pt x="3311" y="1741"/>
                  </a:lnTo>
                  <a:lnTo>
                    <a:pt x="3314" y="1741"/>
                  </a:lnTo>
                  <a:lnTo>
                    <a:pt x="3314" y="1741"/>
                  </a:lnTo>
                  <a:lnTo>
                    <a:pt x="3314" y="1741"/>
                  </a:lnTo>
                  <a:lnTo>
                    <a:pt x="3314" y="1741"/>
                  </a:lnTo>
                  <a:lnTo>
                    <a:pt x="3317" y="1741"/>
                  </a:lnTo>
                  <a:lnTo>
                    <a:pt x="3317" y="1741"/>
                  </a:lnTo>
                  <a:lnTo>
                    <a:pt x="3320" y="1736"/>
                  </a:lnTo>
                  <a:lnTo>
                    <a:pt x="3320" y="1736"/>
                  </a:lnTo>
                  <a:lnTo>
                    <a:pt x="3320" y="1736"/>
                  </a:lnTo>
                  <a:lnTo>
                    <a:pt x="3320" y="1736"/>
                  </a:lnTo>
                  <a:lnTo>
                    <a:pt x="3323" y="1736"/>
                  </a:lnTo>
                  <a:lnTo>
                    <a:pt x="3323" y="1736"/>
                  </a:lnTo>
                  <a:lnTo>
                    <a:pt x="3323" y="1731"/>
                  </a:lnTo>
                  <a:lnTo>
                    <a:pt x="3323" y="1731"/>
                  </a:lnTo>
                  <a:lnTo>
                    <a:pt x="3326" y="1727"/>
                  </a:lnTo>
                  <a:lnTo>
                    <a:pt x="3326" y="1727"/>
                  </a:lnTo>
                  <a:lnTo>
                    <a:pt x="3326" y="1717"/>
                  </a:lnTo>
                  <a:lnTo>
                    <a:pt x="3326" y="1717"/>
                  </a:lnTo>
                  <a:lnTo>
                    <a:pt x="3329" y="1703"/>
                  </a:lnTo>
                  <a:lnTo>
                    <a:pt x="3329" y="1698"/>
                  </a:lnTo>
                  <a:lnTo>
                    <a:pt x="3329" y="1683"/>
                  </a:lnTo>
                  <a:lnTo>
                    <a:pt x="3333" y="1679"/>
                  </a:lnTo>
                  <a:lnTo>
                    <a:pt x="3333" y="1688"/>
                  </a:lnTo>
                  <a:lnTo>
                    <a:pt x="3333" y="1693"/>
                  </a:lnTo>
                  <a:lnTo>
                    <a:pt x="3336" y="1717"/>
                  </a:lnTo>
                  <a:lnTo>
                    <a:pt x="3336" y="1722"/>
                  </a:lnTo>
                  <a:lnTo>
                    <a:pt x="3336" y="1741"/>
                  </a:lnTo>
                  <a:lnTo>
                    <a:pt x="3336" y="1746"/>
                  </a:lnTo>
                  <a:lnTo>
                    <a:pt x="3339" y="1751"/>
                  </a:lnTo>
                  <a:lnTo>
                    <a:pt x="3339" y="1755"/>
                  </a:lnTo>
                  <a:lnTo>
                    <a:pt x="3339" y="1760"/>
                  </a:lnTo>
                  <a:lnTo>
                    <a:pt x="3339" y="1765"/>
                  </a:lnTo>
                  <a:lnTo>
                    <a:pt x="3342" y="1765"/>
                  </a:lnTo>
                  <a:lnTo>
                    <a:pt x="3342" y="1770"/>
                  </a:lnTo>
                  <a:lnTo>
                    <a:pt x="3342" y="1770"/>
                  </a:lnTo>
                  <a:lnTo>
                    <a:pt x="3345" y="1770"/>
                  </a:lnTo>
                  <a:lnTo>
                    <a:pt x="3345" y="1774"/>
                  </a:lnTo>
                  <a:lnTo>
                    <a:pt x="3345" y="1774"/>
                  </a:lnTo>
                  <a:lnTo>
                    <a:pt x="3348" y="1779"/>
                  </a:lnTo>
                  <a:lnTo>
                    <a:pt x="3348" y="1779"/>
                  </a:lnTo>
                  <a:lnTo>
                    <a:pt x="3348" y="1779"/>
                  </a:lnTo>
                  <a:lnTo>
                    <a:pt x="3348" y="1779"/>
                  </a:lnTo>
                  <a:lnTo>
                    <a:pt x="3351" y="1779"/>
                  </a:lnTo>
                  <a:lnTo>
                    <a:pt x="3351" y="1779"/>
                  </a:lnTo>
                  <a:lnTo>
                    <a:pt x="3351" y="1784"/>
                  </a:lnTo>
                  <a:lnTo>
                    <a:pt x="3351" y="1784"/>
                  </a:lnTo>
                  <a:lnTo>
                    <a:pt x="3355" y="1784"/>
                  </a:lnTo>
                  <a:lnTo>
                    <a:pt x="3355" y="1784"/>
                  </a:lnTo>
                  <a:lnTo>
                    <a:pt x="3355" y="1784"/>
                  </a:lnTo>
                  <a:lnTo>
                    <a:pt x="3355" y="1784"/>
                  </a:lnTo>
                  <a:lnTo>
                    <a:pt x="3358" y="1784"/>
                  </a:lnTo>
                  <a:lnTo>
                    <a:pt x="3358" y="1784"/>
                  </a:lnTo>
                  <a:lnTo>
                    <a:pt x="3358" y="1789"/>
                  </a:lnTo>
                  <a:lnTo>
                    <a:pt x="3361" y="1789"/>
                  </a:lnTo>
                  <a:lnTo>
                    <a:pt x="3361" y="1789"/>
                  </a:lnTo>
                  <a:lnTo>
                    <a:pt x="3361" y="1789"/>
                  </a:lnTo>
                  <a:lnTo>
                    <a:pt x="3364" y="1789"/>
                  </a:lnTo>
                  <a:lnTo>
                    <a:pt x="3364" y="1789"/>
                  </a:lnTo>
                  <a:lnTo>
                    <a:pt x="3364" y="1789"/>
                  </a:lnTo>
                  <a:lnTo>
                    <a:pt x="3364" y="1789"/>
                  </a:lnTo>
                  <a:lnTo>
                    <a:pt x="3367" y="1789"/>
                  </a:lnTo>
                  <a:lnTo>
                    <a:pt x="3367" y="1789"/>
                  </a:lnTo>
                  <a:lnTo>
                    <a:pt x="3367" y="1789"/>
                  </a:lnTo>
                  <a:lnTo>
                    <a:pt x="3367" y="1789"/>
                  </a:lnTo>
                  <a:lnTo>
                    <a:pt x="3370" y="1784"/>
                  </a:lnTo>
                  <a:lnTo>
                    <a:pt x="3370" y="1784"/>
                  </a:lnTo>
                  <a:lnTo>
                    <a:pt x="3370" y="1784"/>
                  </a:lnTo>
                  <a:lnTo>
                    <a:pt x="3373" y="1784"/>
                  </a:lnTo>
                  <a:lnTo>
                    <a:pt x="3373" y="1779"/>
                  </a:lnTo>
                  <a:lnTo>
                    <a:pt x="3373" y="1779"/>
                  </a:lnTo>
                  <a:lnTo>
                    <a:pt x="3377" y="1774"/>
                  </a:lnTo>
                  <a:lnTo>
                    <a:pt x="3377" y="1774"/>
                  </a:lnTo>
                  <a:lnTo>
                    <a:pt x="3377" y="1774"/>
                  </a:lnTo>
                  <a:lnTo>
                    <a:pt x="3377" y="1774"/>
                  </a:lnTo>
                  <a:lnTo>
                    <a:pt x="3380" y="1770"/>
                  </a:lnTo>
                  <a:lnTo>
                    <a:pt x="3380" y="1770"/>
                  </a:lnTo>
                  <a:lnTo>
                    <a:pt x="3380" y="1770"/>
                  </a:lnTo>
                  <a:lnTo>
                    <a:pt x="3380" y="1774"/>
                  </a:lnTo>
                  <a:lnTo>
                    <a:pt x="3383" y="1774"/>
                  </a:lnTo>
                  <a:lnTo>
                    <a:pt x="3383" y="1779"/>
                  </a:lnTo>
                  <a:lnTo>
                    <a:pt x="3383" y="1779"/>
                  </a:lnTo>
                  <a:lnTo>
                    <a:pt x="3386" y="1779"/>
                  </a:lnTo>
                  <a:lnTo>
                    <a:pt x="3386" y="1784"/>
                  </a:lnTo>
                  <a:lnTo>
                    <a:pt x="3386" y="1784"/>
                  </a:lnTo>
                  <a:lnTo>
                    <a:pt x="3389" y="1784"/>
                  </a:lnTo>
                  <a:lnTo>
                    <a:pt x="3389" y="1784"/>
                  </a:lnTo>
                  <a:lnTo>
                    <a:pt x="3389" y="1784"/>
                  </a:lnTo>
                  <a:lnTo>
                    <a:pt x="3389" y="1784"/>
                  </a:lnTo>
                  <a:lnTo>
                    <a:pt x="3392" y="1784"/>
                  </a:lnTo>
                  <a:lnTo>
                    <a:pt x="3392" y="1784"/>
                  </a:lnTo>
                  <a:lnTo>
                    <a:pt x="3392" y="1784"/>
                  </a:lnTo>
                  <a:lnTo>
                    <a:pt x="3392" y="1789"/>
                  </a:lnTo>
                  <a:lnTo>
                    <a:pt x="3395" y="1789"/>
                  </a:lnTo>
                  <a:lnTo>
                    <a:pt x="3395" y="1789"/>
                  </a:lnTo>
                  <a:lnTo>
                    <a:pt x="3395" y="1789"/>
                  </a:lnTo>
                  <a:lnTo>
                    <a:pt x="3395" y="1789"/>
                  </a:lnTo>
                  <a:lnTo>
                    <a:pt x="3399" y="1789"/>
                  </a:lnTo>
                  <a:lnTo>
                    <a:pt x="3399" y="1789"/>
                  </a:lnTo>
                  <a:lnTo>
                    <a:pt x="3399" y="1789"/>
                  </a:lnTo>
                  <a:lnTo>
                    <a:pt x="3402" y="1789"/>
                  </a:lnTo>
                  <a:lnTo>
                    <a:pt x="3402" y="1789"/>
                  </a:lnTo>
                  <a:lnTo>
                    <a:pt x="3402" y="1789"/>
                  </a:lnTo>
                  <a:lnTo>
                    <a:pt x="3405" y="1789"/>
                  </a:lnTo>
                  <a:lnTo>
                    <a:pt x="3405" y="1789"/>
                  </a:lnTo>
                  <a:lnTo>
                    <a:pt x="3405" y="1789"/>
                  </a:lnTo>
                  <a:lnTo>
                    <a:pt x="3405" y="1789"/>
                  </a:lnTo>
                  <a:lnTo>
                    <a:pt x="3408" y="1789"/>
                  </a:lnTo>
                  <a:lnTo>
                    <a:pt x="3408" y="1789"/>
                  </a:lnTo>
                  <a:lnTo>
                    <a:pt x="3408" y="1789"/>
                  </a:lnTo>
                  <a:lnTo>
                    <a:pt x="3408" y="1789"/>
                  </a:lnTo>
                  <a:lnTo>
                    <a:pt x="3411" y="1789"/>
                  </a:lnTo>
                  <a:lnTo>
                    <a:pt x="3411" y="1789"/>
                  </a:lnTo>
                  <a:lnTo>
                    <a:pt x="3411" y="1789"/>
                  </a:lnTo>
                  <a:lnTo>
                    <a:pt x="3414" y="1789"/>
                  </a:lnTo>
                  <a:lnTo>
                    <a:pt x="3414" y="1789"/>
                  </a:lnTo>
                  <a:lnTo>
                    <a:pt x="3414" y="1789"/>
                  </a:lnTo>
                  <a:lnTo>
                    <a:pt x="3417" y="1789"/>
                  </a:lnTo>
                  <a:lnTo>
                    <a:pt x="3417" y="1789"/>
                  </a:lnTo>
                  <a:lnTo>
                    <a:pt x="3417" y="1789"/>
                  </a:lnTo>
                  <a:lnTo>
                    <a:pt x="3417" y="1789"/>
                  </a:lnTo>
                  <a:lnTo>
                    <a:pt x="3421" y="1794"/>
                  </a:lnTo>
                  <a:lnTo>
                    <a:pt x="3421" y="1794"/>
                  </a:lnTo>
                  <a:lnTo>
                    <a:pt x="3421" y="1794"/>
                  </a:lnTo>
                  <a:lnTo>
                    <a:pt x="3421" y="1794"/>
                  </a:lnTo>
                  <a:lnTo>
                    <a:pt x="3424" y="1794"/>
                  </a:lnTo>
                  <a:lnTo>
                    <a:pt x="3424" y="1794"/>
                  </a:lnTo>
                  <a:lnTo>
                    <a:pt x="3424" y="1794"/>
                  </a:lnTo>
                  <a:lnTo>
                    <a:pt x="3424" y="1794"/>
                  </a:lnTo>
                  <a:lnTo>
                    <a:pt x="3427" y="1794"/>
                  </a:lnTo>
                  <a:lnTo>
                    <a:pt x="3427" y="1794"/>
                  </a:lnTo>
                  <a:lnTo>
                    <a:pt x="3430" y="1794"/>
                  </a:lnTo>
                  <a:lnTo>
                    <a:pt x="3430" y="1794"/>
                  </a:lnTo>
                  <a:lnTo>
                    <a:pt x="3430" y="1794"/>
                  </a:lnTo>
                  <a:lnTo>
                    <a:pt x="3430" y="1794"/>
                  </a:lnTo>
                  <a:lnTo>
                    <a:pt x="3433" y="1794"/>
                  </a:lnTo>
                  <a:lnTo>
                    <a:pt x="3433" y="1794"/>
                  </a:lnTo>
                  <a:lnTo>
                    <a:pt x="3433" y="1794"/>
                  </a:lnTo>
                  <a:lnTo>
                    <a:pt x="3433" y="1794"/>
                  </a:lnTo>
                  <a:lnTo>
                    <a:pt x="3436" y="1794"/>
                  </a:lnTo>
                  <a:lnTo>
                    <a:pt x="3436" y="1794"/>
                  </a:lnTo>
                  <a:lnTo>
                    <a:pt x="3436" y="1794"/>
                  </a:lnTo>
                  <a:lnTo>
                    <a:pt x="3436" y="1794"/>
                  </a:lnTo>
                  <a:lnTo>
                    <a:pt x="3439" y="1794"/>
                  </a:lnTo>
                  <a:lnTo>
                    <a:pt x="3439" y="1794"/>
                  </a:lnTo>
                  <a:lnTo>
                    <a:pt x="3439" y="1794"/>
                  </a:lnTo>
                  <a:lnTo>
                    <a:pt x="3443" y="1794"/>
                  </a:lnTo>
                  <a:lnTo>
                    <a:pt x="3443" y="1794"/>
                  </a:lnTo>
                  <a:lnTo>
                    <a:pt x="3443" y="1794"/>
                  </a:lnTo>
                  <a:lnTo>
                    <a:pt x="3446" y="1794"/>
                  </a:lnTo>
                  <a:lnTo>
                    <a:pt x="3446" y="1794"/>
                  </a:lnTo>
                  <a:lnTo>
                    <a:pt x="3446" y="1794"/>
                  </a:lnTo>
                  <a:lnTo>
                    <a:pt x="3446" y="1794"/>
                  </a:lnTo>
                  <a:lnTo>
                    <a:pt x="3449" y="1794"/>
                  </a:lnTo>
                  <a:lnTo>
                    <a:pt x="3449" y="1794"/>
                  </a:lnTo>
                  <a:lnTo>
                    <a:pt x="3449" y="1794"/>
                  </a:lnTo>
                  <a:lnTo>
                    <a:pt x="3449" y="1794"/>
                  </a:lnTo>
                  <a:lnTo>
                    <a:pt x="3452" y="1794"/>
                  </a:lnTo>
                  <a:lnTo>
                    <a:pt x="3452" y="1794"/>
                  </a:lnTo>
                  <a:lnTo>
                    <a:pt x="3452" y="1794"/>
                  </a:lnTo>
                  <a:lnTo>
                    <a:pt x="3452" y="1794"/>
                  </a:lnTo>
                  <a:lnTo>
                    <a:pt x="3455" y="1794"/>
                  </a:lnTo>
                  <a:lnTo>
                    <a:pt x="3455" y="1794"/>
                  </a:lnTo>
                  <a:lnTo>
                    <a:pt x="3458" y="1794"/>
                  </a:lnTo>
                  <a:lnTo>
                    <a:pt x="3458" y="1794"/>
                  </a:lnTo>
                  <a:lnTo>
                    <a:pt x="3458" y="1794"/>
                  </a:lnTo>
                  <a:lnTo>
                    <a:pt x="3458" y="1794"/>
                  </a:lnTo>
                  <a:lnTo>
                    <a:pt x="3461" y="1794"/>
                  </a:lnTo>
                  <a:lnTo>
                    <a:pt x="3461" y="1794"/>
                  </a:lnTo>
                  <a:lnTo>
                    <a:pt x="3461" y="1794"/>
                  </a:lnTo>
                  <a:lnTo>
                    <a:pt x="3461" y="1794"/>
                  </a:lnTo>
                  <a:lnTo>
                    <a:pt x="3465" y="1794"/>
                  </a:lnTo>
                  <a:lnTo>
                    <a:pt x="3465" y="1794"/>
                  </a:lnTo>
                  <a:lnTo>
                    <a:pt x="3465" y="1794"/>
                  </a:lnTo>
                  <a:lnTo>
                    <a:pt x="3465" y="1794"/>
                  </a:lnTo>
                  <a:lnTo>
                    <a:pt x="3468" y="1794"/>
                  </a:lnTo>
                  <a:lnTo>
                    <a:pt x="3468" y="1794"/>
                  </a:lnTo>
                  <a:lnTo>
                    <a:pt x="3468" y="1794"/>
                  </a:lnTo>
                  <a:lnTo>
                    <a:pt x="3471" y="1794"/>
                  </a:lnTo>
                  <a:lnTo>
                    <a:pt x="3471" y="1794"/>
                  </a:lnTo>
                  <a:lnTo>
                    <a:pt x="3471" y="1794"/>
                  </a:lnTo>
                  <a:lnTo>
                    <a:pt x="3474" y="1794"/>
                  </a:lnTo>
                  <a:lnTo>
                    <a:pt x="3474" y="1794"/>
                  </a:lnTo>
                  <a:lnTo>
                    <a:pt x="3474" y="1798"/>
                  </a:lnTo>
                  <a:lnTo>
                    <a:pt x="3474" y="1798"/>
                  </a:lnTo>
                  <a:lnTo>
                    <a:pt x="3477" y="1798"/>
                  </a:lnTo>
                  <a:lnTo>
                    <a:pt x="3477" y="1798"/>
                  </a:lnTo>
                  <a:lnTo>
                    <a:pt x="3477" y="1798"/>
                  </a:lnTo>
                  <a:lnTo>
                    <a:pt x="3477" y="1798"/>
                  </a:lnTo>
                  <a:lnTo>
                    <a:pt x="3480" y="1798"/>
                  </a:lnTo>
                  <a:lnTo>
                    <a:pt x="3480" y="1798"/>
                  </a:lnTo>
                  <a:lnTo>
                    <a:pt x="3480" y="1798"/>
                  </a:lnTo>
                  <a:lnTo>
                    <a:pt x="3483" y="1798"/>
                  </a:lnTo>
                  <a:lnTo>
                    <a:pt x="3483" y="1798"/>
                  </a:lnTo>
                  <a:lnTo>
                    <a:pt x="3483" y="1798"/>
                  </a:lnTo>
                  <a:lnTo>
                    <a:pt x="3487" y="1798"/>
                  </a:lnTo>
                  <a:lnTo>
                    <a:pt x="3487" y="1798"/>
                  </a:lnTo>
                  <a:lnTo>
                    <a:pt x="3487" y="1798"/>
                  </a:lnTo>
                  <a:lnTo>
                    <a:pt x="3487" y="1798"/>
                  </a:lnTo>
                  <a:lnTo>
                    <a:pt x="3490" y="1798"/>
                  </a:lnTo>
                  <a:lnTo>
                    <a:pt x="3490" y="1798"/>
                  </a:lnTo>
                  <a:lnTo>
                    <a:pt x="3490" y="1798"/>
                  </a:lnTo>
                  <a:lnTo>
                    <a:pt x="3490" y="1798"/>
                  </a:lnTo>
                  <a:lnTo>
                    <a:pt x="3493" y="1798"/>
                  </a:lnTo>
                  <a:lnTo>
                    <a:pt x="3493" y="1798"/>
                  </a:lnTo>
                  <a:lnTo>
                    <a:pt x="3493" y="1798"/>
                  </a:lnTo>
                  <a:lnTo>
                    <a:pt x="3493" y="1798"/>
                  </a:lnTo>
                  <a:lnTo>
                    <a:pt x="3496" y="1798"/>
                  </a:lnTo>
                  <a:lnTo>
                    <a:pt x="3496" y="1798"/>
                  </a:lnTo>
                  <a:lnTo>
                    <a:pt x="3496" y="1798"/>
                  </a:lnTo>
                  <a:lnTo>
                    <a:pt x="3499" y="1798"/>
                  </a:lnTo>
                  <a:lnTo>
                    <a:pt x="3499" y="1798"/>
                  </a:lnTo>
                  <a:lnTo>
                    <a:pt x="3499" y="1798"/>
                  </a:lnTo>
                  <a:lnTo>
                    <a:pt x="3502" y="1798"/>
                  </a:lnTo>
                  <a:lnTo>
                    <a:pt x="3502" y="1798"/>
                  </a:lnTo>
                  <a:lnTo>
                    <a:pt x="3502" y="1798"/>
                  </a:lnTo>
                  <a:lnTo>
                    <a:pt x="3502" y="1798"/>
                  </a:lnTo>
                  <a:lnTo>
                    <a:pt x="3505" y="1798"/>
                  </a:lnTo>
                  <a:lnTo>
                    <a:pt x="3505" y="1798"/>
                  </a:lnTo>
                  <a:lnTo>
                    <a:pt x="3505" y="1798"/>
                  </a:lnTo>
                  <a:lnTo>
                    <a:pt x="3505" y="1798"/>
                  </a:lnTo>
                  <a:lnTo>
                    <a:pt x="3509" y="1798"/>
                  </a:lnTo>
                  <a:lnTo>
                    <a:pt x="3509" y="1798"/>
                  </a:lnTo>
                  <a:lnTo>
                    <a:pt x="3509" y="1798"/>
                  </a:lnTo>
                  <a:lnTo>
                    <a:pt x="3512" y="1798"/>
                  </a:lnTo>
                  <a:lnTo>
                    <a:pt x="3512" y="1798"/>
                  </a:lnTo>
                  <a:lnTo>
                    <a:pt x="3512" y="1798"/>
                  </a:lnTo>
                  <a:lnTo>
                    <a:pt x="3512" y="1798"/>
                  </a:lnTo>
                  <a:lnTo>
                    <a:pt x="3515" y="1798"/>
                  </a:lnTo>
                  <a:lnTo>
                    <a:pt x="3515" y="1798"/>
                  </a:lnTo>
                  <a:lnTo>
                    <a:pt x="3515" y="1798"/>
                  </a:lnTo>
                  <a:lnTo>
                    <a:pt x="3518" y="1798"/>
                  </a:lnTo>
                  <a:lnTo>
                    <a:pt x="3518" y="1798"/>
                  </a:lnTo>
                  <a:lnTo>
                    <a:pt x="3518" y="1798"/>
                  </a:lnTo>
                  <a:lnTo>
                    <a:pt x="3518" y="1798"/>
                  </a:lnTo>
                  <a:lnTo>
                    <a:pt x="3521" y="1798"/>
                  </a:lnTo>
                  <a:lnTo>
                    <a:pt x="3521" y="1798"/>
                  </a:lnTo>
                  <a:lnTo>
                    <a:pt x="3521" y="1798"/>
                  </a:lnTo>
                  <a:lnTo>
                    <a:pt x="3524" y="1798"/>
                  </a:lnTo>
                  <a:lnTo>
                    <a:pt x="3524" y="1798"/>
                  </a:lnTo>
                  <a:lnTo>
                    <a:pt x="3524" y="1798"/>
                  </a:lnTo>
                  <a:lnTo>
                    <a:pt x="3527" y="1798"/>
                  </a:lnTo>
                  <a:lnTo>
                    <a:pt x="3527" y="1798"/>
                  </a:lnTo>
                  <a:lnTo>
                    <a:pt x="3527" y="1798"/>
                  </a:lnTo>
                  <a:lnTo>
                    <a:pt x="3527" y="1798"/>
                  </a:lnTo>
                  <a:lnTo>
                    <a:pt x="3531" y="1798"/>
                  </a:lnTo>
                  <a:lnTo>
                    <a:pt x="3531" y="1798"/>
                  </a:lnTo>
                  <a:lnTo>
                    <a:pt x="3531" y="1798"/>
                  </a:lnTo>
                  <a:lnTo>
                    <a:pt x="3531" y="1798"/>
                  </a:lnTo>
                  <a:lnTo>
                    <a:pt x="3534" y="1798"/>
                  </a:lnTo>
                  <a:lnTo>
                    <a:pt x="3534" y="1798"/>
                  </a:lnTo>
                  <a:lnTo>
                    <a:pt x="3534" y="1798"/>
                  </a:lnTo>
                  <a:lnTo>
                    <a:pt x="3534" y="1798"/>
                  </a:lnTo>
                  <a:lnTo>
                    <a:pt x="3537" y="1798"/>
                  </a:lnTo>
                  <a:lnTo>
                    <a:pt x="3537" y="1798"/>
                  </a:lnTo>
                  <a:lnTo>
                    <a:pt x="3537" y="1798"/>
                  </a:lnTo>
                  <a:lnTo>
                    <a:pt x="3537" y="1798"/>
                  </a:lnTo>
                  <a:lnTo>
                    <a:pt x="3540" y="1798"/>
                  </a:lnTo>
                  <a:lnTo>
                    <a:pt x="3540" y="1798"/>
                  </a:lnTo>
                  <a:lnTo>
                    <a:pt x="3543" y="1798"/>
                  </a:lnTo>
                  <a:lnTo>
                    <a:pt x="3543" y="1798"/>
                  </a:lnTo>
                  <a:lnTo>
                    <a:pt x="3543" y="1798"/>
                  </a:lnTo>
                  <a:lnTo>
                    <a:pt x="3543" y="1798"/>
                  </a:lnTo>
                  <a:lnTo>
                    <a:pt x="3546" y="1798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26" name="Rectangle 126"/>
            <p:cNvSpPr>
              <a:spLocks noChangeArrowheads="1"/>
            </p:cNvSpPr>
            <p:nvPr/>
          </p:nvSpPr>
          <p:spPr bwMode="auto">
            <a:xfrm rot="16200000">
              <a:off x="1355184" y="2445163"/>
              <a:ext cx="21320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AU</a:t>
              </a:r>
              <a:endParaRPr kumimoji="1" lang="ko-KR" altLang="ko-KR" sz="4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127" name="Line 127"/>
            <p:cNvSpPr>
              <a:spLocks noChangeShapeType="1"/>
            </p:cNvSpPr>
            <p:nvPr/>
          </p:nvSpPr>
          <p:spPr bwMode="auto">
            <a:xfrm flipH="1">
              <a:off x="2108200" y="4061495"/>
              <a:ext cx="14287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28" name="Line 128"/>
            <p:cNvSpPr>
              <a:spLocks noChangeShapeType="1"/>
            </p:cNvSpPr>
            <p:nvPr/>
          </p:nvSpPr>
          <p:spPr bwMode="auto">
            <a:xfrm flipH="1">
              <a:off x="2092325" y="3969420"/>
              <a:ext cx="30162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29" name="Rectangle 129"/>
            <p:cNvSpPr>
              <a:spLocks noChangeArrowheads="1"/>
            </p:cNvSpPr>
            <p:nvPr/>
          </p:nvSpPr>
          <p:spPr bwMode="auto">
            <a:xfrm>
              <a:off x="1753561" y="3917032"/>
              <a:ext cx="29815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0.00</a:t>
              </a:r>
              <a:endParaRPr kumimoji="1" lang="ko-KR" altLang="ko-KR" sz="4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130" name="Line 130"/>
            <p:cNvSpPr>
              <a:spLocks noChangeShapeType="1"/>
            </p:cNvSpPr>
            <p:nvPr/>
          </p:nvSpPr>
          <p:spPr bwMode="auto">
            <a:xfrm flipH="1">
              <a:off x="2108200" y="3878932"/>
              <a:ext cx="14287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31" name="Line 131"/>
            <p:cNvSpPr>
              <a:spLocks noChangeShapeType="1"/>
            </p:cNvSpPr>
            <p:nvPr/>
          </p:nvSpPr>
          <p:spPr bwMode="auto">
            <a:xfrm flipH="1">
              <a:off x="2108200" y="3778920"/>
              <a:ext cx="14287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32" name="Line 132"/>
            <p:cNvSpPr>
              <a:spLocks noChangeShapeType="1"/>
            </p:cNvSpPr>
            <p:nvPr/>
          </p:nvSpPr>
          <p:spPr bwMode="auto">
            <a:xfrm flipH="1">
              <a:off x="2108200" y="3688432"/>
              <a:ext cx="14287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33" name="Line 133"/>
            <p:cNvSpPr>
              <a:spLocks noChangeShapeType="1"/>
            </p:cNvSpPr>
            <p:nvPr/>
          </p:nvSpPr>
          <p:spPr bwMode="auto">
            <a:xfrm flipH="1">
              <a:off x="2108200" y="3588420"/>
              <a:ext cx="14287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34" name="Line 134"/>
            <p:cNvSpPr>
              <a:spLocks noChangeShapeType="1"/>
            </p:cNvSpPr>
            <p:nvPr/>
          </p:nvSpPr>
          <p:spPr bwMode="auto">
            <a:xfrm flipH="1">
              <a:off x="2092325" y="3497932"/>
              <a:ext cx="30162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35" name="Rectangle 135"/>
            <p:cNvSpPr>
              <a:spLocks noChangeArrowheads="1"/>
            </p:cNvSpPr>
            <p:nvPr/>
          </p:nvSpPr>
          <p:spPr bwMode="auto">
            <a:xfrm>
              <a:off x="1753561" y="3443957"/>
              <a:ext cx="29815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0.10</a:t>
              </a:r>
              <a:endParaRPr kumimoji="1" lang="ko-KR" altLang="ko-KR" sz="4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136" name="Line 136"/>
            <p:cNvSpPr>
              <a:spLocks noChangeShapeType="1"/>
            </p:cNvSpPr>
            <p:nvPr/>
          </p:nvSpPr>
          <p:spPr bwMode="auto">
            <a:xfrm flipH="1">
              <a:off x="2108200" y="3399507"/>
              <a:ext cx="14287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37" name="Line 137"/>
            <p:cNvSpPr>
              <a:spLocks noChangeShapeType="1"/>
            </p:cNvSpPr>
            <p:nvPr/>
          </p:nvSpPr>
          <p:spPr bwMode="auto">
            <a:xfrm flipH="1">
              <a:off x="2108200" y="3307432"/>
              <a:ext cx="14287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38" name="Line 138"/>
            <p:cNvSpPr>
              <a:spLocks noChangeShapeType="1"/>
            </p:cNvSpPr>
            <p:nvPr/>
          </p:nvSpPr>
          <p:spPr bwMode="auto">
            <a:xfrm flipH="1">
              <a:off x="2108200" y="3215357"/>
              <a:ext cx="14287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39" name="Line 139"/>
            <p:cNvSpPr>
              <a:spLocks noChangeShapeType="1"/>
            </p:cNvSpPr>
            <p:nvPr/>
          </p:nvSpPr>
          <p:spPr bwMode="auto">
            <a:xfrm flipH="1">
              <a:off x="2108200" y="3116932"/>
              <a:ext cx="14287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40" name="Line 140"/>
            <p:cNvSpPr>
              <a:spLocks noChangeShapeType="1"/>
            </p:cNvSpPr>
            <p:nvPr/>
          </p:nvSpPr>
          <p:spPr bwMode="auto">
            <a:xfrm flipH="1">
              <a:off x="2092325" y="3024857"/>
              <a:ext cx="30162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41" name="Rectangle 141"/>
            <p:cNvSpPr>
              <a:spLocks noChangeArrowheads="1"/>
            </p:cNvSpPr>
            <p:nvPr/>
          </p:nvSpPr>
          <p:spPr bwMode="auto">
            <a:xfrm>
              <a:off x="1753561" y="2972470"/>
              <a:ext cx="29815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0.20</a:t>
              </a:r>
              <a:endParaRPr kumimoji="1" lang="ko-KR" altLang="ko-KR" sz="4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142" name="Line 142"/>
            <p:cNvSpPr>
              <a:spLocks noChangeShapeType="1"/>
            </p:cNvSpPr>
            <p:nvPr/>
          </p:nvSpPr>
          <p:spPr bwMode="auto">
            <a:xfrm flipH="1">
              <a:off x="2108200" y="2934370"/>
              <a:ext cx="14287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43" name="Line 143"/>
            <p:cNvSpPr>
              <a:spLocks noChangeShapeType="1"/>
            </p:cNvSpPr>
            <p:nvPr/>
          </p:nvSpPr>
          <p:spPr bwMode="auto">
            <a:xfrm flipH="1">
              <a:off x="2108200" y="2835945"/>
              <a:ext cx="14287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44" name="Line 144"/>
            <p:cNvSpPr>
              <a:spLocks noChangeShapeType="1"/>
            </p:cNvSpPr>
            <p:nvPr/>
          </p:nvSpPr>
          <p:spPr bwMode="auto">
            <a:xfrm flipH="1">
              <a:off x="2108200" y="2743870"/>
              <a:ext cx="14287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45" name="Line 145"/>
            <p:cNvSpPr>
              <a:spLocks noChangeShapeType="1"/>
            </p:cNvSpPr>
            <p:nvPr/>
          </p:nvSpPr>
          <p:spPr bwMode="auto">
            <a:xfrm flipH="1">
              <a:off x="2108200" y="2645445"/>
              <a:ext cx="14287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46" name="Line 146"/>
            <p:cNvSpPr>
              <a:spLocks noChangeShapeType="1"/>
            </p:cNvSpPr>
            <p:nvPr/>
          </p:nvSpPr>
          <p:spPr bwMode="auto">
            <a:xfrm flipH="1">
              <a:off x="2092325" y="2553370"/>
              <a:ext cx="30162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47" name="Rectangle 147"/>
            <p:cNvSpPr>
              <a:spLocks noChangeArrowheads="1"/>
            </p:cNvSpPr>
            <p:nvPr/>
          </p:nvSpPr>
          <p:spPr bwMode="auto">
            <a:xfrm>
              <a:off x="1753561" y="2500982"/>
              <a:ext cx="29815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0.30</a:t>
              </a:r>
              <a:endParaRPr kumimoji="1" lang="ko-KR" altLang="ko-KR" sz="4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148" name="Line 148"/>
            <p:cNvSpPr>
              <a:spLocks noChangeShapeType="1"/>
            </p:cNvSpPr>
            <p:nvPr/>
          </p:nvSpPr>
          <p:spPr bwMode="auto">
            <a:xfrm flipH="1">
              <a:off x="2108200" y="2462882"/>
              <a:ext cx="14287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49" name="Line 149"/>
            <p:cNvSpPr>
              <a:spLocks noChangeShapeType="1"/>
            </p:cNvSpPr>
            <p:nvPr/>
          </p:nvSpPr>
          <p:spPr bwMode="auto">
            <a:xfrm flipH="1">
              <a:off x="2108200" y="2362870"/>
              <a:ext cx="14287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50" name="Line 150"/>
            <p:cNvSpPr>
              <a:spLocks noChangeShapeType="1"/>
            </p:cNvSpPr>
            <p:nvPr/>
          </p:nvSpPr>
          <p:spPr bwMode="auto">
            <a:xfrm flipH="1">
              <a:off x="2108200" y="2272382"/>
              <a:ext cx="14287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51" name="Line 151"/>
            <p:cNvSpPr>
              <a:spLocks noChangeShapeType="1"/>
            </p:cNvSpPr>
            <p:nvPr/>
          </p:nvSpPr>
          <p:spPr bwMode="auto">
            <a:xfrm flipH="1">
              <a:off x="2108200" y="2172370"/>
              <a:ext cx="14287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52" name="Line 152"/>
            <p:cNvSpPr>
              <a:spLocks noChangeShapeType="1"/>
            </p:cNvSpPr>
            <p:nvPr/>
          </p:nvSpPr>
          <p:spPr bwMode="auto">
            <a:xfrm flipH="1">
              <a:off x="2092325" y="2081882"/>
              <a:ext cx="30162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53" name="Rectangle 153"/>
            <p:cNvSpPr>
              <a:spLocks noChangeArrowheads="1"/>
            </p:cNvSpPr>
            <p:nvPr/>
          </p:nvSpPr>
          <p:spPr bwMode="auto">
            <a:xfrm>
              <a:off x="1753561" y="2027907"/>
              <a:ext cx="29815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0.40</a:t>
              </a:r>
              <a:endParaRPr kumimoji="1" lang="ko-KR" altLang="ko-KR" sz="4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154" name="Line 154"/>
            <p:cNvSpPr>
              <a:spLocks noChangeShapeType="1"/>
            </p:cNvSpPr>
            <p:nvPr/>
          </p:nvSpPr>
          <p:spPr bwMode="auto">
            <a:xfrm flipH="1">
              <a:off x="2108200" y="1989807"/>
              <a:ext cx="14287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55" name="Line 155"/>
            <p:cNvSpPr>
              <a:spLocks noChangeShapeType="1"/>
            </p:cNvSpPr>
            <p:nvPr/>
          </p:nvSpPr>
          <p:spPr bwMode="auto">
            <a:xfrm flipH="1">
              <a:off x="2108200" y="1891382"/>
              <a:ext cx="14287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56" name="Line 156"/>
            <p:cNvSpPr>
              <a:spLocks noChangeShapeType="1"/>
            </p:cNvSpPr>
            <p:nvPr/>
          </p:nvSpPr>
          <p:spPr bwMode="auto">
            <a:xfrm flipH="1">
              <a:off x="2108200" y="1799307"/>
              <a:ext cx="14287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57" name="Line 157"/>
            <p:cNvSpPr>
              <a:spLocks noChangeShapeType="1"/>
            </p:cNvSpPr>
            <p:nvPr/>
          </p:nvSpPr>
          <p:spPr bwMode="auto">
            <a:xfrm flipH="1">
              <a:off x="2108200" y="1700882"/>
              <a:ext cx="14287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58" name="Line 158"/>
            <p:cNvSpPr>
              <a:spLocks noChangeShapeType="1"/>
            </p:cNvSpPr>
            <p:nvPr/>
          </p:nvSpPr>
          <p:spPr bwMode="auto">
            <a:xfrm flipH="1">
              <a:off x="2092325" y="1608807"/>
              <a:ext cx="30162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59" name="Rectangle 159"/>
            <p:cNvSpPr>
              <a:spLocks noChangeArrowheads="1"/>
            </p:cNvSpPr>
            <p:nvPr/>
          </p:nvSpPr>
          <p:spPr bwMode="auto">
            <a:xfrm>
              <a:off x="1753561" y="1556420"/>
              <a:ext cx="29815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0.50</a:t>
              </a:r>
              <a:endParaRPr kumimoji="1" lang="ko-KR" altLang="ko-KR" sz="4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160" name="Line 160"/>
            <p:cNvSpPr>
              <a:spLocks noChangeShapeType="1"/>
            </p:cNvSpPr>
            <p:nvPr/>
          </p:nvSpPr>
          <p:spPr bwMode="auto">
            <a:xfrm flipH="1">
              <a:off x="2108200" y="1510382"/>
              <a:ext cx="14287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61" name="Line 161"/>
            <p:cNvSpPr>
              <a:spLocks noChangeShapeType="1"/>
            </p:cNvSpPr>
            <p:nvPr/>
          </p:nvSpPr>
          <p:spPr bwMode="auto">
            <a:xfrm flipH="1">
              <a:off x="2108200" y="1418307"/>
              <a:ext cx="14287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62" name="Line 162"/>
            <p:cNvSpPr>
              <a:spLocks noChangeShapeType="1"/>
            </p:cNvSpPr>
            <p:nvPr/>
          </p:nvSpPr>
          <p:spPr bwMode="auto">
            <a:xfrm flipH="1">
              <a:off x="2108200" y="1327820"/>
              <a:ext cx="14287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63" name="Line 163"/>
            <p:cNvSpPr>
              <a:spLocks noChangeShapeType="1"/>
            </p:cNvSpPr>
            <p:nvPr/>
          </p:nvSpPr>
          <p:spPr bwMode="auto">
            <a:xfrm flipH="1">
              <a:off x="2108200" y="1227807"/>
              <a:ext cx="14287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64" name="Line 164"/>
            <p:cNvSpPr>
              <a:spLocks noChangeShapeType="1"/>
            </p:cNvSpPr>
            <p:nvPr/>
          </p:nvSpPr>
          <p:spPr bwMode="auto">
            <a:xfrm flipH="1">
              <a:off x="2092325" y="1137320"/>
              <a:ext cx="30162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65" name="Rectangle 165"/>
            <p:cNvSpPr>
              <a:spLocks noChangeArrowheads="1"/>
            </p:cNvSpPr>
            <p:nvPr/>
          </p:nvSpPr>
          <p:spPr bwMode="auto">
            <a:xfrm>
              <a:off x="1753561" y="1083345"/>
              <a:ext cx="29815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0.60</a:t>
              </a:r>
              <a:endParaRPr kumimoji="1" lang="ko-KR" altLang="ko-KR" sz="4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166" name="Line 166"/>
            <p:cNvSpPr>
              <a:spLocks noChangeShapeType="1"/>
            </p:cNvSpPr>
            <p:nvPr/>
          </p:nvSpPr>
          <p:spPr bwMode="auto">
            <a:xfrm flipH="1">
              <a:off x="2108200" y="1038895"/>
              <a:ext cx="14287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67" name="Rectangle 167"/>
            <p:cNvSpPr>
              <a:spLocks noChangeArrowheads="1"/>
            </p:cNvSpPr>
            <p:nvPr/>
          </p:nvSpPr>
          <p:spPr bwMode="auto">
            <a:xfrm>
              <a:off x="4499992" y="4436442"/>
              <a:ext cx="626775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Minutes</a:t>
              </a:r>
              <a:endParaRPr kumimoji="1" lang="ko-KR" altLang="ko-KR" sz="4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168" name="Line 168"/>
            <p:cNvSpPr>
              <a:spLocks noChangeShapeType="1"/>
            </p:cNvSpPr>
            <p:nvPr/>
          </p:nvSpPr>
          <p:spPr bwMode="auto">
            <a:xfrm>
              <a:off x="2122488" y="4121820"/>
              <a:ext cx="0" cy="460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69" name="Rectangle 169"/>
            <p:cNvSpPr>
              <a:spLocks noChangeArrowheads="1"/>
            </p:cNvSpPr>
            <p:nvPr/>
          </p:nvSpPr>
          <p:spPr bwMode="auto">
            <a:xfrm>
              <a:off x="2051050" y="4220418"/>
              <a:ext cx="29815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0.00</a:t>
              </a:r>
              <a:endParaRPr kumimoji="1" lang="ko-KR" altLang="ko-KR" sz="4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170" name="Line 170"/>
            <p:cNvSpPr>
              <a:spLocks noChangeShapeType="1"/>
            </p:cNvSpPr>
            <p:nvPr/>
          </p:nvSpPr>
          <p:spPr bwMode="auto">
            <a:xfrm>
              <a:off x="2227263" y="4121820"/>
              <a:ext cx="0" cy="23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71" name="Line 171"/>
            <p:cNvSpPr>
              <a:spLocks noChangeShapeType="1"/>
            </p:cNvSpPr>
            <p:nvPr/>
          </p:nvSpPr>
          <p:spPr bwMode="auto">
            <a:xfrm>
              <a:off x="2327275" y="4121820"/>
              <a:ext cx="0" cy="23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72" name="Line 172"/>
            <p:cNvSpPr>
              <a:spLocks noChangeShapeType="1"/>
            </p:cNvSpPr>
            <p:nvPr/>
          </p:nvSpPr>
          <p:spPr bwMode="auto">
            <a:xfrm>
              <a:off x="2432050" y="4121820"/>
              <a:ext cx="0" cy="23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73" name="Line 173"/>
            <p:cNvSpPr>
              <a:spLocks noChangeShapeType="1"/>
            </p:cNvSpPr>
            <p:nvPr/>
          </p:nvSpPr>
          <p:spPr bwMode="auto">
            <a:xfrm>
              <a:off x="2532063" y="4121820"/>
              <a:ext cx="0" cy="23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74" name="Line 174"/>
            <p:cNvSpPr>
              <a:spLocks noChangeShapeType="1"/>
            </p:cNvSpPr>
            <p:nvPr/>
          </p:nvSpPr>
          <p:spPr bwMode="auto">
            <a:xfrm>
              <a:off x="2636838" y="4121820"/>
              <a:ext cx="0" cy="460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75" name="Rectangle 175"/>
            <p:cNvSpPr>
              <a:spLocks noChangeArrowheads="1"/>
            </p:cNvSpPr>
            <p:nvPr/>
          </p:nvSpPr>
          <p:spPr bwMode="auto">
            <a:xfrm>
              <a:off x="2565400" y="4220418"/>
              <a:ext cx="29815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1.00</a:t>
              </a:r>
              <a:endParaRPr kumimoji="1" lang="ko-KR" altLang="ko-KR" sz="4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176" name="Line 176"/>
            <p:cNvSpPr>
              <a:spLocks noChangeShapeType="1"/>
            </p:cNvSpPr>
            <p:nvPr/>
          </p:nvSpPr>
          <p:spPr bwMode="auto">
            <a:xfrm>
              <a:off x="2736850" y="4121820"/>
              <a:ext cx="0" cy="23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77" name="Line 177"/>
            <p:cNvSpPr>
              <a:spLocks noChangeShapeType="1"/>
            </p:cNvSpPr>
            <p:nvPr/>
          </p:nvSpPr>
          <p:spPr bwMode="auto">
            <a:xfrm>
              <a:off x="2841625" y="4121820"/>
              <a:ext cx="0" cy="23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78" name="Line 178"/>
            <p:cNvSpPr>
              <a:spLocks noChangeShapeType="1"/>
            </p:cNvSpPr>
            <p:nvPr/>
          </p:nvSpPr>
          <p:spPr bwMode="auto">
            <a:xfrm>
              <a:off x="2941638" y="4121820"/>
              <a:ext cx="0" cy="23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79" name="Line 179"/>
            <p:cNvSpPr>
              <a:spLocks noChangeShapeType="1"/>
            </p:cNvSpPr>
            <p:nvPr/>
          </p:nvSpPr>
          <p:spPr bwMode="auto">
            <a:xfrm>
              <a:off x="3046413" y="4121820"/>
              <a:ext cx="0" cy="23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80" name="Line 180"/>
            <p:cNvSpPr>
              <a:spLocks noChangeShapeType="1"/>
            </p:cNvSpPr>
            <p:nvPr/>
          </p:nvSpPr>
          <p:spPr bwMode="auto">
            <a:xfrm>
              <a:off x="3146425" y="4121820"/>
              <a:ext cx="0" cy="460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81" name="Rectangle 181"/>
            <p:cNvSpPr>
              <a:spLocks noChangeArrowheads="1"/>
            </p:cNvSpPr>
            <p:nvPr/>
          </p:nvSpPr>
          <p:spPr bwMode="auto">
            <a:xfrm>
              <a:off x="3074988" y="4220418"/>
              <a:ext cx="29815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2.00</a:t>
              </a:r>
              <a:endParaRPr kumimoji="1" lang="ko-KR" altLang="ko-KR" sz="4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182" name="Line 182"/>
            <p:cNvSpPr>
              <a:spLocks noChangeShapeType="1"/>
            </p:cNvSpPr>
            <p:nvPr/>
          </p:nvSpPr>
          <p:spPr bwMode="auto">
            <a:xfrm>
              <a:off x="3251200" y="4121820"/>
              <a:ext cx="0" cy="23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83" name="Line 183"/>
            <p:cNvSpPr>
              <a:spLocks noChangeShapeType="1"/>
            </p:cNvSpPr>
            <p:nvPr/>
          </p:nvSpPr>
          <p:spPr bwMode="auto">
            <a:xfrm>
              <a:off x="3351213" y="4121820"/>
              <a:ext cx="0" cy="23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84" name="Line 184"/>
            <p:cNvSpPr>
              <a:spLocks noChangeShapeType="1"/>
            </p:cNvSpPr>
            <p:nvPr/>
          </p:nvSpPr>
          <p:spPr bwMode="auto">
            <a:xfrm>
              <a:off x="3455988" y="4121820"/>
              <a:ext cx="0" cy="23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85" name="Line 185"/>
            <p:cNvSpPr>
              <a:spLocks noChangeShapeType="1"/>
            </p:cNvSpPr>
            <p:nvPr/>
          </p:nvSpPr>
          <p:spPr bwMode="auto">
            <a:xfrm>
              <a:off x="3556000" y="4121820"/>
              <a:ext cx="0" cy="23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86" name="Line 186"/>
            <p:cNvSpPr>
              <a:spLocks noChangeShapeType="1"/>
            </p:cNvSpPr>
            <p:nvPr/>
          </p:nvSpPr>
          <p:spPr bwMode="auto">
            <a:xfrm>
              <a:off x="3660775" y="4121820"/>
              <a:ext cx="0" cy="460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87" name="Rectangle 187"/>
            <p:cNvSpPr>
              <a:spLocks noChangeArrowheads="1"/>
            </p:cNvSpPr>
            <p:nvPr/>
          </p:nvSpPr>
          <p:spPr bwMode="auto">
            <a:xfrm>
              <a:off x="3589338" y="4220418"/>
              <a:ext cx="29815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3.00</a:t>
              </a:r>
              <a:endParaRPr kumimoji="1" lang="ko-KR" altLang="ko-KR" sz="4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188" name="Line 188"/>
            <p:cNvSpPr>
              <a:spLocks noChangeShapeType="1"/>
            </p:cNvSpPr>
            <p:nvPr/>
          </p:nvSpPr>
          <p:spPr bwMode="auto">
            <a:xfrm>
              <a:off x="3759200" y="4121820"/>
              <a:ext cx="0" cy="23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89" name="Line 189"/>
            <p:cNvSpPr>
              <a:spLocks noChangeShapeType="1"/>
            </p:cNvSpPr>
            <p:nvPr/>
          </p:nvSpPr>
          <p:spPr bwMode="auto">
            <a:xfrm>
              <a:off x="3863975" y="4121820"/>
              <a:ext cx="0" cy="23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90" name="Line 190"/>
            <p:cNvSpPr>
              <a:spLocks noChangeShapeType="1"/>
            </p:cNvSpPr>
            <p:nvPr/>
          </p:nvSpPr>
          <p:spPr bwMode="auto">
            <a:xfrm>
              <a:off x="3963988" y="4121820"/>
              <a:ext cx="0" cy="23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91" name="Line 191"/>
            <p:cNvSpPr>
              <a:spLocks noChangeShapeType="1"/>
            </p:cNvSpPr>
            <p:nvPr/>
          </p:nvSpPr>
          <p:spPr bwMode="auto">
            <a:xfrm>
              <a:off x="4068763" y="4121820"/>
              <a:ext cx="0" cy="23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92" name="Line 192"/>
            <p:cNvSpPr>
              <a:spLocks noChangeShapeType="1"/>
            </p:cNvSpPr>
            <p:nvPr/>
          </p:nvSpPr>
          <p:spPr bwMode="auto">
            <a:xfrm>
              <a:off x="4168775" y="4121820"/>
              <a:ext cx="0" cy="460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93" name="Rectangle 193"/>
            <p:cNvSpPr>
              <a:spLocks noChangeArrowheads="1"/>
            </p:cNvSpPr>
            <p:nvPr/>
          </p:nvSpPr>
          <p:spPr bwMode="auto">
            <a:xfrm>
              <a:off x="4097338" y="4220418"/>
              <a:ext cx="29815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4.00</a:t>
              </a:r>
              <a:endParaRPr kumimoji="1" lang="ko-KR" altLang="ko-KR" sz="4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194" name="Line 194"/>
            <p:cNvSpPr>
              <a:spLocks noChangeShapeType="1"/>
            </p:cNvSpPr>
            <p:nvPr/>
          </p:nvSpPr>
          <p:spPr bwMode="auto">
            <a:xfrm>
              <a:off x="4273550" y="4121820"/>
              <a:ext cx="0" cy="23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95" name="Line 195"/>
            <p:cNvSpPr>
              <a:spLocks noChangeShapeType="1"/>
            </p:cNvSpPr>
            <p:nvPr/>
          </p:nvSpPr>
          <p:spPr bwMode="auto">
            <a:xfrm>
              <a:off x="4373563" y="4121820"/>
              <a:ext cx="0" cy="23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96" name="Line 196"/>
            <p:cNvSpPr>
              <a:spLocks noChangeShapeType="1"/>
            </p:cNvSpPr>
            <p:nvPr/>
          </p:nvSpPr>
          <p:spPr bwMode="auto">
            <a:xfrm>
              <a:off x="4478338" y="4121820"/>
              <a:ext cx="0" cy="23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97" name="Line 197"/>
            <p:cNvSpPr>
              <a:spLocks noChangeShapeType="1"/>
            </p:cNvSpPr>
            <p:nvPr/>
          </p:nvSpPr>
          <p:spPr bwMode="auto">
            <a:xfrm>
              <a:off x="4578350" y="4121820"/>
              <a:ext cx="0" cy="23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98" name="Line 198"/>
            <p:cNvSpPr>
              <a:spLocks noChangeShapeType="1"/>
            </p:cNvSpPr>
            <p:nvPr/>
          </p:nvSpPr>
          <p:spPr bwMode="auto">
            <a:xfrm>
              <a:off x="4683125" y="4121820"/>
              <a:ext cx="0" cy="460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199" name="Rectangle 199"/>
            <p:cNvSpPr>
              <a:spLocks noChangeArrowheads="1"/>
            </p:cNvSpPr>
            <p:nvPr/>
          </p:nvSpPr>
          <p:spPr bwMode="auto">
            <a:xfrm>
              <a:off x="4611688" y="4220418"/>
              <a:ext cx="29815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5.00</a:t>
              </a:r>
              <a:endParaRPr kumimoji="1" lang="ko-KR" altLang="ko-KR" sz="4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200" name="Line 200"/>
            <p:cNvSpPr>
              <a:spLocks noChangeShapeType="1"/>
            </p:cNvSpPr>
            <p:nvPr/>
          </p:nvSpPr>
          <p:spPr bwMode="auto">
            <a:xfrm>
              <a:off x="4783138" y="4121820"/>
              <a:ext cx="0" cy="23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201" name="Line 201"/>
            <p:cNvSpPr>
              <a:spLocks noChangeShapeType="1"/>
            </p:cNvSpPr>
            <p:nvPr/>
          </p:nvSpPr>
          <p:spPr bwMode="auto">
            <a:xfrm>
              <a:off x="4887913" y="4121820"/>
              <a:ext cx="0" cy="23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202" name="Line 202"/>
            <p:cNvSpPr>
              <a:spLocks noChangeShapeType="1"/>
            </p:cNvSpPr>
            <p:nvPr/>
          </p:nvSpPr>
          <p:spPr bwMode="auto">
            <a:xfrm>
              <a:off x="4987925" y="4121820"/>
              <a:ext cx="0" cy="23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203" name="Line 203"/>
            <p:cNvSpPr>
              <a:spLocks noChangeShapeType="1"/>
            </p:cNvSpPr>
            <p:nvPr/>
          </p:nvSpPr>
          <p:spPr bwMode="auto">
            <a:xfrm>
              <a:off x="5092700" y="4121820"/>
              <a:ext cx="0" cy="23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204" name="Line 204"/>
            <p:cNvSpPr>
              <a:spLocks noChangeShapeType="1"/>
            </p:cNvSpPr>
            <p:nvPr/>
          </p:nvSpPr>
          <p:spPr bwMode="auto">
            <a:xfrm>
              <a:off x="5192713" y="4121820"/>
              <a:ext cx="0" cy="460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205" name="Rectangle 205"/>
            <p:cNvSpPr>
              <a:spLocks noChangeArrowheads="1"/>
            </p:cNvSpPr>
            <p:nvPr/>
          </p:nvSpPr>
          <p:spPr bwMode="auto">
            <a:xfrm>
              <a:off x="5121275" y="4220418"/>
              <a:ext cx="29815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6.00</a:t>
              </a:r>
              <a:endParaRPr kumimoji="1" lang="ko-KR" altLang="ko-KR" sz="4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206" name="Line 206"/>
            <p:cNvSpPr>
              <a:spLocks noChangeShapeType="1"/>
            </p:cNvSpPr>
            <p:nvPr/>
          </p:nvSpPr>
          <p:spPr bwMode="auto">
            <a:xfrm>
              <a:off x="5297488" y="4121820"/>
              <a:ext cx="0" cy="23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207" name="Line 207"/>
            <p:cNvSpPr>
              <a:spLocks noChangeShapeType="1"/>
            </p:cNvSpPr>
            <p:nvPr/>
          </p:nvSpPr>
          <p:spPr bwMode="auto">
            <a:xfrm>
              <a:off x="5397500" y="4121820"/>
              <a:ext cx="0" cy="23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208" name="Line 208"/>
            <p:cNvSpPr>
              <a:spLocks noChangeShapeType="1"/>
            </p:cNvSpPr>
            <p:nvPr/>
          </p:nvSpPr>
          <p:spPr bwMode="auto">
            <a:xfrm>
              <a:off x="5502275" y="4121820"/>
              <a:ext cx="0" cy="23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209" name="Line 209"/>
            <p:cNvSpPr>
              <a:spLocks noChangeShapeType="1"/>
            </p:cNvSpPr>
            <p:nvPr/>
          </p:nvSpPr>
          <p:spPr bwMode="auto">
            <a:xfrm>
              <a:off x="5600700" y="4121820"/>
              <a:ext cx="0" cy="23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210" name="Line 210"/>
            <p:cNvSpPr>
              <a:spLocks noChangeShapeType="1"/>
            </p:cNvSpPr>
            <p:nvPr/>
          </p:nvSpPr>
          <p:spPr bwMode="auto">
            <a:xfrm>
              <a:off x="5705475" y="4121820"/>
              <a:ext cx="0" cy="460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211" name="Rectangle 211"/>
            <p:cNvSpPr>
              <a:spLocks noChangeArrowheads="1"/>
            </p:cNvSpPr>
            <p:nvPr/>
          </p:nvSpPr>
          <p:spPr bwMode="auto">
            <a:xfrm>
              <a:off x="5634038" y="4220418"/>
              <a:ext cx="29815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7.00</a:t>
              </a:r>
              <a:endParaRPr kumimoji="1" lang="ko-KR" altLang="ko-KR" sz="4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212" name="Line 212"/>
            <p:cNvSpPr>
              <a:spLocks noChangeShapeType="1"/>
            </p:cNvSpPr>
            <p:nvPr/>
          </p:nvSpPr>
          <p:spPr bwMode="auto">
            <a:xfrm>
              <a:off x="5805488" y="4121820"/>
              <a:ext cx="0" cy="23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213" name="Line 213"/>
            <p:cNvSpPr>
              <a:spLocks noChangeShapeType="1"/>
            </p:cNvSpPr>
            <p:nvPr/>
          </p:nvSpPr>
          <p:spPr bwMode="auto">
            <a:xfrm>
              <a:off x="5910263" y="4121820"/>
              <a:ext cx="0" cy="23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214" name="Line 214"/>
            <p:cNvSpPr>
              <a:spLocks noChangeShapeType="1"/>
            </p:cNvSpPr>
            <p:nvPr/>
          </p:nvSpPr>
          <p:spPr bwMode="auto">
            <a:xfrm>
              <a:off x="6010275" y="4121820"/>
              <a:ext cx="0" cy="23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215" name="Line 215"/>
            <p:cNvSpPr>
              <a:spLocks noChangeShapeType="1"/>
            </p:cNvSpPr>
            <p:nvPr/>
          </p:nvSpPr>
          <p:spPr bwMode="auto">
            <a:xfrm>
              <a:off x="6115050" y="4121820"/>
              <a:ext cx="0" cy="23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216" name="Line 216"/>
            <p:cNvSpPr>
              <a:spLocks noChangeShapeType="1"/>
            </p:cNvSpPr>
            <p:nvPr/>
          </p:nvSpPr>
          <p:spPr bwMode="auto">
            <a:xfrm>
              <a:off x="6215063" y="4121820"/>
              <a:ext cx="0" cy="460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217" name="Rectangle 217"/>
            <p:cNvSpPr>
              <a:spLocks noChangeArrowheads="1"/>
            </p:cNvSpPr>
            <p:nvPr/>
          </p:nvSpPr>
          <p:spPr bwMode="auto">
            <a:xfrm>
              <a:off x="6143625" y="4220418"/>
              <a:ext cx="29815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8.00</a:t>
              </a:r>
              <a:endParaRPr kumimoji="1" lang="ko-KR" altLang="ko-KR" sz="4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218" name="Line 218"/>
            <p:cNvSpPr>
              <a:spLocks noChangeShapeType="1"/>
            </p:cNvSpPr>
            <p:nvPr/>
          </p:nvSpPr>
          <p:spPr bwMode="auto">
            <a:xfrm>
              <a:off x="6319838" y="4121820"/>
              <a:ext cx="0" cy="23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219" name="Line 219"/>
            <p:cNvSpPr>
              <a:spLocks noChangeShapeType="1"/>
            </p:cNvSpPr>
            <p:nvPr/>
          </p:nvSpPr>
          <p:spPr bwMode="auto">
            <a:xfrm>
              <a:off x="6419850" y="4121820"/>
              <a:ext cx="0" cy="23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220" name="Line 220"/>
            <p:cNvSpPr>
              <a:spLocks noChangeShapeType="1"/>
            </p:cNvSpPr>
            <p:nvPr/>
          </p:nvSpPr>
          <p:spPr bwMode="auto">
            <a:xfrm>
              <a:off x="6524625" y="4121820"/>
              <a:ext cx="0" cy="23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221" name="Line 221"/>
            <p:cNvSpPr>
              <a:spLocks noChangeShapeType="1"/>
            </p:cNvSpPr>
            <p:nvPr/>
          </p:nvSpPr>
          <p:spPr bwMode="auto">
            <a:xfrm>
              <a:off x="6624638" y="4121820"/>
              <a:ext cx="0" cy="23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222" name="Line 222"/>
            <p:cNvSpPr>
              <a:spLocks noChangeShapeType="1"/>
            </p:cNvSpPr>
            <p:nvPr/>
          </p:nvSpPr>
          <p:spPr bwMode="auto">
            <a:xfrm>
              <a:off x="6724650" y="4121820"/>
              <a:ext cx="0" cy="460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223" name="Rectangle 223"/>
            <p:cNvSpPr>
              <a:spLocks noChangeArrowheads="1"/>
            </p:cNvSpPr>
            <p:nvPr/>
          </p:nvSpPr>
          <p:spPr bwMode="auto">
            <a:xfrm>
              <a:off x="6653213" y="4220418"/>
              <a:ext cx="29815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9.00</a:t>
              </a:r>
              <a:endParaRPr kumimoji="1" lang="ko-KR" altLang="ko-KR" sz="4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224" name="Line 224"/>
            <p:cNvSpPr>
              <a:spLocks noChangeShapeType="1"/>
            </p:cNvSpPr>
            <p:nvPr/>
          </p:nvSpPr>
          <p:spPr bwMode="auto">
            <a:xfrm>
              <a:off x="6829425" y="4121820"/>
              <a:ext cx="0" cy="23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225" name="Line 225"/>
            <p:cNvSpPr>
              <a:spLocks noChangeShapeType="1"/>
            </p:cNvSpPr>
            <p:nvPr/>
          </p:nvSpPr>
          <p:spPr bwMode="auto">
            <a:xfrm>
              <a:off x="6934200" y="4121820"/>
              <a:ext cx="0" cy="23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226" name="Line 226"/>
            <p:cNvSpPr>
              <a:spLocks noChangeShapeType="1"/>
            </p:cNvSpPr>
            <p:nvPr/>
          </p:nvSpPr>
          <p:spPr bwMode="auto">
            <a:xfrm>
              <a:off x="7034213" y="4121820"/>
              <a:ext cx="0" cy="23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227" name="Line 227"/>
            <p:cNvSpPr>
              <a:spLocks noChangeShapeType="1"/>
            </p:cNvSpPr>
            <p:nvPr/>
          </p:nvSpPr>
          <p:spPr bwMode="auto">
            <a:xfrm>
              <a:off x="7132638" y="4121820"/>
              <a:ext cx="0" cy="23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228" name="Line 228"/>
            <p:cNvSpPr>
              <a:spLocks noChangeShapeType="1"/>
            </p:cNvSpPr>
            <p:nvPr/>
          </p:nvSpPr>
          <p:spPr bwMode="auto">
            <a:xfrm>
              <a:off x="7237413" y="4121820"/>
              <a:ext cx="0" cy="460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229" name="Rectangle 229"/>
            <p:cNvSpPr>
              <a:spLocks noChangeArrowheads="1"/>
            </p:cNvSpPr>
            <p:nvPr/>
          </p:nvSpPr>
          <p:spPr bwMode="auto">
            <a:xfrm>
              <a:off x="7148513" y="4220418"/>
              <a:ext cx="38311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10.00</a:t>
              </a:r>
              <a:endParaRPr kumimoji="1" lang="ko-KR" altLang="ko-KR" sz="4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230" name="Line 230"/>
            <p:cNvSpPr>
              <a:spLocks noChangeShapeType="1"/>
            </p:cNvSpPr>
            <p:nvPr/>
          </p:nvSpPr>
          <p:spPr bwMode="auto">
            <a:xfrm>
              <a:off x="7343775" y="4121820"/>
              <a:ext cx="0" cy="23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231" name="Line 231"/>
            <p:cNvSpPr>
              <a:spLocks noChangeShapeType="1"/>
            </p:cNvSpPr>
            <p:nvPr/>
          </p:nvSpPr>
          <p:spPr bwMode="auto">
            <a:xfrm>
              <a:off x="7442200" y="4121820"/>
              <a:ext cx="0" cy="23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232" name="Line 232"/>
            <p:cNvSpPr>
              <a:spLocks noChangeShapeType="1"/>
            </p:cNvSpPr>
            <p:nvPr/>
          </p:nvSpPr>
          <p:spPr bwMode="auto">
            <a:xfrm>
              <a:off x="7542213" y="4121820"/>
              <a:ext cx="0" cy="23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233" name="Line 233"/>
            <p:cNvSpPr>
              <a:spLocks noChangeShapeType="1"/>
            </p:cNvSpPr>
            <p:nvPr/>
          </p:nvSpPr>
          <p:spPr bwMode="auto">
            <a:xfrm>
              <a:off x="7646988" y="4121820"/>
              <a:ext cx="0" cy="238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234" name="Line 234"/>
            <p:cNvSpPr>
              <a:spLocks noChangeShapeType="1"/>
            </p:cNvSpPr>
            <p:nvPr/>
          </p:nvSpPr>
          <p:spPr bwMode="auto">
            <a:xfrm>
              <a:off x="7751763" y="4121820"/>
              <a:ext cx="0" cy="460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4000"/>
            </a:p>
          </p:txBody>
        </p:sp>
        <p:sp>
          <p:nvSpPr>
            <p:cNvPr id="235" name="Rectangle 235"/>
            <p:cNvSpPr>
              <a:spLocks noChangeArrowheads="1"/>
            </p:cNvSpPr>
            <p:nvPr/>
          </p:nvSpPr>
          <p:spPr bwMode="auto">
            <a:xfrm>
              <a:off x="7662863" y="4220418"/>
              <a:ext cx="371705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11.00</a:t>
              </a:r>
              <a:endParaRPr kumimoji="1" lang="ko-KR" altLang="ko-KR" sz="4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</p:grpSp>
      <p:sp>
        <p:nvSpPr>
          <p:cNvPr id="236" name="TextBox 235"/>
          <p:cNvSpPr txBox="1"/>
          <p:nvPr/>
        </p:nvSpPr>
        <p:spPr>
          <a:xfrm>
            <a:off x="251520" y="251356"/>
            <a:ext cx="2313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Times New Roman" pitchFamily="18" charset="0"/>
                <a:cs typeface="Times New Roman" pitchFamily="18" charset="0"/>
              </a:rPr>
              <a:t>Supplement Fig. 1.</a:t>
            </a:r>
            <a:endParaRPr lang="ko-KR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38" name="TextBox 237"/>
          <p:cNvSpPr txBox="1"/>
          <p:nvPr/>
        </p:nvSpPr>
        <p:spPr>
          <a:xfrm>
            <a:off x="1079374" y="4785246"/>
            <a:ext cx="7309050" cy="10926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Fingerprinting of FGS was 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performed 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with HPLC (</a:t>
            </a:r>
            <a:r>
              <a:rPr lang="en-US" altLang="ko-KR" sz="1400" dirty="0" err="1" smtClean="0">
                <a:latin typeface="Times New Roman" pitchFamily="18" charset="0"/>
                <a:cs typeface="Times New Roman" pitchFamily="18" charset="0"/>
              </a:rPr>
              <a:t>Dionex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). FGS run through a column was analyzed by 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a detector (PDA-100) at 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UV260nm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and </a:t>
            </a:r>
            <a:r>
              <a:rPr lang="en-US" altLang="ko-KR" sz="1400" dirty="0" err="1">
                <a:latin typeface="Times New Roman" pitchFamily="18" charset="0"/>
                <a:cs typeface="Times New Roman" pitchFamily="18" charset="0"/>
              </a:rPr>
              <a:t>chromelon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 (</a:t>
            </a:r>
            <a:r>
              <a:rPr lang="en-US" altLang="ko-KR" sz="1400" dirty="0" err="1">
                <a:latin typeface="Times New Roman" pitchFamily="18" charset="0"/>
                <a:cs typeface="Times New Roman" pitchFamily="18" charset="0"/>
              </a:rPr>
              <a:t>Dionex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). There 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are several 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distinctive and unique 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peaks in the water extract of 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FGS. While we don’t know the identity of those peaks, we referred them as key indices for the purpose of quality control. </a:t>
            </a:r>
            <a:endParaRPr lang="ko-KR" altLang="ko-KR" sz="1400" dirty="0">
              <a:latin typeface="Times New Roman" pitchFamily="18" charset="0"/>
              <a:cs typeface="Times New Roman" pitchFamily="18" charset="0"/>
            </a:endParaRPr>
          </a:p>
          <a:p>
            <a:endParaRPr lang="ko-KR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084768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" name="그룹 36"/>
          <p:cNvGrpSpPr/>
          <p:nvPr/>
        </p:nvGrpSpPr>
        <p:grpSpPr>
          <a:xfrm>
            <a:off x="2515042" y="1340768"/>
            <a:ext cx="4109565" cy="3574067"/>
            <a:chOff x="2166119" y="2168481"/>
            <a:chExt cx="4109565" cy="3574067"/>
          </a:xfrm>
        </p:grpSpPr>
        <p:pic>
          <p:nvPicPr>
            <p:cNvPr id="19" name="그림 18" descr="kkh .jpg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2699792" y="2311400"/>
              <a:ext cx="3528392" cy="2989808"/>
            </a:xfrm>
            <a:prstGeom prst="rect">
              <a:avLst/>
            </a:prstGeom>
          </p:spPr>
        </p:pic>
        <p:sp>
          <p:nvSpPr>
            <p:cNvPr id="25" name="TextBox 24"/>
            <p:cNvSpPr txBox="1"/>
            <p:nvPr/>
          </p:nvSpPr>
          <p:spPr>
            <a:xfrm>
              <a:off x="3430989" y="5181700"/>
              <a:ext cx="43204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>
                  <a:latin typeface="Times New Roman" pitchFamily="18" charset="0"/>
                  <a:cs typeface="Times New Roman" pitchFamily="18" charset="0"/>
                </a:rPr>
                <a:t>10</a:t>
              </a:r>
              <a:r>
                <a:rPr lang="en-US" altLang="ko-KR" sz="1050" b="1" baseline="30000" dirty="0" smtClean="0">
                  <a:latin typeface="Times New Roman" pitchFamily="18" charset="0"/>
                  <a:cs typeface="Times New Roman" pitchFamily="18" charset="0"/>
                </a:rPr>
                <a:t>1</a:t>
              </a:r>
              <a:endParaRPr lang="ko-KR" altLang="en-US" sz="1050" b="1" baseline="30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4283968" y="5180942"/>
              <a:ext cx="43204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>
                  <a:latin typeface="Times New Roman" pitchFamily="18" charset="0"/>
                  <a:cs typeface="Times New Roman" pitchFamily="18" charset="0"/>
                </a:rPr>
                <a:t>10</a:t>
              </a:r>
              <a:r>
                <a:rPr lang="en-US" altLang="ko-KR" sz="1050" b="1" baseline="30000" dirty="0" smtClean="0">
                  <a:latin typeface="Times New Roman" pitchFamily="18" charset="0"/>
                  <a:cs typeface="Times New Roman" pitchFamily="18" charset="0"/>
                </a:rPr>
                <a:t>2</a:t>
              </a:r>
              <a:endParaRPr lang="ko-KR" altLang="en-US" sz="1050" b="1" baseline="30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5086415" y="5181700"/>
              <a:ext cx="43204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>
                  <a:latin typeface="Times New Roman" pitchFamily="18" charset="0"/>
                  <a:cs typeface="Times New Roman" pitchFamily="18" charset="0"/>
                </a:rPr>
                <a:t>10</a:t>
              </a:r>
              <a:r>
                <a:rPr lang="en-US" altLang="ko-KR" sz="1050" b="1" baseline="30000" dirty="0" smtClean="0">
                  <a:latin typeface="Times New Roman" pitchFamily="18" charset="0"/>
                  <a:cs typeface="Times New Roman" pitchFamily="18" charset="0"/>
                </a:rPr>
                <a:t>3</a:t>
              </a:r>
              <a:endParaRPr lang="ko-KR" altLang="en-US" sz="1050" b="1" baseline="30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5843636" y="5181700"/>
              <a:ext cx="43204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>
                  <a:latin typeface="Times New Roman" pitchFamily="18" charset="0"/>
                  <a:cs typeface="Times New Roman" pitchFamily="18" charset="0"/>
                </a:rPr>
                <a:t>10</a:t>
              </a:r>
              <a:r>
                <a:rPr lang="en-US" altLang="ko-KR" sz="1050" b="1" baseline="30000" dirty="0" smtClean="0">
                  <a:latin typeface="Times New Roman" pitchFamily="18" charset="0"/>
                  <a:cs typeface="Times New Roman" pitchFamily="18" charset="0"/>
                </a:rPr>
                <a:t>4</a:t>
              </a:r>
              <a:endParaRPr lang="ko-KR" altLang="en-US" sz="1050" b="1" baseline="30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 rot="16200000">
              <a:off x="2370107" y="2322950"/>
              <a:ext cx="56285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>
                  <a:latin typeface="Times New Roman" pitchFamily="18" charset="0"/>
                  <a:cs typeface="Times New Roman" pitchFamily="18" charset="0"/>
                </a:rPr>
                <a:t>1000</a:t>
              </a:r>
              <a:endParaRPr lang="ko-KR" altLang="en-US" sz="1050" b="1" baseline="30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3995936" y="5373216"/>
              <a:ext cx="100811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b="1" dirty="0" smtClean="0">
                  <a:latin typeface="Times New Roman" pitchFamily="18" charset="0"/>
                  <a:cs typeface="Times New Roman" pitchFamily="18" charset="0"/>
                </a:rPr>
                <a:t>FL1 Lin</a:t>
              </a:r>
              <a:endParaRPr lang="ko-KR" altLang="en-US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 rot="10800000">
              <a:off x="2166119" y="3212975"/>
              <a:ext cx="461665" cy="864096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ko-KR" b="1" dirty="0" smtClean="0">
                  <a:latin typeface="Times New Roman" pitchFamily="18" charset="0"/>
                  <a:cs typeface="Times New Roman" pitchFamily="18" charset="0"/>
                </a:rPr>
                <a:t>Counts</a:t>
              </a:r>
              <a:endParaRPr lang="ko-KR" altLang="en-US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cxnSp>
        <p:nvCxnSpPr>
          <p:cNvPr id="39" name="직선 연결선 38"/>
          <p:cNvCxnSpPr/>
          <p:nvPr/>
        </p:nvCxnSpPr>
        <p:spPr>
          <a:xfrm>
            <a:off x="5724128" y="1700808"/>
            <a:ext cx="216024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직선 연결선 40"/>
          <p:cNvCxnSpPr/>
          <p:nvPr/>
        </p:nvCxnSpPr>
        <p:spPr>
          <a:xfrm>
            <a:off x="5724128" y="1853208"/>
            <a:ext cx="216024" cy="0"/>
          </a:xfrm>
          <a:prstGeom prst="line">
            <a:avLst/>
          </a:prstGeom>
          <a:ln w="19050">
            <a:solidFill>
              <a:srgbClr val="0070C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직선 연결선 41"/>
          <p:cNvCxnSpPr/>
          <p:nvPr/>
        </p:nvCxnSpPr>
        <p:spPr>
          <a:xfrm>
            <a:off x="5724128" y="2005608"/>
            <a:ext cx="216024" cy="0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TextBox 42"/>
          <p:cNvSpPr txBox="1"/>
          <p:nvPr/>
        </p:nvSpPr>
        <p:spPr>
          <a:xfrm>
            <a:off x="5940152" y="1556792"/>
            <a:ext cx="5760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 smtClean="0">
                <a:latin typeface="Times New Roman" pitchFamily="18" charset="0"/>
                <a:cs typeface="Times New Roman" pitchFamily="18" charset="0"/>
              </a:rPr>
              <a:t>cont</a:t>
            </a:r>
            <a:endParaRPr lang="ko-KR" altLang="en-US" sz="11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5940152" y="1709192"/>
            <a:ext cx="5760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 smtClean="0">
                <a:latin typeface="Times New Roman" pitchFamily="18" charset="0"/>
                <a:cs typeface="Times New Roman" pitchFamily="18" charset="0"/>
              </a:rPr>
              <a:t>FGS</a:t>
            </a:r>
            <a:endParaRPr lang="ko-KR" altLang="en-US" sz="11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5940152" y="1873467"/>
            <a:ext cx="5760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 smtClean="0">
                <a:latin typeface="Times New Roman" pitchFamily="18" charset="0"/>
                <a:cs typeface="Times New Roman" pitchFamily="18" charset="0"/>
              </a:rPr>
              <a:t>LPS</a:t>
            </a:r>
            <a:endParaRPr lang="ko-KR" altLang="en-US" sz="11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5076056" y="2519318"/>
            <a:ext cx="5760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 smtClean="0">
                <a:latin typeface="Times New Roman" pitchFamily="18" charset="0"/>
                <a:cs typeface="Times New Roman" pitchFamily="18" charset="0"/>
              </a:rPr>
              <a:t>LPS</a:t>
            </a:r>
            <a:endParaRPr lang="ko-KR" altLang="en-US" sz="11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995936" y="1556792"/>
            <a:ext cx="5760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 smtClean="0">
                <a:latin typeface="Times New Roman" pitchFamily="18" charset="0"/>
                <a:cs typeface="Times New Roman" pitchFamily="18" charset="0"/>
              </a:rPr>
              <a:t>FGS</a:t>
            </a:r>
            <a:endParaRPr lang="ko-KR" altLang="en-US" sz="11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3419872" y="1511206"/>
            <a:ext cx="5760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 smtClean="0">
                <a:latin typeface="Times New Roman" pitchFamily="18" charset="0"/>
                <a:cs typeface="Times New Roman" pitchFamily="18" charset="0"/>
              </a:rPr>
              <a:t>cont</a:t>
            </a:r>
            <a:endParaRPr lang="ko-KR" altLang="en-US" sz="11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251520" y="251356"/>
            <a:ext cx="2313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Times New Roman" pitchFamily="18" charset="0"/>
                <a:cs typeface="Times New Roman" pitchFamily="18" charset="0"/>
              </a:rPr>
              <a:t>Supplement Fig. 2.</a:t>
            </a:r>
            <a:endParaRPr lang="ko-KR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079374" y="5000689"/>
            <a:ext cx="7309050" cy="10926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Reactive oxygen species (ROS) produced by RAW 264.7 cells treated with FGS or LPS were measured by</a:t>
            </a:r>
            <a:r>
              <a:rPr lang="en-US" altLang="ko-KR" sz="1400" dirty="0" smtClean="0"/>
              <a:t> 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using the redox sensitive dyes 5-(and-6)-carboxy-2’,7’-dichlorodihydrofluorescein </a:t>
            </a:r>
            <a:r>
              <a:rPr lang="en-US" altLang="ko-KR" sz="1400" dirty="0" err="1">
                <a:latin typeface="Times New Roman" pitchFamily="18" charset="0"/>
                <a:cs typeface="Times New Roman" pitchFamily="18" charset="0"/>
              </a:rPr>
              <a:t>diacetate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 (carboxy-H</a:t>
            </a:r>
            <a:r>
              <a:rPr lang="en-US" altLang="ko-KR" sz="1400" baseline="-25000" dirty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DCFDA, Invitrogen) in conjunction with flow </a:t>
            </a:r>
            <a:r>
              <a:rPr lang="en-US" altLang="ko-KR" sz="1400" dirty="0" err="1" smtClean="0">
                <a:latin typeface="Times New Roman" pitchFamily="18" charset="0"/>
                <a:cs typeface="Times New Roman" pitchFamily="18" charset="0"/>
              </a:rPr>
              <a:t>cytometry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.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No significant ROS was produced by FGS. Shown are representatives of three independent measurements.</a:t>
            </a:r>
            <a:endParaRPr lang="ko-KR" altLang="ko-KR" sz="1400" dirty="0">
              <a:latin typeface="Times New Roman" pitchFamily="18" charset="0"/>
              <a:cs typeface="Times New Roman" pitchFamily="18" charset="0"/>
            </a:endParaRPr>
          </a:p>
          <a:p>
            <a:endParaRPr lang="ko-KR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076679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69</TotalTime>
  <Words>173</Words>
  <Application>Microsoft Office PowerPoint</Application>
  <PresentationFormat>화면 슬라이드 쇼(4:3)</PresentationFormat>
  <Paragraphs>38</Paragraphs>
  <Slides>2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3" baseType="lpstr">
      <vt:lpstr>Office 테마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9</cp:revision>
  <dcterms:created xsi:type="dcterms:W3CDTF">2012-03-14T06:43:25Z</dcterms:created>
  <dcterms:modified xsi:type="dcterms:W3CDTF">2013-03-04T06:01:09Z</dcterms:modified>
</cp:coreProperties>
</file>